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svg" ContentType="image/svg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diagrams/data3.xml" ContentType="application/vnd.openxmlformats-officedocument.drawingml.diagramData+xml"/>
  <Override PartName="/ppt/diagrams/layout3.xml" ContentType="application/vnd.openxmlformats-officedocument.drawingml.diagramLayout+xml"/>
  <Override PartName="/ppt/diagrams/quickStyle3.xml" ContentType="application/vnd.openxmlformats-officedocument.drawingml.diagramStyle+xml"/>
  <Override PartName="/ppt/diagrams/colors3.xml" ContentType="application/vnd.openxmlformats-officedocument.drawingml.diagramColors+xml"/>
  <Override PartName="/ppt/diagrams/drawing3.xml" ContentType="application/vnd.ms-office.drawingml.diagramDrawing+xml"/>
  <Override PartName="/ppt/notesSlides/notesSlide6.xml" ContentType="application/vnd.openxmlformats-officedocument.presentationml.notesSlide+xml"/>
  <Override PartName="/ppt/diagrams/data4.xml" ContentType="application/vnd.openxmlformats-officedocument.drawingml.diagramData+xml"/>
  <Override PartName="/ppt/diagrams/layout4.xml" ContentType="application/vnd.openxmlformats-officedocument.drawingml.diagramLayout+xml"/>
  <Override PartName="/ppt/diagrams/quickStyle4.xml" ContentType="application/vnd.openxmlformats-officedocument.drawingml.diagramStyle+xml"/>
  <Override PartName="/ppt/diagrams/colors4.xml" ContentType="application/vnd.openxmlformats-officedocument.drawingml.diagramColors+xml"/>
  <Override PartName="/ppt/diagrams/drawing4.xml" ContentType="application/vnd.ms-office.drawingml.diagramDrawing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diagrams/data5.xml" ContentType="application/vnd.openxmlformats-officedocument.drawingml.diagramData+xml"/>
  <Override PartName="/ppt/diagrams/layout5.xml" ContentType="application/vnd.openxmlformats-officedocument.drawingml.diagramLayout+xml"/>
  <Override PartName="/ppt/diagrams/quickStyle5.xml" ContentType="application/vnd.openxmlformats-officedocument.drawingml.diagramStyle+xml"/>
  <Override PartName="/ppt/diagrams/colors5.xml" ContentType="application/vnd.openxmlformats-officedocument.drawingml.diagramColors+xml"/>
  <Override PartName="/ppt/diagrams/drawing5.xml" ContentType="application/vnd.ms-office.drawingml.diagramDrawing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diagrams/data6.xml" ContentType="application/vnd.openxmlformats-officedocument.drawingml.diagramData+xml"/>
  <Override PartName="/ppt/diagrams/layout6.xml" ContentType="application/vnd.openxmlformats-officedocument.drawingml.diagramLayout+xml"/>
  <Override PartName="/ppt/diagrams/quickStyle6.xml" ContentType="application/vnd.openxmlformats-officedocument.drawingml.diagramStyle+xml"/>
  <Override PartName="/ppt/diagrams/colors6.xml" ContentType="application/vnd.openxmlformats-officedocument.drawingml.diagramColors+xml"/>
  <Override PartName="/ppt/diagrams/drawing6.xml" ContentType="application/vnd.ms-office.drawingml.diagramDrawing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diagrams/data7.xml" ContentType="application/vnd.openxmlformats-officedocument.drawingml.diagramData+xml"/>
  <Override PartName="/ppt/diagrams/layout7.xml" ContentType="application/vnd.openxmlformats-officedocument.drawingml.diagramLayout+xml"/>
  <Override PartName="/ppt/diagrams/quickStyle7.xml" ContentType="application/vnd.openxmlformats-officedocument.drawingml.diagramStyle+xml"/>
  <Override PartName="/ppt/diagrams/colors7.xml" ContentType="application/vnd.openxmlformats-officedocument.drawingml.diagramColors+xml"/>
  <Override PartName="/ppt/diagrams/drawing7.xml" ContentType="application/vnd.ms-office.drawingml.diagramDrawing+xml"/>
  <Override PartName="/ppt/notesSlides/notesSlide14.xml" ContentType="application/vnd.openxmlformats-officedocument.presentationml.notesSlide+xml"/>
  <Override PartName="/ppt/diagrams/data8.xml" ContentType="application/vnd.openxmlformats-officedocument.drawingml.diagramData+xml"/>
  <Override PartName="/ppt/diagrams/layout8.xml" ContentType="application/vnd.openxmlformats-officedocument.drawingml.diagramLayout+xml"/>
  <Override PartName="/ppt/diagrams/quickStyle8.xml" ContentType="application/vnd.openxmlformats-officedocument.drawingml.diagramStyle+xml"/>
  <Override PartName="/ppt/diagrams/colors8.xml" ContentType="application/vnd.openxmlformats-officedocument.drawingml.diagramColors+xml"/>
  <Override PartName="/ppt/diagrams/drawing8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22"/>
  </p:notesMasterIdLst>
  <p:sldIdLst>
    <p:sldId id="256" r:id="rId2"/>
    <p:sldId id="270" r:id="rId3"/>
    <p:sldId id="312" r:id="rId4"/>
    <p:sldId id="263" r:id="rId5"/>
    <p:sldId id="267" r:id="rId6"/>
    <p:sldId id="279" r:id="rId7"/>
    <p:sldId id="269" r:id="rId8"/>
    <p:sldId id="282" r:id="rId9"/>
    <p:sldId id="283" r:id="rId10"/>
    <p:sldId id="284" r:id="rId11"/>
    <p:sldId id="285" r:id="rId12"/>
    <p:sldId id="286" r:id="rId13"/>
    <p:sldId id="271" r:id="rId14"/>
    <p:sldId id="287" r:id="rId15"/>
    <p:sldId id="288" r:id="rId16"/>
    <p:sldId id="289" r:id="rId17"/>
    <p:sldId id="290" r:id="rId18"/>
    <p:sldId id="291" r:id="rId19"/>
    <p:sldId id="311" r:id="rId20"/>
    <p:sldId id="278" r:id="rId2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3A0"/>
    <a:srgbClr val="B23445"/>
    <a:srgbClr val="138098"/>
    <a:srgbClr val="58C9E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563"/>
    <p:restoredTop sz="92173"/>
  </p:normalViewPr>
  <p:slideViewPr>
    <p:cSldViewPr snapToGrid="0" snapToObjects="1">
      <p:cViewPr varScale="1">
        <p:scale>
          <a:sx n="59" d="100"/>
          <a:sy n="59" d="100"/>
        </p:scale>
        <p:origin x="216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notesMaster" Target="notesMasters/notesMaster1.xml"/></Relationships>
</file>

<file path=ppt/diagrams/_rels/data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svg"/><Relationship Id="rId1" Type="http://schemas.openxmlformats.org/officeDocument/2006/relationships/image" Target="../media/image5.png"/><Relationship Id="rId6" Type="http://schemas.openxmlformats.org/officeDocument/2006/relationships/image" Target="../media/image10.svg"/><Relationship Id="rId5" Type="http://schemas.openxmlformats.org/officeDocument/2006/relationships/image" Target="../media/image9.png"/><Relationship Id="rId4" Type="http://schemas.openxmlformats.org/officeDocument/2006/relationships/image" Target="../media/image8.svg"/></Relationships>
</file>

<file path=ppt/diagrams/_rels/data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svg"/><Relationship Id="rId1" Type="http://schemas.openxmlformats.org/officeDocument/2006/relationships/image" Target="../media/image12.png"/><Relationship Id="rId6" Type="http://schemas.openxmlformats.org/officeDocument/2006/relationships/image" Target="../media/image17.svg"/><Relationship Id="rId5" Type="http://schemas.openxmlformats.org/officeDocument/2006/relationships/image" Target="../media/image16.png"/><Relationship Id="rId4" Type="http://schemas.openxmlformats.org/officeDocument/2006/relationships/image" Target="../media/image15.svg"/></Relationships>
</file>

<file path=ppt/diagrams/_rels/drawing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svg"/><Relationship Id="rId1" Type="http://schemas.openxmlformats.org/officeDocument/2006/relationships/image" Target="../media/image5.png"/><Relationship Id="rId6" Type="http://schemas.openxmlformats.org/officeDocument/2006/relationships/image" Target="../media/image10.svg"/><Relationship Id="rId5" Type="http://schemas.openxmlformats.org/officeDocument/2006/relationships/image" Target="../media/image9.png"/><Relationship Id="rId4" Type="http://schemas.openxmlformats.org/officeDocument/2006/relationships/image" Target="../media/image8.svg"/></Relationships>
</file>

<file path=ppt/diagrams/_rels/drawing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svg"/><Relationship Id="rId1" Type="http://schemas.openxmlformats.org/officeDocument/2006/relationships/image" Target="../media/image12.png"/><Relationship Id="rId6" Type="http://schemas.openxmlformats.org/officeDocument/2006/relationships/image" Target="../media/image17.svg"/><Relationship Id="rId5" Type="http://schemas.openxmlformats.org/officeDocument/2006/relationships/image" Target="../media/image16.png"/><Relationship Id="rId4" Type="http://schemas.openxmlformats.org/officeDocument/2006/relationships/image" Target="../media/image15.svg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5">
  <dgm:title val=""/>
  <dgm:desc val=""/>
  <dgm:catLst>
    <dgm:cat type="colorful" pri="10500"/>
  </dgm:catLst>
  <dgm:styleLbl name="node0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5"/>
      <a:schemeClr val="accent6"/>
    </dgm:fillClrLst>
    <dgm:linClrLst>
      <a:schemeClr val="accent5"/>
      <a:schemeClr val="accent6"/>
    </dgm:linClrLst>
    <dgm:effectClrLst/>
    <dgm:txLinClrLst/>
    <dgm:txFillClrLst/>
    <dgm:txEffectClrLst/>
  </dgm:styleLbl>
  <dgm:styleLbl name="ln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5"/>
    </dgm:fillClrLst>
    <dgm:linClrLst meth="repeat">
      <a:schemeClr val="accent5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6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1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5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5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5">
        <a:tint val="50000"/>
        <a:alpha val="4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5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18/5/colors/Iconchunking_neutralbg_colorful1">
  <dgm:title val=""/>
  <dgm:desc val=""/>
  <dgm:catLst>
    <dgm:cat type="colorful" pri="101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lt1">
        <a:alpha val="0"/>
      </a:schemeClr>
    </dgm:linClrLst>
    <dgm:effectClrLst/>
    <dgm:txLinClrLst/>
    <dgm:txFillClrLst/>
    <dgm:txEffectClrLst/>
  </dgm:styleLbl>
  <dgm:styleLbl name="align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/>
    <dgm:txEffectClrLst/>
  </dgm:styleLbl>
  <dgm:styleLbl name="ln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2">
        <a:alpha val="50000"/>
      </a:schemeClr>
      <a:schemeClr val="accent3">
        <a:alpha val="50000"/>
      </a:schemeClr>
      <a:schemeClr val="accent4">
        <a:alpha val="50000"/>
      </a:schemeClr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2">
        <a:tint val="50000"/>
      </a:schemeClr>
      <a:schemeClr val="accent3">
        <a:tint val="50000"/>
      </a:schemeClr>
      <a:schemeClr val="accent4">
        <a:tint val="50000"/>
      </a:schemeClr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1">
        <a:tint val="50000"/>
      </a:schemeClr>
      <a:schemeClr val="accent2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1">
        <a:tint val="50000"/>
      </a:schemeClr>
      <a:schemeClr val="accent2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/>
    <dgm:txEffectClrLst/>
  </dgm:styleLbl>
  <dgm:styleLbl name="fg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2"/>
    </dgm:fillClrLst>
    <dgm:linClrLst meth="repeat">
      <a:schemeClr val="accent2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2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3">
        <a:tint val="9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4">
        <a:tint val="70000"/>
      </a:schemeClr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5">
        <a:tint val="5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bg1">
        <a:lumMod val="95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2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2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3.xml><?xml version="1.0" encoding="utf-8"?>
<dgm:colorsDef xmlns:dgm="http://schemas.openxmlformats.org/drawingml/2006/diagram" xmlns:a="http://schemas.openxmlformats.org/drawingml/2006/main" uniqueId="urn:microsoft.com/office/officeart/2005/8/colors/colorful5">
  <dgm:title val=""/>
  <dgm:desc val=""/>
  <dgm:catLst>
    <dgm:cat type="colorful" pri="10500"/>
  </dgm:catLst>
  <dgm:styleLbl name="node0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5"/>
      <a:schemeClr val="accent6"/>
    </dgm:fillClrLst>
    <dgm:linClrLst>
      <a:schemeClr val="accent5"/>
      <a:schemeClr val="accent6"/>
    </dgm:linClrLst>
    <dgm:effectClrLst/>
    <dgm:txLinClrLst/>
    <dgm:txFillClrLst/>
    <dgm:txEffectClrLst/>
  </dgm:styleLbl>
  <dgm:styleLbl name="ln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5"/>
    </dgm:fillClrLst>
    <dgm:linClrLst meth="repeat">
      <a:schemeClr val="accent5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6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1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5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5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5">
        <a:tint val="50000"/>
        <a:alpha val="4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5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4.xml><?xml version="1.0" encoding="utf-8"?>
<dgm:colorsDef xmlns:dgm="http://schemas.openxmlformats.org/drawingml/2006/diagram" xmlns:a="http://schemas.openxmlformats.org/drawingml/2006/main" uniqueId="urn:microsoft.com/office/officeart/2018/5/colors/Iconchunking_neutralbg_colorful1">
  <dgm:title val=""/>
  <dgm:desc val=""/>
  <dgm:catLst>
    <dgm:cat type="colorful" pri="101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lt1">
        <a:alpha val="0"/>
      </a:schemeClr>
    </dgm:linClrLst>
    <dgm:effectClrLst/>
    <dgm:txLinClrLst/>
    <dgm:txFillClrLst/>
    <dgm:txEffectClrLst/>
  </dgm:styleLbl>
  <dgm:styleLbl name="align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/>
    <dgm:txEffectClrLst/>
  </dgm:styleLbl>
  <dgm:styleLbl name="ln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2">
        <a:alpha val="50000"/>
      </a:schemeClr>
      <a:schemeClr val="accent3">
        <a:alpha val="50000"/>
      </a:schemeClr>
      <a:schemeClr val="accent4">
        <a:alpha val="50000"/>
      </a:schemeClr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2">
        <a:tint val="50000"/>
      </a:schemeClr>
      <a:schemeClr val="accent3">
        <a:tint val="50000"/>
      </a:schemeClr>
      <a:schemeClr val="accent4">
        <a:tint val="50000"/>
      </a:schemeClr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1">
        <a:tint val="50000"/>
      </a:schemeClr>
      <a:schemeClr val="accent2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1">
        <a:tint val="50000"/>
      </a:schemeClr>
      <a:schemeClr val="accent2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/>
    <dgm:txEffectClrLst/>
  </dgm:styleLbl>
  <dgm:styleLbl name="fg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2"/>
    </dgm:fillClrLst>
    <dgm:linClrLst meth="repeat">
      <a:schemeClr val="accent2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2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3">
        <a:tint val="9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4">
        <a:tint val="70000"/>
      </a:schemeClr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5">
        <a:tint val="5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bg1">
        <a:lumMod val="95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2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2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5.xml><?xml version="1.0" encoding="utf-8"?>
<dgm:colorsDef xmlns:dgm="http://schemas.openxmlformats.org/drawingml/2006/diagram" xmlns:a="http://schemas.openxmlformats.org/drawingml/2006/main" uniqueId="urn:microsoft.com/office/officeart/2005/8/colors/colorful2">
  <dgm:title val=""/>
  <dgm:desc val=""/>
  <dgm:catLst>
    <dgm:cat type="colorful" pri="10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2"/>
      <a:schemeClr val="accent3"/>
    </dgm:fillClrLst>
    <dgm:linClrLst>
      <a:schemeClr val="accent2"/>
      <a:schemeClr val="accent3"/>
    </dgm:linClrLst>
    <dgm:effectClrLst/>
    <dgm:txLinClrLst/>
    <dgm:txFillClrLst/>
    <dgm:txEffectClrLst/>
  </dgm:styleLbl>
  <dgm:styleLbl name="lnNode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2">
        <a:alpha val="50000"/>
      </a:schemeClr>
      <a:schemeClr val="accent3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2">
        <a:tint val="50000"/>
      </a:schemeClr>
      <a:schemeClr val="accent3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2">
        <a:tint val="50000"/>
      </a:schemeClr>
      <a:schemeClr val="accent3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2">
        <a:tint val="50000"/>
      </a:schemeClr>
      <a:schemeClr val="accent3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2"/>
      <a:schemeClr val="accent3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2"/>
    </dgm:fillClrLst>
    <dgm:linClrLst meth="repeat">
      <a:schemeClr val="accent2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2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3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2"/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2">
        <a:tint val="90000"/>
      </a:schemeClr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2">
        <a:tint val="7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2">
        <a:tint val="50000"/>
      </a:schemeClr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5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2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2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2">
        <a:tint val="50000"/>
        <a:alpha val="4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2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6.xml><?xml version="1.0" encoding="utf-8"?>
<dgm:colorsDef xmlns:dgm="http://schemas.openxmlformats.org/drawingml/2006/diagram" xmlns:a="http://schemas.openxmlformats.org/drawingml/2006/main" uniqueId="urn:microsoft.com/office/officeart/2005/8/colors/accent3_2">
  <dgm:title val=""/>
  <dgm:desc val=""/>
  <dgm:catLst>
    <dgm:cat type="accent3" pri="11200"/>
  </dgm:catLst>
  <dgm:styleLbl name="node0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1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3"/>
    </dgm:fillClrLst>
    <dgm:linClrLst meth="repeat">
      <a:schemeClr val="accent3"/>
    </dgm:linClrLst>
    <dgm:effectClrLst/>
    <dgm:txLinClrLst/>
    <dgm:txFillClrLst/>
    <dgm:txEffectClrLst/>
  </dgm:styleLbl>
  <dgm:styleLbl name="lnNode1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3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3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3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3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3">
        <a:tint val="60000"/>
      </a:schemeClr>
    </dgm:fillClrLst>
    <dgm:linClrLst meth="repeat">
      <a:schemeClr val="accent3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3">
        <a:tint val="60000"/>
      </a:schemeClr>
    </dgm:fillClrLst>
    <dgm:linClrLst meth="repeat">
      <a:schemeClr val="accent3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3">
        <a:tint val="60000"/>
      </a:schemeClr>
    </dgm:fillClrLst>
    <dgm:linClrLst meth="repeat">
      <a:schemeClr val="accent3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3"/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3"/>
    </dgm:fillClrLst>
    <dgm:linClrLst meth="repeat">
      <a:schemeClr val="accent3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3">
        <a:tint val="60000"/>
      </a:schemeClr>
    </dgm:fillClrLst>
    <dgm:linClrLst meth="repeat">
      <a:schemeClr val="accent3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accent3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3"/>
    </dgm:fillClrLst>
    <dgm:linClrLst meth="repeat">
      <a:schemeClr val="accent3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3"/>
    </dgm:fillClrLst>
    <dgm:linClrLst meth="repeat">
      <a:schemeClr val="accent3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3"/>
    </dgm:fillClrLst>
    <dgm:linClrLst meth="repeat">
      <a:schemeClr val="accent3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3"/>
    </dgm:fillClrLst>
    <dgm:linClrLst meth="repeat">
      <a:schemeClr val="accent3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3"/>
    </dgm:fillClrLst>
    <dgm:linClrLst meth="repeat">
      <a:schemeClr val="accent3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3"/>
    </dgm:fillClrLst>
    <dgm:linClrLst meth="repeat">
      <a:schemeClr val="accent3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3">
        <a:alpha val="90000"/>
        <a:tint val="40000"/>
      </a:schemeClr>
    </dgm:fillClrLst>
    <dgm:linClrLst meth="repeat">
      <a:schemeClr val="accent3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3">
        <a:alpha val="90000"/>
        <a:tint val="40000"/>
      </a:schemeClr>
    </dgm:fillClrLst>
    <dgm:linClrLst meth="repeat">
      <a:schemeClr val="accent3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3">
        <a:alpha val="90000"/>
        <a:tint val="40000"/>
      </a:schemeClr>
    </dgm:fillClrLst>
    <dgm:linClrLst meth="repeat">
      <a:schemeClr val="accent3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3">
        <a:tint val="40000"/>
      </a:schemeClr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3">
        <a:shade val="80000"/>
      </a:schemeClr>
    </dgm:fillClrLst>
    <dgm:linClrLst meth="repeat">
      <a:schemeClr val="accent3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3">
        <a:tint val="50000"/>
        <a:alpha val="40000"/>
      </a:schemeClr>
    </dgm:fillClrLst>
    <dgm:linClrLst meth="repeat">
      <a:schemeClr val="accent3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3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7.xml><?xml version="1.0" encoding="utf-8"?>
<dgm:colorsDef xmlns:dgm="http://schemas.openxmlformats.org/drawingml/2006/diagram" xmlns:a="http://schemas.openxmlformats.org/drawingml/2006/main" uniqueId="urn:microsoft.com/office/officeart/2005/8/colors/colorful5">
  <dgm:title val=""/>
  <dgm:desc val=""/>
  <dgm:catLst>
    <dgm:cat type="colorful" pri="10500"/>
  </dgm:catLst>
  <dgm:styleLbl name="node0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5"/>
      <a:schemeClr val="accent6"/>
    </dgm:fillClrLst>
    <dgm:linClrLst>
      <a:schemeClr val="accent5"/>
      <a:schemeClr val="accent6"/>
    </dgm:linClrLst>
    <dgm:effectClrLst/>
    <dgm:txLinClrLst/>
    <dgm:txFillClrLst/>
    <dgm:txEffectClrLst/>
  </dgm:styleLbl>
  <dgm:styleLbl name="ln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5"/>
    </dgm:fillClrLst>
    <dgm:linClrLst meth="repeat">
      <a:schemeClr val="accent5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6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1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5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5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5">
        <a:tint val="50000"/>
        <a:alpha val="4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5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8.xml><?xml version="1.0" encoding="utf-8"?>
<dgm:colorsDef xmlns:dgm="http://schemas.openxmlformats.org/drawingml/2006/diagram" xmlns:a="http://schemas.openxmlformats.org/drawingml/2006/main" uniqueId="urn:microsoft.com/office/officeart/2005/8/colors/colorful5">
  <dgm:title val=""/>
  <dgm:desc val=""/>
  <dgm:catLst>
    <dgm:cat type="colorful" pri="10500"/>
  </dgm:catLst>
  <dgm:styleLbl name="node0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5"/>
      <a:schemeClr val="accent6"/>
    </dgm:fillClrLst>
    <dgm:linClrLst>
      <a:schemeClr val="accent5"/>
      <a:schemeClr val="accent6"/>
    </dgm:linClrLst>
    <dgm:effectClrLst/>
    <dgm:txLinClrLst/>
    <dgm:txFillClrLst/>
    <dgm:txEffectClrLst/>
  </dgm:styleLbl>
  <dgm:styleLbl name="ln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5"/>
    </dgm:fillClrLst>
    <dgm:linClrLst meth="repeat">
      <a:schemeClr val="accent5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6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1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5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5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5">
        <a:tint val="50000"/>
        <a:alpha val="4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5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ADDBF75A-AA21-4E30-99FA-BAAFEC19F654}" type="doc">
      <dgm:prSet loTypeId="urn:microsoft.com/office/officeart/2005/8/layout/list1" loCatId="list" qsTypeId="urn:microsoft.com/office/officeart/2005/8/quickstyle/simple1" qsCatId="simple" csTypeId="urn:microsoft.com/office/officeart/2005/8/colors/colorful5" csCatId="colorful" phldr="1"/>
      <dgm:spPr/>
      <dgm:t>
        <a:bodyPr/>
        <a:lstStyle/>
        <a:p>
          <a:endParaRPr lang="en-US"/>
        </a:p>
      </dgm:t>
    </dgm:pt>
    <dgm:pt modelId="{B297B14B-9B42-4724-86CE-60C2DFE3507B}">
      <dgm:prSet/>
      <dgm:spPr>
        <a:solidFill>
          <a:schemeClr val="accent5"/>
        </a:solidFill>
      </dgm:spPr>
      <dgm:t>
        <a:bodyPr/>
        <a:lstStyle/>
        <a:p>
          <a:r>
            <a:rPr lang="en-US" dirty="0">
              <a:latin typeface="Arial" panose="020B0604020202020204" pitchFamily="34" charset="0"/>
              <a:cs typeface="Arial" panose="020B0604020202020204" pitchFamily="34" charset="0"/>
            </a:rPr>
            <a:t>Immunotherapy</a:t>
          </a:r>
        </a:p>
      </dgm:t>
    </dgm:pt>
    <dgm:pt modelId="{9AF1E657-C2D8-45BB-B481-4051A2CCC376}" type="parTrans" cxnId="{202B7A25-AC59-4F9E-8303-B0151D248EC7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8B7BF50-688B-4B97-A425-04F33E939FDE}" type="sibTrans" cxnId="{202B7A25-AC59-4F9E-8303-B0151D248EC7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CEB1CC19-20CD-4EE9-8AB4-CBE4754702DD}">
      <dgm:prSet/>
      <dgm:spPr>
        <a:solidFill>
          <a:schemeClr val="accent1"/>
        </a:solidFill>
      </dgm:spPr>
      <dgm:t>
        <a:bodyPr/>
        <a:lstStyle/>
        <a:p>
          <a:r>
            <a:rPr lang="en-US" dirty="0">
              <a:latin typeface="Arial" panose="020B0604020202020204" pitchFamily="34" charset="0"/>
              <a:cs typeface="Arial" panose="020B0604020202020204" pitchFamily="34" charset="0"/>
            </a:rPr>
            <a:t>Targeted Therapy</a:t>
          </a:r>
        </a:p>
      </dgm:t>
    </dgm:pt>
    <dgm:pt modelId="{F71AC9FB-BF59-478D-9B5D-2584E7A7864E}" type="parTrans" cxnId="{D6C2F454-798B-47EF-AD9A-B7CBDB24A18F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06F4C60-7903-4468-B5BC-CA1E3AB1205F}" type="sibTrans" cxnId="{D6C2F454-798B-47EF-AD9A-B7CBDB24A18F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5B3B416-71B6-44B2-8DEE-97B9BF57F1BF}">
      <dgm:prSet/>
      <dgm:spPr>
        <a:solidFill>
          <a:schemeClr val="accent6"/>
        </a:solidFill>
      </dgm:spPr>
      <dgm:t>
        <a:bodyPr/>
        <a:lstStyle/>
        <a:p>
          <a:r>
            <a:rPr lang="en-US" dirty="0">
              <a:latin typeface="Arial" panose="020B0604020202020204" pitchFamily="34" charset="0"/>
              <a:cs typeface="Arial" panose="020B0604020202020204" pitchFamily="34" charset="0"/>
            </a:rPr>
            <a:t>Precision Medicine</a:t>
          </a:r>
        </a:p>
      </dgm:t>
    </dgm:pt>
    <dgm:pt modelId="{19138FDE-B759-4082-8F61-5F7EBAC9E8BE}" type="parTrans" cxnId="{C932D0AA-1FAA-46D5-B131-8CDE6C318667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2A48D26-47D9-4A2D-A059-BBE70A6D0686}" type="sibTrans" cxnId="{C932D0AA-1FAA-46D5-B131-8CDE6C318667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290C0AD-CE4F-EF44-85D2-3546F198CB51}">
      <dgm:prSet/>
      <dgm:spPr>
        <a:solidFill>
          <a:schemeClr val="accent2"/>
        </a:solidFill>
      </dgm:spPr>
      <dgm:t>
        <a:bodyPr/>
        <a:lstStyle/>
        <a:p>
          <a:r>
            <a:rPr lang="en-US" dirty="0">
              <a:latin typeface="Arial" panose="020B0604020202020204" pitchFamily="34" charset="0"/>
              <a:cs typeface="Arial" panose="020B0604020202020204" pitchFamily="34" charset="0"/>
            </a:rPr>
            <a:t>Hormone Therapy</a:t>
          </a:r>
        </a:p>
      </dgm:t>
    </dgm:pt>
    <dgm:pt modelId="{79C64CCB-67D0-BC42-BBF9-F13F7F31113D}" type="parTrans" cxnId="{6ACE05B2-ECFE-BE4F-9CA6-42B68ECBF9F6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E3430AC8-8280-A640-BB0E-5D5DA184E036}" type="sibTrans" cxnId="{6ACE05B2-ECFE-BE4F-9CA6-42B68ECBF9F6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9FE3653-6D5A-1A48-89B8-612C46762120}" type="pres">
      <dgm:prSet presAssocID="{ADDBF75A-AA21-4E30-99FA-BAAFEC19F654}" presName="linear" presStyleCnt="0">
        <dgm:presLayoutVars>
          <dgm:dir/>
          <dgm:animLvl val="lvl"/>
          <dgm:resizeHandles val="exact"/>
        </dgm:presLayoutVars>
      </dgm:prSet>
      <dgm:spPr/>
    </dgm:pt>
    <dgm:pt modelId="{1DA518C8-B56D-714C-8D26-66CFF3E286CA}" type="pres">
      <dgm:prSet presAssocID="{B297B14B-9B42-4724-86CE-60C2DFE3507B}" presName="parentLin" presStyleCnt="0"/>
      <dgm:spPr/>
    </dgm:pt>
    <dgm:pt modelId="{89244905-EAC5-6B43-8AE1-662581B47D6F}" type="pres">
      <dgm:prSet presAssocID="{B297B14B-9B42-4724-86CE-60C2DFE3507B}" presName="parentLeftMargin" presStyleLbl="node1" presStyleIdx="0" presStyleCnt="4"/>
      <dgm:spPr/>
    </dgm:pt>
    <dgm:pt modelId="{348957E5-B8E2-7544-9449-22DF6E42295F}" type="pres">
      <dgm:prSet presAssocID="{B297B14B-9B42-4724-86CE-60C2DFE3507B}" presName="parentText" presStyleLbl="node1" presStyleIdx="0" presStyleCnt="4">
        <dgm:presLayoutVars>
          <dgm:chMax val="0"/>
          <dgm:bulletEnabled val="1"/>
        </dgm:presLayoutVars>
      </dgm:prSet>
      <dgm:spPr/>
    </dgm:pt>
    <dgm:pt modelId="{0048EEC6-F160-174F-B9D9-D967675B09A0}" type="pres">
      <dgm:prSet presAssocID="{B297B14B-9B42-4724-86CE-60C2DFE3507B}" presName="negativeSpace" presStyleCnt="0"/>
      <dgm:spPr/>
    </dgm:pt>
    <dgm:pt modelId="{49ED9A47-8FDF-6640-8D15-21C17522ED0A}" type="pres">
      <dgm:prSet presAssocID="{B297B14B-9B42-4724-86CE-60C2DFE3507B}" presName="childText" presStyleLbl="conFgAcc1" presStyleIdx="0" presStyleCnt="4">
        <dgm:presLayoutVars>
          <dgm:bulletEnabled val="1"/>
        </dgm:presLayoutVars>
      </dgm:prSet>
      <dgm:spPr>
        <a:ln>
          <a:solidFill>
            <a:schemeClr val="accent5"/>
          </a:solidFill>
        </a:ln>
      </dgm:spPr>
    </dgm:pt>
    <dgm:pt modelId="{DDB86499-B596-694C-9E18-08D2CAE65880}" type="pres">
      <dgm:prSet presAssocID="{68B7BF50-688B-4B97-A425-04F33E939FDE}" presName="spaceBetweenRectangles" presStyleCnt="0"/>
      <dgm:spPr/>
    </dgm:pt>
    <dgm:pt modelId="{0AD61744-3799-DB4D-8A29-47E3F710A778}" type="pres">
      <dgm:prSet presAssocID="{CEB1CC19-20CD-4EE9-8AB4-CBE4754702DD}" presName="parentLin" presStyleCnt="0"/>
      <dgm:spPr/>
    </dgm:pt>
    <dgm:pt modelId="{32889A88-0CF8-A04D-A3F0-4C6A4FC8CFED}" type="pres">
      <dgm:prSet presAssocID="{CEB1CC19-20CD-4EE9-8AB4-CBE4754702DD}" presName="parentLeftMargin" presStyleLbl="node1" presStyleIdx="0" presStyleCnt="4"/>
      <dgm:spPr/>
    </dgm:pt>
    <dgm:pt modelId="{0DE1B89D-FC04-BE43-9A3C-39A21BE932D5}" type="pres">
      <dgm:prSet presAssocID="{CEB1CC19-20CD-4EE9-8AB4-CBE4754702DD}" presName="parentText" presStyleLbl="node1" presStyleIdx="1" presStyleCnt="4">
        <dgm:presLayoutVars>
          <dgm:chMax val="0"/>
          <dgm:bulletEnabled val="1"/>
        </dgm:presLayoutVars>
      </dgm:prSet>
      <dgm:spPr/>
    </dgm:pt>
    <dgm:pt modelId="{8D2D289A-64D3-1D42-A9CA-A098442A9E49}" type="pres">
      <dgm:prSet presAssocID="{CEB1CC19-20CD-4EE9-8AB4-CBE4754702DD}" presName="negativeSpace" presStyleCnt="0"/>
      <dgm:spPr/>
    </dgm:pt>
    <dgm:pt modelId="{AE50FDCE-C9AB-C14E-8502-0AE08651A723}" type="pres">
      <dgm:prSet presAssocID="{CEB1CC19-20CD-4EE9-8AB4-CBE4754702DD}" presName="childText" presStyleLbl="conFgAcc1" presStyleIdx="1" presStyleCnt="4">
        <dgm:presLayoutVars>
          <dgm:bulletEnabled val="1"/>
        </dgm:presLayoutVars>
      </dgm:prSet>
      <dgm:spPr>
        <a:ln>
          <a:solidFill>
            <a:schemeClr val="accent1"/>
          </a:solidFill>
        </a:ln>
      </dgm:spPr>
    </dgm:pt>
    <dgm:pt modelId="{906D9EA5-6384-9341-A169-97E1433F5EA7}" type="pres">
      <dgm:prSet presAssocID="{306F4C60-7903-4468-B5BC-CA1E3AB1205F}" presName="spaceBetweenRectangles" presStyleCnt="0"/>
      <dgm:spPr/>
    </dgm:pt>
    <dgm:pt modelId="{EF01CF42-B55F-7443-9E65-E7DCB8209E82}" type="pres">
      <dgm:prSet presAssocID="{9290C0AD-CE4F-EF44-85D2-3546F198CB51}" presName="parentLin" presStyleCnt="0"/>
      <dgm:spPr/>
    </dgm:pt>
    <dgm:pt modelId="{B038EC7B-7BE3-F049-B8D5-1872CD1E3657}" type="pres">
      <dgm:prSet presAssocID="{9290C0AD-CE4F-EF44-85D2-3546F198CB51}" presName="parentLeftMargin" presStyleLbl="node1" presStyleIdx="1" presStyleCnt="4"/>
      <dgm:spPr/>
    </dgm:pt>
    <dgm:pt modelId="{BF5E5E7F-E0BD-F041-A2B3-0AA35A04D108}" type="pres">
      <dgm:prSet presAssocID="{9290C0AD-CE4F-EF44-85D2-3546F198CB51}" presName="parentText" presStyleLbl="node1" presStyleIdx="2" presStyleCnt="4">
        <dgm:presLayoutVars>
          <dgm:chMax val="0"/>
          <dgm:bulletEnabled val="1"/>
        </dgm:presLayoutVars>
      </dgm:prSet>
      <dgm:spPr/>
    </dgm:pt>
    <dgm:pt modelId="{ABEE7A40-9DAD-2144-A212-26126998EC0A}" type="pres">
      <dgm:prSet presAssocID="{9290C0AD-CE4F-EF44-85D2-3546F198CB51}" presName="negativeSpace" presStyleCnt="0"/>
      <dgm:spPr/>
    </dgm:pt>
    <dgm:pt modelId="{EF67C343-2EB3-C54A-90FD-566557A2F4EE}" type="pres">
      <dgm:prSet presAssocID="{9290C0AD-CE4F-EF44-85D2-3546F198CB51}" presName="childText" presStyleLbl="conFgAcc1" presStyleIdx="2" presStyleCnt="4">
        <dgm:presLayoutVars>
          <dgm:bulletEnabled val="1"/>
        </dgm:presLayoutVars>
      </dgm:prSet>
      <dgm:spPr>
        <a:ln>
          <a:solidFill>
            <a:schemeClr val="accent2"/>
          </a:solidFill>
        </a:ln>
      </dgm:spPr>
    </dgm:pt>
    <dgm:pt modelId="{812862C0-DE16-424D-86F4-219EC03A06AD}" type="pres">
      <dgm:prSet presAssocID="{E3430AC8-8280-A640-BB0E-5D5DA184E036}" presName="spaceBetweenRectangles" presStyleCnt="0"/>
      <dgm:spPr/>
    </dgm:pt>
    <dgm:pt modelId="{F1B97A69-16B6-1641-B8A6-F6D2ABBA67B5}" type="pres">
      <dgm:prSet presAssocID="{55B3B416-71B6-44B2-8DEE-97B9BF57F1BF}" presName="parentLin" presStyleCnt="0"/>
      <dgm:spPr/>
    </dgm:pt>
    <dgm:pt modelId="{791343FB-AB62-9841-9FAD-FDAD8F62F60C}" type="pres">
      <dgm:prSet presAssocID="{55B3B416-71B6-44B2-8DEE-97B9BF57F1BF}" presName="parentLeftMargin" presStyleLbl="node1" presStyleIdx="2" presStyleCnt="4"/>
      <dgm:spPr/>
    </dgm:pt>
    <dgm:pt modelId="{50960FB0-3C4F-D542-A215-8A63B047CE67}" type="pres">
      <dgm:prSet presAssocID="{55B3B416-71B6-44B2-8DEE-97B9BF57F1BF}" presName="parentText" presStyleLbl="node1" presStyleIdx="3" presStyleCnt="4">
        <dgm:presLayoutVars>
          <dgm:chMax val="0"/>
          <dgm:bulletEnabled val="1"/>
        </dgm:presLayoutVars>
      </dgm:prSet>
      <dgm:spPr/>
    </dgm:pt>
    <dgm:pt modelId="{69703D3C-67F5-1447-BA5E-D114447BEA8C}" type="pres">
      <dgm:prSet presAssocID="{55B3B416-71B6-44B2-8DEE-97B9BF57F1BF}" presName="negativeSpace" presStyleCnt="0"/>
      <dgm:spPr/>
    </dgm:pt>
    <dgm:pt modelId="{E5B26FBB-84BC-814B-8028-01F4E0E57F45}" type="pres">
      <dgm:prSet presAssocID="{55B3B416-71B6-44B2-8DEE-97B9BF57F1BF}" presName="childText" presStyleLbl="conFgAcc1" presStyleIdx="3" presStyleCnt="4">
        <dgm:presLayoutVars>
          <dgm:bulletEnabled val="1"/>
        </dgm:presLayoutVars>
      </dgm:prSet>
      <dgm:spPr/>
    </dgm:pt>
  </dgm:ptLst>
  <dgm:cxnLst>
    <dgm:cxn modelId="{D6A64B11-457E-1F40-960E-1DADD7F615C8}" type="presOf" srcId="{ADDBF75A-AA21-4E30-99FA-BAAFEC19F654}" destId="{69FE3653-6D5A-1A48-89B8-612C46762120}" srcOrd="0" destOrd="0" presId="urn:microsoft.com/office/officeart/2005/8/layout/list1"/>
    <dgm:cxn modelId="{202B7A25-AC59-4F9E-8303-B0151D248EC7}" srcId="{ADDBF75A-AA21-4E30-99FA-BAAFEC19F654}" destId="{B297B14B-9B42-4724-86CE-60C2DFE3507B}" srcOrd="0" destOrd="0" parTransId="{9AF1E657-C2D8-45BB-B481-4051A2CCC376}" sibTransId="{68B7BF50-688B-4B97-A425-04F33E939FDE}"/>
    <dgm:cxn modelId="{062D5947-659A-0A43-8F1A-644FBD20923D}" type="presOf" srcId="{CEB1CC19-20CD-4EE9-8AB4-CBE4754702DD}" destId="{32889A88-0CF8-A04D-A3F0-4C6A4FC8CFED}" srcOrd="0" destOrd="0" presId="urn:microsoft.com/office/officeart/2005/8/layout/list1"/>
    <dgm:cxn modelId="{947B4E69-3437-2A41-A38B-E77ABB2894B0}" type="presOf" srcId="{55B3B416-71B6-44B2-8DEE-97B9BF57F1BF}" destId="{50960FB0-3C4F-D542-A215-8A63B047CE67}" srcOrd="1" destOrd="0" presId="urn:microsoft.com/office/officeart/2005/8/layout/list1"/>
    <dgm:cxn modelId="{D6C2F454-798B-47EF-AD9A-B7CBDB24A18F}" srcId="{ADDBF75A-AA21-4E30-99FA-BAAFEC19F654}" destId="{CEB1CC19-20CD-4EE9-8AB4-CBE4754702DD}" srcOrd="1" destOrd="0" parTransId="{F71AC9FB-BF59-478D-9B5D-2584E7A7864E}" sibTransId="{306F4C60-7903-4468-B5BC-CA1E3AB1205F}"/>
    <dgm:cxn modelId="{F6988182-BE4F-8442-AA1C-EF25CFC1CBE4}" type="presOf" srcId="{B297B14B-9B42-4724-86CE-60C2DFE3507B}" destId="{348957E5-B8E2-7544-9449-22DF6E42295F}" srcOrd="1" destOrd="0" presId="urn:microsoft.com/office/officeart/2005/8/layout/list1"/>
    <dgm:cxn modelId="{C932D0AA-1FAA-46D5-B131-8CDE6C318667}" srcId="{ADDBF75A-AA21-4E30-99FA-BAAFEC19F654}" destId="{55B3B416-71B6-44B2-8DEE-97B9BF57F1BF}" srcOrd="3" destOrd="0" parTransId="{19138FDE-B759-4082-8F61-5F7EBAC9E8BE}" sibTransId="{72A48D26-47D9-4A2D-A059-BBE70A6D0686}"/>
    <dgm:cxn modelId="{6ACE05B2-ECFE-BE4F-9CA6-42B68ECBF9F6}" srcId="{ADDBF75A-AA21-4E30-99FA-BAAFEC19F654}" destId="{9290C0AD-CE4F-EF44-85D2-3546F198CB51}" srcOrd="2" destOrd="0" parTransId="{79C64CCB-67D0-BC42-BBF9-F13F7F31113D}" sibTransId="{E3430AC8-8280-A640-BB0E-5D5DA184E036}"/>
    <dgm:cxn modelId="{E184D2B4-0689-C145-BF4F-ADAAEE0B1341}" type="presOf" srcId="{B297B14B-9B42-4724-86CE-60C2DFE3507B}" destId="{89244905-EAC5-6B43-8AE1-662581B47D6F}" srcOrd="0" destOrd="0" presId="urn:microsoft.com/office/officeart/2005/8/layout/list1"/>
    <dgm:cxn modelId="{64F256BD-403A-1A45-8AA5-4D38ADDA2991}" type="presOf" srcId="{55B3B416-71B6-44B2-8DEE-97B9BF57F1BF}" destId="{791343FB-AB62-9841-9FAD-FDAD8F62F60C}" srcOrd="0" destOrd="0" presId="urn:microsoft.com/office/officeart/2005/8/layout/list1"/>
    <dgm:cxn modelId="{76C6B6BE-0CDD-8D47-BD31-015E11A6F92D}" type="presOf" srcId="{CEB1CC19-20CD-4EE9-8AB4-CBE4754702DD}" destId="{0DE1B89D-FC04-BE43-9A3C-39A21BE932D5}" srcOrd="1" destOrd="0" presId="urn:microsoft.com/office/officeart/2005/8/layout/list1"/>
    <dgm:cxn modelId="{92E42ECA-0B6F-9642-8340-6479D6ADB208}" type="presOf" srcId="{9290C0AD-CE4F-EF44-85D2-3546F198CB51}" destId="{BF5E5E7F-E0BD-F041-A2B3-0AA35A04D108}" srcOrd="1" destOrd="0" presId="urn:microsoft.com/office/officeart/2005/8/layout/list1"/>
    <dgm:cxn modelId="{73D500D8-59E7-6041-A953-4D7BBCC96426}" type="presOf" srcId="{9290C0AD-CE4F-EF44-85D2-3546F198CB51}" destId="{B038EC7B-7BE3-F049-B8D5-1872CD1E3657}" srcOrd="0" destOrd="0" presId="urn:microsoft.com/office/officeart/2005/8/layout/list1"/>
    <dgm:cxn modelId="{782A4731-532F-6A42-981B-9AC387196469}" type="presParOf" srcId="{69FE3653-6D5A-1A48-89B8-612C46762120}" destId="{1DA518C8-B56D-714C-8D26-66CFF3E286CA}" srcOrd="0" destOrd="0" presId="urn:microsoft.com/office/officeart/2005/8/layout/list1"/>
    <dgm:cxn modelId="{B666C59A-ADF5-4D44-9E69-246BAED7406D}" type="presParOf" srcId="{1DA518C8-B56D-714C-8D26-66CFF3E286CA}" destId="{89244905-EAC5-6B43-8AE1-662581B47D6F}" srcOrd="0" destOrd="0" presId="urn:microsoft.com/office/officeart/2005/8/layout/list1"/>
    <dgm:cxn modelId="{C22A1536-505A-644E-BE05-1CDCDCD23A0A}" type="presParOf" srcId="{1DA518C8-B56D-714C-8D26-66CFF3E286CA}" destId="{348957E5-B8E2-7544-9449-22DF6E42295F}" srcOrd="1" destOrd="0" presId="urn:microsoft.com/office/officeart/2005/8/layout/list1"/>
    <dgm:cxn modelId="{2495F711-BF3A-4F4A-B5B3-02AFACAEEEB7}" type="presParOf" srcId="{69FE3653-6D5A-1A48-89B8-612C46762120}" destId="{0048EEC6-F160-174F-B9D9-D967675B09A0}" srcOrd="1" destOrd="0" presId="urn:microsoft.com/office/officeart/2005/8/layout/list1"/>
    <dgm:cxn modelId="{B1A93A2C-7308-894F-85CE-66AB9BAEE427}" type="presParOf" srcId="{69FE3653-6D5A-1A48-89B8-612C46762120}" destId="{49ED9A47-8FDF-6640-8D15-21C17522ED0A}" srcOrd="2" destOrd="0" presId="urn:microsoft.com/office/officeart/2005/8/layout/list1"/>
    <dgm:cxn modelId="{89950BBE-BEB2-A048-B6B0-D09E5F597CD6}" type="presParOf" srcId="{69FE3653-6D5A-1A48-89B8-612C46762120}" destId="{DDB86499-B596-694C-9E18-08D2CAE65880}" srcOrd="3" destOrd="0" presId="urn:microsoft.com/office/officeart/2005/8/layout/list1"/>
    <dgm:cxn modelId="{36DC38D9-DF96-E84D-A2EB-C635CE2C00F1}" type="presParOf" srcId="{69FE3653-6D5A-1A48-89B8-612C46762120}" destId="{0AD61744-3799-DB4D-8A29-47E3F710A778}" srcOrd="4" destOrd="0" presId="urn:microsoft.com/office/officeart/2005/8/layout/list1"/>
    <dgm:cxn modelId="{8183FBBD-8628-0048-8D22-5D3CF14849AA}" type="presParOf" srcId="{0AD61744-3799-DB4D-8A29-47E3F710A778}" destId="{32889A88-0CF8-A04D-A3F0-4C6A4FC8CFED}" srcOrd="0" destOrd="0" presId="urn:microsoft.com/office/officeart/2005/8/layout/list1"/>
    <dgm:cxn modelId="{0205B68C-956F-6A45-94CE-E2C9165E1E8C}" type="presParOf" srcId="{0AD61744-3799-DB4D-8A29-47E3F710A778}" destId="{0DE1B89D-FC04-BE43-9A3C-39A21BE932D5}" srcOrd="1" destOrd="0" presId="urn:microsoft.com/office/officeart/2005/8/layout/list1"/>
    <dgm:cxn modelId="{6BC86BA2-D389-E642-9D70-F28A7008F688}" type="presParOf" srcId="{69FE3653-6D5A-1A48-89B8-612C46762120}" destId="{8D2D289A-64D3-1D42-A9CA-A098442A9E49}" srcOrd="5" destOrd="0" presId="urn:microsoft.com/office/officeart/2005/8/layout/list1"/>
    <dgm:cxn modelId="{59CB491D-2532-A74A-B57F-F0CA0425E25C}" type="presParOf" srcId="{69FE3653-6D5A-1A48-89B8-612C46762120}" destId="{AE50FDCE-C9AB-C14E-8502-0AE08651A723}" srcOrd="6" destOrd="0" presId="urn:microsoft.com/office/officeart/2005/8/layout/list1"/>
    <dgm:cxn modelId="{F9652970-8C5E-7048-9938-2E709AE10671}" type="presParOf" srcId="{69FE3653-6D5A-1A48-89B8-612C46762120}" destId="{906D9EA5-6384-9341-A169-97E1433F5EA7}" srcOrd="7" destOrd="0" presId="urn:microsoft.com/office/officeart/2005/8/layout/list1"/>
    <dgm:cxn modelId="{D2851181-6F3B-BF40-83ED-F611CD9DCD96}" type="presParOf" srcId="{69FE3653-6D5A-1A48-89B8-612C46762120}" destId="{EF01CF42-B55F-7443-9E65-E7DCB8209E82}" srcOrd="8" destOrd="0" presId="urn:microsoft.com/office/officeart/2005/8/layout/list1"/>
    <dgm:cxn modelId="{56DB7263-69D3-934C-A0DA-3652C28B93B7}" type="presParOf" srcId="{EF01CF42-B55F-7443-9E65-E7DCB8209E82}" destId="{B038EC7B-7BE3-F049-B8D5-1872CD1E3657}" srcOrd="0" destOrd="0" presId="urn:microsoft.com/office/officeart/2005/8/layout/list1"/>
    <dgm:cxn modelId="{668932A7-5B5B-CF44-A878-2DE5FD1344F7}" type="presParOf" srcId="{EF01CF42-B55F-7443-9E65-E7DCB8209E82}" destId="{BF5E5E7F-E0BD-F041-A2B3-0AA35A04D108}" srcOrd="1" destOrd="0" presId="urn:microsoft.com/office/officeart/2005/8/layout/list1"/>
    <dgm:cxn modelId="{56B6FC2E-BD3A-594D-844D-322512337A6C}" type="presParOf" srcId="{69FE3653-6D5A-1A48-89B8-612C46762120}" destId="{ABEE7A40-9DAD-2144-A212-26126998EC0A}" srcOrd="9" destOrd="0" presId="urn:microsoft.com/office/officeart/2005/8/layout/list1"/>
    <dgm:cxn modelId="{B4224AF7-F091-9043-9165-0B67C66F178C}" type="presParOf" srcId="{69FE3653-6D5A-1A48-89B8-612C46762120}" destId="{EF67C343-2EB3-C54A-90FD-566557A2F4EE}" srcOrd="10" destOrd="0" presId="urn:microsoft.com/office/officeart/2005/8/layout/list1"/>
    <dgm:cxn modelId="{A321C008-32A7-B74F-931D-374F25B53F49}" type="presParOf" srcId="{69FE3653-6D5A-1A48-89B8-612C46762120}" destId="{812862C0-DE16-424D-86F4-219EC03A06AD}" srcOrd="11" destOrd="0" presId="urn:microsoft.com/office/officeart/2005/8/layout/list1"/>
    <dgm:cxn modelId="{AA36B97C-97FC-F14B-BB48-B27D9DC1E540}" type="presParOf" srcId="{69FE3653-6D5A-1A48-89B8-612C46762120}" destId="{F1B97A69-16B6-1641-B8A6-F6D2ABBA67B5}" srcOrd="12" destOrd="0" presId="urn:microsoft.com/office/officeart/2005/8/layout/list1"/>
    <dgm:cxn modelId="{BB53436F-4652-D94D-8BFE-E16FD94AB129}" type="presParOf" srcId="{F1B97A69-16B6-1641-B8A6-F6D2ABBA67B5}" destId="{791343FB-AB62-9841-9FAD-FDAD8F62F60C}" srcOrd="0" destOrd="0" presId="urn:microsoft.com/office/officeart/2005/8/layout/list1"/>
    <dgm:cxn modelId="{CD8A98B2-D874-9B4B-96BB-027D03BC8E69}" type="presParOf" srcId="{F1B97A69-16B6-1641-B8A6-F6D2ABBA67B5}" destId="{50960FB0-3C4F-D542-A215-8A63B047CE67}" srcOrd="1" destOrd="0" presId="urn:microsoft.com/office/officeart/2005/8/layout/list1"/>
    <dgm:cxn modelId="{3BBF9D42-D8D7-674F-AF28-2330C417DB79}" type="presParOf" srcId="{69FE3653-6D5A-1A48-89B8-612C46762120}" destId="{69703D3C-67F5-1447-BA5E-D114447BEA8C}" srcOrd="13" destOrd="0" presId="urn:microsoft.com/office/officeart/2005/8/layout/list1"/>
    <dgm:cxn modelId="{CA207CCA-4AFB-274D-9FD0-41DC1640622C}" type="presParOf" srcId="{69FE3653-6D5A-1A48-89B8-612C46762120}" destId="{E5B26FBB-84BC-814B-8028-01F4E0E57F45}" srcOrd="14" destOrd="0" presId="urn:microsoft.com/office/officeart/2005/8/layout/list1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30051227-E351-43EC-BB73-491820DEE313}" type="doc">
      <dgm:prSet loTypeId="urn:microsoft.com/office/officeart/2018/2/layout/IconVerticalSolidList" loCatId="icon" qsTypeId="urn:microsoft.com/office/officeart/2005/8/quickstyle/simple1" qsCatId="simple" csTypeId="urn:microsoft.com/office/officeart/2018/5/colors/Iconchunking_neutralbg_colorful1" csCatId="colorful" phldr="1"/>
      <dgm:spPr/>
      <dgm:t>
        <a:bodyPr/>
        <a:lstStyle/>
        <a:p>
          <a:endParaRPr lang="en-US"/>
        </a:p>
      </dgm:t>
    </dgm:pt>
    <dgm:pt modelId="{40487685-AFF1-4EDC-A958-A6656FC6E907}">
      <dgm:prSet/>
      <dgm:spPr/>
      <dgm:t>
        <a:bodyPr/>
        <a:lstStyle/>
        <a:p>
          <a:r>
            <a:rPr lang="en-US">
              <a:latin typeface="Arial" panose="020B0604020202020204" pitchFamily="34" charset="0"/>
              <a:cs typeface="Arial" panose="020B0604020202020204" pitchFamily="34" charset="0"/>
            </a:rPr>
            <a:t>Skin reactions at the needle site</a:t>
          </a:r>
        </a:p>
      </dgm:t>
    </dgm:pt>
    <dgm:pt modelId="{DBB9CD2F-F378-4189-AA5C-0A0B5E382292}" type="parTrans" cxnId="{A7714590-FAC6-4763-A99D-D2138062DE93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CC2C7733-186C-4389-9D31-E74C2B7D1CAC}" type="sibTrans" cxnId="{A7714590-FAC6-4763-A99D-D2138062DE93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ED89FB2-BE37-4996-BFC8-AEDAFE4828D4}">
      <dgm:prSet/>
      <dgm:spPr/>
      <dgm:t>
        <a:bodyPr/>
        <a:lstStyle/>
        <a:p>
          <a:r>
            <a:rPr lang="en-US">
              <a:latin typeface="Arial" panose="020B0604020202020204" pitchFamily="34" charset="0"/>
              <a:cs typeface="Arial" panose="020B0604020202020204" pitchFamily="34" charset="0"/>
            </a:rPr>
            <a:t>Pain, swelling, soreness, rash</a:t>
          </a:r>
        </a:p>
      </dgm:t>
    </dgm:pt>
    <dgm:pt modelId="{74CB082B-5C1F-4995-AC41-5E797C21B2F5}" type="parTrans" cxnId="{BEEFA199-9313-4ECC-8A83-6120AA72D7BD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33687DC-FA64-462C-B17A-72E944FBA8C8}" type="sibTrans" cxnId="{BEEFA199-9313-4ECC-8A83-6120AA72D7BD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BBAE759-98B6-457B-B16F-4E532954A645}">
      <dgm:prSet/>
      <dgm:spPr/>
      <dgm:t>
        <a:bodyPr/>
        <a:lstStyle/>
        <a:p>
          <a:r>
            <a:rPr lang="en-US">
              <a:latin typeface="Arial" panose="020B0604020202020204" pitchFamily="34" charset="0"/>
              <a:cs typeface="Arial" panose="020B0604020202020204" pitchFamily="34" charset="0"/>
            </a:rPr>
            <a:t>Flu-like symptoms</a:t>
          </a:r>
        </a:p>
      </dgm:t>
    </dgm:pt>
    <dgm:pt modelId="{CDE9C4D1-6A83-48B8-B28D-82B07F4FD9E7}" type="parTrans" cxnId="{40470DB1-519C-4C61-A5F5-1F695DE1BF28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E52E6D2E-5527-4974-ACC5-968B1FD471D9}" type="sibTrans" cxnId="{40470DB1-519C-4C61-A5F5-1F695DE1BF28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8F927AC-2190-4E50-AC9A-A84AA7265187}">
      <dgm:prSet/>
      <dgm:spPr/>
      <dgm:t>
        <a:bodyPr/>
        <a:lstStyle/>
        <a:p>
          <a:r>
            <a:rPr lang="en-US" dirty="0">
              <a:latin typeface="Arial" panose="020B0604020202020204" pitchFamily="34" charset="0"/>
              <a:cs typeface="Arial" panose="020B0604020202020204" pitchFamily="34" charset="0"/>
            </a:rPr>
            <a:t>Fever, chills, muscle aches, fatigue, nausea/vomiting</a:t>
          </a:r>
        </a:p>
      </dgm:t>
    </dgm:pt>
    <dgm:pt modelId="{FC8703DD-CB36-4884-BBFF-8C3C686D3A14}" type="parTrans" cxnId="{73092ECD-722C-4547-935B-94B42724057D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C49CD81-CBC4-40B3-9060-B89424A8B54A}" type="sibTrans" cxnId="{73092ECD-722C-4547-935B-94B42724057D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F5D6181A-33C0-4AD3-80A6-486D46AA6404}">
      <dgm:prSet/>
      <dgm:spPr/>
      <dgm:t>
        <a:bodyPr/>
        <a:lstStyle/>
        <a:p>
          <a:r>
            <a:rPr lang="en-US">
              <a:latin typeface="Arial" panose="020B0604020202020204" pitchFamily="34" charset="0"/>
              <a:cs typeface="Arial" panose="020B0604020202020204" pitchFamily="34" charset="0"/>
            </a:rPr>
            <a:t>Additional effects</a:t>
          </a:r>
        </a:p>
      </dgm:t>
    </dgm:pt>
    <dgm:pt modelId="{E5A5F281-F955-4471-93F0-B0D99D539BD6}" type="parTrans" cxnId="{7948FDA8-0467-4E4A-BA8A-49D85F1F6386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3C333D1-FA29-4247-A359-38C8021F2C71}" type="sibTrans" cxnId="{7948FDA8-0467-4E4A-BA8A-49D85F1F6386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B222DE6-10EC-48D2-A692-21BEC799222F}">
      <dgm:prSet/>
      <dgm:spPr/>
      <dgm:t>
        <a:bodyPr/>
        <a:lstStyle/>
        <a:p>
          <a:r>
            <a:rPr lang="en-US">
              <a:latin typeface="Arial" panose="020B0604020202020204" pitchFamily="34" charset="0"/>
              <a:cs typeface="Arial" panose="020B0604020202020204" pitchFamily="34" charset="0"/>
            </a:rPr>
            <a:t>Weight gain, heart palpitations, organ inflammation</a:t>
          </a:r>
        </a:p>
      </dgm:t>
    </dgm:pt>
    <dgm:pt modelId="{918CBD49-C0D4-4586-AFC6-445215BAA280}" type="parTrans" cxnId="{DAD6AA21-6620-487B-A1EA-7B485B1059CC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F1769D4-40DF-491D-8553-F4E77666E711}" type="sibTrans" cxnId="{DAD6AA21-6620-487B-A1EA-7B485B1059CC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85A66CF-2C16-4194-B1BC-6FC2BE7DF5C0}" type="pres">
      <dgm:prSet presAssocID="{30051227-E351-43EC-BB73-491820DEE313}" presName="root" presStyleCnt="0">
        <dgm:presLayoutVars>
          <dgm:dir/>
          <dgm:resizeHandles val="exact"/>
        </dgm:presLayoutVars>
      </dgm:prSet>
      <dgm:spPr/>
    </dgm:pt>
    <dgm:pt modelId="{53531C4F-8915-4A24-92CB-7F28FC791428}" type="pres">
      <dgm:prSet presAssocID="{40487685-AFF1-4EDC-A958-A6656FC6E907}" presName="compNode" presStyleCnt="0"/>
      <dgm:spPr/>
    </dgm:pt>
    <dgm:pt modelId="{548751DB-3388-4376-9383-9A5859865062}" type="pres">
      <dgm:prSet presAssocID="{40487685-AFF1-4EDC-A958-A6656FC6E907}" presName="bgRect" presStyleLbl="bgShp" presStyleIdx="0" presStyleCnt="3"/>
      <dgm:spPr/>
    </dgm:pt>
    <dgm:pt modelId="{751493B5-A38B-44BB-9934-776AB3640EEA}" type="pres">
      <dgm:prSet presAssocID="{40487685-AFF1-4EDC-A958-A6656FC6E907}" presName="iconRect" presStyleLbl="node1" presStyleIdx="0" presStyleCnt="3"/>
      <dgm:spPr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2"/>
              </a:ext>
            </a:extLst>
          </a:blip>
          <a:stretch>
            <a:fillRect/>
          </a:stretch>
        </a:blipFill>
        <a:ln>
          <a:noFill/>
        </a:ln>
      </dgm:spPr>
      <dgm:extLst>
        <a:ext uri="{E40237B7-FDA0-4F09-8148-C483321AD2D9}">
          <dgm14:cNvPr xmlns:dgm14="http://schemas.microsoft.com/office/drawing/2010/diagram" id="0" name="" descr="Needle"/>
        </a:ext>
      </dgm:extLst>
    </dgm:pt>
    <dgm:pt modelId="{3B61A87F-7327-4734-A39B-A74B4FA61AC0}" type="pres">
      <dgm:prSet presAssocID="{40487685-AFF1-4EDC-A958-A6656FC6E907}" presName="spaceRect" presStyleCnt="0"/>
      <dgm:spPr/>
    </dgm:pt>
    <dgm:pt modelId="{1B201135-6A77-44A2-9DAC-B39AAEBD6B23}" type="pres">
      <dgm:prSet presAssocID="{40487685-AFF1-4EDC-A958-A6656FC6E907}" presName="parTx" presStyleLbl="revTx" presStyleIdx="0" presStyleCnt="6">
        <dgm:presLayoutVars>
          <dgm:chMax val="0"/>
          <dgm:chPref val="0"/>
        </dgm:presLayoutVars>
      </dgm:prSet>
      <dgm:spPr/>
    </dgm:pt>
    <dgm:pt modelId="{DFF2CDEB-D0BB-445B-9164-00B103173CE7}" type="pres">
      <dgm:prSet presAssocID="{40487685-AFF1-4EDC-A958-A6656FC6E907}" presName="desTx" presStyleLbl="revTx" presStyleIdx="1" presStyleCnt="6">
        <dgm:presLayoutVars/>
      </dgm:prSet>
      <dgm:spPr/>
    </dgm:pt>
    <dgm:pt modelId="{DEE61349-C87B-46BD-B448-23CAD78A8B7F}" type="pres">
      <dgm:prSet presAssocID="{CC2C7733-186C-4389-9D31-E74C2B7D1CAC}" presName="sibTrans" presStyleCnt="0"/>
      <dgm:spPr/>
    </dgm:pt>
    <dgm:pt modelId="{BC4B9E05-8924-46E9-8F1E-AA8E8867F191}" type="pres">
      <dgm:prSet presAssocID="{DBBAE759-98B6-457B-B16F-4E532954A645}" presName="compNode" presStyleCnt="0"/>
      <dgm:spPr/>
    </dgm:pt>
    <dgm:pt modelId="{EE4F78A4-1EB2-4D4D-86A4-9CE3EE715569}" type="pres">
      <dgm:prSet presAssocID="{DBBAE759-98B6-457B-B16F-4E532954A645}" presName="bgRect" presStyleLbl="bgShp" presStyleIdx="1" presStyleCnt="3"/>
      <dgm:spPr/>
    </dgm:pt>
    <dgm:pt modelId="{FB0369A3-D468-4424-A9CA-6447FDB275E3}" type="pres">
      <dgm:prSet presAssocID="{DBBAE759-98B6-457B-B16F-4E532954A645}" presName="iconRect" presStyleLbl="node1" presStyleIdx="1" presStyleCnt="3"/>
      <dgm:spPr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a:blipFill>
        <a:ln>
          <a:noFill/>
        </a:ln>
      </dgm:spPr>
      <dgm:extLst>
        <a:ext uri="{E40237B7-FDA0-4F09-8148-C483321AD2D9}">
          <dgm14:cNvPr xmlns:dgm14="http://schemas.microsoft.com/office/drawing/2010/diagram" id="0" name="" descr="Low Temperature"/>
        </a:ext>
      </dgm:extLst>
    </dgm:pt>
    <dgm:pt modelId="{18CA87B6-574D-4118-9182-9AFA546F5664}" type="pres">
      <dgm:prSet presAssocID="{DBBAE759-98B6-457B-B16F-4E532954A645}" presName="spaceRect" presStyleCnt="0"/>
      <dgm:spPr/>
    </dgm:pt>
    <dgm:pt modelId="{B35D1D0F-21F7-493E-AA58-6064C6BCA07B}" type="pres">
      <dgm:prSet presAssocID="{DBBAE759-98B6-457B-B16F-4E532954A645}" presName="parTx" presStyleLbl="revTx" presStyleIdx="2" presStyleCnt="6">
        <dgm:presLayoutVars>
          <dgm:chMax val="0"/>
          <dgm:chPref val="0"/>
        </dgm:presLayoutVars>
      </dgm:prSet>
      <dgm:spPr/>
    </dgm:pt>
    <dgm:pt modelId="{813DDB59-1425-4930-96D7-2F708A3C020E}" type="pres">
      <dgm:prSet presAssocID="{DBBAE759-98B6-457B-B16F-4E532954A645}" presName="desTx" presStyleLbl="revTx" presStyleIdx="3" presStyleCnt="6">
        <dgm:presLayoutVars/>
      </dgm:prSet>
      <dgm:spPr/>
    </dgm:pt>
    <dgm:pt modelId="{074BF6F7-08D9-4529-9605-57BC1E1D1A46}" type="pres">
      <dgm:prSet presAssocID="{E52E6D2E-5527-4974-ACC5-968B1FD471D9}" presName="sibTrans" presStyleCnt="0"/>
      <dgm:spPr/>
    </dgm:pt>
    <dgm:pt modelId="{CC1C2294-CDD7-48F6-830D-11C0A839377D}" type="pres">
      <dgm:prSet presAssocID="{F5D6181A-33C0-4AD3-80A6-486D46AA6404}" presName="compNode" presStyleCnt="0"/>
      <dgm:spPr/>
    </dgm:pt>
    <dgm:pt modelId="{AE7E70D4-A4EA-4CEA-BEE8-222FCA6FA51E}" type="pres">
      <dgm:prSet presAssocID="{F5D6181A-33C0-4AD3-80A6-486D46AA6404}" presName="bgRect" presStyleLbl="bgShp" presStyleIdx="2" presStyleCnt="3"/>
      <dgm:spPr/>
    </dgm:pt>
    <dgm:pt modelId="{D90A5BCB-4A70-4204-8389-71AFA224F1F6}" type="pres">
      <dgm:prSet presAssocID="{F5D6181A-33C0-4AD3-80A6-486D46AA6404}" presName="iconRect" presStyleLbl="node1" presStyleIdx="2" presStyleCnt="3"/>
      <dgm:spPr>
        <a:blipFill>
          <a:blip xmlns:r="http://schemas.openxmlformats.org/officeDocument/2006/relationships"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a:blipFill>
        <a:ln>
          <a:noFill/>
        </a:ln>
      </dgm:spPr>
      <dgm:extLst>
        <a:ext uri="{E40237B7-FDA0-4F09-8148-C483321AD2D9}">
          <dgm14:cNvPr xmlns:dgm14="http://schemas.microsoft.com/office/drawing/2010/diagram" id="0" name="" descr="Heart Organ"/>
        </a:ext>
      </dgm:extLst>
    </dgm:pt>
    <dgm:pt modelId="{D6CEC69A-2B64-4E65-B6A0-539B47AD0ABC}" type="pres">
      <dgm:prSet presAssocID="{F5D6181A-33C0-4AD3-80A6-486D46AA6404}" presName="spaceRect" presStyleCnt="0"/>
      <dgm:spPr/>
    </dgm:pt>
    <dgm:pt modelId="{1C2E0A66-F456-40AD-9752-968000207A26}" type="pres">
      <dgm:prSet presAssocID="{F5D6181A-33C0-4AD3-80A6-486D46AA6404}" presName="parTx" presStyleLbl="revTx" presStyleIdx="4" presStyleCnt="6">
        <dgm:presLayoutVars>
          <dgm:chMax val="0"/>
          <dgm:chPref val="0"/>
        </dgm:presLayoutVars>
      </dgm:prSet>
      <dgm:spPr/>
    </dgm:pt>
    <dgm:pt modelId="{8F05AE7E-2A91-44F1-88B8-F1DB6D0DC5F2}" type="pres">
      <dgm:prSet presAssocID="{F5D6181A-33C0-4AD3-80A6-486D46AA6404}" presName="desTx" presStyleLbl="revTx" presStyleIdx="5" presStyleCnt="6">
        <dgm:presLayoutVars/>
      </dgm:prSet>
      <dgm:spPr/>
    </dgm:pt>
  </dgm:ptLst>
  <dgm:cxnLst>
    <dgm:cxn modelId="{F993980C-5F51-4C2B-8000-FD99F902C1BF}" type="presOf" srcId="{F5D6181A-33C0-4AD3-80A6-486D46AA6404}" destId="{1C2E0A66-F456-40AD-9752-968000207A26}" srcOrd="0" destOrd="0" presId="urn:microsoft.com/office/officeart/2018/2/layout/IconVerticalSolidList"/>
    <dgm:cxn modelId="{DAD6AA21-6620-487B-A1EA-7B485B1059CC}" srcId="{F5D6181A-33C0-4AD3-80A6-486D46AA6404}" destId="{7B222DE6-10EC-48D2-A692-21BEC799222F}" srcOrd="0" destOrd="0" parTransId="{918CBD49-C0D4-4586-AFC6-445215BAA280}" sibTransId="{5F1769D4-40DF-491D-8553-F4E77666E711}"/>
    <dgm:cxn modelId="{B779F52B-6055-49F6-A85A-3611F2295B76}" type="presOf" srcId="{7B222DE6-10EC-48D2-A692-21BEC799222F}" destId="{8F05AE7E-2A91-44F1-88B8-F1DB6D0DC5F2}" srcOrd="0" destOrd="0" presId="urn:microsoft.com/office/officeart/2018/2/layout/IconVerticalSolidList"/>
    <dgm:cxn modelId="{120E5569-C97C-47B3-8A22-7B37569AAC42}" type="presOf" srcId="{30051227-E351-43EC-BB73-491820DEE313}" destId="{685A66CF-2C16-4194-B1BC-6FC2BE7DF5C0}" srcOrd="0" destOrd="0" presId="urn:microsoft.com/office/officeart/2018/2/layout/IconVerticalSolidList"/>
    <dgm:cxn modelId="{75B6DC69-279D-4FE7-9360-D76000C3929B}" type="presOf" srcId="{DBBAE759-98B6-457B-B16F-4E532954A645}" destId="{B35D1D0F-21F7-493E-AA58-6064C6BCA07B}" srcOrd="0" destOrd="0" presId="urn:microsoft.com/office/officeart/2018/2/layout/IconVerticalSolidList"/>
    <dgm:cxn modelId="{A7714590-FAC6-4763-A99D-D2138062DE93}" srcId="{30051227-E351-43EC-BB73-491820DEE313}" destId="{40487685-AFF1-4EDC-A958-A6656FC6E907}" srcOrd="0" destOrd="0" parTransId="{DBB9CD2F-F378-4189-AA5C-0A0B5E382292}" sibTransId="{CC2C7733-186C-4389-9D31-E74C2B7D1CAC}"/>
    <dgm:cxn modelId="{BEEFA199-9313-4ECC-8A83-6120AA72D7BD}" srcId="{40487685-AFF1-4EDC-A958-A6656FC6E907}" destId="{6ED89FB2-BE37-4996-BFC8-AEDAFE4828D4}" srcOrd="0" destOrd="0" parTransId="{74CB082B-5C1F-4995-AC41-5E797C21B2F5}" sibTransId="{933687DC-FA64-462C-B17A-72E944FBA8C8}"/>
    <dgm:cxn modelId="{7948FDA8-0467-4E4A-BA8A-49D85F1F6386}" srcId="{30051227-E351-43EC-BB73-491820DEE313}" destId="{F5D6181A-33C0-4AD3-80A6-486D46AA6404}" srcOrd="2" destOrd="0" parTransId="{E5A5F281-F955-4471-93F0-B0D99D539BD6}" sibTransId="{D3C333D1-FA29-4247-A359-38C8021F2C71}"/>
    <dgm:cxn modelId="{102C3FB0-A01A-4397-9AEC-0620614B8798}" type="presOf" srcId="{6ED89FB2-BE37-4996-BFC8-AEDAFE4828D4}" destId="{DFF2CDEB-D0BB-445B-9164-00B103173CE7}" srcOrd="0" destOrd="0" presId="urn:microsoft.com/office/officeart/2018/2/layout/IconVerticalSolidList"/>
    <dgm:cxn modelId="{40470DB1-519C-4C61-A5F5-1F695DE1BF28}" srcId="{30051227-E351-43EC-BB73-491820DEE313}" destId="{DBBAE759-98B6-457B-B16F-4E532954A645}" srcOrd="1" destOrd="0" parTransId="{CDE9C4D1-6A83-48B8-B28D-82B07F4FD9E7}" sibTransId="{E52E6D2E-5527-4974-ACC5-968B1FD471D9}"/>
    <dgm:cxn modelId="{73092ECD-722C-4547-935B-94B42724057D}" srcId="{DBBAE759-98B6-457B-B16F-4E532954A645}" destId="{98F927AC-2190-4E50-AC9A-A84AA7265187}" srcOrd="0" destOrd="0" parTransId="{FC8703DD-CB36-4884-BBFF-8C3C686D3A14}" sibTransId="{6C49CD81-CBC4-40B3-9060-B89424A8B54A}"/>
    <dgm:cxn modelId="{045AFCE4-61D4-4CE7-9AD0-1C8689D6A640}" type="presOf" srcId="{40487685-AFF1-4EDC-A958-A6656FC6E907}" destId="{1B201135-6A77-44A2-9DAC-B39AAEBD6B23}" srcOrd="0" destOrd="0" presId="urn:microsoft.com/office/officeart/2018/2/layout/IconVerticalSolidList"/>
    <dgm:cxn modelId="{76487CF2-C185-419E-8AD1-1D4069597ECC}" type="presOf" srcId="{98F927AC-2190-4E50-AC9A-A84AA7265187}" destId="{813DDB59-1425-4930-96D7-2F708A3C020E}" srcOrd="0" destOrd="0" presId="urn:microsoft.com/office/officeart/2018/2/layout/IconVerticalSolidList"/>
    <dgm:cxn modelId="{EC21BE6B-B65B-48B4-A46A-481E334CAE42}" type="presParOf" srcId="{685A66CF-2C16-4194-B1BC-6FC2BE7DF5C0}" destId="{53531C4F-8915-4A24-92CB-7F28FC791428}" srcOrd="0" destOrd="0" presId="urn:microsoft.com/office/officeart/2018/2/layout/IconVerticalSolidList"/>
    <dgm:cxn modelId="{49FC52DA-4277-4076-8904-B896FF5891D8}" type="presParOf" srcId="{53531C4F-8915-4A24-92CB-7F28FC791428}" destId="{548751DB-3388-4376-9383-9A5859865062}" srcOrd="0" destOrd="0" presId="urn:microsoft.com/office/officeart/2018/2/layout/IconVerticalSolidList"/>
    <dgm:cxn modelId="{298BF7BA-9553-4845-9C78-2C91A0C3B4E4}" type="presParOf" srcId="{53531C4F-8915-4A24-92CB-7F28FC791428}" destId="{751493B5-A38B-44BB-9934-776AB3640EEA}" srcOrd="1" destOrd="0" presId="urn:microsoft.com/office/officeart/2018/2/layout/IconVerticalSolidList"/>
    <dgm:cxn modelId="{50618FFF-1F37-421D-918E-1CEC1092A916}" type="presParOf" srcId="{53531C4F-8915-4A24-92CB-7F28FC791428}" destId="{3B61A87F-7327-4734-A39B-A74B4FA61AC0}" srcOrd="2" destOrd="0" presId="urn:microsoft.com/office/officeart/2018/2/layout/IconVerticalSolidList"/>
    <dgm:cxn modelId="{872374A6-26D1-4152-AAFA-B3FB55A693AE}" type="presParOf" srcId="{53531C4F-8915-4A24-92CB-7F28FC791428}" destId="{1B201135-6A77-44A2-9DAC-B39AAEBD6B23}" srcOrd="3" destOrd="0" presId="urn:microsoft.com/office/officeart/2018/2/layout/IconVerticalSolidList"/>
    <dgm:cxn modelId="{5D1986C9-2CDF-4E15-A3A0-905301CF553A}" type="presParOf" srcId="{53531C4F-8915-4A24-92CB-7F28FC791428}" destId="{DFF2CDEB-D0BB-445B-9164-00B103173CE7}" srcOrd="4" destOrd="0" presId="urn:microsoft.com/office/officeart/2018/2/layout/IconVerticalSolidList"/>
    <dgm:cxn modelId="{22384C79-D876-4C65-A7AF-048AD402AD37}" type="presParOf" srcId="{685A66CF-2C16-4194-B1BC-6FC2BE7DF5C0}" destId="{DEE61349-C87B-46BD-B448-23CAD78A8B7F}" srcOrd="1" destOrd="0" presId="urn:microsoft.com/office/officeart/2018/2/layout/IconVerticalSolidList"/>
    <dgm:cxn modelId="{59EE345F-0611-451A-817F-D4EE254F150C}" type="presParOf" srcId="{685A66CF-2C16-4194-B1BC-6FC2BE7DF5C0}" destId="{BC4B9E05-8924-46E9-8F1E-AA8E8867F191}" srcOrd="2" destOrd="0" presId="urn:microsoft.com/office/officeart/2018/2/layout/IconVerticalSolidList"/>
    <dgm:cxn modelId="{AA120C40-1DCC-498B-8036-FEF63540027D}" type="presParOf" srcId="{BC4B9E05-8924-46E9-8F1E-AA8E8867F191}" destId="{EE4F78A4-1EB2-4D4D-86A4-9CE3EE715569}" srcOrd="0" destOrd="0" presId="urn:microsoft.com/office/officeart/2018/2/layout/IconVerticalSolidList"/>
    <dgm:cxn modelId="{4F72295E-0FB0-4CCB-A60E-6468F38409AF}" type="presParOf" srcId="{BC4B9E05-8924-46E9-8F1E-AA8E8867F191}" destId="{FB0369A3-D468-4424-A9CA-6447FDB275E3}" srcOrd="1" destOrd="0" presId="urn:microsoft.com/office/officeart/2018/2/layout/IconVerticalSolidList"/>
    <dgm:cxn modelId="{29E04D82-98A9-44FE-B135-89C59D30AE3E}" type="presParOf" srcId="{BC4B9E05-8924-46E9-8F1E-AA8E8867F191}" destId="{18CA87B6-574D-4118-9182-9AFA546F5664}" srcOrd="2" destOrd="0" presId="urn:microsoft.com/office/officeart/2018/2/layout/IconVerticalSolidList"/>
    <dgm:cxn modelId="{EE6DD73A-8B4B-4371-BF40-35BB9B1E7CB6}" type="presParOf" srcId="{BC4B9E05-8924-46E9-8F1E-AA8E8867F191}" destId="{B35D1D0F-21F7-493E-AA58-6064C6BCA07B}" srcOrd="3" destOrd="0" presId="urn:microsoft.com/office/officeart/2018/2/layout/IconVerticalSolidList"/>
    <dgm:cxn modelId="{7523763B-C432-4698-A0F3-E831717A376F}" type="presParOf" srcId="{BC4B9E05-8924-46E9-8F1E-AA8E8867F191}" destId="{813DDB59-1425-4930-96D7-2F708A3C020E}" srcOrd="4" destOrd="0" presId="urn:microsoft.com/office/officeart/2018/2/layout/IconVerticalSolidList"/>
    <dgm:cxn modelId="{0B657B81-D880-4158-AF31-963174292BCD}" type="presParOf" srcId="{685A66CF-2C16-4194-B1BC-6FC2BE7DF5C0}" destId="{074BF6F7-08D9-4529-9605-57BC1E1D1A46}" srcOrd="3" destOrd="0" presId="urn:microsoft.com/office/officeart/2018/2/layout/IconVerticalSolidList"/>
    <dgm:cxn modelId="{5CB2BE11-3C3A-4F77-AA2E-E85B8C9AF5B8}" type="presParOf" srcId="{685A66CF-2C16-4194-B1BC-6FC2BE7DF5C0}" destId="{CC1C2294-CDD7-48F6-830D-11C0A839377D}" srcOrd="4" destOrd="0" presId="urn:microsoft.com/office/officeart/2018/2/layout/IconVerticalSolidList"/>
    <dgm:cxn modelId="{062BF129-6BA0-4918-8E96-FB960CE5E8C6}" type="presParOf" srcId="{CC1C2294-CDD7-48F6-830D-11C0A839377D}" destId="{AE7E70D4-A4EA-4CEA-BEE8-222FCA6FA51E}" srcOrd="0" destOrd="0" presId="urn:microsoft.com/office/officeart/2018/2/layout/IconVerticalSolidList"/>
    <dgm:cxn modelId="{C75B87EF-D709-4C84-9E49-BEF6EEA51232}" type="presParOf" srcId="{CC1C2294-CDD7-48F6-830D-11C0A839377D}" destId="{D90A5BCB-4A70-4204-8389-71AFA224F1F6}" srcOrd="1" destOrd="0" presId="urn:microsoft.com/office/officeart/2018/2/layout/IconVerticalSolidList"/>
    <dgm:cxn modelId="{704D25ED-663A-45B9-828F-3DFF370C171B}" type="presParOf" srcId="{CC1C2294-CDD7-48F6-830D-11C0A839377D}" destId="{D6CEC69A-2B64-4E65-B6A0-539B47AD0ABC}" srcOrd="2" destOrd="0" presId="urn:microsoft.com/office/officeart/2018/2/layout/IconVerticalSolidList"/>
    <dgm:cxn modelId="{A2CB982C-17A7-4BCD-9BD6-26E137883B3F}" type="presParOf" srcId="{CC1C2294-CDD7-48F6-830D-11C0A839377D}" destId="{1C2E0A66-F456-40AD-9752-968000207A26}" srcOrd="3" destOrd="0" presId="urn:microsoft.com/office/officeart/2018/2/layout/IconVerticalSolidList"/>
    <dgm:cxn modelId="{3E0799DD-5FAE-4CE8-839B-8EBF24D0BB3D}" type="presParOf" srcId="{CC1C2294-CDD7-48F6-830D-11C0A839377D}" destId="{8F05AE7E-2A91-44F1-88B8-F1DB6D0DC5F2}" srcOrd="4" destOrd="0" presId="urn:microsoft.com/office/officeart/2018/2/layout/IconVerticalSolidList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3.xml><?xml version="1.0" encoding="utf-8"?>
<dgm:dataModel xmlns:dgm="http://schemas.openxmlformats.org/drawingml/2006/diagram" xmlns:a="http://schemas.openxmlformats.org/drawingml/2006/main">
  <dgm:ptLst>
    <dgm:pt modelId="{80EF67B3-8636-4E97-865E-61144CD4240E}" type="doc">
      <dgm:prSet loTypeId="urn:microsoft.com/office/officeart/2005/8/layout/list1" loCatId="list" qsTypeId="urn:microsoft.com/office/officeart/2005/8/quickstyle/simple1" qsCatId="simple" csTypeId="urn:microsoft.com/office/officeart/2005/8/colors/colorful5" csCatId="colorful"/>
      <dgm:spPr/>
      <dgm:t>
        <a:bodyPr/>
        <a:lstStyle/>
        <a:p>
          <a:endParaRPr lang="en-US"/>
        </a:p>
      </dgm:t>
    </dgm:pt>
    <dgm:pt modelId="{98A711FE-A4CB-452E-8208-984A54C7EC2B}">
      <dgm:prSet/>
      <dgm:spPr/>
      <dgm:t>
        <a:bodyPr/>
        <a:lstStyle/>
        <a:p>
          <a:r>
            <a:rPr lang="en-US" b="1" dirty="0">
              <a:latin typeface="Arial" panose="020B0604020202020204" pitchFamily="34" charset="0"/>
              <a:cs typeface="Arial" panose="020B0604020202020204" pitchFamily="34" charset="0"/>
            </a:rPr>
            <a:t>Small-molecule drugs</a:t>
          </a:r>
        </a:p>
      </dgm:t>
    </dgm:pt>
    <dgm:pt modelId="{0C624F3A-B4D0-405D-B6EA-A7F537D292C0}" type="parTrans" cxnId="{AB053038-277E-40C9-A6ED-5E5AD789889D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7D89818-E2FA-42A5-814D-7EAA3DF70E71}" type="sibTrans" cxnId="{AB053038-277E-40C9-A6ED-5E5AD789889D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31909E1-0B26-4DDA-8210-41DA348E9DEE}">
      <dgm:prSet/>
      <dgm:spPr/>
      <dgm:t>
        <a:bodyPr/>
        <a:lstStyle/>
        <a:p>
          <a:r>
            <a:rPr lang="en-US" dirty="0">
              <a:latin typeface="Arial" panose="020B0604020202020204" pitchFamily="34" charset="0"/>
              <a:cs typeface="Arial" panose="020B0604020202020204" pitchFamily="34" charset="0"/>
            </a:rPr>
            <a:t>Drugs small enough to enter cells easily</a:t>
          </a:r>
        </a:p>
      </dgm:t>
    </dgm:pt>
    <dgm:pt modelId="{1CCC6936-779A-454B-811F-35079974A8DA}" type="parTrans" cxnId="{9028BA90-E8E2-4B9B-A5A6-6068A471508E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1FC10ED-E70E-411D-A268-DA752BCEB359}" type="sibTrans" cxnId="{9028BA90-E8E2-4B9B-A5A6-6068A471508E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C18703D-242A-4D10-9A81-E39DD74D76BA}">
      <dgm:prSet/>
      <dgm:spPr/>
      <dgm:t>
        <a:bodyPr/>
        <a:lstStyle/>
        <a:p>
          <a:r>
            <a:rPr lang="en-US" dirty="0">
              <a:latin typeface="Arial" panose="020B0604020202020204" pitchFamily="34" charset="0"/>
              <a:cs typeface="Arial" panose="020B0604020202020204" pitchFamily="34" charset="0"/>
            </a:rPr>
            <a:t>Used for targets inside the cells</a:t>
          </a:r>
        </a:p>
      </dgm:t>
    </dgm:pt>
    <dgm:pt modelId="{E1D70B22-9AED-4BC2-8ED0-59AA58AB11ED}" type="parTrans" cxnId="{08044F3D-0CB7-44B9-8D94-2F7A60B8DF83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CA1983D-CF68-435E-80CB-CA3267B2604E}" type="sibTrans" cxnId="{08044F3D-0CB7-44B9-8D94-2F7A60B8DF83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D5918D3-8BCC-459F-AA1A-D7260AA006AC}">
      <dgm:prSet/>
      <dgm:spPr/>
      <dgm:t>
        <a:bodyPr/>
        <a:lstStyle/>
        <a:p>
          <a:r>
            <a:rPr lang="en-US" b="1" dirty="0">
              <a:latin typeface="Arial" panose="020B0604020202020204" pitchFamily="34" charset="0"/>
              <a:cs typeface="Arial" panose="020B0604020202020204" pitchFamily="34" charset="0"/>
            </a:rPr>
            <a:t>Monoclonal antibodies</a:t>
          </a:r>
        </a:p>
      </dgm:t>
    </dgm:pt>
    <dgm:pt modelId="{F52B5B8D-8FAB-4759-93D1-5C2B64D98373}" type="parTrans" cxnId="{0A58787B-8B11-4679-B25F-8331B62FE37D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CDAEE0C9-CE98-4FEA-8064-D9479926B800}" type="sibTrans" cxnId="{0A58787B-8B11-4679-B25F-8331B62FE37D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DAA144E-8AF4-413B-A69A-7428E79477EC}">
      <dgm:prSet/>
      <dgm:spPr/>
      <dgm:t>
        <a:bodyPr/>
        <a:lstStyle/>
        <a:p>
          <a:r>
            <a:rPr lang="en-US">
              <a:latin typeface="Arial" panose="020B0604020202020204" pitchFamily="34" charset="0"/>
              <a:cs typeface="Arial" panose="020B0604020202020204" pitchFamily="34" charset="0"/>
            </a:rPr>
            <a:t>Proteins designed to attach to specific targets on cancer cells</a:t>
          </a:r>
        </a:p>
      </dgm:t>
    </dgm:pt>
    <dgm:pt modelId="{852B2AB0-B5CF-4246-A1CD-0D9F75BCD6A6}" type="parTrans" cxnId="{C75B897B-3B26-4CBD-9E31-8F7DFA7818B9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53AFF6B-4868-4640-AE52-B69C7086A9BC}" type="sibTrans" cxnId="{C75B897B-3B26-4CBD-9E31-8F7DFA7818B9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BFE0B91-F92E-4B43-8EC9-C326B3725EB2}">
      <dgm:prSet/>
      <dgm:spPr/>
      <dgm:t>
        <a:bodyPr/>
        <a:lstStyle/>
        <a:p>
          <a:r>
            <a:rPr lang="en-US">
              <a:latin typeface="Arial" panose="020B0604020202020204" pitchFamily="34" charset="0"/>
              <a:cs typeface="Arial" panose="020B0604020202020204" pitchFamily="34" charset="0"/>
            </a:rPr>
            <a:t>Makes it easier for it to be destroyed by immune system</a:t>
          </a:r>
        </a:p>
      </dgm:t>
    </dgm:pt>
    <dgm:pt modelId="{952799DF-3BEF-4A64-A73D-B0FF9EFC42CD}" type="parTrans" cxnId="{CCF6DD89-0CE9-4C96-960B-BE8410929256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2C273AA-D125-4117-9557-14B2ED6BFF6F}" type="sibTrans" cxnId="{CCF6DD89-0CE9-4C96-960B-BE8410929256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468FFDA-0117-C748-AD10-EBEFDFE331BA}" type="pres">
      <dgm:prSet presAssocID="{80EF67B3-8636-4E97-865E-61144CD4240E}" presName="linear" presStyleCnt="0">
        <dgm:presLayoutVars>
          <dgm:dir/>
          <dgm:animLvl val="lvl"/>
          <dgm:resizeHandles val="exact"/>
        </dgm:presLayoutVars>
      </dgm:prSet>
      <dgm:spPr/>
    </dgm:pt>
    <dgm:pt modelId="{1786E901-2756-B94B-929A-2FFAEE804594}" type="pres">
      <dgm:prSet presAssocID="{98A711FE-A4CB-452E-8208-984A54C7EC2B}" presName="parentLin" presStyleCnt="0"/>
      <dgm:spPr/>
    </dgm:pt>
    <dgm:pt modelId="{A17F394B-7667-8041-A413-2BA5C14DDEEF}" type="pres">
      <dgm:prSet presAssocID="{98A711FE-A4CB-452E-8208-984A54C7EC2B}" presName="parentLeftMargin" presStyleLbl="node1" presStyleIdx="0" presStyleCnt="2"/>
      <dgm:spPr/>
    </dgm:pt>
    <dgm:pt modelId="{ACCBF021-1716-734A-A7A0-DFFDE9C16D30}" type="pres">
      <dgm:prSet presAssocID="{98A711FE-A4CB-452E-8208-984A54C7EC2B}" presName="parentText" presStyleLbl="node1" presStyleIdx="0" presStyleCnt="2">
        <dgm:presLayoutVars>
          <dgm:chMax val="0"/>
          <dgm:bulletEnabled val="1"/>
        </dgm:presLayoutVars>
      </dgm:prSet>
      <dgm:spPr/>
    </dgm:pt>
    <dgm:pt modelId="{59B065CF-97C7-F247-8B16-C9F2275049F1}" type="pres">
      <dgm:prSet presAssocID="{98A711FE-A4CB-452E-8208-984A54C7EC2B}" presName="negativeSpace" presStyleCnt="0"/>
      <dgm:spPr/>
    </dgm:pt>
    <dgm:pt modelId="{505D4817-07C3-CA4B-A8B8-5188F272A1DA}" type="pres">
      <dgm:prSet presAssocID="{98A711FE-A4CB-452E-8208-984A54C7EC2B}" presName="childText" presStyleLbl="conFgAcc1" presStyleIdx="0" presStyleCnt="2">
        <dgm:presLayoutVars>
          <dgm:bulletEnabled val="1"/>
        </dgm:presLayoutVars>
      </dgm:prSet>
      <dgm:spPr/>
    </dgm:pt>
    <dgm:pt modelId="{7A584E3A-1924-134E-B251-DB8B5C64AC9E}" type="pres">
      <dgm:prSet presAssocID="{A7D89818-E2FA-42A5-814D-7EAA3DF70E71}" presName="spaceBetweenRectangles" presStyleCnt="0"/>
      <dgm:spPr/>
    </dgm:pt>
    <dgm:pt modelId="{666490FA-4F74-DC43-BAD2-1A2D55C1212A}" type="pres">
      <dgm:prSet presAssocID="{7D5918D3-8BCC-459F-AA1A-D7260AA006AC}" presName="parentLin" presStyleCnt="0"/>
      <dgm:spPr/>
    </dgm:pt>
    <dgm:pt modelId="{A1AFB659-4D19-8742-A700-B9B717A878D9}" type="pres">
      <dgm:prSet presAssocID="{7D5918D3-8BCC-459F-AA1A-D7260AA006AC}" presName="parentLeftMargin" presStyleLbl="node1" presStyleIdx="0" presStyleCnt="2"/>
      <dgm:spPr/>
    </dgm:pt>
    <dgm:pt modelId="{020D1C76-A3A1-8145-AC2A-0F3E1F78F5A0}" type="pres">
      <dgm:prSet presAssocID="{7D5918D3-8BCC-459F-AA1A-D7260AA006AC}" presName="parentText" presStyleLbl="node1" presStyleIdx="1" presStyleCnt="2">
        <dgm:presLayoutVars>
          <dgm:chMax val="0"/>
          <dgm:bulletEnabled val="1"/>
        </dgm:presLayoutVars>
      </dgm:prSet>
      <dgm:spPr/>
    </dgm:pt>
    <dgm:pt modelId="{6A599F6D-ACA6-1B46-8880-C70AB77B381E}" type="pres">
      <dgm:prSet presAssocID="{7D5918D3-8BCC-459F-AA1A-D7260AA006AC}" presName="negativeSpace" presStyleCnt="0"/>
      <dgm:spPr/>
    </dgm:pt>
    <dgm:pt modelId="{D4F299E3-76CA-B44D-AD47-312000A81794}" type="pres">
      <dgm:prSet presAssocID="{7D5918D3-8BCC-459F-AA1A-D7260AA006AC}" presName="childText" presStyleLbl="conFgAcc1" presStyleIdx="1" presStyleCnt="2">
        <dgm:presLayoutVars>
          <dgm:bulletEnabled val="1"/>
        </dgm:presLayoutVars>
      </dgm:prSet>
      <dgm:spPr/>
    </dgm:pt>
  </dgm:ptLst>
  <dgm:cxnLst>
    <dgm:cxn modelId="{79831D20-9322-CA49-9CDA-8BBA8DC90511}" type="presOf" srcId="{98A711FE-A4CB-452E-8208-984A54C7EC2B}" destId="{A17F394B-7667-8041-A413-2BA5C14DDEEF}" srcOrd="0" destOrd="0" presId="urn:microsoft.com/office/officeart/2005/8/layout/list1"/>
    <dgm:cxn modelId="{66F93324-F695-A842-890B-B78D07E0E41C}" type="presOf" srcId="{7D5918D3-8BCC-459F-AA1A-D7260AA006AC}" destId="{A1AFB659-4D19-8742-A700-B9B717A878D9}" srcOrd="0" destOrd="0" presId="urn:microsoft.com/office/officeart/2005/8/layout/list1"/>
    <dgm:cxn modelId="{AB053038-277E-40C9-A6ED-5E5AD789889D}" srcId="{80EF67B3-8636-4E97-865E-61144CD4240E}" destId="{98A711FE-A4CB-452E-8208-984A54C7EC2B}" srcOrd="0" destOrd="0" parTransId="{0C624F3A-B4D0-405D-B6EA-A7F537D292C0}" sibTransId="{A7D89818-E2FA-42A5-814D-7EAA3DF70E71}"/>
    <dgm:cxn modelId="{08044F3D-0CB7-44B9-8D94-2F7A60B8DF83}" srcId="{98A711FE-A4CB-452E-8208-984A54C7EC2B}" destId="{3C18703D-242A-4D10-9A81-E39DD74D76BA}" srcOrd="1" destOrd="0" parTransId="{E1D70B22-9AED-4BC2-8ED0-59AA58AB11ED}" sibTransId="{8CA1983D-CF68-435E-80CB-CA3267B2604E}"/>
    <dgm:cxn modelId="{C770D85B-BFED-4640-8086-8F28FC2DCE35}" type="presOf" srcId="{8BFE0B91-F92E-4B43-8EC9-C326B3725EB2}" destId="{D4F299E3-76CA-B44D-AD47-312000A81794}" srcOrd="0" destOrd="1" presId="urn:microsoft.com/office/officeart/2005/8/layout/list1"/>
    <dgm:cxn modelId="{9594B752-23A8-3D4B-82BD-B360B9D70174}" type="presOf" srcId="{7D5918D3-8BCC-459F-AA1A-D7260AA006AC}" destId="{020D1C76-A3A1-8145-AC2A-0F3E1F78F5A0}" srcOrd="1" destOrd="0" presId="urn:microsoft.com/office/officeart/2005/8/layout/list1"/>
    <dgm:cxn modelId="{40698954-2679-BD47-B78C-C694A9D276F7}" type="presOf" srcId="{98A711FE-A4CB-452E-8208-984A54C7EC2B}" destId="{ACCBF021-1716-734A-A7A0-DFFDE9C16D30}" srcOrd="1" destOrd="0" presId="urn:microsoft.com/office/officeart/2005/8/layout/list1"/>
    <dgm:cxn modelId="{0A58787B-8B11-4679-B25F-8331B62FE37D}" srcId="{80EF67B3-8636-4E97-865E-61144CD4240E}" destId="{7D5918D3-8BCC-459F-AA1A-D7260AA006AC}" srcOrd="1" destOrd="0" parTransId="{F52B5B8D-8FAB-4759-93D1-5C2B64D98373}" sibTransId="{CDAEE0C9-CE98-4FEA-8064-D9479926B800}"/>
    <dgm:cxn modelId="{C75B897B-3B26-4CBD-9E31-8F7DFA7818B9}" srcId="{7D5918D3-8BCC-459F-AA1A-D7260AA006AC}" destId="{BDAA144E-8AF4-413B-A69A-7428E79477EC}" srcOrd="0" destOrd="0" parTransId="{852B2AB0-B5CF-4246-A1CD-0D9F75BCD6A6}" sibTransId="{653AFF6B-4868-4640-AE52-B69C7086A9BC}"/>
    <dgm:cxn modelId="{98745F89-60A5-6747-8A48-716188DDEEE1}" type="presOf" srcId="{831909E1-0B26-4DDA-8210-41DA348E9DEE}" destId="{505D4817-07C3-CA4B-A8B8-5188F272A1DA}" srcOrd="0" destOrd="0" presId="urn:microsoft.com/office/officeart/2005/8/layout/list1"/>
    <dgm:cxn modelId="{CCF6DD89-0CE9-4C96-960B-BE8410929256}" srcId="{7D5918D3-8BCC-459F-AA1A-D7260AA006AC}" destId="{8BFE0B91-F92E-4B43-8EC9-C326B3725EB2}" srcOrd="1" destOrd="0" parTransId="{952799DF-3BEF-4A64-A73D-B0FF9EFC42CD}" sibTransId="{62C273AA-D125-4117-9557-14B2ED6BFF6F}"/>
    <dgm:cxn modelId="{9028BA90-E8E2-4B9B-A5A6-6068A471508E}" srcId="{98A711FE-A4CB-452E-8208-984A54C7EC2B}" destId="{831909E1-0B26-4DDA-8210-41DA348E9DEE}" srcOrd="0" destOrd="0" parTransId="{1CCC6936-779A-454B-811F-35079974A8DA}" sibTransId="{21FC10ED-E70E-411D-A268-DA752BCEB359}"/>
    <dgm:cxn modelId="{9042B4DC-7A83-B944-A685-4E78604EA70D}" type="presOf" srcId="{80EF67B3-8636-4E97-865E-61144CD4240E}" destId="{A468FFDA-0117-C748-AD10-EBEFDFE331BA}" srcOrd="0" destOrd="0" presId="urn:microsoft.com/office/officeart/2005/8/layout/list1"/>
    <dgm:cxn modelId="{23FBC2F2-46A6-6C40-8BAF-8FD3D39A3272}" type="presOf" srcId="{BDAA144E-8AF4-413B-A69A-7428E79477EC}" destId="{D4F299E3-76CA-B44D-AD47-312000A81794}" srcOrd="0" destOrd="0" presId="urn:microsoft.com/office/officeart/2005/8/layout/list1"/>
    <dgm:cxn modelId="{8B9654FC-A07C-4F47-A487-8CDC44C29772}" type="presOf" srcId="{3C18703D-242A-4D10-9A81-E39DD74D76BA}" destId="{505D4817-07C3-CA4B-A8B8-5188F272A1DA}" srcOrd="0" destOrd="1" presId="urn:microsoft.com/office/officeart/2005/8/layout/list1"/>
    <dgm:cxn modelId="{1F05CE29-B692-2841-AE95-2C84EFEA6789}" type="presParOf" srcId="{A468FFDA-0117-C748-AD10-EBEFDFE331BA}" destId="{1786E901-2756-B94B-929A-2FFAEE804594}" srcOrd="0" destOrd="0" presId="urn:microsoft.com/office/officeart/2005/8/layout/list1"/>
    <dgm:cxn modelId="{3F5B97C5-9ED7-9249-BE19-C523A812EEA1}" type="presParOf" srcId="{1786E901-2756-B94B-929A-2FFAEE804594}" destId="{A17F394B-7667-8041-A413-2BA5C14DDEEF}" srcOrd="0" destOrd="0" presId="urn:microsoft.com/office/officeart/2005/8/layout/list1"/>
    <dgm:cxn modelId="{77201A2B-2E7E-6040-9FBA-4E1A78B4757E}" type="presParOf" srcId="{1786E901-2756-B94B-929A-2FFAEE804594}" destId="{ACCBF021-1716-734A-A7A0-DFFDE9C16D30}" srcOrd="1" destOrd="0" presId="urn:microsoft.com/office/officeart/2005/8/layout/list1"/>
    <dgm:cxn modelId="{6EB4838B-4025-4C4E-BF6E-E4B0AC145507}" type="presParOf" srcId="{A468FFDA-0117-C748-AD10-EBEFDFE331BA}" destId="{59B065CF-97C7-F247-8B16-C9F2275049F1}" srcOrd="1" destOrd="0" presId="urn:microsoft.com/office/officeart/2005/8/layout/list1"/>
    <dgm:cxn modelId="{DF237EA2-C532-3040-A780-4EFF40C8406D}" type="presParOf" srcId="{A468FFDA-0117-C748-AD10-EBEFDFE331BA}" destId="{505D4817-07C3-CA4B-A8B8-5188F272A1DA}" srcOrd="2" destOrd="0" presId="urn:microsoft.com/office/officeart/2005/8/layout/list1"/>
    <dgm:cxn modelId="{191D9ACB-CBA7-3D47-BDDD-6B7A5CE720A0}" type="presParOf" srcId="{A468FFDA-0117-C748-AD10-EBEFDFE331BA}" destId="{7A584E3A-1924-134E-B251-DB8B5C64AC9E}" srcOrd="3" destOrd="0" presId="urn:microsoft.com/office/officeart/2005/8/layout/list1"/>
    <dgm:cxn modelId="{207466CD-5946-E64D-8914-2C1E7E657103}" type="presParOf" srcId="{A468FFDA-0117-C748-AD10-EBEFDFE331BA}" destId="{666490FA-4F74-DC43-BAD2-1A2D55C1212A}" srcOrd="4" destOrd="0" presId="urn:microsoft.com/office/officeart/2005/8/layout/list1"/>
    <dgm:cxn modelId="{568A6960-6A39-704E-A73E-1716DCF090F5}" type="presParOf" srcId="{666490FA-4F74-DC43-BAD2-1A2D55C1212A}" destId="{A1AFB659-4D19-8742-A700-B9B717A878D9}" srcOrd="0" destOrd="0" presId="urn:microsoft.com/office/officeart/2005/8/layout/list1"/>
    <dgm:cxn modelId="{A5B0817A-F06E-4140-B20F-80F5CAD523C3}" type="presParOf" srcId="{666490FA-4F74-DC43-BAD2-1A2D55C1212A}" destId="{020D1C76-A3A1-8145-AC2A-0F3E1F78F5A0}" srcOrd="1" destOrd="0" presId="urn:microsoft.com/office/officeart/2005/8/layout/list1"/>
    <dgm:cxn modelId="{E7B089CE-3C9F-614E-8FE4-74B23480DE7E}" type="presParOf" srcId="{A468FFDA-0117-C748-AD10-EBEFDFE331BA}" destId="{6A599F6D-ACA6-1B46-8880-C70AB77B381E}" srcOrd="5" destOrd="0" presId="urn:microsoft.com/office/officeart/2005/8/layout/list1"/>
    <dgm:cxn modelId="{74F44A5A-084E-8740-83B5-E85AE60895FE}" type="presParOf" srcId="{A468FFDA-0117-C748-AD10-EBEFDFE331BA}" destId="{D4F299E3-76CA-B44D-AD47-312000A81794}" srcOrd="6" destOrd="0" presId="urn:microsoft.com/office/officeart/2005/8/layout/list1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4.xml><?xml version="1.0" encoding="utf-8"?>
<dgm:dataModel xmlns:dgm="http://schemas.openxmlformats.org/drawingml/2006/diagram" xmlns:a="http://schemas.openxmlformats.org/drawingml/2006/main">
  <dgm:ptLst>
    <dgm:pt modelId="{AB480724-AA33-4774-97AB-ED4F2ED61051}" type="doc">
      <dgm:prSet loTypeId="urn:microsoft.com/office/officeart/2018/2/layout/IconVerticalSolidList" loCatId="icon" qsTypeId="urn:microsoft.com/office/officeart/2005/8/quickstyle/simple1" qsCatId="simple" csTypeId="urn:microsoft.com/office/officeart/2018/5/colors/Iconchunking_neutralbg_colorful1" csCatId="colorful" phldr="1"/>
      <dgm:spPr/>
      <dgm:t>
        <a:bodyPr/>
        <a:lstStyle/>
        <a:p>
          <a:endParaRPr lang="en-US"/>
        </a:p>
      </dgm:t>
    </dgm:pt>
    <dgm:pt modelId="{3DF5A36A-933E-4F4C-B167-347EF37923B1}">
      <dgm:prSet/>
      <dgm:spPr/>
      <dgm:t>
        <a:bodyPr/>
        <a:lstStyle/>
        <a:p>
          <a:r>
            <a:rPr lang="en-US">
              <a:latin typeface="Arial" panose="020B0604020202020204" pitchFamily="34" charset="0"/>
              <a:cs typeface="Arial" panose="020B0604020202020204" pitchFamily="34" charset="0"/>
            </a:rPr>
            <a:t>Depends on the type of targeted therapy</a:t>
          </a:r>
        </a:p>
      </dgm:t>
    </dgm:pt>
    <dgm:pt modelId="{9C9522BB-7B23-4725-B6B6-C984073C9B6D}" type="parTrans" cxnId="{947FF8AD-C27D-47F3-B3BF-82331DC12532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C38BC46D-1C22-49A9-98B8-F23FE0CE91C8}" type="sibTrans" cxnId="{947FF8AD-C27D-47F3-B3BF-82331DC12532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E966C427-D80A-46E6-BC39-7B7300B45397}">
      <dgm:prSet/>
      <dgm:spPr/>
      <dgm:t>
        <a:bodyPr/>
        <a:lstStyle/>
        <a:p>
          <a:r>
            <a:rPr lang="en-US">
              <a:latin typeface="Arial" panose="020B0604020202020204" pitchFamily="34" charset="0"/>
              <a:cs typeface="Arial" panose="020B0604020202020204" pitchFamily="34" charset="0"/>
            </a:rPr>
            <a:t>Most common</a:t>
          </a:r>
        </a:p>
      </dgm:t>
    </dgm:pt>
    <dgm:pt modelId="{5596BD3C-9C0E-41C4-A96B-91CE7F2CF8A8}" type="parTrans" cxnId="{770742B4-7FDD-42F1-AF34-876AD950EAEB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E33A324-BDF0-4C0D-9FCA-8F7D9D6189C4}" type="sibTrans" cxnId="{770742B4-7FDD-42F1-AF34-876AD950EAEB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9B4AD64-224F-44AC-A007-13D8D01FF3BD}">
      <dgm:prSet/>
      <dgm:spPr/>
      <dgm:t>
        <a:bodyPr/>
        <a:lstStyle/>
        <a:p>
          <a:r>
            <a:rPr lang="en-US">
              <a:latin typeface="Arial" panose="020B0604020202020204" pitchFamily="34" charset="0"/>
              <a:cs typeface="Arial" panose="020B0604020202020204" pitchFamily="34" charset="0"/>
            </a:rPr>
            <a:t>Diarrhea</a:t>
          </a:r>
        </a:p>
      </dgm:t>
    </dgm:pt>
    <dgm:pt modelId="{DE054AC7-899E-4D44-B28E-8CF2A69A7345}" type="parTrans" cxnId="{AEF8F1A4-5DB7-4A44-BC2C-B05DBB86EE22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82482C9-BD83-4ED4-98E6-06CF8F923BE7}" type="sibTrans" cxnId="{AEF8F1A4-5DB7-4A44-BC2C-B05DBB86EE22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15FE384-23B7-4DAA-923E-B76170318C86}">
      <dgm:prSet/>
      <dgm:spPr/>
      <dgm:t>
        <a:bodyPr/>
        <a:lstStyle/>
        <a:p>
          <a:r>
            <a:rPr lang="en-US">
              <a:latin typeface="Arial" panose="020B0604020202020204" pitchFamily="34" charset="0"/>
              <a:cs typeface="Arial" panose="020B0604020202020204" pitchFamily="34" charset="0"/>
            </a:rPr>
            <a:t>Liver problems</a:t>
          </a:r>
        </a:p>
      </dgm:t>
    </dgm:pt>
    <dgm:pt modelId="{E586EAB2-3C00-449E-8F90-02336EC7A565}" type="parTrans" cxnId="{019B22BA-78A4-4A42-97C5-3BFA1FCD4072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4588FDC4-A4D2-46CD-9E51-56F912F1C3BB}" type="sibTrans" cxnId="{019B22BA-78A4-4A42-97C5-3BFA1FCD4072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F8FF7318-1B97-4269-AECC-393BE8F67CE7}">
      <dgm:prSet/>
      <dgm:spPr/>
      <dgm:t>
        <a:bodyPr/>
        <a:lstStyle/>
        <a:p>
          <a:r>
            <a:rPr lang="en-US" dirty="0">
              <a:latin typeface="Arial" panose="020B0604020202020204" pitchFamily="34" charset="0"/>
              <a:cs typeface="Arial" panose="020B0604020202020204" pitchFamily="34" charset="0"/>
            </a:rPr>
            <a:t>Less common</a:t>
          </a:r>
        </a:p>
      </dgm:t>
    </dgm:pt>
    <dgm:pt modelId="{E8171FF0-EF96-4280-AAAD-645A687CECF5}" type="parTrans" cxnId="{1C5E90F2-EAC3-4F94-AC5A-1C16B451246A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FCDF1D2-A603-4C80-A721-3B07FA2FEB67}" type="sibTrans" cxnId="{1C5E90F2-EAC3-4F94-AC5A-1C16B451246A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0BC496F-E866-48B2-9E71-ED055B7BC057}">
      <dgm:prSet/>
      <dgm:spPr/>
      <dgm:t>
        <a:bodyPr/>
        <a:lstStyle/>
        <a:p>
          <a:r>
            <a:rPr lang="en-US">
              <a:latin typeface="Arial" panose="020B0604020202020204" pitchFamily="34" charset="0"/>
              <a:cs typeface="Arial" panose="020B0604020202020204" pitchFamily="34" charset="0"/>
            </a:rPr>
            <a:t>Problems with blood clotting</a:t>
          </a:r>
        </a:p>
      </dgm:t>
    </dgm:pt>
    <dgm:pt modelId="{40F5350E-A295-43D8-AE20-93BB91898D30}" type="parTrans" cxnId="{AE24E98E-E27C-4C89-9103-5EB820C5D42B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AA9C5F4-EDAB-42E9-BC36-6A44424D02C3}" type="sibTrans" cxnId="{AE24E98E-E27C-4C89-9103-5EB820C5D42B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CD07A3C5-5C01-456A-B651-9783D815F1D2}">
      <dgm:prSet/>
      <dgm:spPr/>
      <dgm:t>
        <a:bodyPr/>
        <a:lstStyle/>
        <a:p>
          <a:r>
            <a:rPr lang="en-US" dirty="0">
              <a:latin typeface="Arial" panose="020B0604020202020204" pitchFamily="34" charset="0"/>
              <a:cs typeface="Arial" panose="020B0604020202020204" pitchFamily="34" charset="0"/>
            </a:rPr>
            <a:t>High blood pressure</a:t>
          </a:r>
        </a:p>
      </dgm:t>
    </dgm:pt>
    <dgm:pt modelId="{E92D29EA-42CE-492F-8196-4EDACB74AF2E}" type="parTrans" cxnId="{3471170A-88F9-480F-AF74-0AE2A2163091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D786206-6C2B-43C4-8573-CB8D7CE3B4D4}" type="sibTrans" cxnId="{3471170A-88F9-480F-AF74-0AE2A2163091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C81B2EB7-8942-4689-AE1E-2319D9A84A0C}">
      <dgm:prSet/>
      <dgm:spPr/>
      <dgm:t>
        <a:bodyPr/>
        <a:lstStyle/>
        <a:p>
          <a:r>
            <a:rPr lang="en-US" dirty="0">
              <a:latin typeface="Arial" panose="020B0604020202020204" pitchFamily="34" charset="0"/>
              <a:cs typeface="Arial" panose="020B0604020202020204" pitchFamily="34" charset="0"/>
            </a:rPr>
            <a:t>Fatigue</a:t>
          </a:r>
        </a:p>
      </dgm:t>
    </dgm:pt>
    <dgm:pt modelId="{4B15936D-B6B9-484A-A405-F830255051F7}" type="parTrans" cxnId="{953E46DD-6027-4BAE-9FCC-EB74E25E7361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4125A225-3DD3-41BF-A049-7A89470E5873}" type="sibTrans" cxnId="{953E46DD-6027-4BAE-9FCC-EB74E25E7361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C4BA5111-D28D-46CC-AC8A-756D45075964}">
      <dgm:prSet/>
      <dgm:spPr/>
      <dgm:t>
        <a:bodyPr/>
        <a:lstStyle/>
        <a:p>
          <a:r>
            <a:rPr lang="en-US">
              <a:latin typeface="Arial" panose="020B0604020202020204" pitchFamily="34" charset="0"/>
              <a:cs typeface="Arial" panose="020B0604020202020204" pitchFamily="34" charset="0"/>
            </a:rPr>
            <a:t>Loss or hair color</a:t>
          </a:r>
        </a:p>
      </dgm:t>
    </dgm:pt>
    <dgm:pt modelId="{1712EC25-DBE9-495D-B10C-A0DD4657B858}" type="parTrans" cxnId="{3A83A2E5-6F1B-45F4-A1F7-B763E072B331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F98B09AB-8C3F-4FE2-83E7-852E401882BD}" type="sibTrans" cxnId="{3A83A2E5-6F1B-45F4-A1F7-B763E072B331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DC03AEC-D9DA-4F40-AF8A-65A415DE7EA7}" type="pres">
      <dgm:prSet presAssocID="{AB480724-AA33-4774-97AB-ED4F2ED61051}" presName="root" presStyleCnt="0">
        <dgm:presLayoutVars>
          <dgm:dir/>
          <dgm:resizeHandles val="exact"/>
        </dgm:presLayoutVars>
      </dgm:prSet>
      <dgm:spPr/>
    </dgm:pt>
    <dgm:pt modelId="{F839A06F-9589-4B35-8BC0-D697C8898EB0}" type="pres">
      <dgm:prSet presAssocID="{3DF5A36A-933E-4F4C-B167-347EF37923B1}" presName="compNode" presStyleCnt="0"/>
      <dgm:spPr/>
    </dgm:pt>
    <dgm:pt modelId="{4D98EFF5-8E79-4395-AD45-054A1A4D6AE3}" type="pres">
      <dgm:prSet presAssocID="{3DF5A36A-933E-4F4C-B167-347EF37923B1}" presName="bgRect" presStyleLbl="bgShp" presStyleIdx="0" presStyleCnt="3"/>
      <dgm:spPr/>
    </dgm:pt>
    <dgm:pt modelId="{E96C1EA4-8FF1-4007-9108-3509BC24936D}" type="pres">
      <dgm:prSet presAssocID="{3DF5A36A-933E-4F4C-B167-347EF37923B1}" presName="iconRect" presStyleLbl="node1" presStyleIdx="0" presStyleCnt="3"/>
      <dgm:spPr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2"/>
              </a:ext>
            </a:extLst>
          </a:blip>
          <a:stretch>
            <a:fillRect/>
          </a:stretch>
        </a:blipFill>
        <a:ln>
          <a:noFill/>
        </a:ln>
      </dgm:spPr>
      <dgm:extLst>
        <a:ext uri="{E40237B7-FDA0-4F09-8148-C483321AD2D9}">
          <dgm14:cNvPr xmlns:dgm14="http://schemas.microsoft.com/office/drawing/2010/diagram" id="0" name="" descr="Bullseye"/>
        </a:ext>
      </dgm:extLst>
    </dgm:pt>
    <dgm:pt modelId="{15A5C609-F45C-4C9A-9F1F-200717138EF8}" type="pres">
      <dgm:prSet presAssocID="{3DF5A36A-933E-4F4C-B167-347EF37923B1}" presName="spaceRect" presStyleCnt="0"/>
      <dgm:spPr/>
    </dgm:pt>
    <dgm:pt modelId="{298532AE-009A-467A-AFA8-CC787A4364A9}" type="pres">
      <dgm:prSet presAssocID="{3DF5A36A-933E-4F4C-B167-347EF37923B1}" presName="parTx" presStyleLbl="revTx" presStyleIdx="0" presStyleCnt="5">
        <dgm:presLayoutVars>
          <dgm:chMax val="0"/>
          <dgm:chPref val="0"/>
        </dgm:presLayoutVars>
      </dgm:prSet>
      <dgm:spPr/>
    </dgm:pt>
    <dgm:pt modelId="{5BA77DC3-CA51-47D9-8239-302371830801}" type="pres">
      <dgm:prSet presAssocID="{C38BC46D-1C22-49A9-98B8-F23FE0CE91C8}" presName="sibTrans" presStyleCnt="0"/>
      <dgm:spPr/>
    </dgm:pt>
    <dgm:pt modelId="{C9629357-66FD-4B04-B9A0-CE6EB59B33AA}" type="pres">
      <dgm:prSet presAssocID="{E966C427-D80A-46E6-BC39-7B7300B45397}" presName="compNode" presStyleCnt="0"/>
      <dgm:spPr/>
    </dgm:pt>
    <dgm:pt modelId="{F761A3C3-1388-4438-ACBA-D84868CC9FD8}" type="pres">
      <dgm:prSet presAssocID="{E966C427-D80A-46E6-BC39-7B7300B45397}" presName="bgRect" presStyleLbl="bgShp" presStyleIdx="1" presStyleCnt="3"/>
      <dgm:spPr/>
    </dgm:pt>
    <dgm:pt modelId="{9D12D4A9-0468-4AD5-BAAC-55FF3C0F4D06}" type="pres">
      <dgm:prSet presAssocID="{E966C427-D80A-46E6-BC39-7B7300B45397}" presName="iconRect" presStyleLbl="node1" presStyleIdx="1" presStyleCnt="3"/>
      <dgm:spPr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a:blipFill>
        <a:ln>
          <a:noFill/>
        </a:ln>
      </dgm:spPr>
      <dgm:extLst>
        <a:ext uri="{E40237B7-FDA0-4F09-8148-C483321AD2D9}">
          <dgm14:cNvPr xmlns:dgm14="http://schemas.microsoft.com/office/drawing/2010/diagram" id="0" name="" descr="Stethoscope"/>
        </a:ext>
      </dgm:extLst>
    </dgm:pt>
    <dgm:pt modelId="{17EFE177-616A-4FD8-94A1-9646CE7E16AD}" type="pres">
      <dgm:prSet presAssocID="{E966C427-D80A-46E6-BC39-7B7300B45397}" presName="spaceRect" presStyleCnt="0"/>
      <dgm:spPr/>
    </dgm:pt>
    <dgm:pt modelId="{2AC88B4C-6FE4-4273-B787-2793A0E51EFC}" type="pres">
      <dgm:prSet presAssocID="{E966C427-D80A-46E6-BC39-7B7300B45397}" presName="parTx" presStyleLbl="revTx" presStyleIdx="1" presStyleCnt="5">
        <dgm:presLayoutVars>
          <dgm:chMax val="0"/>
          <dgm:chPref val="0"/>
        </dgm:presLayoutVars>
      </dgm:prSet>
      <dgm:spPr/>
    </dgm:pt>
    <dgm:pt modelId="{6BE34653-D3E7-430E-B300-9C5026258855}" type="pres">
      <dgm:prSet presAssocID="{E966C427-D80A-46E6-BC39-7B7300B45397}" presName="desTx" presStyleLbl="revTx" presStyleIdx="2" presStyleCnt="5">
        <dgm:presLayoutVars/>
      </dgm:prSet>
      <dgm:spPr/>
    </dgm:pt>
    <dgm:pt modelId="{27CB34D6-1634-4FD2-91A9-7E304B45B2C8}" type="pres">
      <dgm:prSet presAssocID="{8E33A324-BDF0-4C0D-9FCA-8F7D9D6189C4}" presName="sibTrans" presStyleCnt="0"/>
      <dgm:spPr/>
    </dgm:pt>
    <dgm:pt modelId="{92A31915-B09F-4FC0-97C4-E754EE5B222A}" type="pres">
      <dgm:prSet presAssocID="{F8FF7318-1B97-4269-AECC-393BE8F67CE7}" presName="compNode" presStyleCnt="0"/>
      <dgm:spPr/>
    </dgm:pt>
    <dgm:pt modelId="{415B3723-CE08-4C65-9407-FEEBD7B84BBE}" type="pres">
      <dgm:prSet presAssocID="{F8FF7318-1B97-4269-AECC-393BE8F67CE7}" presName="bgRect" presStyleLbl="bgShp" presStyleIdx="2" presStyleCnt="3"/>
      <dgm:spPr/>
    </dgm:pt>
    <dgm:pt modelId="{C7655AAF-641B-4F83-8EC3-5248421501E1}" type="pres">
      <dgm:prSet presAssocID="{F8FF7318-1B97-4269-AECC-393BE8F67CE7}" presName="iconRect" presStyleLbl="node1" presStyleIdx="2" presStyleCnt="3"/>
      <dgm:spPr>
        <a:blipFill>
          <a:blip xmlns:r="http://schemas.openxmlformats.org/officeDocument/2006/relationships"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a:blipFill>
        <a:ln>
          <a:noFill/>
        </a:ln>
      </dgm:spPr>
      <dgm:extLst>
        <a:ext uri="{E40237B7-FDA0-4F09-8148-C483321AD2D9}">
          <dgm14:cNvPr xmlns:dgm14="http://schemas.microsoft.com/office/drawing/2010/diagram" id="0" name="" descr="Brain in head"/>
        </a:ext>
      </dgm:extLst>
    </dgm:pt>
    <dgm:pt modelId="{D3C1545F-9CFF-4635-861E-D39186B11B88}" type="pres">
      <dgm:prSet presAssocID="{F8FF7318-1B97-4269-AECC-393BE8F67CE7}" presName="spaceRect" presStyleCnt="0"/>
      <dgm:spPr/>
    </dgm:pt>
    <dgm:pt modelId="{5B66E54E-C57B-4BBD-B604-7AC92B15DFF5}" type="pres">
      <dgm:prSet presAssocID="{F8FF7318-1B97-4269-AECC-393BE8F67CE7}" presName="parTx" presStyleLbl="revTx" presStyleIdx="3" presStyleCnt="5">
        <dgm:presLayoutVars>
          <dgm:chMax val="0"/>
          <dgm:chPref val="0"/>
        </dgm:presLayoutVars>
      </dgm:prSet>
      <dgm:spPr/>
    </dgm:pt>
    <dgm:pt modelId="{9AC9D6E7-674C-4EE9-9239-3BF2C610BAEE}" type="pres">
      <dgm:prSet presAssocID="{F8FF7318-1B97-4269-AECC-393BE8F67CE7}" presName="desTx" presStyleLbl="revTx" presStyleIdx="4" presStyleCnt="5" custScaleX="125234">
        <dgm:presLayoutVars/>
      </dgm:prSet>
      <dgm:spPr/>
    </dgm:pt>
  </dgm:ptLst>
  <dgm:cxnLst>
    <dgm:cxn modelId="{3471170A-88F9-480F-AF74-0AE2A2163091}" srcId="{F8FF7318-1B97-4269-AECC-393BE8F67CE7}" destId="{CD07A3C5-5C01-456A-B651-9783D815F1D2}" srcOrd="1" destOrd="0" parTransId="{E92D29EA-42CE-492F-8196-4EDACB74AF2E}" sibTransId="{0D786206-6C2B-43C4-8573-CB8D7CE3B4D4}"/>
    <dgm:cxn modelId="{FF11BC50-C750-4BB0-8985-C8306305C6BC}" type="presOf" srcId="{E966C427-D80A-46E6-BC39-7B7300B45397}" destId="{2AC88B4C-6FE4-4273-B787-2793A0E51EFC}" srcOrd="0" destOrd="0" presId="urn:microsoft.com/office/officeart/2018/2/layout/IconVerticalSolidList"/>
    <dgm:cxn modelId="{27A21A55-71A4-4647-9583-E1EDDB888ADB}" type="presOf" srcId="{20BC496F-E866-48B2-9E71-ED055B7BC057}" destId="{9AC9D6E7-674C-4EE9-9239-3BF2C610BAEE}" srcOrd="0" destOrd="0" presId="urn:microsoft.com/office/officeart/2018/2/layout/IconVerticalSolidList"/>
    <dgm:cxn modelId="{BD91A57B-0A83-448F-8E88-2F5AEB6EBAD4}" type="presOf" srcId="{715FE384-23B7-4DAA-923E-B76170318C86}" destId="{6BE34653-D3E7-430E-B300-9C5026258855}" srcOrd="0" destOrd="1" presId="urn:microsoft.com/office/officeart/2018/2/layout/IconVerticalSolidList"/>
    <dgm:cxn modelId="{E1156788-AA15-4E4C-AC58-1501890AF9DF}" type="presOf" srcId="{3DF5A36A-933E-4F4C-B167-347EF37923B1}" destId="{298532AE-009A-467A-AFA8-CC787A4364A9}" srcOrd="0" destOrd="0" presId="urn:microsoft.com/office/officeart/2018/2/layout/IconVerticalSolidList"/>
    <dgm:cxn modelId="{633B6B89-05FE-4B9A-9F76-9B8D7E65CED9}" type="presOf" srcId="{29B4AD64-224F-44AC-A007-13D8D01FF3BD}" destId="{6BE34653-D3E7-430E-B300-9C5026258855}" srcOrd="0" destOrd="0" presId="urn:microsoft.com/office/officeart/2018/2/layout/IconVerticalSolidList"/>
    <dgm:cxn modelId="{0E5D4E8B-0F9A-48C6-A9E9-3C576CAEA675}" type="presOf" srcId="{C81B2EB7-8942-4689-AE1E-2319D9A84A0C}" destId="{9AC9D6E7-674C-4EE9-9239-3BF2C610BAEE}" srcOrd="0" destOrd="2" presId="urn:microsoft.com/office/officeart/2018/2/layout/IconVerticalSolidList"/>
    <dgm:cxn modelId="{AE24E98E-E27C-4C89-9103-5EB820C5D42B}" srcId="{F8FF7318-1B97-4269-AECC-393BE8F67CE7}" destId="{20BC496F-E866-48B2-9E71-ED055B7BC057}" srcOrd="0" destOrd="0" parTransId="{40F5350E-A295-43D8-AE20-93BB91898D30}" sibTransId="{3AA9C5F4-EDAB-42E9-BC36-6A44424D02C3}"/>
    <dgm:cxn modelId="{B0E39D9B-1614-40F0-82F8-67E5F0720AB6}" type="presOf" srcId="{AB480724-AA33-4774-97AB-ED4F2ED61051}" destId="{9DC03AEC-D9DA-4F40-AF8A-65A415DE7EA7}" srcOrd="0" destOrd="0" presId="urn:microsoft.com/office/officeart/2018/2/layout/IconVerticalSolidList"/>
    <dgm:cxn modelId="{AEF8F1A4-5DB7-4A44-BC2C-B05DBB86EE22}" srcId="{E966C427-D80A-46E6-BC39-7B7300B45397}" destId="{29B4AD64-224F-44AC-A007-13D8D01FF3BD}" srcOrd="0" destOrd="0" parTransId="{DE054AC7-899E-4D44-B28E-8CF2A69A7345}" sibTransId="{B82482C9-BD83-4ED4-98E6-06CF8F923BE7}"/>
    <dgm:cxn modelId="{947FF8AD-C27D-47F3-B3BF-82331DC12532}" srcId="{AB480724-AA33-4774-97AB-ED4F2ED61051}" destId="{3DF5A36A-933E-4F4C-B167-347EF37923B1}" srcOrd="0" destOrd="0" parTransId="{9C9522BB-7B23-4725-B6B6-C984073C9B6D}" sibTransId="{C38BC46D-1C22-49A9-98B8-F23FE0CE91C8}"/>
    <dgm:cxn modelId="{770742B4-7FDD-42F1-AF34-876AD950EAEB}" srcId="{AB480724-AA33-4774-97AB-ED4F2ED61051}" destId="{E966C427-D80A-46E6-BC39-7B7300B45397}" srcOrd="1" destOrd="0" parTransId="{5596BD3C-9C0E-41C4-A96B-91CE7F2CF8A8}" sibTransId="{8E33A324-BDF0-4C0D-9FCA-8F7D9D6189C4}"/>
    <dgm:cxn modelId="{019B22BA-78A4-4A42-97C5-3BFA1FCD4072}" srcId="{E966C427-D80A-46E6-BC39-7B7300B45397}" destId="{715FE384-23B7-4DAA-923E-B76170318C86}" srcOrd="1" destOrd="0" parTransId="{E586EAB2-3C00-449E-8F90-02336EC7A565}" sibTransId="{4588FDC4-A4D2-46CD-9E51-56F912F1C3BB}"/>
    <dgm:cxn modelId="{FC5B28D2-4075-49E2-AADB-8B08417BBE51}" type="presOf" srcId="{C4BA5111-D28D-46CC-AC8A-756D45075964}" destId="{9AC9D6E7-674C-4EE9-9239-3BF2C610BAEE}" srcOrd="0" destOrd="3" presId="urn:microsoft.com/office/officeart/2018/2/layout/IconVerticalSolidList"/>
    <dgm:cxn modelId="{2FB047DB-E2DE-4E2B-BBA6-93DB3695304C}" type="presOf" srcId="{F8FF7318-1B97-4269-AECC-393BE8F67CE7}" destId="{5B66E54E-C57B-4BBD-B604-7AC92B15DFF5}" srcOrd="0" destOrd="0" presId="urn:microsoft.com/office/officeart/2018/2/layout/IconVerticalSolidList"/>
    <dgm:cxn modelId="{953E46DD-6027-4BAE-9FCC-EB74E25E7361}" srcId="{F8FF7318-1B97-4269-AECC-393BE8F67CE7}" destId="{C81B2EB7-8942-4689-AE1E-2319D9A84A0C}" srcOrd="2" destOrd="0" parTransId="{4B15936D-B6B9-484A-A405-F830255051F7}" sibTransId="{4125A225-3DD3-41BF-A049-7A89470E5873}"/>
    <dgm:cxn modelId="{3A83A2E5-6F1B-45F4-A1F7-B763E072B331}" srcId="{F8FF7318-1B97-4269-AECC-393BE8F67CE7}" destId="{C4BA5111-D28D-46CC-AC8A-756D45075964}" srcOrd="3" destOrd="0" parTransId="{1712EC25-DBE9-495D-B10C-A0DD4657B858}" sibTransId="{F98B09AB-8C3F-4FE2-83E7-852E401882BD}"/>
    <dgm:cxn modelId="{1C5E90F2-EAC3-4F94-AC5A-1C16B451246A}" srcId="{AB480724-AA33-4774-97AB-ED4F2ED61051}" destId="{F8FF7318-1B97-4269-AECC-393BE8F67CE7}" srcOrd="2" destOrd="0" parTransId="{E8171FF0-EF96-4280-AAAD-645A687CECF5}" sibTransId="{0FCDF1D2-A603-4C80-A721-3B07FA2FEB67}"/>
    <dgm:cxn modelId="{EE6830F6-293D-4909-B428-343DA7E277A2}" type="presOf" srcId="{CD07A3C5-5C01-456A-B651-9783D815F1D2}" destId="{9AC9D6E7-674C-4EE9-9239-3BF2C610BAEE}" srcOrd="0" destOrd="1" presId="urn:microsoft.com/office/officeart/2018/2/layout/IconVerticalSolidList"/>
    <dgm:cxn modelId="{CD5376C5-E8AF-452A-B222-CC8D1E72CA6D}" type="presParOf" srcId="{9DC03AEC-D9DA-4F40-AF8A-65A415DE7EA7}" destId="{F839A06F-9589-4B35-8BC0-D697C8898EB0}" srcOrd="0" destOrd="0" presId="urn:microsoft.com/office/officeart/2018/2/layout/IconVerticalSolidList"/>
    <dgm:cxn modelId="{85A4030B-9259-42D6-A96D-729EDD6C9144}" type="presParOf" srcId="{F839A06F-9589-4B35-8BC0-D697C8898EB0}" destId="{4D98EFF5-8E79-4395-AD45-054A1A4D6AE3}" srcOrd="0" destOrd="0" presId="urn:microsoft.com/office/officeart/2018/2/layout/IconVerticalSolidList"/>
    <dgm:cxn modelId="{86CEEECA-9DF6-4CDD-BDC6-20FF7DBF29AE}" type="presParOf" srcId="{F839A06F-9589-4B35-8BC0-D697C8898EB0}" destId="{E96C1EA4-8FF1-4007-9108-3509BC24936D}" srcOrd="1" destOrd="0" presId="urn:microsoft.com/office/officeart/2018/2/layout/IconVerticalSolidList"/>
    <dgm:cxn modelId="{9116F515-C930-4153-AFFD-5F3FC831742D}" type="presParOf" srcId="{F839A06F-9589-4B35-8BC0-D697C8898EB0}" destId="{15A5C609-F45C-4C9A-9F1F-200717138EF8}" srcOrd="2" destOrd="0" presId="urn:microsoft.com/office/officeart/2018/2/layout/IconVerticalSolidList"/>
    <dgm:cxn modelId="{7EF8ABD4-FF7A-4E0E-8B33-CD68B983C436}" type="presParOf" srcId="{F839A06F-9589-4B35-8BC0-D697C8898EB0}" destId="{298532AE-009A-467A-AFA8-CC787A4364A9}" srcOrd="3" destOrd="0" presId="urn:microsoft.com/office/officeart/2018/2/layout/IconVerticalSolidList"/>
    <dgm:cxn modelId="{D760EAAE-6A1E-4183-B8DC-A5890D1CE981}" type="presParOf" srcId="{9DC03AEC-D9DA-4F40-AF8A-65A415DE7EA7}" destId="{5BA77DC3-CA51-47D9-8239-302371830801}" srcOrd="1" destOrd="0" presId="urn:microsoft.com/office/officeart/2018/2/layout/IconVerticalSolidList"/>
    <dgm:cxn modelId="{088CDE2E-AB22-4566-AE55-828704FEFC3B}" type="presParOf" srcId="{9DC03AEC-D9DA-4F40-AF8A-65A415DE7EA7}" destId="{C9629357-66FD-4B04-B9A0-CE6EB59B33AA}" srcOrd="2" destOrd="0" presId="urn:microsoft.com/office/officeart/2018/2/layout/IconVerticalSolidList"/>
    <dgm:cxn modelId="{C43183EA-5555-4E75-B74D-249CA247AA36}" type="presParOf" srcId="{C9629357-66FD-4B04-B9A0-CE6EB59B33AA}" destId="{F761A3C3-1388-4438-ACBA-D84868CC9FD8}" srcOrd="0" destOrd="0" presId="urn:microsoft.com/office/officeart/2018/2/layout/IconVerticalSolidList"/>
    <dgm:cxn modelId="{7046B3D6-6179-41C9-9210-DA7077E56155}" type="presParOf" srcId="{C9629357-66FD-4B04-B9A0-CE6EB59B33AA}" destId="{9D12D4A9-0468-4AD5-BAAC-55FF3C0F4D06}" srcOrd="1" destOrd="0" presId="urn:microsoft.com/office/officeart/2018/2/layout/IconVerticalSolidList"/>
    <dgm:cxn modelId="{32376001-5220-4819-851E-6F153B0E043B}" type="presParOf" srcId="{C9629357-66FD-4B04-B9A0-CE6EB59B33AA}" destId="{17EFE177-616A-4FD8-94A1-9646CE7E16AD}" srcOrd="2" destOrd="0" presId="urn:microsoft.com/office/officeart/2018/2/layout/IconVerticalSolidList"/>
    <dgm:cxn modelId="{6394A552-25FB-41EF-BE62-1743A4C69E40}" type="presParOf" srcId="{C9629357-66FD-4B04-B9A0-CE6EB59B33AA}" destId="{2AC88B4C-6FE4-4273-B787-2793A0E51EFC}" srcOrd="3" destOrd="0" presId="urn:microsoft.com/office/officeart/2018/2/layout/IconVerticalSolidList"/>
    <dgm:cxn modelId="{B4E41AC9-F78D-4ADC-89C7-7D11D38016E7}" type="presParOf" srcId="{C9629357-66FD-4B04-B9A0-CE6EB59B33AA}" destId="{6BE34653-D3E7-430E-B300-9C5026258855}" srcOrd="4" destOrd="0" presId="urn:microsoft.com/office/officeart/2018/2/layout/IconVerticalSolidList"/>
    <dgm:cxn modelId="{E5B23418-E469-4465-8225-1BFEAF038921}" type="presParOf" srcId="{9DC03AEC-D9DA-4F40-AF8A-65A415DE7EA7}" destId="{27CB34D6-1634-4FD2-91A9-7E304B45B2C8}" srcOrd="3" destOrd="0" presId="urn:microsoft.com/office/officeart/2018/2/layout/IconVerticalSolidList"/>
    <dgm:cxn modelId="{912B131F-D918-424B-9A99-3E3C762920CB}" type="presParOf" srcId="{9DC03AEC-D9DA-4F40-AF8A-65A415DE7EA7}" destId="{92A31915-B09F-4FC0-97C4-E754EE5B222A}" srcOrd="4" destOrd="0" presId="urn:microsoft.com/office/officeart/2018/2/layout/IconVerticalSolidList"/>
    <dgm:cxn modelId="{BF73CE41-B932-4DF1-B9D7-E9A6B3EC7E42}" type="presParOf" srcId="{92A31915-B09F-4FC0-97C4-E754EE5B222A}" destId="{415B3723-CE08-4C65-9407-FEEBD7B84BBE}" srcOrd="0" destOrd="0" presId="urn:microsoft.com/office/officeart/2018/2/layout/IconVerticalSolidList"/>
    <dgm:cxn modelId="{CD116740-03B8-4B1E-BFC8-4054DD92AB5C}" type="presParOf" srcId="{92A31915-B09F-4FC0-97C4-E754EE5B222A}" destId="{C7655AAF-641B-4F83-8EC3-5248421501E1}" srcOrd="1" destOrd="0" presId="urn:microsoft.com/office/officeart/2018/2/layout/IconVerticalSolidList"/>
    <dgm:cxn modelId="{BE62941B-1E01-42FC-BD21-854D642722F0}" type="presParOf" srcId="{92A31915-B09F-4FC0-97C4-E754EE5B222A}" destId="{D3C1545F-9CFF-4635-861E-D39186B11B88}" srcOrd="2" destOrd="0" presId="urn:microsoft.com/office/officeart/2018/2/layout/IconVerticalSolidList"/>
    <dgm:cxn modelId="{9286C021-E4E5-491A-BC54-3B52A898FFE5}" type="presParOf" srcId="{92A31915-B09F-4FC0-97C4-E754EE5B222A}" destId="{5B66E54E-C57B-4BBD-B604-7AC92B15DFF5}" srcOrd="3" destOrd="0" presId="urn:microsoft.com/office/officeart/2018/2/layout/IconVerticalSolidList"/>
    <dgm:cxn modelId="{AC76D604-1504-4BB1-B3CB-C7D61458F0F3}" type="presParOf" srcId="{92A31915-B09F-4FC0-97C4-E754EE5B222A}" destId="{9AC9D6E7-674C-4EE9-9239-3BF2C610BAEE}" srcOrd="4" destOrd="0" presId="urn:microsoft.com/office/officeart/2018/2/layout/IconVerticalSolidList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5.xml><?xml version="1.0" encoding="utf-8"?>
<dgm:dataModel xmlns:dgm="http://schemas.openxmlformats.org/drawingml/2006/diagram" xmlns:a="http://schemas.openxmlformats.org/drawingml/2006/main">
  <dgm:ptLst>
    <dgm:pt modelId="{BEDBD513-6345-4338-9AF4-9553E9C3A1F1}" type="doc">
      <dgm:prSet loTypeId="urn:microsoft.com/office/officeart/2005/8/layout/process4" loCatId="process" qsTypeId="urn:microsoft.com/office/officeart/2005/8/quickstyle/simple4" qsCatId="simple" csTypeId="urn:microsoft.com/office/officeart/2005/8/colors/colorful2" csCatId="colorful" phldr="1"/>
      <dgm:spPr/>
      <dgm:t>
        <a:bodyPr/>
        <a:lstStyle/>
        <a:p>
          <a:endParaRPr lang="en-US"/>
        </a:p>
      </dgm:t>
    </dgm:pt>
    <dgm:pt modelId="{D8AAFEEC-66B1-4133-8DD5-BF76EDBC3C24}">
      <dgm:prSet/>
      <dgm:spPr>
        <a:solidFill>
          <a:schemeClr val="accent1"/>
        </a:solidFill>
      </dgm:spPr>
      <dgm:t>
        <a:bodyPr/>
        <a:lstStyle/>
        <a:p>
          <a:r>
            <a:rPr 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rPr>
            <a:t>Two main types of hormone therapies</a:t>
          </a:r>
        </a:p>
      </dgm:t>
    </dgm:pt>
    <dgm:pt modelId="{D74B5799-ED54-47D0-BA41-232222AEBA44}" type="parTrans" cxnId="{49128B1C-9839-415E-91B5-BAED153DE1F0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EA5E144A-E9C7-4A59-8C1E-6ED8FBC5F70C}" type="sibTrans" cxnId="{49128B1C-9839-415E-91B5-BAED153DE1F0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7259EE2-6CBD-4BB7-96B4-CCD8D73B9AAE}">
      <dgm:prSet/>
      <dgm:spPr/>
      <dgm:t>
        <a:bodyPr/>
        <a:lstStyle/>
        <a:p>
          <a:r>
            <a:rPr lang="en-US" dirty="0">
              <a:latin typeface="Arial" panose="020B0604020202020204" pitchFamily="34" charset="0"/>
              <a:cs typeface="Arial" panose="020B0604020202020204" pitchFamily="34" charset="0"/>
            </a:rPr>
            <a:t>Drugs that </a:t>
          </a:r>
          <a:r>
            <a:rPr lang="en-US" b="1" dirty="0">
              <a:latin typeface="Arial" panose="020B0604020202020204" pitchFamily="34" charset="0"/>
              <a:cs typeface="Arial" panose="020B0604020202020204" pitchFamily="34" charset="0"/>
            </a:rPr>
            <a:t>block</a:t>
          </a:r>
          <a:r>
            <a:rPr lang="en-US" dirty="0">
              <a:latin typeface="Arial" panose="020B0604020202020204" pitchFamily="34" charset="0"/>
              <a:cs typeface="Arial" panose="020B0604020202020204" pitchFamily="34" charset="0"/>
            </a:rPr>
            <a:t> the body’s ability to produce hormones.</a:t>
          </a:r>
        </a:p>
      </dgm:t>
    </dgm:pt>
    <dgm:pt modelId="{0C8FF512-4B55-44B2-8890-F91991D7DBFD}" type="parTrans" cxnId="{51AC6284-9ED0-426A-9954-05EE35858B65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2371A05-AC4F-4032-AEE9-9F2E9BDAFDA7}" type="sibTrans" cxnId="{51AC6284-9ED0-426A-9954-05EE35858B65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92AD7FE-E313-404E-8033-B6DCA7950F7F}">
      <dgm:prSet/>
      <dgm:spPr/>
      <dgm:t>
        <a:bodyPr/>
        <a:lstStyle/>
        <a:p>
          <a:r>
            <a:rPr lang="en-US" dirty="0">
              <a:latin typeface="Arial" panose="020B0604020202020204" pitchFamily="34" charset="0"/>
              <a:cs typeface="Arial" panose="020B0604020202020204" pitchFamily="34" charset="0"/>
            </a:rPr>
            <a:t>Drugs that </a:t>
          </a:r>
          <a:r>
            <a:rPr lang="en-US" b="1" dirty="0">
              <a:latin typeface="Arial" panose="020B0604020202020204" pitchFamily="34" charset="0"/>
              <a:cs typeface="Arial" panose="020B0604020202020204" pitchFamily="34" charset="0"/>
            </a:rPr>
            <a:t>interfere</a:t>
          </a:r>
          <a:r>
            <a:rPr lang="en-US" dirty="0">
              <a:latin typeface="Arial" panose="020B0604020202020204" pitchFamily="34" charset="0"/>
              <a:cs typeface="Arial" panose="020B0604020202020204" pitchFamily="34" charset="0"/>
            </a:rPr>
            <a:t> with how hormones behave in the body.</a:t>
          </a:r>
        </a:p>
      </dgm:t>
    </dgm:pt>
    <dgm:pt modelId="{48256A9E-FFD2-434C-A2E1-7B26F65330A8}" type="parTrans" cxnId="{3B653A6E-FD82-470A-B0F3-CEF2C1715B69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C2CBF4FD-9B57-492B-8F32-A7A15F3B2CDE}" type="sibTrans" cxnId="{3B653A6E-FD82-470A-B0F3-CEF2C1715B69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A3C95FA-14D7-412E-A1C8-6CB84280DC97}">
      <dgm:prSet/>
      <dgm:spPr>
        <a:solidFill>
          <a:schemeClr val="accent2"/>
        </a:solidFill>
      </dgm:spPr>
      <dgm:t>
        <a:bodyPr/>
        <a:lstStyle/>
        <a:p>
          <a:r>
            <a:rPr lang="en-US" dirty="0">
              <a:solidFill>
                <a:schemeClr val="tx1">
                  <a:lumMod val="85000"/>
                  <a:lumOff val="1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rPr>
            <a:t>Because cancer cells use hormones to grow, these drugs greatly inhibit a cancer cell’s ability to grow.</a:t>
          </a:r>
        </a:p>
      </dgm:t>
    </dgm:pt>
    <dgm:pt modelId="{10BC431B-7E8C-4E4A-A5CE-50F274691764}" type="parTrans" cxnId="{9BC7C95F-E820-4442-9026-408667F486B4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A941E07-2460-4793-B65F-B9E726960947}" type="sibTrans" cxnId="{9BC7C95F-E820-4442-9026-408667F486B4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808D125-AC5D-1549-88A7-0DE196718B8D}" type="pres">
      <dgm:prSet presAssocID="{BEDBD513-6345-4338-9AF4-9553E9C3A1F1}" presName="Name0" presStyleCnt="0">
        <dgm:presLayoutVars>
          <dgm:dir/>
          <dgm:animLvl val="lvl"/>
          <dgm:resizeHandles val="exact"/>
        </dgm:presLayoutVars>
      </dgm:prSet>
      <dgm:spPr/>
    </dgm:pt>
    <dgm:pt modelId="{242B20A2-0558-3B4B-8F70-B222BB93C87D}" type="pres">
      <dgm:prSet presAssocID="{0A3C95FA-14D7-412E-A1C8-6CB84280DC97}" presName="boxAndChildren" presStyleCnt="0"/>
      <dgm:spPr/>
    </dgm:pt>
    <dgm:pt modelId="{4F529C9B-0BBB-2A41-BE83-5846CC908621}" type="pres">
      <dgm:prSet presAssocID="{0A3C95FA-14D7-412E-A1C8-6CB84280DC97}" presName="parentTextBox" presStyleLbl="node1" presStyleIdx="0" presStyleCnt="2"/>
      <dgm:spPr/>
    </dgm:pt>
    <dgm:pt modelId="{FBD716C8-CB16-EA4C-902F-533A5544E491}" type="pres">
      <dgm:prSet presAssocID="{EA5E144A-E9C7-4A59-8C1E-6ED8FBC5F70C}" presName="sp" presStyleCnt="0"/>
      <dgm:spPr/>
    </dgm:pt>
    <dgm:pt modelId="{6426A392-DD1B-C94C-A659-AF248E790983}" type="pres">
      <dgm:prSet presAssocID="{D8AAFEEC-66B1-4133-8DD5-BF76EDBC3C24}" presName="arrowAndChildren" presStyleCnt="0"/>
      <dgm:spPr/>
    </dgm:pt>
    <dgm:pt modelId="{31DC9C37-8B41-9B47-A29D-E835CA0FBAA5}" type="pres">
      <dgm:prSet presAssocID="{D8AAFEEC-66B1-4133-8DD5-BF76EDBC3C24}" presName="parentTextArrow" presStyleLbl="node1" presStyleIdx="0" presStyleCnt="2"/>
      <dgm:spPr/>
    </dgm:pt>
    <dgm:pt modelId="{795E3102-D915-AA46-9C92-BCF062CC656C}" type="pres">
      <dgm:prSet presAssocID="{D8AAFEEC-66B1-4133-8DD5-BF76EDBC3C24}" presName="arrow" presStyleLbl="node1" presStyleIdx="1" presStyleCnt="2"/>
      <dgm:spPr/>
    </dgm:pt>
    <dgm:pt modelId="{75258458-5FC4-0B40-8A6D-44026A4415D9}" type="pres">
      <dgm:prSet presAssocID="{D8AAFEEC-66B1-4133-8DD5-BF76EDBC3C24}" presName="descendantArrow" presStyleCnt="0"/>
      <dgm:spPr/>
    </dgm:pt>
    <dgm:pt modelId="{60800158-254E-B74B-92A9-3222883C37BC}" type="pres">
      <dgm:prSet presAssocID="{57259EE2-6CBD-4BB7-96B4-CCD8D73B9AAE}" presName="childTextArrow" presStyleLbl="fgAccFollowNode1" presStyleIdx="0" presStyleCnt="2">
        <dgm:presLayoutVars>
          <dgm:bulletEnabled val="1"/>
        </dgm:presLayoutVars>
      </dgm:prSet>
      <dgm:spPr/>
    </dgm:pt>
    <dgm:pt modelId="{AE8D45A1-4B4C-8645-9C35-97ED0F39A8F6}" type="pres">
      <dgm:prSet presAssocID="{192AD7FE-E313-404E-8033-B6DCA7950F7F}" presName="childTextArrow" presStyleLbl="fgAccFollowNode1" presStyleIdx="1" presStyleCnt="2">
        <dgm:presLayoutVars>
          <dgm:bulletEnabled val="1"/>
        </dgm:presLayoutVars>
      </dgm:prSet>
      <dgm:spPr/>
    </dgm:pt>
  </dgm:ptLst>
  <dgm:cxnLst>
    <dgm:cxn modelId="{0367F403-3BC7-114B-BDB4-2BF69925C9D6}" type="presOf" srcId="{0A3C95FA-14D7-412E-A1C8-6CB84280DC97}" destId="{4F529C9B-0BBB-2A41-BE83-5846CC908621}" srcOrd="0" destOrd="0" presId="urn:microsoft.com/office/officeart/2005/8/layout/process4"/>
    <dgm:cxn modelId="{49128B1C-9839-415E-91B5-BAED153DE1F0}" srcId="{BEDBD513-6345-4338-9AF4-9553E9C3A1F1}" destId="{D8AAFEEC-66B1-4133-8DD5-BF76EDBC3C24}" srcOrd="0" destOrd="0" parTransId="{D74B5799-ED54-47D0-BA41-232222AEBA44}" sibTransId="{EA5E144A-E9C7-4A59-8C1E-6ED8FBC5F70C}"/>
    <dgm:cxn modelId="{9BC7C95F-E820-4442-9026-408667F486B4}" srcId="{BEDBD513-6345-4338-9AF4-9553E9C3A1F1}" destId="{0A3C95FA-14D7-412E-A1C8-6CB84280DC97}" srcOrd="1" destOrd="0" parTransId="{10BC431B-7E8C-4E4A-A5CE-50F274691764}" sibTransId="{3A941E07-2460-4793-B65F-B9E726960947}"/>
    <dgm:cxn modelId="{3B653A6E-FD82-470A-B0F3-CEF2C1715B69}" srcId="{D8AAFEEC-66B1-4133-8DD5-BF76EDBC3C24}" destId="{192AD7FE-E313-404E-8033-B6DCA7950F7F}" srcOrd="1" destOrd="0" parTransId="{48256A9E-FFD2-434C-A2E1-7B26F65330A8}" sibTransId="{C2CBF4FD-9B57-492B-8F32-A7A15F3B2CDE}"/>
    <dgm:cxn modelId="{51AC6284-9ED0-426A-9954-05EE35858B65}" srcId="{D8AAFEEC-66B1-4133-8DD5-BF76EDBC3C24}" destId="{57259EE2-6CBD-4BB7-96B4-CCD8D73B9AAE}" srcOrd="0" destOrd="0" parTransId="{0C8FF512-4B55-44B2-8890-F91991D7DBFD}" sibTransId="{02371A05-AC4F-4032-AEE9-9F2E9BDAFDA7}"/>
    <dgm:cxn modelId="{B4E6E29B-641B-7644-B435-09FBD45504C0}" type="presOf" srcId="{D8AAFEEC-66B1-4133-8DD5-BF76EDBC3C24}" destId="{31DC9C37-8B41-9B47-A29D-E835CA0FBAA5}" srcOrd="0" destOrd="0" presId="urn:microsoft.com/office/officeart/2005/8/layout/process4"/>
    <dgm:cxn modelId="{3D29CBAD-5CC3-A646-A90F-715495406D03}" type="presOf" srcId="{192AD7FE-E313-404E-8033-B6DCA7950F7F}" destId="{AE8D45A1-4B4C-8645-9C35-97ED0F39A8F6}" srcOrd="0" destOrd="0" presId="urn:microsoft.com/office/officeart/2005/8/layout/process4"/>
    <dgm:cxn modelId="{ACC2FBB1-935D-9740-A1DE-7469DA70C0B6}" type="presOf" srcId="{BEDBD513-6345-4338-9AF4-9553E9C3A1F1}" destId="{8808D125-AC5D-1549-88A7-0DE196718B8D}" srcOrd="0" destOrd="0" presId="urn:microsoft.com/office/officeart/2005/8/layout/process4"/>
    <dgm:cxn modelId="{867C3ABC-48F9-AB4B-8051-DDA56563A80B}" type="presOf" srcId="{D8AAFEEC-66B1-4133-8DD5-BF76EDBC3C24}" destId="{795E3102-D915-AA46-9C92-BCF062CC656C}" srcOrd="1" destOrd="0" presId="urn:microsoft.com/office/officeart/2005/8/layout/process4"/>
    <dgm:cxn modelId="{8CA31AEC-70AC-DF41-9811-475933633D3A}" type="presOf" srcId="{57259EE2-6CBD-4BB7-96B4-CCD8D73B9AAE}" destId="{60800158-254E-B74B-92A9-3222883C37BC}" srcOrd="0" destOrd="0" presId="urn:microsoft.com/office/officeart/2005/8/layout/process4"/>
    <dgm:cxn modelId="{2D16D8DE-B8A9-FA43-AFEE-E22B87D47C06}" type="presParOf" srcId="{8808D125-AC5D-1549-88A7-0DE196718B8D}" destId="{242B20A2-0558-3B4B-8F70-B222BB93C87D}" srcOrd="0" destOrd="0" presId="urn:microsoft.com/office/officeart/2005/8/layout/process4"/>
    <dgm:cxn modelId="{A44CAB89-77D2-3445-8A4E-B9D154BA010B}" type="presParOf" srcId="{242B20A2-0558-3B4B-8F70-B222BB93C87D}" destId="{4F529C9B-0BBB-2A41-BE83-5846CC908621}" srcOrd="0" destOrd="0" presId="urn:microsoft.com/office/officeart/2005/8/layout/process4"/>
    <dgm:cxn modelId="{4A8613EC-4D5A-C14F-8C12-278A5456AEB8}" type="presParOf" srcId="{8808D125-AC5D-1549-88A7-0DE196718B8D}" destId="{FBD716C8-CB16-EA4C-902F-533A5544E491}" srcOrd="1" destOrd="0" presId="urn:microsoft.com/office/officeart/2005/8/layout/process4"/>
    <dgm:cxn modelId="{1CD2D678-EEE2-FC4D-80EA-38905614DCB5}" type="presParOf" srcId="{8808D125-AC5D-1549-88A7-0DE196718B8D}" destId="{6426A392-DD1B-C94C-A659-AF248E790983}" srcOrd="2" destOrd="0" presId="urn:microsoft.com/office/officeart/2005/8/layout/process4"/>
    <dgm:cxn modelId="{B64C4542-98A0-A046-A211-F19C71E05264}" type="presParOf" srcId="{6426A392-DD1B-C94C-A659-AF248E790983}" destId="{31DC9C37-8B41-9B47-A29D-E835CA0FBAA5}" srcOrd="0" destOrd="0" presId="urn:microsoft.com/office/officeart/2005/8/layout/process4"/>
    <dgm:cxn modelId="{3E3290D2-20B4-5C41-ACDC-716A84809ABB}" type="presParOf" srcId="{6426A392-DD1B-C94C-A659-AF248E790983}" destId="{795E3102-D915-AA46-9C92-BCF062CC656C}" srcOrd="1" destOrd="0" presId="urn:microsoft.com/office/officeart/2005/8/layout/process4"/>
    <dgm:cxn modelId="{78B835DB-8C46-3C40-B6F0-3465785593CF}" type="presParOf" srcId="{6426A392-DD1B-C94C-A659-AF248E790983}" destId="{75258458-5FC4-0B40-8A6D-44026A4415D9}" srcOrd="2" destOrd="0" presId="urn:microsoft.com/office/officeart/2005/8/layout/process4"/>
    <dgm:cxn modelId="{BD691D6C-44AE-9C42-80FE-E658E1C2D8C3}" type="presParOf" srcId="{75258458-5FC4-0B40-8A6D-44026A4415D9}" destId="{60800158-254E-B74B-92A9-3222883C37BC}" srcOrd="0" destOrd="0" presId="urn:microsoft.com/office/officeart/2005/8/layout/process4"/>
    <dgm:cxn modelId="{07125019-7E01-C345-9E93-DEA03902A528}" type="presParOf" srcId="{75258458-5FC4-0B40-8A6D-44026A4415D9}" destId="{AE8D45A1-4B4C-8645-9C35-97ED0F39A8F6}" srcOrd="1" destOrd="0" presId="urn:microsoft.com/office/officeart/2005/8/layout/process4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6.xml><?xml version="1.0" encoding="utf-8"?>
<dgm:dataModel xmlns:dgm="http://schemas.openxmlformats.org/drawingml/2006/diagram" xmlns:a="http://schemas.openxmlformats.org/drawingml/2006/main">
  <dgm:ptLst>
    <dgm:pt modelId="{6BB2CA03-ACA5-4FAE-868B-98B792A2A477}" type="doc">
      <dgm:prSet loTypeId="urn:microsoft.com/office/officeart/2005/8/layout/process4" loCatId="process" qsTypeId="urn:microsoft.com/office/officeart/2005/8/quickstyle/simple1" qsCatId="simple" csTypeId="urn:microsoft.com/office/officeart/2005/8/colors/accent3_2" csCatId="accent3"/>
      <dgm:spPr/>
      <dgm:t>
        <a:bodyPr/>
        <a:lstStyle/>
        <a:p>
          <a:endParaRPr lang="en-US"/>
        </a:p>
      </dgm:t>
    </dgm:pt>
    <dgm:pt modelId="{0D994436-A7D7-420A-B443-7F4A1FBC8E97}">
      <dgm:prSet/>
      <dgm:spPr/>
      <dgm:t>
        <a:bodyPr/>
        <a:lstStyle/>
        <a:p>
          <a:r>
            <a:rPr lang="en-US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rPr>
            <a:t>No!</a:t>
          </a:r>
          <a:r>
            <a:rPr lang="en-US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rPr>
            <a:t> Some treatments will work for some patients, while others won’t. </a:t>
          </a:r>
        </a:p>
      </dgm:t>
    </dgm:pt>
    <dgm:pt modelId="{0E45A4A3-B307-4BFD-85FD-C9993205C21C}" type="parTrans" cxnId="{313C49CA-3D4B-41C0-B5C8-8FEDEF34F3A2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AF661FE-2C3D-4FDF-B041-CB6A0A64CC3E}" type="sibTrans" cxnId="{313C49CA-3D4B-41C0-B5C8-8FEDEF34F3A2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5754D82-0658-4666-B5C1-65081384FF47}">
      <dgm:prSet/>
      <dgm:spPr/>
      <dgm:t>
        <a:bodyPr/>
        <a:lstStyle/>
        <a:p>
          <a:r>
            <a:rPr lang="en-US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rPr>
            <a:t>What causes these differences?</a:t>
          </a:r>
        </a:p>
      </dgm:t>
    </dgm:pt>
    <dgm:pt modelId="{DDB68CED-7C2C-4869-B76F-FF25DFFFEF80}" type="parTrans" cxnId="{EE325799-ECF6-4D24-8CFB-7833C8CE7B93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F0812178-6192-440B-ABF8-03C9E56D1614}" type="sibTrans" cxnId="{EE325799-ECF6-4D24-8CFB-7833C8CE7B93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8594DD1-C18E-4FA2-88C1-A37F28C574F4}">
      <dgm:prSet/>
      <dgm:spPr/>
      <dgm:t>
        <a:bodyPr/>
        <a:lstStyle/>
        <a:p>
          <a:r>
            <a:rPr lang="en-US">
              <a:latin typeface="Arial" panose="020B0604020202020204" pitchFamily="34" charset="0"/>
              <a:cs typeface="Arial" panose="020B0604020202020204" pitchFamily="34" charset="0"/>
            </a:rPr>
            <a:t>Genetics</a:t>
          </a:r>
        </a:p>
      </dgm:t>
    </dgm:pt>
    <dgm:pt modelId="{FB5654DC-EBD7-482E-9DB1-788C9B90B598}" type="parTrans" cxnId="{A94ED619-2FBB-424F-807F-11537BF3403E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296A685-2990-48C5-876C-14FB2DE2FF44}" type="sibTrans" cxnId="{A94ED619-2FBB-424F-807F-11537BF3403E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E4538DD3-39C8-4560-A2DA-1FA92BC0B91E}">
      <dgm:prSet/>
      <dgm:spPr/>
      <dgm:t>
        <a:bodyPr/>
        <a:lstStyle/>
        <a:p>
          <a:r>
            <a:rPr lang="en-US">
              <a:latin typeface="Arial" panose="020B0604020202020204" pitchFamily="34" charset="0"/>
              <a:cs typeface="Arial" panose="020B0604020202020204" pitchFamily="34" charset="0"/>
            </a:rPr>
            <a:t>Interactions of drugs and treatments with the body</a:t>
          </a:r>
        </a:p>
      </dgm:t>
    </dgm:pt>
    <dgm:pt modelId="{BCA80D8D-4402-4B80-813D-B94FAE64B5F1}" type="parTrans" cxnId="{CDC612F4-EE8C-409C-B0A7-FB43E891E015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C1F558D-EF86-4FAD-9EDF-5A0BDF344808}" type="sibTrans" cxnId="{CDC612F4-EE8C-409C-B0A7-FB43E891E015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199BA9F-3A54-4042-AA8B-788F6FF33B82}">
      <dgm:prSet/>
      <dgm:spPr/>
      <dgm:t>
        <a:bodyPr/>
        <a:lstStyle/>
        <a:p>
          <a:r>
            <a:rPr lang="en-US">
              <a:latin typeface="Arial" panose="020B0604020202020204" pitchFamily="34" charset="0"/>
              <a:cs typeface="Arial" panose="020B0604020202020204" pitchFamily="34" charset="0"/>
            </a:rPr>
            <a:t>Cancer and tumor type</a:t>
          </a:r>
        </a:p>
      </dgm:t>
    </dgm:pt>
    <dgm:pt modelId="{D2B80496-B41D-4006-9F5B-7DF8094A23BC}" type="parTrans" cxnId="{EC83BE24-C393-4750-A781-25073099C5B8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F81B2008-86E9-4648-A6A3-02645F875AD3}" type="sibTrans" cxnId="{EC83BE24-C393-4750-A781-25073099C5B8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B9CA619-220C-5A4E-B33F-EBFFC3B0EDD3}" type="pres">
      <dgm:prSet presAssocID="{6BB2CA03-ACA5-4FAE-868B-98B792A2A477}" presName="Name0" presStyleCnt="0">
        <dgm:presLayoutVars>
          <dgm:dir/>
          <dgm:animLvl val="lvl"/>
          <dgm:resizeHandles val="exact"/>
        </dgm:presLayoutVars>
      </dgm:prSet>
      <dgm:spPr/>
    </dgm:pt>
    <dgm:pt modelId="{B5DE9C1D-0712-7C40-B01E-3261C5FC3424}" type="pres">
      <dgm:prSet presAssocID="{65754D82-0658-4666-B5C1-65081384FF47}" presName="boxAndChildren" presStyleCnt="0"/>
      <dgm:spPr/>
    </dgm:pt>
    <dgm:pt modelId="{EDBC67F2-7B38-7F4B-A05D-C8EABD99FBFD}" type="pres">
      <dgm:prSet presAssocID="{65754D82-0658-4666-B5C1-65081384FF47}" presName="parentTextBox" presStyleLbl="node1" presStyleIdx="0" presStyleCnt="2"/>
      <dgm:spPr/>
    </dgm:pt>
    <dgm:pt modelId="{B08FD63D-F074-DE45-AC55-4F9470DEC614}" type="pres">
      <dgm:prSet presAssocID="{65754D82-0658-4666-B5C1-65081384FF47}" presName="entireBox" presStyleLbl="node1" presStyleIdx="0" presStyleCnt="2"/>
      <dgm:spPr/>
    </dgm:pt>
    <dgm:pt modelId="{792F05F7-F3AA-1C43-BBFC-66B8612572A4}" type="pres">
      <dgm:prSet presAssocID="{65754D82-0658-4666-B5C1-65081384FF47}" presName="descendantBox" presStyleCnt="0"/>
      <dgm:spPr/>
    </dgm:pt>
    <dgm:pt modelId="{91C61337-F8B0-1548-8ED4-F1515FDADD4E}" type="pres">
      <dgm:prSet presAssocID="{B8594DD1-C18E-4FA2-88C1-A37F28C574F4}" presName="childTextBox" presStyleLbl="fgAccFollowNode1" presStyleIdx="0" presStyleCnt="3">
        <dgm:presLayoutVars>
          <dgm:bulletEnabled val="1"/>
        </dgm:presLayoutVars>
      </dgm:prSet>
      <dgm:spPr/>
    </dgm:pt>
    <dgm:pt modelId="{5D6E6FEE-1495-E64F-9F21-F1F2440AB5D1}" type="pres">
      <dgm:prSet presAssocID="{E4538DD3-39C8-4560-A2DA-1FA92BC0B91E}" presName="childTextBox" presStyleLbl="fgAccFollowNode1" presStyleIdx="1" presStyleCnt="3">
        <dgm:presLayoutVars>
          <dgm:bulletEnabled val="1"/>
        </dgm:presLayoutVars>
      </dgm:prSet>
      <dgm:spPr/>
    </dgm:pt>
    <dgm:pt modelId="{D3D59393-533D-2E43-8626-59A3D8119A8A}" type="pres">
      <dgm:prSet presAssocID="{7199BA9F-3A54-4042-AA8B-788F6FF33B82}" presName="childTextBox" presStyleLbl="fgAccFollowNode1" presStyleIdx="2" presStyleCnt="3">
        <dgm:presLayoutVars>
          <dgm:bulletEnabled val="1"/>
        </dgm:presLayoutVars>
      </dgm:prSet>
      <dgm:spPr/>
    </dgm:pt>
    <dgm:pt modelId="{1A301FFB-2EE6-1D47-A872-551F377C0A68}" type="pres">
      <dgm:prSet presAssocID="{9AF661FE-2C3D-4FDF-B041-CB6A0A64CC3E}" presName="sp" presStyleCnt="0"/>
      <dgm:spPr/>
    </dgm:pt>
    <dgm:pt modelId="{228957E6-E24D-F246-B90D-ECED59B3BB5E}" type="pres">
      <dgm:prSet presAssocID="{0D994436-A7D7-420A-B443-7F4A1FBC8E97}" presName="arrowAndChildren" presStyleCnt="0"/>
      <dgm:spPr/>
    </dgm:pt>
    <dgm:pt modelId="{93657314-A251-5748-BE25-3EE59AC7C52F}" type="pres">
      <dgm:prSet presAssocID="{0D994436-A7D7-420A-B443-7F4A1FBC8E97}" presName="parentTextArrow" presStyleLbl="node1" presStyleIdx="1" presStyleCnt="2"/>
      <dgm:spPr/>
    </dgm:pt>
  </dgm:ptLst>
  <dgm:cxnLst>
    <dgm:cxn modelId="{A94ED619-2FBB-424F-807F-11537BF3403E}" srcId="{65754D82-0658-4666-B5C1-65081384FF47}" destId="{B8594DD1-C18E-4FA2-88C1-A37F28C574F4}" srcOrd="0" destOrd="0" parTransId="{FB5654DC-EBD7-482E-9DB1-788C9B90B598}" sibTransId="{3296A685-2990-48C5-876C-14FB2DE2FF44}"/>
    <dgm:cxn modelId="{EC83BE24-C393-4750-A781-25073099C5B8}" srcId="{65754D82-0658-4666-B5C1-65081384FF47}" destId="{7199BA9F-3A54-4042-AA8B-788F6FF33B82}" srcOrd="2" destOrd="0" parTransId="{D2B80496-B41D-4006-9F5B-7DF8094A23BC}" sibTransId="{F81B2008-86E9-4648-A6A3-02645F875AD3}"/>
    <dgm:cxn modelId="{0E285B2D-B4FA-D34C-A0B4-977083B87B85}" type="presOf" srcId="{65754D82-0658-4666-B5C1-65081384FF47}" destId="{EDBC67F2-7B38-7F4B-A05D-C8EABD99FBFD}" srcOrd="0" destOrd="0" presId="urn:microsoft.com/office/officeart/2005/8/layout/process4"/>
    <dgm:cxn modelId="{41769D5E-84CB-3B46-A331-9B57CF22447E}" type="presOf" srcId="{B8594DD1-C18E-4FA2-88C1-A37F28C574F4}" destId="{91C61337-F8B0-1548-8ED4-F1515FDADD4E}" srcOrd="0" destOrd="0" presId="urn:microsoft.com/office/officeart/2005/8/layout/process4"/>
    <dgm:cxn modelId="{24C58A61-A683-9B4C-BD8B-EE313F9C4205}" type="presOf" srcId="{65754D82-0658-4666-B5C1-65081384FF47}" destId="{B08FD63D-F074-DE45-AC55-4F9470DEC614}" srcOrd="1" destOrd="0" presId="urn:microsoft.com/office/officeart/2005/8/layout/process4"/>
    <dgm:cxn modelId="{D526868A-9090-B444-ACC5-45E13BB4CB87}" type="presOf" srcId="{7199BA9F-3A54-4042-AA8B-788F6FF33B82}" destId="{D3D59393-533D-2E43-8626-59A3D8119A8A}" srcOrd="0" destOrd="0" presId="urn:microsoft.com/office/officeart/2005/8/layout/process4"/>
    <dgm:cxn modelId="{EE325799-ECF6-4D24-8CFB-7833C8CE7B93}" srcId="{6BB2CA03-ACA5-4FAE-868B-98B792A2A477}" destId="{65754D82-0658-4666-B5C1-65081384FF47}" srcOrd="1" destOrd="0" parTransId="{DDB68CED-7C2C-4869-B76F-FF25DFFFEF80}" sibTransId="{F0812178-6192-440B-ABF8-03C9E56D1614}"/>
    <dgm:cxn modelId="{CAF8F0C3-202B-A74D-9FBF-8FFB1D8E1A2F}" type="presOf" srcId="{0D994436-A7D7-420A-B443-7F4A1FBC8E97}" destId="{93657314-A251-5748-BE25-3EE59AC7C52F}" srcOrd="0" destOrd="0" presId="urn:microsoft.com/office/officeart/2005/8/layout/process4"/>
    <dgm:cxn modelId="{313C49CA-3D4B-41C0-B5C8-8FEDEF34F3A2}" srcId="{6BB2CA03-ACA5-4FAE-868B-98B792A2A477}" destId="{0D994436-A7D7-420A-B443-7F4A1FBC8E97}" srcOrd="0" destOrd="0" parTransId="{0E45A4A3-B307-4BFD-85FD-C9993205C21C}" sibTransId="{9AF661FE-2C3D-4FDF-B041-CB6A0A64CC3E}"/>
    <dgm:cxn modelId="{83AFAFF3-7215-3240-A4F7-F7DD00785E61}" type="presOf" srcId="{E4538DD3-39C8-4560-A2DA-1FA92BC0B91E}" destId="{5D6E6FEE-1495-E64F-9F21-F1F2440AB5D1}" srcOrd="0" destOrd="0" presId="urn:microsoft.com/office/officeart/2005/8/layout/process4"/>
    <dgm:cxn modelId="{CDC612F4-EE8C-409C-B0A7-FB43E891E015}" srcId="{65754D82-0658-4666-B5C1-65081384FF47}" destId="{E4538DD3-39C8-4560-A2DA-1FA92BC0B91E}" srcOrd="1" destOrd="0" parTransId="{BCA80D8D-4402-4B80-813D-B94FAE64B5F1}" sibTransId="{0C1F558D-EF86-4FAD-9EDF-5A0BDF344808}"/>
    <dgm:cxn modelId="{A20066F7-5C9C-3049-82DE-C0ED235091F3}" type="presOf" srcId="{6BB2CA03-ACA5-4FAE-868B-98B792A2A477}" destId="{9B9CA619-220C-5A4E-B33F-EBFFC3B0EDD3}" srcOrd="0" destOrd="0" presId="urn:microsoft.com/office/officeart/2005/8/layout/process4"/>
    <dgm:cxn modelId="{26011C7D-C6AE-7E43-A4D9-BDE0EFDA9CEC}" type="presParOf" srcId="{9B9CA619-220C-5A4E-B33F-EBFFC3B0EDD3}" destId="{B5DE9C1D-0712-7C40-B01E-3261C5FC3424}" srcOrd="0" destOrd="0" presId="urn:microsoft.com/office/officeart/2005/8/layout/process4"/>
    <dgm:cxn modelId="{A00C5B35-7031-B342-804D-63E4B69E3A65}" type="presParOf" srcId="{B5DE9C1D-0712-7C40-B01E-3261C5FC3424}" destId="{EDBC67F2-7B38-7F4B-A05D-C8EABD99FBFD}" srcOrd="0" destOrd="0" presId="urn:microsoft.com/office/officeart/2005/8/layout/process4"/>
    <dgm:cxn modelId="{FF8A4A77-25C6-3A41-888A-26209ADEF4B2}" type="presParOf" srcId="{B5DE9C1D-0712-7C40-B01E-3261C5FC3424}" destId="{B08FD63D-F074-DE45-AC55-4F9470DEC614}" srcOrd="1" destOrd="0" presId="urn:microsoft.com/office/officeart/2005/8/layout/process4"/>
    <dgm:cxn modelId="{9D4EFDD2-108D-6745-8F22-DB9C30C0E40F}" type="presParOf" srcId="{B5DE9C1D-0712-7C40-B01E-3261C5FC3424}" destId="{792F05F7-F3AA-1C43-BBFC-66B8612572A4}" srcOrd="2" destOrd="0" presId="urn:microsoft.com/office/officeart/2005/8/layout/process4"/>
    <dgm:cxn modelId="{6051FD3C-5583-9C47-AE2D-9FE242530441}" type="presParOf" srcId="{792F05F7-F3AA-1C43-BBFC-66B8612572A4}" destId="{91C61337-F8B0-1548-8ED4-F1515FDADD4E}" srcOrd="0" destOrd="0" presId="urn:microsoft.com/office/officeart/2005/8/layout/process4"/>
    <dgm:cxn modelId="{B5451CB2-8A3A-334B-AC63-5DF78F15A970}" type="presParOf" srcId="{792F05F7-F3AA-1C43-BBFC-66B8612572A4}" destId="{5D6E6FEE-1495-E64F-9F21-F1F2440AB5D1}" srcOrd="1" destOrd="0" presId="urn:microsoft.com/office/officeart/2005/8/layout/process4"/>
    <dgm:cxn modelId="{53F3BF96-14BE-3C41-B066-4D85962D0C1F}" type="presParOf" srcId="{792F05F7-F3AA-1C43-BBFC-66B8612572A4}" destId="{D3D59393-533D-2E43-8626-59A3D8119A8A}" srcOrd="2" destOrd="0" presId="urn:microsoft.com/office/officeart/2005/8/layout/process4"/>
    <dgm:cxn modelId="{171D877E-FADC-9146-8110-B10A35C4CB36}" type="presParOf" srcId="{9B9CA619-220C-5A4E-B33F-EBFFC3B0EDD3}" destId="{1A301FFB-2EE6-1D47-A872-551F377C0A68}" srcOrd="1" destOrd="0" presId="urn:microsoft.com/office/officeart/2005/8/layout/process4"/>
    <dgm:cxn modelId="{B2F18BAD-4E1C-4643-AB36-8B0E33E70DBE}" type="presParOf" srcId="{9B9CA619-220C-5A4E-B33F-EBFFC3B0EDD3}" destId="{228957E6-E24D-F246-B90D-ECED59B3BB5E}" srcOrd="2" destOrd="0" presId="urn:microsoft.com/office/officeart/2005/8/layout/process4"/>
    <dgm:cxn modelId="{D81FDA62-55AD-8849-BC9A-72E97F9B8FED}" type="presParOf" srcId="{228957E6-E24D-F246-B90D-ECED59B3BB5E}" destId="{93657314-A251-5748-BE25-3EE59AC7C52F}" srcOrd="0" destOrd="0" presId="urn:microsoft.com/office/officeart/2005/8/layout/process4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7.xml><?xml version="1.0" encoding="utf-8"?>
<dgm:dataModel xmlns:dgm="http://schemas.openxmlformats.org/drawingml/2006/diagram" xmlns:a="http://schemas.openxmlformats.org/drawingml/2006/main">
  <dgm:ptLst>
    <dgm:pt modelId="{C466AEF0-1A56-4F2C-8BBA-60E122F375CF}" type="doc">
      <dgm:prSet loTypeId="urn:microsoft.com/office/officeart/2005/8/layout/vList2" loCatId="list" qsTypeId="urn:microsoft.com/office/officeart/2005/8/quickstyle/simple1" qsCatId="simple" csTypeId="urn:microsoft.com/office/officeart/2005/8/colors/colorful5" csCatId="colorful" phldr="1"/>
      <dgm:spPr/>
      <dgm:t>
        <a:bodyPr/>
        <a:lstStyle/>
        <a:p>
          <a:endParaRPr lang="en-US"/>
        </a:p>
      </dgm:t>
    </dgm:pt>
    <dgm:pt modelId="{3FDC8E08-3A6B-4F56-97A2-637F78D5F665}">
      <dgm:prSet/>
      <dgm:spPr>
        <a:solidFill>
          <a:schemeClr val="accent5"/>
        </a:solidFill>
      </dgm:spPr>
      <dgm:t>
        <a:bodyPr/>
        <a:lstStyle/>
        <a:p>
          <a:r>
            <a:rPr lang="en-US" dirty="0">
              <a:latin typeface="Arial" panose="020B0604020202020204" pitchFamily="34" charset="0"/>
              <a:cs typeface="Arial" panose="020B0604020202020204" pitchFamily="34" charset="0"/>
            </a:rPr>
            <a:t>Increases the likelihood the cancer will be eliminated</a:t>
          </a:r>
        </a:p>
      </dgm:t>
    </dgm:pt>
    <dgm:pt modelId="{4535DE00-0513-438F-B14C-E6C17A5281EA}" type="parTrans" cxnId="{DDB5654A-47B5-4730-A6F9-D0C4C9CC7A96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4012154C-1552-4BC6-B3A5-BAD05D8BA631}" type="sibTrans" cxnId="{DDB5654A-47B5-4730-A6F9-D0C4C9CC7A96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318A7E8-FAEF-4CC5-B006-6D41E3306A9F}">
      <dgm:prSet/>
      <dgm:spPr/>
      <dgm:t>
        <a:bodyPr/>
        <a:lstStyle/>
        <a:p>
          <a:r>
            <a:rPr lang="en-US" dirty="0">
              <a:latin typeface="Arial" panose="020B0604020202020204" pitchFamily="34" charset="0"/>
              <a:cs typeface="Arial" panose="020B0604020202020204" pitchFamily="34" charset="0"/>
            </a:rPr>
            <a:t>If the cancer is not sensitive to one treatment type, it may be eliminated by another.</a:t>
          </a:r>
        </a:p>
      </dgm:t>
    </dgm:pt>
    <dgm:pt modelId="{B0F3278A-BD91-4F6E-A7A5-40CBE5BB2563}" type="parTrans" cxnId="{3A95D138-C3DD-4401-BC46-65BA9E6C38A9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BA9B9AE-0BE3-4AFA-A10C-CF5B5922C741}" type="sibTrans" cxnId="{3A95D138-C3DD-4401-BC46-65BA9E6C38A9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DBB439F-6C30-44D5-BB2E-5C97C32C3996}">
      <dgm:prSet/>
      <dgm:spPr>
        <a:solidFill>
          <a:schemeClr val="accent1"/>
        </a:solidFill>
      </dgm:spPr>
      <dgm:t>
        <a:bodyPr/>
        <a:lstStyle/>
        <a:p>
          <a:r>
            <a:rPr lang="en-US" dirty="0">
              <a:latin typeface="Arial" panose="020B0604020202020204" pitchFamily="34" charset="0"/>
              <a:cs typeface="Arial" panose="020B0604020202020204" pitchFamily="34" charset="0"/>
            </a:rPr>
            <a:t>Prevents developments of drug resistance</a:t>
          </a:r>
        </a:p>
      </dgm:t>
    </dgm:pt>
    <dgm:pt modelId="{C8D0E26F-8BA4-44CD-BC5B-02F422916879}" type="parTrans" cxnId="{916CC2C4-4A44-4FE3-9548-E11DBB58A228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E93573DF-01F8-40F3-9141-724E818A8272}" type="sibTrans" cxnId="{916CC2C4-4A44-4FE3-9548-E11DBB58A228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2BFB2F1-520D-468A-A98A-5CC01BBA30A3}">
      <dgm:prSet/>
      <dgm:spPr/>
      <dgm:t>
        <a:bodyPr/>
        <a:lstStyle/>
        <a:p>
          <a:r>
            <a:rPr lang="en-US" dirty="0">
              <a:latin typeface="Arial" panose="020B0604020202020204" pitchFamily="34" charset="0"/>
              <a:cs typeface="Arial" panose="020B0604020202020204" pitchFamily="34" charset="0"/>
            </a:rPr>
            <a:t>If the cancer mutates and becomes resistant to one drug type, the likelihood that it will mutate and become resistant to both is extremely slim.</a:t>
          </a:r>
        </a:p>
      </dgm:t>
    </dgm:pt>
    <dgm:pt modelId="{14BB2A25-1FC7-4E34-B880-D8CA2765CC3C}" type="parTrans" cxnId="{60021EFC-9DB7-492D-8FE2-9F2A7D0D02C0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5C368B1-A817-4852-B971-C419F05BCA43}" type="sibTrans" cxnId="{60021EFC-9DB7-492D-8FE2-9F2A7D0D02C0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BAF58AB-B134-4BC5-A21D-9B3D707FF252}">
      <dgm:prSet/>
      <dgm:spPr>
        <a:solidFill>
          <a:schemeClr val="accent6"/>
        </a:solidFill>
      </dgm:spPr>
      <dgm:t>
        <a:bodyPr/>
        <a:lstStyle/>
        <a:p>
          <a:r>
            <a:rPr lang="en-US">
              <a:latin typeface="Arial" panose="020B0604020202020204" pitchFamily="34" charset="0"/>
              <a:cs typeface="Arial" panose="020B0604020202020204" pitchFamily="34" charset="0"/>
            </a:rPr>
            <a:t>Reduces length of treatment</a:t>
          </a:r>
        </a:p>
      </dgm:t>
    </dgm:pt>
    <dgm:pt modelId="{24D03F17-888D-4D59-947D-0366A5C3B820}" type="parTrans" cxnId="{92D0CABF-F579-41B3-9BD0-218A968ABCCE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486E38F9-D7DE-4632-89F6-94EB36FA7165}" type="sibTrans" cxnId="{92D0CABF-F579-41B3-9BD0-218A968ABCCE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01A740C-A265-4149-A2A5-A2FE62CCB4A2}">
      <dgm:prSet/>
      <dgm:spPr/>
      <dgm:t>
        <a:bodyPr/>
        <a:lstStyle/>
        <a:p>
          <a:r>
            <a:rPr lang="en-US" dirty="0">
              <a:latin typeface="Arial" panose="020B0604020202020204" pitchFamily="34" charset="0"/>
              <a:cs typeface="Arial" panose="020B0604020202020204" pitchFamily="34" charset="0"/>
            </a:rPr>
            <a:t>By doing two treatments at once, it lessens the ”trial and error” phase to see if one treatment doesn’t work.</a:t>
          </a:r>
        </a:p>
      </dgm:t>
    </dgm:pt>
    <dgm:pt modelId="{AFCC8DDD-EAB0-42F3-BDB8-FA46CDC76B0A}" type="parTrans" cxnId="{EF0D1D7B-E792-4097-82E9-82EAB6CF70D7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05B8C67-4157-4B5B-AB79-4D6D4C510C84}" type="sibTrans" cxnId="{EF0D1D7B-E792-4097-82E9-82EAB6CF70D7}">
      <dgm:prSet/>
      <dgm:spPr/>
      <dgm:t>
        <a:bodyPr/>
        <a:lstStyle/>
        <a:p>
          <a:endParaRPr lang="en-US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E662C6F-9C29-5B49-895F-BAEF2887D915}" type="pres">
      <dgm:prSet presAssocID="{C466AEF0-1A56-4F2C-8BBA-60E122F375CF}" presName="linear" presStyleCnt="0">
        <dgm:presLayoutVars>
          <dgm:animLvl val="lvl"/>
          <dgm:resizeHandles val="exact"/>
        </dgm:presLayoutVars>
      </dgm:prSet>
      <dgm:spPr/>
    </dgm:pt>
    <dgm:pt modelId="{D07D8D82-7559-E44A-A83B-0158FA86DC02}" type="pres">
      <dgm:prSet presAssocID="{3FDC8E08-3A6B-4F56-97A2-637F78D5F665}" presName="parentText" presStyleLbl="node1" presStyleIdx="0" presStyleCnt="3">
        <dgm:presLayoutVars>
          <dgm:chMax val="0"/>
          <dgm:bulletEnabled val="1"/>
        </dgm:presLayoutVars>
      </dgm:prSet>
      <dgm:spPr/>
    </dgm:pt>
    <dgm:pt modelId="{3A97C8F2-52C3-6C4C-BB09-63AB8722A2F4}" type="pres">
      <dgm:prSet presAssocID="{3FDC8E08-3A6B-4F56-97A2-637F78D5F665}" presName="childText" presStyleLbl="revTx" presStyleIdx="0" presStyleCnt="3">
        <dgm:presLayoutVars>
          <dgm:bulletEnabled val="1"/>
        </dgm:presLayoutVars>
      </dgm:prSet>
      <dgm:spPr/>
    </dgm:pt>
    <dgm:pt modelId="{77CE9661-810D-9B41-988B-DB96419D4CC5}" type="pres">
      <dgm:prSet presAssocID="{5DBB439F-6C30-44D5-BB2E-5C97C32C3996}" presName="parentText" presStyleLbl="node1" presStyleIdx="1" presStyleCnt="3">
        <dgm:presLayoutVars>
          <dgm:chMax val="0"/>
          <dgm:bulletEnabled val="1"/>
        </dgm:presLayoutVars>
      </dgm:prSet>
      <dgm:spPr/>
    </dgm:pt>
    <dgm:pt modelId="{6C24F5BC-E73C-DB47-8BC3-199E8FC98AAC}" type="pres">
      <dgm:prSet presAssocID="{5DBB439F-6C30-44D5-BB2E-5C97C32C3996}" presName="childText" presStyleLbl="revTx" presStyleIdx="1" presStyleCnt="3">
        <dgm:presLayoutVars>
          <dgm:bulletEnabled val="1"/>
        </dgm:presLayoutVars>
      </dgm:prSet>
      <dgm:spPr/>
    </dgm:pt>
    <dgm:pt modelId="{F636404D-010E-AB46-9AD3-A4E4702E9530}" type="pres">
      <dgm:prSet presAssocID="{0BAF58AB-B134-4BC5-A21D-9B3D707FF252}" presName="parentText" presStyleLbl="node1" presStyleIdx="2" presStyleCnt="3">
        <dgm:presLayoutVars>
          <dgm:chMax val="0"/>
          <dgm:bulletEnabled val="1"/>
        </dgm:presLayoutVars>
      </dgm:prSet>
      <dgm:spPr/>
    </dgm:pt>
    <dgm:pt modelId="{3ABBF6B3-1845-E948-84DB-EA068A9C2739}" type="pres">
      <dgm:prSet presAssocID="{0BAF58AB-B134-4BC5-A21D-9B3D707FF252}" presName="childText" presStyleLbl="revTx" presStyleIdx="2" presStyleCnt="3">
        <dgm:presLayoutVars>
          <dgm:bulletEnabled val="1"/>
        </dgm:presLayoutVars>
      </dgm:prSet>
      <dgm:spPr/>
    </dgm:pt>
  </dgm:ptLst>
  <dgm:cxnLst>
    <dgm:cxn modelId="{7D562F02-D499-164C-A587-1C71138A955F}" type="presOf" srcId="{5DBB439F-6C30-44D5-BB2E-5C97C32C3996}" destId="{77CE9661-810D-9B41-988B-DB96419D4CC5}" srcOrd="0" destOrd="0" presId="urn:microsoft.com/office/officeart/2005/8/layout/vList2"/>
    <dgm:cxn modelId="{F057E21E-F346-2341-A803-05BA0C209D85}" type="presOf" srcId="{C466AEF0-1A56-4F2C-8BBA-60E122F375CF}" destId="{9E662C6F-9C29-5B49-895F-BAEF2887D915}" srcOrd="0" destOrd="0" presId="urn:microsoft.com/office/officeart/2005/8/layout/vList2"/>
    <dgm:cxn modelId="{3A95D138-C3DD-4401-BC46-65BA9E6C38A9}" srcId="{3FDC8E08-3A6B-4F56-97A2-637F78D5F665}" destId="{7318A7E8-FAEF-4CC5-B006-6D41E3306A9F}" srcOrd="0" destOrd="0" parTransId="{B0F3278A-BD91-4F6E-A7A5-40CBE5BB2563}" sibTransId="{8BA9B9AE-0BE3-4AFA-A10C-CF5B5922C741}"/>
    <dgm:cxn modelId="{DDB5654A-47B5-4730-A6F9-D0C4C9CC7A96}" srcId="{C466AEF0-1A56-4F2C-8BBA-60E122F375CF}" destId="{3FDC8E08-3A6B-4F56-97A2-637F78D5F665}" srcOrd="0" destOrd="0" parTransId="{4535DE00-0513-438F-B14C-E6C17A5281EA}" sibTransId="{4012154C-1552-4BC6-B3A5-BAD05D8BA631}"/>
    <dgm:cxn modelId="{B60B8975-BBDE-B747-AB12-0DB2B37375C1}" type="presOf" srcId="{A2BFB2F1-520D-468A-A98A-5CC01BBA30A3}" destId="{6C24F5BC-E73C-DB47-8BC3-199E8FC98AAC}" srcOrd="0" destOrd="0" presId="urn:microsoft.com/office/officeart/2005/8/layout/vList2"/>
    <dgm:cxn modelId="{EF0D1D7B-E792-4097-82E9-82EAB6CF70D7}" srcId="{0BAF58AB-B134-4BC5-A21D-9B3D707FF252}" destId="{B01A740C-A265-4149-A2A5-A2FE62CCB4A2}" srcOrd="0" destOrd="0" parTransId="{AFCC8DDD-EAB0-42F3-BDB8-FA46CDC76B0A}" sibTransId="{A05B8C67-4157-4B5B-AB79-4D6D4C510C84}"/>
    <dgm:cxn modelId="{B0D93BAB-1A67-8348-BC06-2975DC0DAA39}" type="presOf" srcId="{B01A740C-A265-4149-A2A5-A2FE62CCB4A2}" destId="{3ABBF6B3-1845-E948-84DB-EA068A9C2739}" srcOrd="0" destOrd="0" presId="urn:microsoft.com/office/officeart/2005/8/layout/vList2"/>
    <dgm:cxn modelId="{92D0CABF-F579-41B3-9BD0-218A968ABCCE}" srcId="{C466AEF0-1A56-4F2C-8BBA-60E122F375CF}" destId="{0BAF58AB-B134-4BC5-A21D-9B3D707FF252}" srcOrd="2" destOrd="0" parTransId="{24D03F17-888D-4D59-947D-0366A5C3B820}" sibTransId="{486E38F9-D7DE-4632-89F6-94EB36FA7165}"/>
    <dgm:cxn modelId="{916CC2C4-4A44-4FE3-9548-E11DBB58A228}" srcId="{C466AEF0-1A56-4F2C-8BBA-60E122F375CF}" destId="{5DBB439F-6C30-44D5-BB2E-5C97C32C3996}" srcOrd="1" destOrd="0" parTransId="{C8D0E26F-8BA4-44CD-BC5B-02F422916879}" sibTransId="{E93573DF-01F8-40F3-9141-724E818A8272}"/>
    <dgm:cxn modelId="{AD2C13C7-AB4B-0D48-A58A-D5185582D31F}" type="presOf" srcId="{3FDC8E08-3A6B-4F56-97A2-637F78D5F665}" destId="{D07D8D82-7559-E44A-A83B-0158FA86DC02}" srcOrd="0" destOrd="0" presId="urn:microsoft.com/office/officeart/2005/8/layout/vList2"/>
    <dgm:cxn modelId="{C53DBDD0-DB77-4644-BEDF-39FCF42C9D60}" type="presOf" srcId="{0BAF58AB-B134-4BC5-A21D-9B3D707FF252}" destId="{F636404D-010E-AB46-9AD3-A4E4702E9530}" srcOrd="0" destOrd="0" presId="urn:microsoft.com/office/officeart/2005/8/layout/vList2"/>
    <dgm:cxn modelId="{E8B488F4-462F-D541-B482-D851696716AF}" type="presOf" srcId="{7318A7E8-FAEF-4CC5-B006-6D41E3306A9F}" destId="{3A97C8F2-52C3-6C4C-BB09-63AB8722A2F4}" srcOrd="0" destOrd="0" presId="urn:microsoft.com/office/officeart/2005/8/layout/vList2"/>
    <dgm:cxn modelId="{60021EFC-9DB7-492D-8FE2-9F2A7D0D02C0}" srcId="{5DBB439F-6C30-44D5-BB2E-5C97C32C3996}" destId="{A2BFB2F1-520D-468A-A98A-5CC01BBA30A3}" srcOrd="0" destOrd="0" parTransId="{14BB2A25-1FC7-4E34-B880-D8CA2765CC3C}" sibTransId="{95C368B1-A817-4852-B971-C419F05BCA43}"/>
    <dgm:cxn modelId="{4896C590-FB97-3B48-907D-2464AEFB3E7C}" type="presParOf" srcId="{9E662C6F-9C29-5B49-895F-BAEF2887D915}" destId="{D07D8D82-7559-E44A-A83B-0158FA86DC02}" srcOrd="0" destOrd="0" presId="urn:microsoft.com/office/officeart/2005/8/layout/vList2"/>
    <dgm:cxn modelId="{E77E4302-0D56-4A4F-849C-69DAB05CFFCC}" type="presParOf" srcId="{9E662C6F-9C29-5B49-895F-BAEF2887D915}" destId="{3A97C8F2-52C3-6C4C-BB09-63AB8722A2F4}" srcOrd="1" destOrd="0" presId="urn:microsoft.com/office/officeart/2005/8/layout/vList2"/>
    <dgm:cxn modelId="{32C9838D-F45A-7B44-BE5C-D3A1F6E1455D}" type="presParOf" srcId="{9E662C6F-9C29-5B49-895F-BAEF2887D915}" destId="{77CE9661-810D-9B41-988B-DB96419D4CC5}" srcOrd="2" destOrd="0" presId="urn:microsoft.com/office/officeart/2005/8/layout/vList2"/>
    <dgm:cxn modelId="{028F7083-9EFF-2B42-B128-4E8C96216481}" type="presParOf" srcId="{9E662C6F-9C29-5B49-895F-BAEF2887D915}" destId="{6C24F5BC-E73C-DB47-8BC3-199E8FC98AAC}" srcOrd="3" destOrd="0" presId="urn:microsoft.com/office/officeart/2005/8/layout/vList2"/>
    <dgm:cxn modelId="{3577370D-CEB3-524B-8E18-B583BE2B7142}" type="presParOf" srcId="{9E662C6F-9C29-5B49-895F-BAEF2887D915}" destId="{F636404D-010E-AB46-9AD3-A4E4702E9530}" srcOrd="4" destOrd="0" presId="urn:microsoft.com/office/officeart/2005/8/layout/vList2"/>
    <dgm:cxn modelId="{12C20586-6B4B-B043-BEC2-8BAB6CB3C0C0}" type="presParOf" srcId="{9E662C6F-9C29-5B49-895F-BAEF2887D915}" destId="{3ABBF6B3-1845-E948-84DB-EA068A9C2739}" srcOrd="5" destOrd="0" presId="urn:microsoft.com/office/officeart/2005/8/layout/vList2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8.xml><?xml version="1.0" encoding="utf-8"?>
<dgm:dataModel xmlns:dgm="http://schemas.openxmlformats.org/drawingml/2006/diagram" xmlns:a="http://schemas.openxmlformats.org/drawingml/2006/main">
  <dgm:ptLst>
    <dgm:pt modelId="{04398479-68F1-4BE4-8D4E-77888FBE7F6D}" type="doc">
      <dgm:prSet loTypeId="urn:microsoft.com/office/officeart/2005/8/layout/vList2" loCatId="list" qsTypeId="urn:microsoft.com/office/officeart/2005/8/quickstyle/simple1" qsCatId="simple" csTypeId="urn:microsoft.com/office/officeart/2005/8/colors/colorful5" csCatId="colorful" phldr="1"/>
      <dgm:spPr/>
      <dgm:t>
        <a:bodyPr/>
        <a:lstStyle/>
        <a:p>
          <a:endParaRPr lang="en-US"/>
        </a:p>
      </dgm:t>
    </dgm:pt>
    <dgm:pt modelId="{975FEF96-A3E6-419C-90B2-8841EA04031D}">
      <dgm:prSet custT="1"/>
      <dgm:spPr/>
      <dgm:t>
        <a:bodyPr/>
        <a:lstStyle/>
        <a:p>
          <a:r>
            <a:rPr lang="en-US" sz="3200">
              <a:latin typeface="Arial" panose="020B0604020202020204" pitchFamily="34" charset="0"/>
              <a:cs typeface="Arial" panose="020B0604020202020204" pitchFamily="34" charset="0"/>
            </a:rPr>
            <a:t>Unclear how the patients’ body will interact to two treatment types</a:t>
          </a:r>
        </a:p>
      </dgm:t>
    </dgm:pt>
    <dgm:pt modelId="{0732A637-3EE0-486E-8768-03E193F21115}" type="parTrans" cxnId="{9F38405E-25F3-4EDF-84C0-E05D9A544B3F}">
      <dgm:prSet/>
      <dgm:spPr/>
      <dgm:t>
        <a:bodyPr/>
        <a:lstStyle/>
        <a:p>
          <a:endParaRPr lang="en-US" sz="2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46CB045-EA83-45E6-9958-0E5C7E950F73}" type="sibTrans" cxnId="{9F38405E-25F3-4EDF-84C0-E05D9A544B3F}">
      <dgm:prSet/>
      <dgm:spPr/>
      <dgm:t>
        <a:bodyPr/>
        <a:lstStyle/>
        <a:p>
          <a:endParaRPr lang="en-US" sz="2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4EB1313-EAE2-4C40-B047-41B57A19D6A2}">
      <dgm:prSet custT="1"/>
      <dgm:spPr/>
      <dgm:t>
        <a:bodyPr/>
        <a:lstStyle/>
        <a:p>
          <a:r>
            <a:rPr lang="en-US" sz="2400">
              <a:latin typeface="Arial" panose="020B0604020202020204" pitchFamily="34" charset="0"/>
              <a:cs typeface="Arial" panose="020B0604020202020204" pitchFamily="34" charset="0"/>
            </a:rPr>
            <a:t>Could cause severe side effects</a:t>
          </a:r>
        </a:p>
      </dgm:t>
    </dgm:pt>
    <dgm:pt modelId="{2AC78743-D2A9-4372-AACC-12352AE12D46}" type="parTrans" cxnId="{BA72D5A4-BFDD-430C-8D1C-3C932D233F8D}">
      <dgm:prSet/>
      <dgm:spPr/>
      <dgm:t>
        <a:bodyPr/>
        <a:lstStyle/>
        <a:p>
          <a:endParaRPr lang="en-US" sz="2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B412268-6A55-494B-8C74-CBCA6EDEC537}" type="sibTrans" cxnId="{BA72D5A4-BFDD-430C-8D1C-3C932D233F8D}">
      <dgm:prSet/>
      <dgm:spPr/>
      <dgm:t>
        <a:bodyPr/>
        <a:lstStyle/>
        <a:p>
          <a:endParaRPr lang="en-US" sz="2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D93F137-E152-419C-B468-9FE3A74079AB}">
      <dgm:prSet custT="1"/>
      <dgm:spPr/>
      <dgm:t>
        <a:bodyPr/>
        <a:lstStyle/>
        <a:p>
          <a:r>
            <a:rPr lang="en-US" sz="3200">
              <a:latin typeface="Arial" panose="020B0604020202020204" pitchFamily="34" charset="0"/>
              <a:cs typeface="Arial" panose="020B0604020202020204" pitchFamily="34" charset="0"/>
            </a:rPr>
            <a:t>Occasionally unclear how the two types/drugs will interact with one another</a:t>
          </a:r>
        </a:p>
      </dgm:t>
    </dgm:pt>
    <dgm:pt modelId="{A81E0E43-5C60-4E24-8485-3F19BB71118C}" type="parTrans" cxnId="{9C6902C6-46F5-48C8-9661-D69AEBBE9A76}">
      <dgm:prSet/>
      <dgm:spPr/>
      <dgm:t>
        <a:bodyPr/>
        <a:lstStyle/>
        <a:p>
          <a:endParaRPr lang="en-US" sz="2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A571BA4-E7C5-4A06-BDC0-9F0C8605F5F1}" type="sibTrans" cxnId="{9C6902C6-46F5-48C8-9661-D69AEBBE9A76}">
      <dgm:prSet/>
      <dgm:spPr/>
      <dgm:t>
        <a:bodyPr/>
        <a:lstStyle/>
        <a:p>
          <a:endParaRPr lang="en-US" sz="2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3F64AA6-7798-4454-AEB1-CEBCC63F1061}">
      <dgm:prSet custT="1"/>
      <dgm:spPr/>
      <dgm:t>
        <a:bodyPr/>
        <a:lstStyle/>
        <a:p>
          <a:r>
            <a:rPr lang="en-US" sz="2400" dirty="0">
              <a:latin typeface="Arial" panose="020B0604020202020204" pitchFamily="34" charset="0"/>
              <a:cs typeface="Arial" panose="020B0604020202020204" pitchFamily="34" charset="0"/>
            </a:rPr>
            <a:t>Normally, extensive research is done on drug interaction before they are combined for treatment.</a:t>
          </a:r>
        </a:p>
      </dgm:t>
    </dgm:pt>
    <dgm:pt modelId="{6B96EECE-CFC7-4D27-8FE8-DE59CB8CF8E1}" type="parTrans" cxnId="{551032E0-9252-41F8-96D8-4F49773C1755}">
      <dgm:prSet/>
      <dgm:spPr/>
      <dgm:t>
        <a:bodyPr/>
        <a:lstStyle/>
        <a:p>
          <a:endParaRPr lang="en-US" sz="2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692F883-9DFC-4D1C-AFA4-9FECC20AAFF6}" type="sibTrans" cxnId="{551032E0-9252-41F8-96D8-4F49773C1755}">
      <dgm:prSet/>
      <dgm:spPr/>
      <dgm:t>
        <a:bodyPr/>
        <a:lstStyle/>
        <a:p>
          <a:endParaRPr lang="en-US" sz="2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F101ABAB-4D70-49AB-8512-61F17BE302CE}">
      <dgm:prSet custT="1"/>
      <dgm:spPr/>
      <dgm:t>
        <a:bodyPr/>
        <a:lstStyle/>
        <a:p>
          <a:r>
            <a:rPr lang="en-US" sz="2400" dirty="0">
              <a:latin typeface="Arial" panose="020B0604020202020204" pitchFamily="34" charset="0"/>
              <a:cs typeface="Arial" panose="020B0604020202020204" pitchFamily="34" charset="0"/>
            </a:rPr>
            <a:t>However, some drugs may be in a clinical trial phase where their interaction is not totally understood.</a:t>
          </a:r>
        </a:p>
      </dgm:t>
    </dgm:pt>
    <dgm:pt modelId="{75C4D428-48C7-4FF0-9CA9-D42B3BC8F00E}" type="parTrans" cxnId="{17CAD324-249B-4158-8383-C88DCCB10408}">
      <dgm:prSet/>
      <dgm:spPr/>
      <dgm:t>
        <a:bodyPr/>
        <a:lstStyle/>
        <a:p>
          <a:endParaRPr lang="en-US" sz="2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4BF7742-74A1-45D2-A8E1-5D080C2DAA72}" type="sibTrans" cxnId="{17CAD324-249B-4158-8383-C88DCCB10408}">
      <dgm:prSet/>
      <dgm:spPr/>
      <dgm:t>
        <a:bodyPr/>
        <a:lstStyle/>
        <a:p>
          <a:endParaRPr lang="en-US" sz="20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A0EED25-935D-D149-94E8-864491D384AA}" type="pres">
      <dgm:prSet presAssocID="{04398479-68F1-4BE4-8D4E-77888FBE7F6D}" presName="linear" presStyleCnt="0">
        <dgm:presLayoutVars>
          <dgm:animLvl val="lvl"/>
          <dgm:resizeHandles val="exact"/>
        </dgm:presLayoutVars>
      </dgm:prSet>
      <dgm:spPr/>
    </dgm:pt>
    <dgm:pt modelId="{4F36D69D-6E7E-7A47-AD1E-5124971184A6}" type="pres">
      <dgm:prSet presAssocID="{975FEF96-A3E6-419C-90B2-8841EA04031D}" presName="parentText" presStyleLbl="node1" presStyleIdx="0" presStyleCnt="2">
        <dgm:presLayoutVars>
          <dgm:chMax val="0"/>
          <dgm:bulletEnabled val="1"/>
        </dgm:presLayoutVars>
      </dgm:prSet>
      <dgm:spPr/>
    </dgm:pt>
    <dgm:pt modelId="{3A823256-9961-7047-955A-C3D1B86C2C24}" type="pres">
      <dgm:prSet presAssocID="{975FEF96-A3E6-419C-90B2-8841EA04031D}" presName="childText" presStyleLbl="revTx" presStyleIdx="0" presStyleCnt="2">
        <dgm:presLayoutVars>
          <dgm:bulletEnabled val="1"/>
        </dgm:presLayoutVars>
      </dgm:prSet>
      <dgm:spPr/>
    </dgm:pt>
    <dgm:pt modelId="{70117F78-E04B-AA41-BB31-D0CAC798E5A6}" type="pres">
      <dgm:prSet presAssocID="{0D93F137-E152-419C-B468-9FE3A74079AB}" presName="parentText" presStyleLbl="node1" presStyleIdx="1" presStyleCnt="2">
        <dgm:presLayoutVars>
          <dgm:chMax val="0"/>
          <dgm:bulletEnabled val="1"/>
        </dgm:presLayoutVars>
      </dgm:prSet>
      <dgm:spPr/>
    </dgm:pt>
    <dgm:pt modelId="{7168C23C-5D4E-114A-888F-C33FE215E7E6}" type="pres">
      <dgm:prSet presAssocID="{0D93F137-E152-419C-B468-9FE3A74079AB}" presName="childText" presStyleLbl="revTx" presStyleIdx="1" presStyleCnt="2">
        <dgm:presLayoutVars>
          <dgm:bulletEnabled val="1"/>
        </dgm:presLayoutVars>
      </dgm:prSet>
      <dgm:spPr/>
    </dgm:pt>
  </dgm:ptLst>
  <dgm:cxnLst>
    <dgm:cxn modelId="{17CAD324-249B-4158-8383-C88DCCB10408}" srcId="{0D93F137-E152-419C-B468-9FE3A74079AB}" destId="{F101ABAB-4D70-49AB-8512-61F17BE302CE}" srcOrd="1" destOrd="0" parTransId="{75C4D428-48C7-4FF0-9CA9-D42B3BC8F00E}" sibTransId="{84BF7742-74A1-45D2-A8E1-5D080C2DAA72}"/>
    <dgm:cxn modelId="{158AAF3D-151F-224D-B3FD-953C38D97588}" type="presOf" srcId="{0D93F137-E152-419C-B468-9FE3A74079AB}" destId="{70117F78-E04B-AA41-BB31-D0CAC798E5A6}" srcOrd="0" destOrd="0" presId="urn:microsoft.com/office/officeart/2005/8/layout/vList2"/>
    <dgm:cxn modelId="{9F38405E-25F3-4EDF-84C0-E05D9A544B3F}" srcId="{04398479-68F1-4BE4-8D4E-77888FBE7F6D}" destId="{975FEF96-A3E6-419C-90B2-8841EA04031D}" srcOrd="0" destOrd="0" parTransId="{0732A637-3EE0-486E-8768-03E193F21115}" sibTransId="{146CB045-EA83-45E6-9958-0E5C7E950F73}"/>
    <dgm:cxn modelId="{155FF34A-CE2D-C047-9B50-94A0B02322DB}" type="presOf" srcId="{B3F64AA6-7798-4454-AEB1-CEBCC63F1061}" destId="{7168C23C-5D4E-114A-888F-C33FE215E7E6}" srcOrd="0" destOrd="0" presId="urn:microsoft.com/office/officeart/2005/8/layout/vList2"/>
    <dgm:cxn modelId="{BA72D5A4-BFDD-430C-8D1C-3C932D233F8D}" srcId="{975FEF96-A3E6-419C-90B2-8841EA04031D}" destId="{24EB1313-EAE2-4C40-B047-41B57A19D6A2}" srcOrd="0" destOrd="0" parTransId="{2AC78743-D2A9-4372-AACC-12352AE12D46}" sibTransId="{1B412268-6A55-494B-8C74-CBCA6EDEC537}"/>
    <dgm:cxn modelId="{A9C8BEBA-E3F0-5941-A615-DC6887095544}" type="presOf" srcId="{F101ABAB-4D70-49AB-8512-61F17BE302CE}" destId="{7168C23C-5D4E-114A-888F-C33FE215E7E6}" srcOrd="0" destOrd="1" presId="urn:microsoft.com/office/officeart/2005/8/layout/vList2"/>
    <dgm:cxn modelId="{8C5B91C1-6600-0041-A357-105F9ECD7340}" type="presOf" srcId="{975FEF96-A3E6-419C-90B2-8841EA04031D}" destId="{4F36D69D-6E7E-7A47-AD1E-5124971184A6}" srcOrd="0" destOrd="0" presId="urn:microsoft.com/office/officeart/2005/8/layout/vList2"/>
    <dgm:cxn modelId="{9C6902C6-46F5-48C8-9661-D69AEBBE9A76}" srcId="{04398479-68F1-4BE4-8D4E-77888FBE7F6D}" destId="{0D93F137-E152-419C-B468-9FE3A74079AB}" srcOrd="1" destOrd="0" parTransId="{A81E0E43-5C60-4E24-8485-3F19BB71118C}" sibTransId="{8A571BA4-E7C5-4A06-BDC0-9F0C8605F5F1}"/>
    <dgm:cxn modelId="{C74DDAD9-CA6D-3E49-9317-8DD11E59D51C}" type="presOf" srcId="{04398479-68F1-4BE4-8D4E-77888FBE7F6D}" destId="{9A0EED25-935D-D149-94E8-864491D384AA}" srcOrd="0" destOrd="0" presId="urn:microsoft.com/office/officeart/2005/8/layout/vList2"/>
    <dgm:cxn modelId="{551032E0-9252-41F8-96D8-4F49773C1755}" srcId="{0D93F137-E152-419C-B468-9FE3A74079AB}" destId="{B3F64AA6-7798-4454-AEB1-CEBCC63F1061}" srcOrd="0" destOrd="0" parTransId="{6B96EECE-CFC7-4D27-8FE8-DE59CB8CF8E1}" sibTransId="{3692F883-9DFC-4D1C-AFA4-9FECC20AAFF6}"/>
    <dgm:cxn modelId="{CF0CF3E1-576C-3E44-8F63-0ED187B9DAEB}" type="presOf" srcId="{24EB1313-EAE2-4C40-B047-41B57A19D6A2}" destId="{3A823256-9961-7047-955A-C3D1B86C2C24}" srcOrd="0" destOrd="0" presId="urn:microsoft.com/office/officeart/2005/8/layout/vList2"/>
    <dgm:cxn modelId="{DC07B5B5-4D2B-334A-A5D4-AEFC89698CEA}" type="presParOf" srcId="{9A0EED25-935D-D149-94E8-864491D384AA}" destId="{4F36D69D-6E7E-7A47-AD1E-5124971184A6}" srcOrd="0" destOrd="0" presId="urn:microsoft.com/office/officeart/2005/8/layout/vList2"/>
    <dgm:cxn modelId="{55E665D0-D681-C244-8DB8-82FF0FCE79F2}" type="presParOf" srcId="{9A0EED25-935D-D149-94E8-864491D384AA}" destId="{3A823256-9961-7047-955A-C3D1B86C2C24}" srcOrd="1" destOrd="0" presId="urn:microsoft.com/office/officeart/2005/8/layout/vList2"/>
    <dgm:cxn modelId="{9CA1DF03-6522-2B47-906A-E99566619625}" type="presParOf" srcId="{9A0EED25-935D-D149-94E8-864491D384AA}" destId="{70117F78-E04B-AA41-BB31-D0CAC798E5A6}" srcOrd="2" destOrd="0" presId="urn:microsoft.com/office/officeart/2005/8/layout/vList2"/>
    <dgm:cxn modelId="{385FF198-37B0-114A-9745-A8CF84EC25A9}" type="presParOf" srcId="{9A0EED25-935D-D149-94E8-864491D384AA}" destId="{7168C23C-5D4E-114A-888F-C33FE215E7E6}" srcOrd="3" destOrd="0" presId="urn:microsoft.com/office/officeart/2005/8/layout/vList2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49ED9A47-8FDF-6640-8D15-21C17522ED0A}">
      <dsp:nvSpPr>
        <dsp:cNvPr id="0" name=""/>
        <dsp:cNvSpPr/>
      </dsp:nvSpPr>
      <dsp:spPr>
        <a:xfrm>
          <a:off x="0" y="472139"/>
          <a:ext cx="6240668" cy="781200"/>
        </a:xfrm>
        <a:prstGeom prst="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5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348957E5-B8E2-7544-9449-22DF6E42295F}">
      <dsp:nvSpPr>
        <dsp:cNvPr id="0" name=""/>
        <dsp:cNvSpPr/>
      </dsp:nvSpPr>
      <dsp:spPr>
        <a:xfrm>
          <a:off x="312033" y="14579"/>
          <a:ext cx="4368468" cy="915120"/>
        </a:xfrm>
        <a:prstGeom prst="roundRect">
          <a:avLst/>
        </a:prstGeom>
        <a:solidFill>
          <a:schemeClr val="accent5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65118" tIns="0" rIns="165118" bIns="0" numCol="1" spcCol="1270" anchor="ctr" anchorCtr="0">
          <a:noAutofit/>
        </a:bodyPr>
        <a:lstStyle/>
        <a:p>
          <a:pPr marL="0" lvl="0" indent="0" algn="l" defTabSz="1377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100" kern="1200" dirty="0">
              <a:latin typeface="Arial" panose="020B0604020202020204" pitchFamily="34" charset="0"/>
              <a:cs typeface="Arial" panose="020B0604020202020204" pitchFamily="34" charset="0"/>
            </a:rPr>
            <a:t>Immunotherapy</a:t>
          </a:r>
        </a:p>
      </dsp:txBody>
      <dsp:txXfrm>
        <a:off x="356705" y="59251"/>
        <a:ext cx="4279124" cy="825776"/>
      </dsp:txXfrm>
    </dsp:sp>
    <dsp:sp modelId="{AE50FDCE-C9AB-C14E-8502-0AE08651A723}">
      <dsp:nvSpPr>
        <dsp:cNvPr id="0" name=""/>
        <dsp:cNvSpPr/>
      </dsp:nvSpPr>
      <dsp:spPr>
        <a:xfrm>
          <a:off x="0" y="1878299"/>
          <a:ext cx="6240668" cy="781200"/>
        </a:xfrm>
        <a:prstGeom prst="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0DE1B89D-FC04-BE43-9A3C-39A21BE932D5}">
      <dsp:nvSpPr>
        <dsp:cNvPr id="0" name=""/>
        <dsp:cNvSpPr/>
      </dsp:nvSpPr>
      <dsp:spPr>
        <a:xfrm>
          <a:off x="312033" y="1420739"/>
          <a:ext cx="4368468" cy="915120"/>
        </a:xfrm>
        <a:prstGeom prst="roundRect">
          <a:avLst/>
        </a:prstGeom>
        <a:solidFill>
          <a:schemeClr val="accent1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65118" tIns="0" rIns="165118" bIns="0" numCol="1" spcCol="1270" anchor="ctr" anchorCtr="0">
          <a:noAutofit/>
        </a:bodyPr>
        <a:lstStyle/>
        <a:p>
          <a:pPr marL="0" lvl="0" indent="0" algn="l" defTabSz="1377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100" kern="1200" dirty="0">
              <a:latin typeface="Arial" panose="020B0604020202020204" pitchFamily="34" charset="0"/>
              <a:cs typeface="Arial" panose="020B0604020202020204" pitchFamily="34" charset="0"/>
            </a:rPr>
            <a:t>Targeted Therapy</a:t>
          </a:r>
        </a:p>
      </dsp:txBody>
      <dsp:txXfrm>
        <a:off x="356705" y="1465411"/>
        <a:ext cx="4279124" cy="825776"/>
      </dsp:txXfrm>
    </dsp:sp>
    <dsp:sp modelId="{EF67C343-2EB3-C54A-90FD-566557A2F4EE}">
      <dsp:nvSpPr>
        <dsp:cNvPr id="0" name=""/>
        <dsp:cNvSpPr/>
      </dsp:nvSpPr>
      <dsp:spPr>
        <a:xfrm>
          <a:off x="0" y="3284460"/>
          <a:ext cx="6240668" cy="781200"/>
        </a:xfrm>
        <a:prstGeom prst="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2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BF5E5E7F-E0BD-F041-A2B3-0AA35A04D108}">
      <dsp:nvSpPr>
        <dsp:cNvPr id="0" name=""/>
        <dsp:cNvSpPr/>
      </dsp:nvSpPr>
      <dsp:spPr>
        <a:xfrm>
          <a:off x="312033" y="2826899"/>
          <a:ext cx="4368468" cy="915120"/>
        </a:xfrm>
        <a:prstGeom prst="roundRect">
          <a:avLst/>
        </a:prstGeom>
        <a:solidFill>
          <a:schemeClr val="accent2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65118" tIns="0" rIns="165118" bIns="0" numCol="1" spcCol="1270" anchor="ctr" anchorCtr="0">
          <a:noAutofit/>
        </a:bodyPr>
        <a:lstStyle/>
        <a:p>
          <a:pPr marL="0" lvl="0" indent="0" algn="l" defTabSz="1377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100" kern="1200" dirty="0">
              <a:latin typeface="Arial" panose="020B0604020202020204" pitchFamily="34" charset="0"/>
              <a:cs typeface="Arial" panose="020B0604020202020204" pitchFamily="34" charset="0"/>
            </a:rPr>
            <a:t>Hormone Therapy</a:t>
          </a:r>
        </a:p>
      </dsp:txBody>
      <dsp:txXfrm>
        <a:off x="356705" y="2871571"/>
        <a:ext cx="4279124" cy="825776"/>
      </dsp:txXfrm>
    </dsp:sp>
    <dsp:sp modelId="{E5B26FBB-84BC-814B-8028-01F4E0E57F45}">
      <dsp:nvSpPr>
        <dsp:cNvPr id="0" name=""/>
        <dsp:cNvSpPr/>
      </dsp:nvSpPr>
      <dsp:spPr>
        <a:xfrm>
          <a:off x="0" y="4690620"/>
          <a:ext cx="6240668" cy="781200"/>
        </a:xfrm>
        <a:prstGeom prst="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5">
              <a:hueOff val="-15900093"/>
              <a:satOff val="-36158"/>
              <a:lumOff val="-8431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50960FB0-3C4F-D542-A215-8A63B047CE67}">
      <dsp:nvSpPr>
        <dsp:cNvPr id="0" name=""/>
        <dsp:cNvSpPr/>
      </dsp:nvSpPr>
      <dsp:spPr>
        <a:xfrm>
          <a:off x="312033" y="4233060"/>
          <a:ext cx="4368468" cy="915120"/>
        </a:xfrm>
        <a:prstGeom prst="roundRect">
          <a:avLst/>
        </a:prstGeom>
        <a:solidFill>
          <a:schemeClr val="accent6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65118" tIns="0" rIns="165118" bIns="0" numCol="1" spcCol="1270" anchor="ctr" anchorCtr="0">
          <a:noAutofit/>
        </a:bodyPr>
        <a:lstStyle/>
        <a:p>
          <a:pPr marL="0" lvl="0" indent="0" algn="l" defTabSz="1377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100" kern="1200" dirty="0">
              <a:latin typeface="Arial" panose="020B0604020202020204" pitchFamily="34" charset="0"/>
              <a:cs typeface="Arial" panose="020B0604020202020204" pitchFamily="34" charset="0"/>
            </a:rPr>
            <a:t>Precision Medicine</a:t>
          </a:r>
        </a:p>
      </dsp:txBody>
      <dsp:txXfrm>
        <a:off x="356705" y="4277732"/>
        <a:ext cx="4279124" cy="825776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548751DB-3388-4376-9383-9A5859865062}">
      <dsp:nvSpPr>
        <dsp:cNvPr id="0" name=""/>
        <dsp:cNvSpPr/>
      </dsp:nvSpPr>
      <dsp:spPr>
        <a:xfrm>
          <a:off x="0" y="656"/>
          <a:ext cx="6335540" cy="1537154"/>
        </a:xfrm>
        <a:prstGeom prst="roundRect">
          <a:avLst>
            <a:gd name="adj" fmla="val 10000"/>
          </a:avLst>
        </a:prstGeom>
        <a:solidFill>
          <a:schemeClr val="bg1">
            <a:lumMod val="95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751493B5-A38B-44BB-9934-776AB3640EEA}">
      <dsp:nvSpPr>
        <dsp:cNvPr id="0" name=""/>
        <dsp:cNvSpPr/>
      </dsp:nvSpPr>
      <dsp:spPr>
        <a:xfrm>
          <a:off x="464989" y="346516"/>
          <a:ext cx="845435" cy="845435"/>
        </a:xfrm>
        <a:prstGeom prst="rect">
          <a:avLst/>
        </a:prstGeom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2"/>
              </a:ext>
            </a:extLst>
          </a:blip>
          <a:stretch>
            <a:fillRect/>
          </a:stretch>
        </a:blipFill>
        <a:ln w="12700" cap="flat" cmpd="sng" algn="ctr">
          <a:noFill/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1B201135-6A77-44A2-9DAC-B39AAEBD6B23}">
      <dsp:nvSpPr>
        <dsp:cNvPr id="0" name=""/>
        <dsp:cNvSpPr/>
      </dsp:nvSpPr>
      <dsp:spPr>
        <a:xfrm>
          <a:off x="1775413" y="656"/>
          <a:ext cx="2850993" cy="1537154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62682" tIns="162682" rIns="162682" bIns="162682" numCol="1" spcCol="1270" anchor="ctr" anchorCtr="0">
          <a:noAutofit/>
        </a:bodyPr>
        <a:lstStyle/>
        <a:p>
          <a:pPr marL="0" lvl="0" indent="0" algn="l" defTabSz="11112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500" kern="1200">
              <a:latin typeface="Arial" panose="020B0604020202020204" pitchFamily="34" charset="0"/>
              <a:cs typeface="Arial" panose="020B0604020202020204" pitchFamily="34" charset="0"/>
            </a:rPr>
            <a:t>Skin reactions at the needle site</a:t>
          </a:r>
        </a:p>
      </dsp:txBody>
      <dsp:txXfrm>
        <a:off x="1775413" y="656"/>
        <a:ext cx="2850993" cy="1537154"/>
      </dsp:txXfrm>
    </dsp:sp>
    <dsp:sp modelId="{DFF2CDEB-D0BB-445B-9164-00B103173CE7}">
      <dsp:nvSpPr>
        <dsp:cNvPr id="0" name=""/>
        <dsp:cNvSpPr/>
      </dsp:nvSpPr>
      <dsp:spPr>
        <a:xfrm>
          <a:off x="4626406" y="656"/>
          <a:ext cx="1709133" cy="1537154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62682" tIns="162682" rIns="162682" bIns="162682" numCol="1" spcCol="1270" anchor="ctr" anchorCtr="0">
          <a:noAutofit/>
        </a:bodyPr>
        <a:lstStyle/>
        <a:p>
          <a:pPr marL="0" lvl="0" indent="0" algn="l" defTabSz="5778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300" kern="1200">
              <a:latin typeface="Arial" panose="020B0604020202020204" pitchFamily="34" charset="0"/>
              <a:cs typeface="Arial" panose="020B0604020202020204" pitchFamily="34" charset="0"/>
            </a:rPr>
            <a:t>Pain, swelling, soreness, rash</a:t>
          </a:r>
        </a:p>
      </dsp:txBody>
      <dsp:txXfrm>
        <a:off x="4626406" y="656"/>
        <a:ext cx="1709133" cy="1537154"/>
      </dsp:txXfrm>
    </dsp:sp>
    <dsp:sp modelId="{EE4F78A4-1EB2-4D4D-86A4-9CE3EE715569}">
      <dsp:nvSpPr>
        <dsp:cNvPr id="0" name=""/>
        <dsp:cNvSpPr/>
      </dsp:nvSpPr>
      <dsp:spPr>
        <a:xfrm>
          <a:off x="0" y="1922100"/>
          <a:ext cx="6335540" cy="1537154"/>
        </a:xfrm>
        <a:prstGeom prst="roundRect">
          <a:avLst>
            <a:gd name="adj" fmla="val 10000"/>
          </a:avLst>
        </a:prstGeom>
        <a:solidFill>
          <a:schemeClr val="bg1">
            <a:lumMod val="95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FB0369A3-D468-4424-A9CA-6447FDB275E3}">
      <dsp:nvSpPr>
        <dsp:cNvPr id="0" name=""/>
        <dsp:cNvSpPr/>
      </dsp:nvSpPr>
      <dsp:spPr>
        <a:xfrm>
          <a:off x="464989" y="2267959"/>
          <a:ext cx="845435" cy="845435"/>
        </a:xfrm>
        <a:prstGeom prst="rect">
          <a:avLst/>
        </a:prstGeom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a:blipFill>
        <a:ln w="12700" cap="flat" cmpd="sng" algn="ctr">
          <a:noFill/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B35D1D0F-21F7-493E-AA58-6064C6BCA07B}">
      <dsp:nvSpPr>
        <dsp:cNvPr id="0" name=""/>
        <dsp:cNvSpPr/>
      </dsp:nvSpPr>
      <dsp:spPr>
        <a:xfrm>
          <a:off x="1775413" y="1922100"/>
          <a:ext cx="2850993" cy="1537154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62682" tIns="162682" rIns="162682" bIns="162682" numCol="1" spcCol="1270" anchor="ctr" anchorCtr="0">
          <a:noAutofit/>
        </a:bodyPr>
        <a:lstStyle/>
        <a:p>
          <a:pPr marL="0" lvl="0" indent="0" algn="l" defTabSz="11112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500" kern="1200">
              <a:latin typeface="Arial" panose="020B0604020202020204" pitchFamily="34" charset="0"/>
              <a:cs typeface="Arial" panose="020B0604020202020204" pitchFamily="34" charset="0"/>
            </a:rPr>
            <a:t>Flu-like symptoms</a:t>
          </a:r>
        </a:p>
      </dsp:txBody>
      <dsp:txXfrm>
        <a:off x="1775413" y="1922100"/>
        <a:ext cx="2850993" cy="1537154"/>
      </dsp:txXfrm>
    </dsp:sp>
    <dsp:sp modelId="{813DDB59-1425-4930-96D7-2F708A3C020E}">
      <dsp:nvSpPr>
        <dsp:cNvPr id="0" name=""/>
        <dsp:cNvSpPr/>
      </dsp:nvSpPr>
      <dsp:spPr>
        <a:xfrm>
          <a:off x="4626406" y="1922100"/>
          <a:ext cx="1709133" cy="1537154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62682" tIns="162682" rIns="162682" bIns="162682" numCol="1" spcCol="1270" anchor="ctr" anchorCtr="0">
          <a:noAutofit/>
        </a:bodyPr>
        <a:lstStyle/>
        <a:p>
          <a:pPr marL="0" lvl="0" indent="0" algn="l" defTabSz="5778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300" kern="1200" dirty="0">
              <a:latin typeface="Arial" panose="020B0604020202020204" pitchFamily="34" charset="0"/>
              <a:cs typeface="Arial" panose="020B0604020202020204" pitchFamily="34" charset="0"/>
            </a:rPr>
            <a:t>Fever, chills, muscle aches, fatigue, nausea/vomiting</a:t>
          </a:r>
        </a:p>
      </dsp:txBody>
      <dsp:txXfrm>
        <a:off x="4626406" y="1922100"/>
        <a:ext cx="1709133" cy="1537154"/>
      </dsp:txXfrm>
    </dsp:sp>
    <dsp:sp modelId="{AE7E70D4-A4EA-4CEA-BEE8-222FCA6FA51E}">
      <dsp:nvSpPr>
        <dsp:cNvPr id="0" name=""/>
        <dsp:cNvSpPr/>
      </dsp:nvSpPr>
      <dsp:spPr>
        <a:xfrm>
          <a:off x="0" y="3843543"/>
          <a:ext cx="6335540" cy="1537154"/>
        </a:xfrm>
        <a:prstGeom prst="roundRect">
          <a:avLst>
            <a:gd name="adj" fmla="val 10000"/>
          </a:avLst>
        </a:prstGeom>
        <a:solidFill>
          <a:schemeClr val="bg1">
            <a:lumMod val="95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D90A5BCB-4A70-4204-8389-71AFA224F1F6}">
      <dsp:nvSpPr>
        <dsp:cNvPr id="0" name=""/>
        <dsp:cNvSpPr/>
      </dsp:nvSpPr>
      <dsp:spPr>
        <a:xfrm>
          <a:off x="464989" y="4189403"/>
          <a:ext cx="845435" cy="845435"/>
        </a:xfrm>
        <a:prstGeom prst="rect">
          <a:avLst/>
        </a:prstGeom>
        <a:blipFill>
          <a:blip xmlns:r="http://schemas.openxmlformats.org/officeDocument/2006/relationships"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a:blipFill>
        <a:ln w="12700" cap="flat" cmpd="sng" algn="ctr">
          <a:noFill/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1C2E0A66-F456-40AD-9752-968000207A26}">
      <dsp:nvSpPr>
        <dsp:cNvPr id="0" name=""/>
        <dsp:cNvSpPr/>
      </dsp:nvSpPr>
      <dsp:spPr>
        <a:xfrm>
          <a:off x="1775413" y="3843543"/>
          <a:ext cx="2850993" cy="1537154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62682" tIns="162682" rIns="162682" bIns="162682" numCol="1" spcCol="1270" anchor="ctr" anchorCtr="0">
          <a:noAutofit/>
        </a:bodyPr>
        <a:lstStyle/>
        <a:p>
          <a:pPr marL="0" lvl="0" indent="0" algn="l" defTabSz="11112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500" kern="1200">
              <a:latin typeface="Arial" panose="020B0604020202020204" pitchFamily="34" charset="0"/>
              <a:cs typeface="Arial" panose="020B0604020202020204" pitchFamily="34" charset="0"/>
            </a:rPr>
            <a:t>Additional effects</a:t>
          </a:r>
        </a:p>
      </dsp:txBody>
      <dsp:txXfrm>
        <a:off x="1775413" y="3843543"/>
        <a:ext cx="2850993" cy="1537154"/>
      </dsp:txXfrm>
    </dsp:sp>
    <dsp:sp modelId="{8F05AE7E-2A91-44F1-88B8-F1DB6D0DC5F2}">
      <dsp:nvSpPr>
        <dsp:cNvPr id="0" name=""/>
        <dsp:cNvSpPr/>
      </dsp:nvSpPr>
      <dsp:spPr>
        <a:xfrm>
          <a:off x="4626406" y="3843543"/>
          <a:ext cx="1709133" cy="1537154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62682" tIns="162682" rIns="162682" bIns="162682" numCol="1" spcCol="1270" anchor="ctr" anchorCtr="0">
          <a:noAutofit/>
        </a:bodyPr>
        <a:lstStyle/>
        <a:p>
          <a:pPr marL="0" lvl="0" indent="0" algn="l" defTabSz="5778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300" kern="1200">
              <a:latin typeface="Arial" panose="020B0604020202020204" pitchFamily="34" charset="0"/>
              <a:cs typeface="Arial" panose="020B0604020202020204" pitchFamily="34" charset="0"/>
            </a:rPr>
            <a:t>Weight gain, heart palpitations, organ inflammation</a:t>
          </a:r>
        </a:p>
      </dsp:txBody>
      <dsp:txXfrm>
        <a:off x="4626406" y="3843543"/>
        <a:ext cx="1709133" cy="1537154"/>
      </dsp:txXfrm>
    </dsp:sp>
  </dsp:spTree>
</dsp:drawing>
</file>

<file path=ppt/diagrams/drawing3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505D4817-07C3-CA4B-A8B8-5188F272A1DA}">
      <dsp:nvSpPr>
        <dsp:cNvPr id="0" name=""/>
        <dsp:cNvSpPr/>
      </dsp:nvSpPr>
      <dsp:spPr>
        <a:xfrm>
          <a:off x="0" y="519612"/>
          <a:ext cx="5393367" cy="1701000"/>
        </a:xfrm>
        <a:prstGeom prst="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18585" tIns="499872" rIns="418585" bIns="170688" numCol="1" spcCol="1270" anchor="t" anchorCtr="0">
          <a:noAutofit/>
        </a:bodyPr>
        <a:lstStyle/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2400" kern="1200" dirty="0">
              <a:latin typeface="Arial" panose="020B0604020202020204" pitchFamily="34" charset="0"/>
              <a:cs typeface="Arial" panose="020B0604020202020204" pitchFamily="34" charset="0"/>
            </a:rPr>
            <a:t>Drugs small enough to enter cells easily</a:t>
          </a:r>
        </a:p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2400" kern="1200" dirty="0">
              <a:latin typeface="Arial" panose="020B0604020202020204" pitchFamily="34" charset="0"/>
              <a:cs typeface="Arial" panose="020B0604020202020204" pitchFamily="34" charset="0"/>
            </a:rPr>
            <a:t>Used for targets inside the cells</a:t>
          </a:r>
        </a:p>
      </dsp:txBody>
      <dsp:txXfrm>
        <a:off x="0" y="519612"/>
        <a:ext cx="5393367" cy="1701000"/>
      </dsp:txXfrm>
    </dsp:sp>
    <dsp:sp modelId="{ACCBF021-1716-734A-A7A0-DFFDE9C16D30}">
      <dsp:nvSpPr>
        <dsp:cNvPr id="0" name=""/>
        <dsp:cNvSpPr/>
      </dsp:nvSpPr>
      <dsp:spPr>
        <a:xfrm>
          <a:off x="269668" y="165372"/>
          <a:ext cx="3775356" cy="708480"/>
        </a:xfrm>
        <a:prstGeom prst="roundRect">
          <a:avLst/>
        </a:prstGeom>
        <a:solidFill>
          <a:schemeClr val="accent5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42700" tIns="0" rIns="142700" bIns="0" numCol="1" spcCol="1270" anchor="ctr" anchorCtr="0">
          <a:noAutofit/>
        </a:bodyPr>
        <a:lstStyle/>
        <a:p>
          <a:pPr marL="0" lvl="0" indent="0" algn="l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400" b="1" kern="1200" dirty="0">
              <a:latin typeface="Arial" panose="020B0604020202020204" pitchFamily="34" charset="0"/>
              <a:cs typeface="Arial" panose="020B0604020202020204" pitchFamily="34" charset="0"/>
            </a:rPr>
            <a:t>Small-molecule drugs</a:t>
          </a:r>
        </a:p>
      </dsp:txBody>
      <dsp:txXfrm>
        <a:off x="304253" y="199957"/>
        <a:ext cx="3706186" cy="639310"/>
      </dsp:txXfrm>
    </dsp:sp>
    <dsp:sp modelId="{D4F299E3-76CA-B44D-AD47-312000A81794}">
      <dsp:nvSpPr>
        <dsp:cNvPr id="0" name=""/>
        <dsp:cNvSpPr/>
      </dsp:nvSpPr>
      <dsp:spPr>
        <a:xfrm>
          <a:off x="0" y="2704453"/>
          <a:ext cx="5393367" cy="2003400"/>
        </a:xfrm>
        <a:prstGeom prst="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5">
              <a:hueOff val="-15900093"/>
              <a:satOff val="-36158"/>
              <a:lumOff val="-8431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18585" tIns="499872" rIns="418585" bIns="170688" numCol="1" spcCol="1270" anchor="t" anchorCtr="0">
          <a:noAutofit/>
        </a:bodyPr>
        <a:lstStyle/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2400" kern="1200">
              <a:latin typeface="Arial" panose="020B0604020202020204" pitchFamily="34" charset="0"/>
              <a:cs typeface="Arial" panose="020B0604020202020204" pitchFamily="34" charset="0"/>
            </a:rPr>
            <a:t>Proteins designed to attach to specific targets on cancer cells</a:t>
          </a:r>
        </a:p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2400" kern="1200">
              <a:latin typeface="Arial" panose="020B0604020202020204" pitchFamily="34" charset="0"/>
              <a:cs typeface="Arial" panose="020B0604020202020204" pitchFamily="34" charset="0"/>
            </a:rPr>
            <a:t>Makes it easier for it to be destroyed by immune system</a:t>
          </a:r>
        </a:p>
      </dsp:txBody>
      <dsp:txXfrm>
        <a:off x="0" y="2704453"/>
        <a:ext cx="5393367" cy="2003400"/>
      </dsp:txXfrm>
    </dsp:sp>
    <dsp:sp modelId="{020D1C76-A3A1-8145-AC2A-0F3E1F78F5A0}">
      <dsp:nvSpPr>
        <dsp:cNvPr id="0" name=""/>
        <dsp:cNvSpPr/>
      </dsp:nvSpPr>
      <dsp:spPr>
        <a:xfrm>
          <a:off x="269668" y="2350213"/>
          <a:ext cx="3775356" cy="708480"/>
        </a:xfrm>
        <a:prstGeom prst="roundRect">
          <a:avLst/>
        </a:prstGeom>
        <a:solidFill>
          <a:schemeClr val="accent5">
            <a:hueOff val="-15900093"/>
            <a:satOff val="-36158"/>
            <a:lumOff val="-8431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42700" tIns="0" rIns="142700" bIns="0" numCol="1" spcCol="1270" anchor="ctr" anchorCtr="0">
          <a:noAutofit/>
        </a:bodyPr>
        <a:lstStyle/>
        <a:p>
          <a:pPr marL="0" lvl="0" indent="0" algn="l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400" b="1" kern="1200" dirty="0">
              <a:latin typeface="Arial" panose="020B0604020202020204" pitchFamily="34" charset="0"/>
              <a:cs typeface="Arial" panose="020B0604020202020204" pitchFamily="34" charset="0"/>
            </a:rPr>
            <a:t>Monoclonal antibodies</a:t>
          </a:r>
        </a:p>
      </dsp:txBody>
      <dsp:txXfrm>
        <a:off x="304253" y="2384798"/>
        <a:ext cx="3706186" cy="639310"/>
      </dsp:txXfrm>
    </dsp:sp>
  </dsp:spTree>
</dsp:drawing>
</file>

<file path=ppt/diagrams/drawing4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4D98EFF5-8E79-4395-AD45-054A1A4D6AE3}">
      <dsp:nvSpPr>
        <dsp:cNvPr id="0" name=""/>
        <dsp:cNvSpPr/>
      </dsp:nvSpPr>
      <dsp:spPr>
        <a:xfrm>
          <a:off x="-109092" y="8065"/>
          <a:ext cx="6240668" cy="1449223"/>
        </a:xfrm>
        <a:prstGeom prst="roundRect">
          <a:avLst>
            <a:gd name="adj" fmla="val 10000"/>
          </a:avLst>
        </a:prstGeom>
        <a:solidFill>
          <a:schemeClr val="bg1">
            <a:lumMod val="95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E96C1EA4-8FF1-4007-9108-3509BC24936D}">
      <dsp:nvSpPr>
        <dsp:cNvPr id="0" name=""/>
        <dsp:cNvSpPr/>
      </dsp:nvSpPr>
      <dsp:spPr>
        <a:xfrm>
          <a:off x="329297" y="334141"/>
          <a:ext cx="797072" cy="797072"/>
        </a:xfrm>
        <a:prstGeom prst="rect">
          <a:avLst/>
        </a:prstGeom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2"/>
              </a:ext>
            </a:extLst>
          </a:blip>
          <a:stretch>
            <a:fillRect/>
          </a:stretch>
        </a:blipFill>
        <a:ln w="12700" cap="flat" cmpd="sng" algn="ctr">
          <a:noFill/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298532AE-009A-467A-AFA8-CC787A4364A9}">
      <dsp:nvSpPr>
        <dsp:cNvPr id="0" name=""/>
        <dsp:cNvSpPr/>
      </dsp:nvSpPr>
      <dsp:spPr>
        <a:xfrm>
          <a:off x="1564760" y="8065"/>
          <a:ext cx="4563541" cy="1449223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53376" tIns="153376" rIns="153376" bIns="153376" numCol="1" spcCol="1270" anchor="ctr" anchorCtr="0">
          <a:noAutofit/>
        </a:bodyPr>
        <a:lstStyle/>
        <a:p>
          <a:pPr marL="0" lvl="0" indent="0" algn="l" defTabSz="11112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500" kern="1200">
              <a:latin typeface="Arial" panose="020B0604020202020204" pitchFamily="34" charset="0"/>
              <a:cs typeface="Arial" panose="020B0604020202020204" pitchFamily="34" charset="0"/>
            </a:rPr>
            <a:t>Depends on the type of targeted therapy</a:t>
          </a:r>
        </a:p>
      </dsp:txBody>
      <dsp:txXfrm>
        <a:off x="1564760" y="8065"/>
        <a:ext cx="4563541" cy="1449223"/>
      </dsp:txXfrm>
    </dsp:sp>
    <dsp:sp modelId="{F761A3C3-1388-4438-ACBA-D84868CC9FD8}">
      <dsp:nvSpPr>
        <dsp:cNvPr id="0" name=""/>
        <dsp:cNvSpPr/>
      </dsp:nvSpPr>
      <dsp:spPr>
        <a:xfrm>
          <a:off x="-109092" y="1819595"/>
          <a:ext cx="6240668" cy="1449223"/>
        </a:xfrm>
        <a:prstGeom prst="roundRect">
          <a:avLst>
            <a:gd name="adj" fmla="val 10000"/>
          </a:avLst>
        </a:prstGeom>
        <a:solidFill>
          <a:schemeClr val="bg1">
            <a:lumMod val="95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9D12D4A9-0468-4AD5-BAAC-55FF3C0F4D06}">
      <dsp:nvSpPr>
        <dsp:cNvPr id="0" name=""/>
        <dsp:cNvSpPr/>
      </dsp:nvSpPr>
      <dsp:spPr>
        <a:xfrm>
          <a:off x="329297" y="2145670"/>
          <a:ext cx="797072" cy="797072"/>
        </a:xfrm>
        <a:prstGeom prst="rect">
          <a:avLst/>
        </a:prstGeom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a:blipFill>
        <a:ln w="12700" cap="flat" cmpd="sng" algn="ctr">
          <a:noFill/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2AC88B4C-6FE4-4273-B787-2793A0E51EFC}">
      <dsp:nvSpPr>
        <dsp:cNvPr id="0" name=""/>
        <dsp:cNvSpPr/>
      </dsp:nvSpPr>
      <dsp:spPr>
        <a:xfrm>
          <a:off x="1564760" y="1819595"/>
          <a:ext cx="2808301" cy="1449223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53376" tIns="153376" rIns="153376" bIns="153376" numCol="1" spcCol="1270" anchor="ctr" anchorCtr="0">
          <a:noAutofit/>
        </a:bodyPr>
        <a:lstStyle/>
        <a:p>
          <a:pPr marL="0" lvl="0" indent="0" algn="l" defTabSz="11112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500" kern="1200">
              <a:latin typeface="Arial" panose="020B0604020202020204" pitchFamily="34" charset="0"/>
              <a:cs typeface="Arial" panose="020B0604020202020204" pitchFamily="34" charset="0"/>
            </a:rPr>
            <a:t>Most common</a:t>
          </a:r>
        </a:p>
      </dsp:txBody>
      <dsp:txXfrm>
        <a:off x="1564760" y="1819595"/>
        <a:ext cx="2808301" cy="1449223"/>
      </dsp:txXfrm>
    </dsp:sp>
    <dsp:sp modelId="{6BE34653-D3E7-430E-B300-9C5026258855}">
      <dsp:nvSpPr>
        <dsp:cNvPr id="0" name=""/>
        <dsp:cNvSpPr/>
      </dsp:nvSpPr>
      <dsp:spPr>
        <a:xfrm>
          <a:off x="4373061" y="1819595"/>
          <a:ext cx="1755240" cy="1449223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53376" tIns="153376" rIns="153376" bIns="153376" numCol="1" spcCol="1270" anchor="ctr" anchorCtr="0">
          <a:noAutofit/>
        </a:bodyPr>
        <a:lstStyle/>
        <a:p>
          <a:pPr marL="0" lvl="0" indent="0" algn="l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200" kern="1200">
              <a:latin typeface="Arial" panose="020B0604020202020204" pitchFamily="34" charset="0"/>
              <a:cs typeface="Arial" panose="020B0604020202020204" pitchFamily="34" charset="0"/>
            </a:rPr>
            <a:t>Diarrhea</a:t>
          </a:r>
        </a:p>
        <a:p>
          <a:pPr marL="0" lvl="0" indent="0" algn="l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200" kern="1200">
              <a:latin typeface="Arial" panose="020B0604020202020204" pitchFamily="34" charset="0"/>
              <a:cs typeface="Arial" panose="020B0604020202020204" pitchFamily="34" charset="0"/>
            </a:rPr>
            <a:t>Liver problems</a:t>
          </a:r>
        </a:p>
      </dsp:txBody>
      <dsp:txXfrm>
        <a:off x="4373061" y="1819595"/>
        <a:ext cx="1755240" cy="1449223"/>
      </dsp:txXfrm>
    </dsp:sp>
    <dsp:sp modelId="{415B3723-CE08-4C65-9407-FEEBD7B84BBE}">
      <dsp:nvSpPr>
        <dsp:cNvPr id="0" name=""/>
        <dsp:cNvSpPr/>
      </dsp:nvSpPr>
      <dsp:spPr>
        <a:xfrm>
          <a:off x="-109092" y="3631124"/>
          <a:ext cx="6240668" cy="1449223"/>
        </a:xfrm>
        <a:prstGeom prst="roundRect">
          <a:avLst>
            <a:gd name="adj" fmla="val 10000"/>
          </a:avLst>
        </a:prstGeom>
        <a:solidFill>
          <a:schemeClr val="bg1">
            <a:lumMod val="95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C7655AAF-641B-4F83-8EC3-5248421501E1}">
      <dsp:nvSpPr>
        <dsp:cNvPr id="0" name=""/>
        <dsp:cNvSpPr/>
      </dsp:nvSpPr>
      <dsp:spPr>
        <a:xfrm>
          <a:off x="329297" y="3957199"/>
          <a:ext cx="797072" cy="797072"/>
        </a:xfrm>
        <a:prstGeom prst="rect">
          <a:avLst/>
        </a:prstGeom>
        <a:blipFill>
          <a:blip xmlns:r="http://schemas.openxmlformats.org/officeDocument/2006/relationships"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a:blipFill>
        <a:ln w="12700" cap="flat" cmpd="sng" algn="ctr">
          <a:noFill/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5B66E54E-C57B-4BBD-B604-7AC92B15DFF5}">
      <dsp:nvSpPr>
        <dsp:cNvPr id="0" name=""/>
        <dsp:cNvSpPr/>
      </dsp:nvSpPr>
      <dsp:spPr>
        <a:xfrm>
          <a:off x="1564760" y="3631124"/>
          <a:ext cx="2808301" cy="1449223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53376" tIns="153376" rIns="153376" bIns="153376" numCol="1" spcCol="1270" anchor="ctr" anchorCtr="0">
          <a:noAutofit/>
        </a:bodyPr>
        <a:lstStyle/>
        <a:p>
          <a:pPr marL="0" lvl="0" indent="0" algn="l" defTabSz="11112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500" kern="1200" dirty="0">
              <a:latin typeface="Arial" panose="020B0604020202020204" pitchFamily="34" charset="0"/>
              <a:cs typeface="Arial" panose="020B0604020202020204" pitchFamily="34" charset="0"/>
            </a:rPr>
            <a:t>Less common</a:t>
          </a:r>
        </a:p>
      </dsp:txBody>
      <dsp:txXfrm>
        <a:off x="1564760" y="3631124"/>
        <a:ext cx="2808301" cy="1449223"/>
      </dsp:txXfrm>
    </dsp:sp>
    <dsp:sp modelId="{9AC9D6E7-674C-4EE9-9239-3BF2C610BAEE}">
      <dsp:nvSpPr>
        <dsp:cNvPr id="0" name=""/>
        <dsp:cNvSpPr/>
      </dsp:nvSpPr>
      <dsp:spPr>
        <a:xfrm>
          <a:off x="4151603" y="3631124"/>
          <a:ext cx="2198158" cy="1449223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53376" tIns="153376" rIns="153376" bIns="153376" numCol="1" spcCol="1270" anchor="ctr" anchorCtr="0">
          <a:noAutofit/>
        </a:bodyPr>
        <a:lstStyle/>
        <a:p>
          <a:pPr marL="0" lvl="0" indent="0" algn="l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200" kern="1200">
              <a:latin typeface="Arial" panose="020B0604020202020204" pitchFamily="34" charset="0"/>
              <a:cs typeface="Arial" panose="020B0604020202020204" pitchFamily="34" charset="0"/>
            </a:rPr>
            <a:t>Problems with blood clotting</a:t>
          </a:r>
        </a:p>
        <a:p>
          <a:pPr marL="0" lvl="0" indent="0" algn="l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200" kern="1200" dirty="0">
              <a:latin typeface="Arial" panose="020B0604020202020204" pitchFamily="34" charset="0"/>
              <a:cs typeface="Arial" panose="020B0604020202020204" pitchFamily="34" charset="0"/>
            </a:rPr>
            <a:t>High blood pressure</a:t>
          </a:r>
        </a:p>
        <a:p>
          <a:pPr marL="0" lvl="0" indent="0" algn="l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200" kern="1200" dirty="0">
              <a:latin typeface="Arial" panose="020B0604020202020204" pitchFamily="34" charset="0"/>
              <a:cs typeface="Arial" panose="020B0604020202020204" pitchFamily="34" charset="0"/>
            </a:rPr>
            <a:t>Fatigue</a:t>
          </a:r>
        </a:p>
        <a:p>
          <a:pPr marL="0" lvl="0" indent="0" algn="l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200" kern="1200">
              <a:latin typeface="Arial" panose="020B0604020202020204" pitchFamily="34" charset="0"/>
              <a:cs typeface="Arial" panose="020B0604020202020204" pitchFamily="34" charset="0"/>
            </a:rPr>
            <a:t>Loss or hair color</a:t>
          </a:r>
        </a:p>
      </dsp:txBody>
      <dsp:txXfrm>
        <a:off x="4151603" y="3631124"/>
        <a:ext cx="2198158" cy="1449223"/>
      </dsp:txXfrm>
    </dsp:sp>
  </dsp:spTree>
</dsp:drawing>
</file>

<file path=ppt/diagrams/drawing5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4F529C9B-0BBB-2A41-BE83-5846CC908621}">
      <dsp:nvSpPr>
        <dsp:cNvPr id="0" name=""/>
        <dsp:cNvSpPr/>
      </dsp:nvSpPr>
      <dsp:spPr>
        <a:xfrm>
          <a:off x="0" y="3311333"/>
          <a:ext cx="6240668" cy="2172592"/>
        </a:xfrm>
        <a:prstGeom prst="rect">
          <a:avLst/>
        </a:prstGeom>
        <a:solidFill>
          <a:schemeClr val="accent2"/>
        </a:solidFill>
        <a:ln>
          <a:noFill/>
        </a:ln>
        <a:effectLst/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199136" tIns="199136" rIns="199136" bIns="199136" numCol="1" spcCol="1270" anchor="ctr" anchorCtr="0">
          <a:noAutofit/>
        </a:bodyPr>
        <a:lstStyle/>
        <a:p>
          <a:pPr marL="0" lvl="0" indent="0" algn="ctr" defTabSz="1244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800" kern="1200" dirty="0">
              <a:solidFill>
                <a:schemeClr val="tx1">
                  <a:lumMod val="85000"/>
                  <a:lumOff val="1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rPr>
            <a:t>Because cancer cells use hormones to grow, these drugs greatly inhibit a cancer cell’s ability to grow.</a:t>
          </a:r>
        </a:p>
      </dsp:txBody>
      <dsp:txXfrm>
        <a:off x="0" y="3311333"/>
        <a:ext cx="6240668" cy="2172592"/>
      </dsp:txXfrm>
    </dsp:sp>
    <dsp:sp modelId="{795E3102-D915-AA46-9C92-BCF062CC656C}">
      <dsp:nvSpPr>
        <dsp:cNvPr id="0" name=""/>
        <dsp:cNvSpPr/>
      </dsp:nvSpPr>
      <dsp:spPr>
        <a:xfrm rot="10800000">
          <a:off x="0" y="2473"/>
          <a:ext cx="6240668" cy="3341447"/>
        </a:xfrm>
        <a:prstGeom prst="upArrowCallout">
          <a:avLst/>
        </a:prstGeom>
        <a:solidFill>
          <a:schemeClr val="accent1"/>
        </a:solidFill>
        <a:ln>
          <a:noFill/>
        </a:ln>
        <a:effectLst/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199136" tIns="199136" rIns="199136" bIns="199136" numCol="1" spcCol="1270" anchor="ctr" anchorCtr="0">
          <a:noAutofit/>
        </a:bodyPr>
        <a:lstStyle/>
        <a:p>
          <a:pPr marL="0" lvl="0" indent="0" algn="ctr" defTabSz="1244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800" b="1" kern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rPr>
            <a:t>Two main types of hormone therapies</a:t>
          </a:r>
        </a:p>
      </dsp:txBody>
      <dsp:txXfrm rot="-10800000">
        <a:off x="0" y="2473"/>
        <a:ext cx="6240668" cy="1172848"/>
      </dsp:txXfrm>
    </dsp:sp>
    <dsp:sp modelId="{60800158-254E-B74B-92A9-3222883C37BC}">
      <dsp:nvSpPr>
        <dsp:cNvPr id="0" name=""/>
        <dsp:cNvSpPr/>
      </dsp:nvSpPr>
      <dsp:spPr>
        <a:xfrm>
          <a:off x="0" y="1175322"/>
          <a:ext cx="3120334" cy="999092"/>
        </a:xfrm>
        <a:prstGeom prst="rect">
          <a:avLst/>
        </a:prstGeom>
        <a:solidFill>
          <a:schemeClr val="accent2">
            <a:tint val="40000"/>
            <a:alpha val="90000"/>
            <a:hueOff val="0"/>
            <a:satOff val="0"/>
            <a:lumOff val="0"/>
            <a:alphaOff val="0"/>
          </a:schemeClr>
        </a:solidFill>
        <a:ln w="6350" cap="flat" cmpd="sng" algn="ctr">
          <a:solidFill>
            <a:schemeClr val="accent2">
              <a:tint val="40000"/>
              <a:alpha val="9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63576" tIns="29210" rIns="163576" bIns="29210" numCol="1" spcCol="1270" anchor="ctr" anchorCtr="0">
          <a:noAutofit/>
        </a:bodyPr>
        <a:lstStyle/>
        <a:p>
          <a:pPr marL="0" lvl="0" indent="0" algn="ctr" defTabSz="10223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300" kern="1200" dirty="0">
              <a:latin typeface="Arial" panose="020B0604020202020204" pitchFamily="34" charset="0"/>
              <a:cs typeface="Arial" panose="020B0604020202020204" pitchFamily="34" charset="0"/>
            </a:rPr>
            <a:t>Drugs that </a:t>
          </a:r>
          <a:r>
            <a:rPr lang="en-US" sz="2300" b="1" kern="1200" dirty="0">
              <a:latin typeface="Arial" panose="020B0604020202020204" pitchFamily="34" charset="0"/>
              <a:cs typeface="Arial" panose="020B0604020202020204" pitchFamily="34" charset="0"/>
            </a:rPr>
            <a:t>block</a:t>
          </a:r>
          <a:r>
            <a:rPr lang="en-US" sz="2300" kern="1200" dirty="0">
              <a:latin typeface="Arial" panose="020B0604020202020204" pitchFamily="34" charset="0"/>
              <a:cs typeface="Arial" panose="020B0604020202020204" pitchFamily="34" charset="0"/>
            </a:rPr>
            <a:t> the body’s ability to produce hormones.</a:t>
          </a:r>
        </a:p>
      </dsp:txBody>
      <dsp:txXfrm>
        <a:off x="0" y="1175322"/>
        <a:ext cx="3120334" cy="999092"/>
      </dsp:txXfrm>
    </dsp:sp>
    <dsp:sp modelId="{AE8D45A1-4B4C-8645-9C35-97ED0F39A8F6}">
      <dsp:nvSpPr>
        <dsp:cNvPr id="0" name=""/>
        <dsp:cNvSpPr/>
      </dsp:nvSpPr>
      <dsp:spPr>
        <a:xfrm>
          <a:off x="3120334" y="1175322"/>
          <a:ext cx="3120334" cy="999092"/>
        </a:xfrm>
        <a:prstGeom prst="rect">
          <a:avLst/>
        </a:prstGeom>
        <a:solidFill>
          <a:schemeClr val="accent2">
            <a:tint val="40000"/>
            <a:alpha val="90000"/>
            <a:hueOff val="-11825480"/>
            <a:satOff val="-66453"/>
            <a:lumOff val="-1104"/>
            <a:alphaOff val="0"/>
          </a:schemeClr>
        </a:solidFill>
        <a:ln w="6350" cap="flat" cmpd="sng" algn="ctr">
          <a:solidFill>
            <a:schemeClr val="accent2">
              <a:tint val="40000"/>
              <a:alpha val="90000"/>
              <a:hueOff val="-11825480"/>
              <a:satOff val="-66453"/>
              <a:lumOff val="-1104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63576" tIns="29210" rIns="163576" bIns="29210" numCol="1" spcCol="1270" anchor="ctr" anchorCtr="0">
          <a:noAutofit/>
        </a:bodyPr>
        <a:lstStyle/>
        <a:p>
          <a:pPr marL="0" lvl="0" indent="0" algn="ctr" defTabSz="10223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300" kern="1200" dirty="0">
              <a:latin typeface="Arial" panose="020B0604020202020204" pitchFamily="34" charset="0"/>
              <a:cs typeface="Arial" panose="020B0604020202020204" pitchFamily="34" charset="0"/>
            </a:rPr>
            <a:t>Drugs that </a:t>
          </a:r>
          <a:r>
            <a:rPr lang="en-US" sz="2300" b="1" kern="1200" dirty="0">
              <a:latin typeface="Arial" panose="020B0604020202020204" pitchFamily="34" charset="0"/>
              <a:cs typeface="Arial" panose="020B0604020202020204" pitchFamily="34" charset="0"/>
            </a:rPr>
            <a:t>interfere</a:t>
          </a:r>
          <a:r>
            <a:rPr lang="en-US" sz="2300" kern="1200" dirty="0">
              <a:latin typeface="Arial" panose="020B0604020202020204" pitchFamily="34" charset="0"/>
              <a:cs typeface="Arial" panose="020B0604020202020204" pitchFamily="34" charset="0"/>
            </a:rPr>
            <a:t> with how hormones behave in the body.</a:t>
          </a:r>
        </a:p>
      </dsp:txBody>
      <dsp:txXfrm>
        <a:off x="3120334" y="1175322"/>
        <a:ext cx="3120334" cy="999092"/>
      </dsp:txXfrm>
    </dsp:sp>
  </dsp:spTree>
</dsp:drawing>
</file>

<file path=ppt/diagrams/drawing6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B08FD63D-F074-DE45-AC55-4F9470DEC614}">
      <dsp:nvSpPr>
        <dsp:cNvPr id="0" name=""/>
        <dsp:cNvSpPr/>
      </dsp:nvSpPr>
      <dsp:spPr>
        <a:xfrm>
          <a:off x="0" y="3247932"/>
          <a:ext cx="6635260" cy="2130995"/>
        </a:xfrm>
        <a:prstGeom prst="rect">
          <a:avLst/>
        </a:prstGeom>
        <a:solidFill>
          <a:schemeClr val="accent3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41808" tIns="241808" rIns="241808" bIns="241808" numCol="1" spcCol="1270" anchor="ctr" anchorCtr="0">
          <a:noAutofit/>
        </a:bodyPr>
        <a:lstStyle/>
        <a:p>
          <a:pPr marL="0" lvl="0" indent="0" algn="ctr" defTabSz="1511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400" kern="12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rPr>
            <a:t>What causes these differences?</a:t>
          </a:r>
        </a:p>
      </dsp:txBody>
      <dsp:txXfrm>
        <a:off x="0" y="3247932"/>
        <a:ext cx="6635260" cy="1150737"/>
      </dsp:txXfrm>
    </dsp:sp>
    <dsp:sp modelId="{91C61337-F8B0-1548-8ED4-F1515FDADD4E}">
      <dsp:nvSpPr>
        <dsp:cNvPr id="0" name=""/>
        <dsp:cNvSpPr/>
      </dsp:nvSpPr>
      <dsp:spPr>
        <a:xfrm>
          <a:off x="3239" y="4356050"/>
          <a:ext cx="2209593" cy="980257"/>
        </a:xfrm>
        <a:prstGeom prst="rect">
          <a:avLst/>
        </a:prstGeom>
        <a:solidFill>
          <a:schemeClr val="accent3">
            <a:alpha val="90000"/>
            <a:tint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3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0904" tIns="21590" rIns="120904" bIns="2159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>
              <a:latin typeface="Arial" panose="020B0604020202020204" pitchFamily="34" charset="0"/>
              <a:cs typeface="Arial" panose="020B0604020202020204" pitchFamily="34" charset="0"/>
            </a:rPr>
            <a:t>Genetics</a:t>
          </a:r>
        </a:p>
      </dsp:txBody>
      <dsp:txXfrm>
        <a:off x="3239" y="4356050"/>
        <a:ext cx="2209593" cy="980257"/>
      </dsp:txXfrm>
    </dsp:sp>
    <dsp:sp modelId="{5D6E6FEE-1495-E64F-9F21-F1F2440AB5D1}">
      <dsp:nvSpPr>
        <dsp:cNvPr id="0" name=""/>
        <dsp:cNvSpPr/>
      </dsp:nvSpPr>
      <dsp:spPr>
        <a:xfrm>
          <a:off x="2212833" y="4356050"/>
          <a:ext cx="2209593" cy="980257"/>
        </a:xfrm>
        <a:prstGeom prst="rect">
          <a:avLst/>
        </a:prstGeom>
        <a:solidFill>
          <a:schemeClr val="accent3">
            <a:alpha val="90000"/>
            <a:tint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3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0904" tIns="21590" rIns="120904" bIns="2159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>
              <a:latin typeface="Arial" panose="020B0604020202020204" pitchFamily="34" charset="0"/>
              <a:cs typeface="Arial" panose="020B0604020202020204" pitchFamily="34" charset="0"/>
            </a:rPr>
            <a:t>Interactions of drugs and treatments with the body</a:t>
          </a:r>
        </a:p>
      </dsp:txBody>
      <dsp:txXfrm>
        <a:off x="2212833" y="4356050"/>
        <a:ext cx="2209593" cy="980257"/>
      </dsp:txXfrm>
    </dsp:sp>
    <dsp:sp modelId="{D3D59393-533D-2E43-8626-59A3D8119A8A}">
      <dsp:nvSpPr>
        <dsp:cNvPr id="0" name=""/>
        <dsp:cNvSpPr/>
      </dsp:nvSpPr>
      <dsp:spPr>
        <a:xfrm>
          <a:off x="4422426" y="4356050"/>
          <a:ext cx="2209593" cy="980257"/>
        </a:xfrm>
        <a:prstGeom prst="rect">
          <a:avLst/>
        </a:prstGeom>
        <a:solidFill>
          <a:schemeClr val="accent3">
            <a:alpha val="90000"/>
            <a:tint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3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0904" tIns="21590" rIns="120904" bIns="2159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>
              <a:latin typeface="Arial" panose="020B0604020202020204" pitchFamily="34" charset="0"/>
              <a:cs typeface="Arial" panose="020B0604020202020204" pitchFamily="34" charset="0"/>
            </a:rPr>
            <a:t>Cancer and tumor type</a:t>
          </a:r>
        </a:p>
      </dsp:txBody>
      <dsp:txXfrm>
        <a:off x="4422426" y="4356050"/>
        <a:ext cx="2209593" cy="980257"/>
      </dsp:txXfrm>
    </dsp:sp>
    <dsp:sp modelId="{93657314-A251-5748-BE25-3EE59AC7C52F}">
      <dsp:nvSpPr>
        <dsp:cNvPr id="0" name=""/>
        <dsp:cNvSpPr/>
      </dsp:nvSpPr>
      <dsp:spPr>
        <a:xfrm rot="10800000">
          <a:off x="0" y="2426"/>
          <a:ext cx="6635260" cy="3277471"/>
        </a:xfrm>
        <a:prstGeom prst="upArrowCallout">
          <a:avLst/>
        </a:prstGeom>
        <a:solidFill>
          <a:schemeClr val="accent3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41808" tIns="241808" rIns="241808" bIns="241808" numCol="1" spcCol="1270" anchor="ctr" anchorCtr="0">
          <a:noAutofit/>
        </a:bodyPr>
        <a:lstStyle/>
        <a:p>
          <a:pPr marL="0" lvl="0" indent="0" algn="ctr" defTabSz="1511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400" b="1" kern="12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rPr>
            <a:t>No!</a:t>
          </a:r>
          <a:r>
            <a:rPr lang="en-US" sz="3400" kern="12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rPr>
            <a:t> Some treatments will work for some patients, while others won’t. </a:t>
          </a:r>
        </a:p>
      </dsp:txBody>
      <dsp:txXfrm rot="10800000">
        <a:off x="0" y="2426"/>
        <a:ext cx="6635260" cy="2129602"/>
      </dsp:txXfrm>
    </dsp:sp>
  </dsp:spTree>
</dsp:drawing>
</file>

<file path=ppt/diagrams/drawing7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D07D8D82-7559-E44A-A83B-0158FA86DC02}">
      <dsp:nvSpPr>
        <dsp:cNvPr id="0" name=""/>
        <dsp:cNvSpPr/>
      </dsp:nvSpPr>
      <dsp:spPr>
        <a:xfrm>
          <a:off x="0" y="57057"/>
          <a:ext cx="6681744" cy="1042470"/>
        </a:xfrm>
        <a:prstGeom prst="roundRect">
          <a:avLst/>
        </a:prstGeom>
        <a:solidFill>
          <a:schemeClr val="accent5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02870" tIns="102870" rIns="102870" bIns="102870" numCol="1" spcCol="1270" anchor="ctr" anchorCtr="0">
          <a:noAutofit/>
        </a:bodyPr>
        <a:lstStyle/>
        <a:p>
          <a:pPr marL="0" lvl="0" indent="0" algn="l" defTabSz="12001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700" kern="1200" dirty="0">
              <a:latin typeface="Arial" panose="020B0604020202020204" pitchFamily="34" charset="0"/>
              <a:cs typeface="Arial" panose="020B0604020202020204" pitchFamily="34" charset="0"/>
            </a:rPr>
            <a:t>Increases the likelihood the cancer will be eliminated</a:t>
          </a:r>
        </a:p>
      </dsp:txBody>
      <dsp:txXfrm>
        <a:off x="50889" y="107946"/>
        <a:ext cx="6579966" cy="940692"/>
      </dsp:txXfrm>
    </dsp:sp>
    <dsp:sp modelId="{3A97C8F2-52C3-6C4C-BB09-63AB8722A2F4}">
      <dsp:nvSpPr>
        <dsp:cNvPr id="0" name=""/>
        <dsp:cNvSpPr/>
      </dsp:nvSpPr>
      <dsp:spPr>
        <a:xfrm>
          <a:off x="0" y="1099527"/>
          <a:ext cx="6681744" cy="628762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12145" tIns="34290" rIns="192024" bIns="34290" numCol="1" spcCol="1270" anchor="t" anchorCtr="0">
          <a:noAutofit/>
        </a:bodyPr>
        <a:lstStyle/>
        <a:p>
          <a:pPr marL="228600" lvl="1" indent="-228600" algn="l" defTabSz="933450">
            <a:lnSpc>
              <a:spcPct val="90000"/>
            </a:lnSpc>
            <a:spcBef>
              <a:spcPct val="0"/>
            </a:spcBef>
            <a:spcAft>
              <a:spcPct val="20000"/>
            </a:spcAft>
            <a:buChar char="•"/>
          </a:pPr>
          <a:r>
            <a:rPr lang="en-US" sz="2100" kern="1200" dirty="0">
              <a:latin typeface="Arial" panose="020B0604020202020204" pitchFamily="34" charset="0"/>
              <a:cs typeface="Arial" panose="020B0604020202020204" pitchFamily="34" charset="0"/>
            </a:rPr>
            <a:t>If the cancer is not sensitive to one treatment type, it may be eliminated by another.</a:t>
          </a:r>
        </a:p>
      </dsp:txBody>
      <dsp:txXfrm>
        <a:off x="0" y="1099527"/>
        <a:ext cx="6681744" cy="628762"/>
      </dsp:txXfrm>
    </dsp:sp>
    <dsp:sp modelId="{77CE9661-810D-9B41-988B-DB96419D4CC5}">
      <dsp:nvSpPr>
        <dsp:cNvPr id="0" name=""/>
        <dsp:cNvSpPr/>
      </dsp:nvSpPr>
      <dsp:spPr>
        <a:xfrm>
          <a:off x="0" y="1728290"/>
          <a:ext cx="6681744" cy="1042470"/>
        </a:xfrm>
        <a:prstGeom prst="roundRect">
          <a:avLst/>
        </a:prstGeom>
        <a:solidFill>
          <a:schemeClr val="accent1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02870" tIns="102870" rIns="102870" bIns="102870" numCol="1" spcCol="1270" anchor="ctr" anchorCtr="0">
          <a:noAutofit/>
        </a:bodyPr>
        <a:lstStyle/>
        <a:p>
          <a:pPr marL="0" lvl="0" indent="0" algn="l" defTabSz="12001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700" kern="1200" dirty="0">
              <a:latin typeface="Arial" panose="020B0604020202020204" pitchFamily="34" charset="0"/>
              <a:cs typeface="Arial" panose="020B0604020202020204" pitchFamily="34" charset="0"/>
            </a:rPr>
            <a:t>Prevents developments of drug resistance</a:t>
          </a:r>
        </a:p>
      </dsp:txBody>
      <dsp:txXfrm>
        <a:off x="50889" y="1779179"/>
        <a:ext cx="6579966" cy="940692"/>
      </dsp:txXfrm>
    </dsp:sp>
    <dsp:sp modelId="{6C24F5BC-E73C-DB47-8BC3-199E8FC98AAC}">
      <dsp:nvSpPr>
        <dsp:cNvPr id="0" name=""/>
        <dsp:cNvSpPr/>
      </dsp:nvSpPr>
      <dsp:spPr>
        <a:xfrm>
          <a:off x="0" y="2770760"/>
          <a:ext cx="6681744" cy="922184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12145" tIns="34290" rIns="192024" bIns="34290" numCol="1" spcCol="1270" anchor="t" anchorCtr="0">
          <a:noAutofit/>
        </a:bodyPr>
        <a:lstStyle/>
        <a:p>
          <a:pPr marL="228600" lvl="1" indent="-228600" algn="l" defTabSz="933450">
            <a:lnSpc>
              <a:spcPct val="90000"/>
            </a:lnSpc>
            <a:spcBef>
              <a:spcPct val="0"/>
            </a:spcBef>
            <a:spcAft>
              <a:spcPct val="20000"/>
            </a:spcAft>
            <a:buChar char="•"/>
          </a:pPr>
          <a:r>
            <a:rPr lang="en-US" sz="2100" kern="1200" dirty="0">
              <a:latin typeface="Arial" panose="020B0604020202020204" pitchFamily="34" charset="0"/>
              <a:cs typeface="Arial" panose="020B0604020202020204" pitchFamily="34" charset="0"/>
            </a:rPr>
            <a:t>If the cancer mutates and becomes resistant to one drug type, the likelihood that it will mutate and become resistant to both is extremely slim.</a:t>
          </a:r>
        </a:p>
      </dsp:txBody>
      <dsp:txXfrm>
        <a:off x="0" y="2770760"/>
        <a:ext cx="6681744" cy="922184"/>
      </dsp:txXfrm>
    </dsp:sp>
    <dsp:sp modelId="{F636404D-010E-AB46-9AD3-A4E4702E9530}">
      <dsp:nvSpPr>
        <dsp:cNvPr id="0" name=""/>
        <dsp:cNvSpPr/>
      </dsp:nvSpPr>
      <dsp:spPr>
        <a:xfrm>
          <a:off x="0" y="3692945"/>
          <a:ext cx="6681744" cy="1042470"/>
        </a:xfrm>
        <a:prstGeom prst="roundRect">
          <a:avLst/>
        </a:prstGeom>
        <a:solidFill>
          <a:schemeClr val="accent6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02870" tIns="102870" rIns="102870" bIns="102870" numCol="1" spcCol="1270" anchor="ctr" anchorCtr="0">
          <a:noAutofit/>
        </a:bodyPr>
        <a:lstStyle/>
        <a:p>
          <a:pPr marL="0" lvl="0" indent="0" algn="l" defTabSz="12001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700" kern="1200">
              <a:latin typeface="Arial" panose="020B0604020202020204" pitchFamily="34" charset="0"/>
              <a:cs typeface="Arial" panose="020B0604020202020204" pitchFamily="34" charset="0"/>
            </a:rPr>
            <a:t>Reduces length of treatment</a:t>
          </a:r>
        </a:p>
      </dsp:txBody>
      <dsp:txXfrm>
        <a:off x="50889" y="3743834"/>
        <a:ext cx="6579966" cy="940692"/>
      </dsp:txXfrm>
    </dsp:sp>
    <dsp:sp modelId="{3ABBF6B3-1845-E948-84DB-EA068A9C2739}">
      <dsp:nvSpPr>
        <dsp:cNvPr id="0" name=""/>
        <dsp:cNvSpPr/>
      </dsp:nvSpPr>
      <dsp:spPr>
        <a:xfrm>
          <a:off x="0" y="4735415"/>
          <a:ext cx="6681744" cy="922184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12145" tIns="34290" rIns="192024" bIns="34290" numCol="1" spcCol="1270" anchor="t" anchorCtr="0">
          <a:noAutofit/>
        </a:bodyPr>
        <a:lstStyle/>
        <a:p>
          <a:pPr marL="228600" lvl="1" indent="-228600" algn="l" defTabSz="933450">
            <a:lnSpc>
              <a:spcPct val="90000"/>
            </a:lnSpc>
            <a:spcBef>
              <a:spcPct val="0"/>
            </a:spcBef>
            <a:spcAft>
              <a:spcPct val="20000"/>
            </a:spcAft>
            <a:buChar char="•"/>
          </a:pPr>
          <a:r>
            <a:rPr lang="en-US" sz="2100" kern="1200" dirty="0">
              <a:latin typeface="Arial" panose="020B0604020202020204" pitchFamily="34" charset="0"/>
              <a:cs typeface="Arial" panose="020B0604020202020204" pitchFamily="34" charset="0"/>
            </a:rPr>
            <a:t>By doing two treatments at once, it lessens the ”trial and error” phase to see if one treatment doesn’t work.</a:t>
          </a:r>
        </a:p>
      </dsp:txBody>
      <dsp:txXfrm>
        <a:off x="0" y="4735415"/>
        <a:ext cx="6681744" cy="922184"/>
      </dsp:txXfrm>
    </dsp:sp>
  </dsp:spTree>
</dsp:drawing>
</file>

<file path=ppt/diagrams/drawing8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4F36D69D-6E7E-7A47-AD1E-5124971184A6}">
      <dsp:nvSpPr>
        <dsp:cNvPr id="0" name=""/>
        <dsp:cNvSpPr/>
      </dsp:nvSpPr>
      <dsp:spPr>
        <a:xfrm>
          <a:off x="0" y="4911"/>
          <a:ext cx="6240668" cy="1596038"/>
        </a:xfrm>
        <a:prstGeom prst="roundRect">
          <a:avLst/>
        </a:prstGeom>
        <a:solidFill>
          <a:schemeClr val="accent5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1920" tIns="121920" rIns="121920" bIns="121920" numCol="1" spcCol="1270" anchor="ctr" anchorCtr="0">
          <a:noAutofit/>
        </a:bodyPr>
        <a:lstStyle/>
        <a:p>
          <a:pPr marL="0" lvl="0" indent="0" algn="l" defTabSz="1422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200" kern="1200">
              <a:latin typeface="Arial" panose="020B0604020202020204" pitchFamily="34" charset="0"/>
              <a:cs typeface="Arial" panose="020B0604020202020204" pitchFamily="34" charset="0"/>
            </a:rPr>
            <a:t>Unclear how the patients’ body will interact to two treatment types</a:t>
          </a:r>
        </a:p>
      </dsp:txBody>
      <dsp:txXfrm>
        <a:off x="77912" y="82823"/>
        <a:ext cx="6084844" cy="1440214"/>
      </dsp:txXfrm>
    </dsp:sp>
    <dsp:sp modelId="{3A823256-9961-7047-955A-C3D1B86C2C24}">
      <dsp:nvSpPr>
        <dsp:cNvPr id="0" name=""/>
        <dsp:cNvSpPr/>
      </dsp:nvSpPr>
      <dsp:spPr>
        <a:xfrm>
          <a:off x="0" y="1600949"/>
          <a:ext cx="6240668" cy="362774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8141" tIns="30480" rIns="170688" bIns="30480" numCol="1" spcCol="1270" anchor="t" anchorCtr="0">
          <a:noAutofit/>
        </a:bodyPr>
        <a:lstStyle/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20000"/>
            </a:spcAft>
            <a:buChar char="•"/>
          </a:pPr>
          <a:r>
            <a:rPr lang="en-US" sz="2400" kern="1200">
              <a:latin typeface="Arial" panose="020B0604020202020204" pitchFamily="34" charset="0"/>
              <a:cs typeface="Arial" panose="020B0604020202020204" pitchFamily="34" charset="0"/>
            </a:rPr>
            <a:t>Could cause severe side effects</a:t>
          </a:r>
        </a:p>
      </dsp:txBody>
      <dsp:txXfrm>
        <a:off x="0" y="1600949"/>
        <a:ext cx="6240668" cy="362774"/>
      </dsp:txXfrm>
    </dsp:sp>
    <dsp:sp modelId="{70117F78-E04B-AA41-BB31-D0CAC798E5A6}">
      <dsp:nvSpPr>
        <dsp:cNvPr id="0" name=""/>
        <dsp:cNvSpPr/>
      </dsp:nvSpPr>
      <dsp:spPr>
        <a:xfrm>
          <a:off x="0" y="1963724"/>
          <a:ext cx="6240668" cy="1596038"/>
        </a:xfrm>
        <a:prstGeom prst="roundRect">
          <a:avLst/>
        </a:prstGeom>
        <a:solidFill>
          <a:schemeClr val="accent5">
            <a:hueOff val="-15900093"/>
            <a:satOff val="-36158"/>
            <a:lumOff val="-8431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1920" tIns="121920" rIns="121920" bIns="121920" numCol="1" spcCol="1270" anchor="ctr" anchorCtr="0">
          <a:noAutofit/>
        </a:bodyPr>
        <a:lstStyle/>
        <a:p>
          <a:pPr marL="0" lvl="0" indent="0" algn="l" defTabSz="1422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200" kern="1200">
              <a:latin typeface="Arial" panose="020B0604020202020204" pitchFamily="34" charset="0"/>
              <a:cs typeface="Arial" panose="020B0604020202020204" pitchFamily="34" charset="0"/>
            </a:rPr>
            <a:t>Occasionally unclear how the two types/drugs will interact with one another</a:t>
          </a:r>
        </a:p>
      </dsp:txBody>
      <dsp:txXfrm>
        <a:off x="77912" y="2041636"/>
        <a:ext cx="6084844" cy="1440214"/>
      </dsp:txXfrm>
    </dsp:sp>
    <dsp:sp modelId="{7168C23C-5D4E-114A-888F-C33FE215E7E6}">
      <dsp:nvSpPr>
        <dsp:cNvPr id="0" name=""/>
        <dsp:cNvSpPr/>
      </dsp:nvSpPr>
      <dsp:spPr>
        <a:xfrm>
          <a:off x="0" y="3559762"/>
          <a:ext cx="6240668" cy="1921725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98141" tIns="30480" rIns="170688" bIns="30480" numCol="1" spcCol="1270" anchor="t" anchorCtr="0">
          <a:noAutofit/>
        </a:bodyPr>
        <a:lstStyle/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20000"/>
            </a:spcAft>
            <a:buChar char="•"/>
          </a:pPr>
          <a:r>
            <a:rPr lang="en-US" sz="2400" kern="1200" dirty="0">
              <a:latin typeface="Arial" panose="020B0604020202020204" pitchFamily="34" charset="0"/>
              <a:cs typeface="Arial" panose="020B0604020202020204" pitchFamily="34" charset="0"/>
            </a:rPr>
            <a:t>Normally, extensive research is done on drug interaction before they are combined for treatment.</a:t>
          </a:r>
        </a:p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20000"/>
            </a:spcAft>
            <a:buChar char="•"/>
          </a:pPr>
          <a:r>
            <a:rPr lang="en-US" sz="2400" kern="1200" dirty="0">
              <a:latin typeface="Arial" panose="020B0604020202020204" pitchFamily="34" charset="0"/>
              <a:cs typeface="Arial" panose="020B0604020202020204" pitchFamily="34" charset="0"/>
            </a:rPr>
            <a:t>However, some drugs may be in a clinical trial phase where their interaction is not totally understood.</a:t>
          </a:r>
        </a:p>
      </dsp:txBody>
      <dsp:txXfrm>
        <a:off x="0" y="3559762"/>
        <a:ext cx="6240668" cy="1921725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list1">
  <dgm:title val=""/>
  <dgm:desc val=""/>
  <dgm:catLst>
    <dgm:cat type="list" pri="4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4" srcId="0" destId="1" srcOrd="0" destOrd="0"/>
        <dgm:cxn modelId="5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linear">
    <dgm:varLst>
      <dgm:dir/>
      <dgm:animLvl val="lvl"/>
      <dgm:resizeHandles val="exact"/>
    </dgm:varLst>
    <dgm:choose name="Name0">
      <dgm:if name="Name1" func="var" arg="dir" op="equ" val="norm">
        <dgm:alg type="lin">
          <dgm:param type="linDir" val="fromT"/>
          <dgm:param type="vertAlign" val="mid"/>
          <dgm:param type="horzAlign" val="l"/>
          <dgm:param type="nodeHorzAlign" val="l"/>
        </dgm:alg>
      </dgm:if>
      <dgm:else name="Name2">
        <dgm:alg type="lin">
          <dgm:param type="linDir" val="fromT"/>
          <dgm:param type="vertAlign" val="mid"/>
          <dgm:param type="horzAlign" val="r"/>
          <dgm:param type="nodeHorzAlign" val="r"/>
        </dgm:alg>
      </dgm:else>
    </dgm:choose>
    <dgm:shape xmlns:r="http://schemas.openxmlformats.org/officeDocument/2006/relationships" r:blip="">
      <dgm:adjLst/>
    </dgm:shape>
    <dgm:presOf/>
    <dgm:constrLst>
      <dgm:constr type="w" for="ch" forName="parentLin" refType="w"/>
      <dgm:constr type="h" for="ch" forName="parentLin" val="INF"/>
      <dgm:constr type="w" for="des" forName="parentLeftMargin" refType="w" fact="0.05"/>
      <dgm:constr type="w" for="des" forName="parentText" refType="w" fact="0.7"/>
      <dgm:constr type="h" for="des" forName="parentText" refType="primFontSz" refFor="des" refForName="parentText" fact="0.82"/>
      <dgm:constr type="h" for="ch" forName="negativeSpace" refType="primFontSz" refFor="des" refForName="parentText" fact="-0.41"/>
      <dgm:constr type="h" for="ch" forName="negativeSpace" refType="h" refFor="des" refForName="parentText" op="lte" fact="-0.82"/>
      <dgm:constr type="h" for="ch" forName="negativeSpace" refType="h" refFor="des" refForName="parentText" op="gte" fact="-0.82"/>
      <dgm:constr type="w" for="ch" forName="childText" refType="w"/>
      <dgm:constr type="h" for="ch" forName="childText" refType="primFontSz" refFor="des" refForName="parentText" fact="0.7"/>
      <dgm:constr type="primFontSz" for="des" forName="parentText" val="65"/>
      <dgm:constr type="primFontSz" for="ch" forName="childText" refType="primFontSz" refFor="des" refForName="parentText"/>
      <dgm:constr type="tMarg" for="ch" forName="childText" refType="primFontSz" refFor="des" refForName="parentText" fact="1.64"/>
      <dgm:constr type="tMarg" for="ch" forName="childText" refType="h" refFor="des" refForName="parentText" op="lte" fact="3.28"/>
      <dgm:constr type="tMarg" for="ch" forName="childText" refType="h" refFor="des" refForName="parentText" op="gte" fact="3.28"/>
      <dgm:constr type="lMarg" for="ch" forName="childText" refType="w" fact="0.22"/>
      <dgm:constr type="rMarg" for="ch" forName="childText" refType="lMarg" refFor="ch" refForName="childText"/>
      <dgm:constr type="lMarg" for="des" forName="parentText" refType="w" fact="0.075"/>
      <dgm:constr type="rMarg" for="des" forName="parentText" refType="lMarg" refFor="des" refForName="parentText"/>
      <dgm:constr type="h" for="ch" forName="spaceBetweenRectangles" refType="primFontSz" refFor="des" refForName="parentText" fact="0.15"/>
    </dgm:constrLst>
    <dgm:ruleLst>
      <dgm:rule type="primFontSz" for="des" forName="parentText" val="5" fact="NaN" max="NaN"/>
    </dgm:ruleLst>
    <dgm:forEach name="Name3" axis="ch" ptType="node">
      <dgm:layoutNode name="parentLin">
        <dgm:choose name="Name4">
          <dgm:if name="Name5" func="var" arg="dir" op="equ" val="norm">
            <dgm:alg type="lin">
              <dgm:param type="linDir" val="fromL"/>
              <dgm:param type="horzAlign" val="l"/>
              <dgm:param type="nodeHorzAlign" val="l"/>
            </dgm:alg>
          </dgm:if>
          <dgm:else name="Name6">
            <dgm:alg type="lin">
              <dgm:param type="linDir" val="fromR"/>
              <dgm:param type="horzAlign" val="r"/>
              <dgm:param type="nodeHorzAlign" val="r"/>
            </dgm:alg>
          </dgm:else>
        </dgm:choose>
        <dgm:shape xmlns:r="http://schemas.openxmlformats.org/officeDocument/2006/relationships" r:blip="">
          <dgm:adjLst/>
        </dgm:shape>
        <dgm:presOf/>
        <dgm:constrLst/>
        <dgm:ruleLst/>
        <dgm:layoutNode name="parentLeftMargin">
          <dgm:alg type="sp"/>
          <dgm:shape xmlns:r="http://schemas.openxmlformats.org/officeDocument/2006/relationships" type="rect" r:blip="" hideGeom="1">
            <dgm:adjLst/>
          </dgm:shape>
          <dgm:presOf axis="self"/>
          <dgm:constrLst>
            <dgm:constr type="h"/>
          </dgm:constrLst>
          <dgm:ruleLst/>
        </dgm:layoutNode>
        <dgm:layoutNode name="parentText" styleLbl="node1">
          <dgm:varLst>
            <dgm:chMax val="0"/>
            <dgm:bulletEnabled val="1"/>
          </dgm:varLst>
          <dgm:choose name="Name7">
            <dgm:if name="Name8" func="var" arg="dir" op="equ" val="norm">
              <dgm:alg type="tx">
                <dgm:param type="parTxLTRAlign" val="l"/>
                <dgm:param type="parTxRTLAlign" val="l"/>
              </dgm:alg>
            </dgm:if>
            <dgm:else name="Name9">
              <dgm:alg type="tx">
                <dgm:param type="parTxLTRAlign" val="r"/>
                <dgm:param type="parTxRTLAlign" val="r"/>
              </dgm:alg>
            </dgm:else>
          </dgm:choose>
          <dgm:shape xmlns:r="http://schemas.openxmlformats.org/officeDocument/2006/relationships" type="roundRect" r:blip="">
            <dgm:adjLst/>
          </dgm:shape>
          <dgm:presOf axis="self" ptType="node"/>
          <dgm:constrLst>
            <dgm:constr type="tMarg"/>
            <dgm:constr type="bMarg"/>
          </dgm:constrLst>
          <dgm:ruleLst/>
        </dgm:layoutNode>
      </dgm:layoutNode>
      <dgm:layoutNode name="negativeSpace">
        <dgm:alg type="sp"/>
        <dgm:shape xmlns:r="http://schemas.openxmlformats.org/officeDocument/2006/relationships" r:blip="">
          <dgm:adjLst/>
        </dgm:shape>
        <dgm:presOf/>
        <dgm:constrLst/>
        <dgm:ruleLst/>
      </dgm:layoutNode>
      <dgm:layoutNode name="childText" styleLbl="conFgAcc1">
        <dgm:varLst>
          <dgm:bulletEnabled val="1"/>
        </dgm:varLst>
        <dgm:alg type="tx">
          <dgm:param type="stBulletLvl" val="1"/>
        </dgm:alg>
        <dgm:shape xmlns:r="http://schemas.openxmlformats.org/officeDocument/2006/relationships" type="rect" r:blip="" zOrderOff="-2">
          <dgm:adjLst/>
        </dgm:shape>
        <dgm:presOf axis="des" ptType="node"/>
        <dgm:constrLst>
          <dgm:constr type="secFontSz" refType="primFontSz"/>
        </dgm:constrLst>
        <dgm:ruleLst>
          <dgm:rule type="h" val="INF" fact="NaN" max="NaN"/>
        </dgm:ruleLst>
      </dgm:layoutNode>
      <dgm:forEach name="Name10" axis="followSib" ptType="sibTrans" cnt="1">
        <dgm:layoutNode name="spaceBetweenRectangles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18/2/layout/IconVerticalSolidList">
  <dgm:title val="Icon Vertical Solid List"/>
  <dgm:desc val="Use to show a series of visuals from top to bottom with Level 1 or Level 1 and Level 2 text grouped in a shape. Works best with icons or small pictures with lengthier descriptions."/>
  <dgm:catLst>
    <dgm:cat type="icon" pri="5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 useDef="1">
    <dgm:dataModel>
      <dgm:ptLst/>
      <dgm:bg/>
      <dgm:whole/>
    </dgm:dataModel>
  </dgm:clrData>
  <dgm:layoutNode name="root">
    <dgm:varLst>
      <dgm:dir/>
      <dgm:resizeHandles val="exact"/>
    </dgm:varLst>
    <dgm:choose name="Name0">
      <dgm:if name="Name1" axis="self" func="var" arg="dir" op="equ" val="norm">
        <dgm:alg type="lin">
          <dgm:param type="linDir" val="fromT"/>
          <dgm:param type="nodeHorzAlign" val="l"/>
        </dgm:alg>
      </dgm:if>
      <dgm:else name="Name2">
        <dgm:alg type="lin">
          <dgm:param type="linDir" val="fromT"/>
          <dgm:param type="nodeHorzAlign" val="r"/>
        </dgm:alg>
      </dgm:else>
    </dgm:choose>
    <dgm:shape xmlns:r="http://schemas.openxmlformats.org/officeDocument/2006/relationships" r:blip="">
      <dgm:adjLst/>
    </dgm:shape>
    <dgm:presOf/>
    <dgm:choose name="Name3">
      <dgm:if name="Name4" axis="ch" ptType="node" func="cnt" op="lte" val="3">
        <dgm:constrLst>
          <dgm:constr type="h" for="ch" forName="compNode" refType="h" fact="0.3"/>
          <dgm:constr type="w" for="ch" forName="compNode" refType="w"/>
          <dgm:constr type="h" for="ch" forName="sibTrans" refType="h" refFor="ch" refForName="compNode" fact="0.25"/>
          <dgm:constr type="primFontSz" for="des" forName="parTx" val="25"/>
          <dgm:constr type="primFontSz" for="des" forName="desTx" refType="primFontSz" refFor="des" refForName="parTx" op="lte" fact="0.75"/>
          <dgm:constr type="h" for="des" forName="compNode" op="equ"/>
          <dgm:constr type="h" for="des" forName="bgRect" op="equ"/>
          <dgm:constr type="h" for="des" forName="iconRect" op="equ"/>
          <dgm:constr type="w" for="des" forName="iconRect" op="equ"/>
          <dgm:constr type="h" for="des" forName="spaceRect" op="equ"/>
          <dgm:constr type="h" for="des" forName="parTx" op="equ"/>
          <dgm:constr type="h" for="des" forName="desTx" op="equ"/>
        </dgm:constrLst>
      </dgm:if>
      <dgm:if name="Name5" axis="ch" ptType="node" func="cnt" op="lte" val="4">
        <dgm:constrLst>
          <dgm:constr type="h" for="ch" forName="compNode" refType="h" fact="0.3"/>
          <dgm:constr type="w" for="ch" forName="compNode" refType="w"/>
          <dgm:constr type="h" for="ch" forName="sibTrans" refType="h" refFor="ch" refForName="compNode" fact="0.25"/>
          <dgm:constr type="primFontSz" for="des" forName="parTx" val="22"/>
          <dgm:constr type="primFontSz" for="des" forName="desTx" refType="primFontSz" refFor="des" refForName="parTx" op="lte" fact="0.75"/>
          <dgm:constr type="h" for="des" forName="compNode" op="equ"/>
          <dgm:constr type="h" for="des" forName="bgRect" op="equ"/>
          <dgm:constr type="h" for="des" forName="iconRect" op="equ"/>
          <dgm:constr type="w" for="des" forName="iconRect" op="equ"/>
          <dgm:constr type="h" for="des" forName="spaceRect" op="equ"/>
          <dgm:constr type="h" for="des" forName="parTx" op="equ"/>
          <dgm:constr type="h" for="des" forName="desTx" op="equ"/>
        </dgm:constrLst>
      </dgm:if>
      <dgm:if name="Name6" axis="ch" ptType="node" func="cnt" op="lte" val="6">
        <dgm:constrLst>
          <dgm:constr type="h" for="ch" forName="compNode" refType="h" fact="0.3"/>
          <dgm:constr type="w" for="ch" forName="compNode" refType="w"/>
          <dgm:constr type="h" for="ch" forName="sibTrans" refType="h" refFor="ch" refForName="compNode" fact="0.25"/>
          <dgm:constr type="primFontSz" for="des" forName="parTx" val="19"/>
          <dgm:constr type="primFontSz" for="des" forName="desTx" refType="primFontSz" refFor="des" refForName="parTx" op="lte" fact="0.75"/>
          <dgm:constr type="h" for="des" forName="compNode" op="equ"/>
          <dgm:constr type="h" for="des" forName="bgRect" op="equ"/>
          <dgm:constr type="h" for="des" forName="iconRect" op="equ"/>
          <dgm:constr type="w" for="des" forName="iconRect" op="equ"/>
          <dgm:constr type="h" for="des" forName="spaceRect" op="equ"/>
          <dgm:constr type="h" for="des" forName="parTx" op="equ"/>
          <dgm:constr type="h" for="des" forName="desTx" op="equ"/>
        </dgm:constrLst>
      </dgm:if>
      <dgm:else name="Name7">
        <dgm:constrLst>
          <dgm:constr type="h" for="ch" forName="compNode" refType="h" fact="0.3"/>
          <dgm:constr type="w" for="ch" forName="compNode" refType="w"/>
          <dgm:constr type="h" for="ch" forName="sibTrans" refType="h" refFor="ch" refForName="compNode" fact="0.25"/>
          <dgm:constr type="primFontSz" for="des" forName="parTx" val="16"/>
          <dgm:constr type="primFontSz" for="des" forName="desTx" refType="primFontSz" refFor="des" refForName="parTx" op="lte" fact="0.75"/>
          <dgm:constr type="h" for="des" forName="compNode" op="equ"/>
          <dgm:constr type="h" for="des" forName="bgRect" op="equ"/>
          <dgm:constr type="h" for="des" forName="iconRect" op="equ"/>
          <dgm:constr type="w" for="des" forName="iconRect" op="equ"/>
          <dgm:constr type="h" for="des" forName="spaceRect" op="equ"/>
          <dgm:constr type="h" for="des" forName="parTx" op="equ"/>
          <dgm:constr type="h" for="des" forName="desTx" op="equ"/>
        </dgm:constrLst>
      </dgm:else>
    </dgm:choose>
    <dgm:ruleLst>
      <dgm:rule type="h" for="ch" forName="compNode" val="0" fact="NaN" max="NaN"/>
    </dgm:ruleLst>
    <dgm:forEach name="Name8" axis="ch" ptType="node">
      <dgm:layoutNode name="compNode">
        <dgm:alg type="composite"/>
        <dgm:shape xmlns:r="http://schemas.openxmlformats.org/officeDocument/2006/relationships" r:blip="">
          <dgm:adjLst/>
        </dgm:shape>
        <dgm:presOf axis="self"/>
        <dgm:choose name="Name9">
          <dgm:if name="Name10" axis="ch" ptType="node" func="cnt" op="gte" val="1">
            <dgm:constrLst>
              <dgm:constr type="w" for="ch" forName="bgRect" refType="w"/>
              <dgm:constr type="h" for="ch" forName="bgRect" refType="h"/>
              <dgm:constr type="l" for="ch" forName="bgRect"/>
              <dgm:constr type="t" for="ch" forName="bgRect"/>
              <dgm:constr type="h" for="ch" forName="iconRect" refType="h" fact="0.55"/>
              <dgm:constr type="w" for="ch" forName="iconRect" refType="h" refFor="ch" refForName="iconRect"/>
              <dgm:constr type="l" for="ch" forName="iconRect" refType="h" refFor="ch" refForName="iconRect" fact="0.55"/>
              <dgm:constr type="ctrY" for="ch" forName="iconRect" refType="ctrY" refFor="ch" refForName="bgRect"/>
              <dgm:constr type="w" for="ch" forName="spaceRect" refType="l" refFor="ch" refForName="iconRect"/>
              <dgm:constr type="h" for="ch" forName="spaceRect" refType="h"/>
              <dgm:constr type="l" for="ch" forName="spaceRect" refType="r" refFor="ch" refForName="iconRect"/>
              <dgm:constr type="t" for="ch" forName="spaceRect"/>
              <dgm:constr type="w" for="ch" forName="parTx" refType="w" fact="0.45"/>
              <dgm:constr type="h" for="ch" forName="parTx" refType="h"/>
              <dgm:constr type="l" for="ch" forName="parTx" refType="r" refFor="ch" refForName="spaceRect"/>
              <dgm:constr type="t" for="ch" forName="parTx"/>
              <dgm:constr type="h" for="ch" forName="desTx" refType="h"/>
              <dgm:constr type="l" for="ch" forName="desTx" refType="r" refFor="ch" refForName="parTx"/>
              <dgm:constr type="t" for="ch" forName="desTx"/>
            </dgm:constrLst>
          </dgm:if>
          <dgm:else name="Name11">
            <dgm:constrLst>
              <dgm:constr type="w" for="ch" forName="bgRect" refType="w"/>
              <dgm:constr type="h" for="ch" forName="bgRect" refType="h"/>
              <dgm:constr type="l" for="ch" forName="bgRect"/>
              <dgm:constr type="t" for="ch" forName="bgRect"/>
              <dgm:constr type="h" for="ch" forName="iconRect" refType="h" fact="0.55"/>
              <dgm:constr type="w" for="ch" forName="iconRect" refType="h" refFor="ch" refForName="iconRect"/>
              <dgm:constr type="l" for="ch" forName="iconRect" refType="h" refFor="ch" refForName="iconRect" fact="0.55"/>
              <dgm:constr type="ctrY" for="ch" forName="iconRect" refType="ctrY" refFor="ch" refForName="bgRect"/>
              <dgm:constr type="w" for="ch" forName="spaceRect" refType="l" refFor="ch" refForName="iconRect"/>
              <dgm:constr type="h" for="ch" forName="spaceRect" refType="h"/>
              <dgm:constr type="l" for="ch" forName="spaceRect" refType="r" refFor="ch" refForName="iconRect"/>
              <dgm:constr type="t" for="ch" forName="spaceRect"/>
              <dgm:constr type="h" for="ch" forName="parTx" refType="h"/>
              <dgm:constr type="l" for="ch" forName="parTx" refType="r" refFor="ch" refForName="spaceRect"/>
              <dgm:constr type="t" for="ch" forName="parTx"/>
            </dgm:constrLst>
          </dgm:else>
        </dgm:choose>
        <dgm:ruleLst>
          <dgm:rule type="h" val="INF" fact="NaN" max="NaN"/>
        </dgm:ruleLst>
        <dgm:layoutNode name="bgRect" styleLbl="bgShp">
          <dgm:alg type="sp"/>
          <dgm:shape xmlns:r="http://schemas.openxmlformats.org/officeDocument/2006/relationships" type="roundRect" r:blip="">
            <dgm:adjLst>
              <dgm:adj idx="1" val="0.1"/>
            </dgm:adjLst>
          </dgm:shape>
          <dgm:presOf/>
          <dgm:constrLst/>
          <dgm:ruleLst/>
        </dgm:layoutNode>
        <dgm:layoutNode name="iconRect" styleLbl="node1">
          <dgm:alg type="sp"/>
          <dgm:shape xmlns:r="http://schemas.openxmlformats.org/officeDocument/2006/relationships" type="rect" r:blip="" blipPhldr="1">
            <dgm:adjLst/>
          </dgm:shape>
          <dgm:presOf/>
          <dgm:constrLst/>
          <dgm:ruleLst/>
        </dgm:layoutNode>
        <dgm:layoutNode name="spaceRect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  <dgm:layoutNode name="parTx" styleLbl="revTx">
          <dgm:varLst>
            <dgm:chMax val="0"/>
            <dgm:chPref val="0"/>
          </dgm:varLst>
          <dgm:alg type="tx">
            <dgm:param type="txAnchorVert" val="mid"/>
            <dgm:param type="parTxLTRAlign" val="l"/>
            <dgm:param type="shpTxLTRAlignCh" val="l"/>
            <dgm:param type="parTxRTLAlign" val="r"/>
            <dgm:param type="shpTxRTLAlignCh" val="r"/>
          </dgm:alg>
          <dgm:shape xmlns:r="http://schemas.openxmlformats.org/officeDocument/2006/relationships" type="rect" r:blip="">
            <dgm:adjLst/>
          </dgm:shape>
          <dgm:presOf axis="self" ptType="node"/>
          <dgm:constrLst>
            <dgm:constr type="lMarg" refType="h" fact="0.3"/>
            <dgm:constr type="rMarg" refType="h" fact="0.3"/>
            <dgm:constr type="tMarg" refType="h" fact="0.3"/>
            <dgm:constr type="bMarg" refType="h" fact="0.3"/>
          </dgm:constrLst>
          <dgm:ruleLst>
            <dgm:rule type="primFontSz" val="14" fact="NaN" max="NaN"/>
            <dgm:rule type="h" val="INF" fact="NaN" max="NaN"/>
          </dgm:ruleLst>
        </dgm:layoutNode>
        <dgm:choose name="Name12">
          <dgm:if name="Name13" axis="ch" ptType="node" func="cnt" op="gte" val="1">
            <dgm:layoutNode name="desTx" styleLbl="revTx">
              <dgm:varLst/>
              <dgm:alg type="tx">
                <dgm:param type="txAnchorVertCh" val="mid"/>
                <dgm:param type="parTxLTRAlign" val="l"/>
                <dgm:param type="shpTxLTRAlignCh" val="l"/>
                <dgm:param type="parTxRTLAlign" val="r"/>
                <dgm:param type="shpTxRTLAlignCh" val="r"/>
                <dgm:param type="stBulletLvl" val="0"/>
              </dgm:alg>
              <dgm:shape xmlns:r="http://schemas.openxmlformats.org/officeDocument/2006/relationships" type="rect" r:blip="">
                <dgm:adjLst/>
              </dgm:shape>
              <dgm:presOf axis="des" ptType="node"/>
              <dgm:constrLst>
                <dgm:constr type="primFontSz" val="18"/>
                <dgm:constr type="secFontSz" refType="primFontSz"/>
                <dgm:constr type="lMarg" refType="h" fact="0.3"/>
                <dgm:constr type="rMarg" refType="h" fact="0.3"/>
                <dgm:constr type="tMarg" refType="h" fact="0.3"/>
                <dgm:constr type="bMarg" refType="h" fact="0.3"/>
              </dgm:constrLst>
              <dgm:ruleLst>
                <dgm:rule type="primFontSz" val="11" fact="NaN" max="NaN"/>
              </dgm:ruleLst>
            </dgm:layoutNode>
          </dgm:if>
          <dgm:else name="Name14"/>
        </dgm:choose>
      </dgm:layoutNode>
      <dgm:forEach name="Name15" axis="followSib" ptType="sibTrans" cnt="1">
        <dgm:layoutNode name="sibTrans">
          <dgm:alg type="sp"/>
          <dgm:shape xmlns:r="http://schemas.openxmlformats.org/officeDocument/2006/relationships" r:blip="">
            <dgm:adjLst/>
          </dgm:shape>
          <dgm:presOf axis="self"/>
          <dgm:constrLst/>
          <dgm:ruleLst/>
        </dgm:layoutNode>
      </dgm:forEach>
    </dgm:forEach>
  </dgm:layoutNode>
  <dgm:extLst>
    <a:ext uri="{68A01E43-0DF5-4B5B-8FA6-DAF915123BFB}">
      <dgm1612:lstStyle xmlns:dgm1612="http://schemas.microsoft.com/office/drawing/2016/12/diagram">
        <a:lvl1pPr>
          <a:lnSpc>
            <a:spcPct val="100000"/>
          </a:lnSpc>
        </a:lvl1pPr>
        <a:lvl2pPr>
          <a:lnSpc>
            <a:spcPct val="100000"/>
          </a:lnSpc>
        </a:lvl2pPr>
      </dgm1612:lstStyle>
    </a:ext>
  </dgm:extLst>
</dgm:layoutDef>
</file>

<file path=ppt/diagrams/layout3.xml><?xml version="1.0" encoding="utf-8"?>
<dgm:layoutDef xmlns:dgm="http://schemas.openxmlformats.org/drawingml/2006/diagram" xmlns:a="http://schemas.openxmlformats.org/drawingml/2006/main" uniqueId="urn:microsoft.com/office/officeart/2005/8/layout/list1">
  <dgm:title val=""/>
  <dgm:desc val=""/>
  <dgm:catLst>
    <dgm:cat type="list" pri="4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4" srcId="0" destId="1" srcOrd="0" destOrd="0"/>
        <dgm:cxn modelId="5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linear">
    <dgm:varLst>
      <dgm:dir/>
      <dgm:animLvl val="lvl"/>
      <dgm:resizeHandles val="exact"/>
    </dgm:varLst>
    <dgm:choose name="Name0">
      <dgm:if name="Name1" func="var" arg="dir" op="equ" val="norm">
        <dgm:alg type="lin">
          <dgm:param type="linDir" val="fromT"/>
          <dgm:param type="vertAlign" val="mid"/>
          <dgm:param type="horzAlign" val="l"/>
          <dgm:param type="nodeHorzAlign" val="l"/>
        </dgm:alg>
      </dgm:if>
      <dgm:else name="Name2">
        <dgm:alg type="lin">
          <dgm:param type="linDir" val="fromT"/>
          <dgm:param type="vertAlign" val="mid"/>
          <dgm:param type="horzAlign" val="r"/>
          <dgm:param type="nodeHorzAlign" val="r"/>
        </dgm:alg>
      </dgm:else>
    </dgm:choose>
    <dgm:shape xmlns:r="http://schemas.openxmlformats.org/officeDocument/2006/relationships" r:blip="">
      <dgm:adjLst/>
    </dgm:shape>
    <dgm:presOf/>
    <dgm:constrLst>
      <dgm:constr type="w" for="ch" forName="parentLin" refType="w"/>
      <dgm:constr type="h" for="ch" forName="parentLin" val="INF"/>
      <dgm:constr type="w" for="des" forName="parentLeftMargin" refType="w" fact="0.05"/>
      <dgm:constr type="w" for="des" forName="parentText" refType="w" fact="0.7"/>
      <dgm:constr type="h" for="des" forName="parentText" refType="primFontSz" refFor="des" refForName="parentText" fact="0.82"/>
      <dgm:constr type="h" for="ch" forName="negativeSpace" refType="primFontSz" refFor="des" refForName="parentText" fact="-0.41"/>
      <dgm:constr type="h" for="ch" forName="negativeSpace" refType="h" refFor="des" refForName="parentText" op="lte" fact="-0.82"/>
      <dgm:constr type="h" for="ch" forName="negativeSpace" refType="h" refFor="des" refForName="parentText" op="gte" fact="-0.82"/>
      <dgm:constr type="w" for="ch" forName="childText" refType="w"/>
      <dgm:constr type="h" for="ch" forName="childText" refType="primFontSz" refFor="des" refForName="parentText" fact="0.7"/>
      <dgm:constr type="primFontSz" for="des" forName="parentText" val="65"/>
      <dgm:constr type="primFontSz" for="ch" forName="childText" refType="primFontSz" refFor="des" refForName="parentText"/>
      <dgm:constr type="tMarg" for="ch" forName="childText" refType="primFontSz" refFor="des" refForName="parentText" fact="1.64"/>
      <dgm:constr type="tMarg" for="ch" forName="childText" refType="h" refFor="des" refForName="parentText" op="lte" fact="3.28"/>
      <dgm:constr type="tMarg" for="ch" forName="childText" refType="h" refFor="des" refForName="parentText" op="gte" fact="3.28"/>
      <dgm:constr type="lMarg" for="ch" forName="childText" refType="w" fact="0.22"/>
      <dgm:constr type="rMarg" for="ch" forName="childText" refType="lMarg" refFor="ch" refForName="childText"/>
      <dgm:constr type="lMarg" for="des" forName="parentText" refType="w" fact="0.075"/>
      <dgm:constr type="rMarg" for="des" forName="parentText" refType="lMarg" refFor="des" refForName="parentText"/>
      <dgm:constr type="h" for="ch" forName="spaceBetweenRectangles" refType="primFontSz" refFor="des" refForName="parentText" fact="0.15"/>
    </dgm:constrLst>
    <dgm:ruleLst>
      <dgm:rule type="primFontSz" for="des" forName="parentText" val="5" fact="NaN" max="NaN"/>
    </dgm:ruleLst>
    <dgm:forEach name="Name3" axis="ch" ptType="node">
      <dgm:layoutNode name="parentLin">
        <dgm:choose name="Name4">
          <dgm:if name="Name5" func="var" arg="dir" op="equ" val="norm">
            <dgm:alg type="lin">
              <dgm:param type="linDir" val="fromL"/>
              <dgm:param type="horzAlign" val="l"/>
              <dgm:param type="nodeHorzAlign" val="l"/>
            </dgm:alg>
          </dgm:if>
          <dgm:else name="Name6">
            <dgm:alg type="lin">
              <dgm:param type="linDir" val="fromR"/>
              <dgm:param type="horzAlign" val="r"/>
              <dgm:param type="nodeHorzAlign" val="r"/>
            </dgm:alg>
          </dgm:else>
        </dgm:choose>
        <dgm:shape xmlns:r="http://schemas.openxmlformats.org/officeDocument/2006/relationships" r:blip="">
          <dgm:adjLst/>
        </dgm:shape>
        <dgm:presOf/>
        <dgm:constrLst/>
        <dgm:ruleLst/>
        <dgm:layoutNode name="parentLeftMargin">
          <dgm:alg type="sp"/>
          <dgm:shape xmlns:r="http://schemas.openxmlformats.org/officeDocument/2006/relationships" type="rect" r:blip="" hideGeom="1">
            <dgm:adjLst/>
          </dgm:shape>
          <dgm:presOf axis="self"/>
          <dgm:constrLst>
            <dgm:constr type="h"/>
          </dgm:constrLst>
          <dgm:ruleLst/>
        </dgm:layoutNode>
        <dgm:layoutNode name="parentText" styleLbl="node1">
          <dgm:varLst>
            <dgm:chMax val="0"/>
            <dgm:bulletEnabled val="1"/>
          </dgm:varLst>
          <dgm:choose name="Name7">
            <dgm:if name="Name8" func="var" arg="dir" op="equ" val="norm">
              <dgm:alg type="tx">
                <dgm:param type="parTxLTRAlign" val="l"/>
                <dgm:param type="parTxRTLAlign" val="l"/>
              </dgm:alg>
            </dgm:if>
            <dgm:else name="Name9">
              <dgm:alg type="tx">
                <dgm:param type="parTxLTRAlign" val="r"/>
                <dgm:param type="parTxRTLAlign" val="r"/>
              </dgm:alg>
            </dgm:else>
          </dgm:choose>
          <dgm:shape xmlns:r="http://schemas.openxmlformats.org/officeDocument/2006/relationships" type="roundRect" r:blip="">
            <dgm:adjLst/>
          </dgm:shape>
          <dgm:presOf axis="self" ptType="node"/>
          <dgm:constrLst>
            <dgm:constr type="tMarg"/>
            <dgm:constr type="bMarg"/>
          </dgm:constrLst>
          <dgm:ruleLst/>
        </dgm:layoutNode>
      </dgm:layoutNode>
      <dgm:layoutNode name="negativeSpace">
        <dgm:alg type="sp"/>
        <dgm:shape xmlns:r="http://schemas.openxmlformats.org/officeDocument/2006/relationships" r:blip="">
          <dgm:adjLst/>
        </dgm:shape>
        <dgm:presOf/>
        <dgm:constrLst/>
        <dgm:ruleLst/>
      </dgm:layoutNode>
      <dgm:layoutNode name="childText" styleLbl="conFgAcc1">
        <dgm:varLst>
          <dgm:bulletEnabled val="1"/>
        </dgm:varLst>
        <dgm:alg type="tx">
          <dgm:param type="stBulletLvl" val="1"/>
        </dgm:alg>
        <dgm:shape xmlns:r="http://schemas.openxmlformats.org/officeDocument/2006/relationships" type="rect" r:blip="" zOrderOff="-2">
          <dgm:adjLst/>
        </dgm:shape>
        <dgm:presOf axis="des" ptType="node"/>
        <dgm:constrLst>
          <dgm:constr type="secFontSz" refType="primFontSz"/>
        </dgm:constrLst>
        <dgm:ruleLst>
          <dgm:rule type="h" val="INF" fact="NaN" max="NaN"/>
        </dgm:ruleLst>
      </dgm:layoutNode>
      <dgm:forEach name="Name10" axis="followSib" ptType="sibTrans" cnt="1">
        <dgm:layoutNode name="spaceBetweenRectangles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</dgm:layoutDef>
</file>

<file path=ppt/diagrams/layout4.xml><?xml version="1.0" encoding="utf-8"?>
<dgm:layoutDef xmlns:dgm="http://schemas.openxmlformats.org/drawingml/2006/diagram" xmlns:a="http://schemas.openxmlformats.org/drawingml/2006/main" uniqueId="urn:microsoft.com/office/officeart/2018/2/layout/IconVerticalSolidList">
  <dgm:title val="Icon Vertical Solid List"/>
  <dgm:desc val="Use to show a series of visuals from top to bottom with Level 1 or Level 1 and Level 2 text grouped in a shape. Works best with icons or small pictures with lengthier descriptions."/>
  <dgm:catLst>
    <dgm:cat type="icon" pri="5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 useDef="1">
    <dgm:dataModel>
      <dgm:ptLst/>
      <dgm:bg/>
      <dgm:whole/>
    </dgm:dataModel>
  </dgm:clrData>
  <dgm:layoutNode name="root">
    <dgm:varLst>
      <dgm:dir/>
      <dgm:resizeHandles val="exact"/>
    </dgm:varLst>
    <dgm:choose name="Name0">
      <dgm:if name="Name1" axis="self" func="var" arg="dir" op="equ" val="norm">
        <dgm:alg type="lin">
          <dgm:param type="linDir" val="fromT"/>
          <dgm:param type="nodeHorzAlign" val="l"/>
        </dgm:alg>
      </dgm:if>
      <dgm:else name="Name2">
        <dgm:alg type="lin">
          <dgm:param type="linDir" val="fromT"/>
          <dgm:param type="nodeHorzAlign" val="r"/>
        </dgm:alg>
      </dgm:else>
    </dgm:choose>
    <dgm:shape xmlns:r="http://schemas.openxmlformats.org/officeDocument/2006/relationships" r:blip="">
      <dgm:adjLst/>
    </dgm:shape>
    <dgm:presOf/>
    <dgm:choose name="Name3">
      <dgm:if name="Name4" axis="ch" ptType="node" func="cnt" op="lte" val="3">
        <dgm:constrLst>
          <dgm:constr type="h" for="ch" forName="compNode" refType="h" fact="0.3"/>
          <dgm:constr type="w" for="ch" forName="compNode" refType="w"/>
          <dgm:constr type="h" for="ch" forName="sibTrans" refType="h" refFor="ch" refForName="compNode" fact="0.25"/>
          <dgm:constr type="primFontSz" for="des" forName="parTx" val="25"/>
          <dgm:constr type="primFontSz" for="des" forName="desTx" refType="primFontSz" refFor="des" refForName="parTx" op="lte" fact="0.75"/>
          <dgm:constr type="h" for="des" forName="compNode" op="equ"/>
          <dgm:constr type="h" for="des" forName="bgRect" op="equ"/>
          <dgm:constr type="h" for="des" forName="iconRect" op="equ"/>
          <dgm:constr type="w" for="des" forName="iconRect" op="equ"/>
          <dgm:constr type="h" for="des" forName="spaceRect" op="equ"/>
          <dgm:constr type="h" for="des" forName="parTx" op="equ"/>
          <dgm:constr type="h" for="des" forName="desTx" op="equ"/>
        </dgm:constrLst>
      </dgm:if>
      <dgm:if name="Name5" axis="ch" ptType="node" func="cnt" op="lte" val="4">
        <dgm:constrLst>
          <dgm:constr type="h" for="ch" forName="compNode" refType="h" fact="0.3"/>
          <dgm:constr type="w" for="ch" forName="compNode" refType="w"/>
          <dgm:constr type="h" for="ch" forName="sibTrans" refType="h" refFor="ch" refForName="compNode" fact="0.25"/>
          <dgm:constr type="primFontSz" for="des" forName="parTx" val="22"/>
          <dgm:constr type="primFontSz" for="des" forName="desTx" refType="primFontSz" refFor="des" refForName="parTx" op="lte" fact="0.75"/>
          <dgm:constr type="h" for="des" forName="compNode" op="equ"/>
          <dgm:constr type="h" for="des" forName="bgRect" op="equ"/>
          <dgm:constr type="h" for="des" forName="iconRect" op="equ"/>
          <dgm:constr type="w" for="des" forName="iconRect" op="equ"/>
          <dgm:constr type="h" for="des" forName="spaceRect" op="equ"/>
          <dgm:constr type="h" for="des" forName="parTx" op="equ"/>
          <dgm:constr type="h" for="des" forName="desTx" op="equ"/>
        </dgm:constrLst>
      </dgm:if>
      <dgm:if name="Name6" axis="ch" ptType="node" func="cnt" op="lte" val="6">
        <dgm:constrLst>
          <dgm:constr type="h" for="ch" forName="compNode" refType="h" fact="0.3"/>
          <dgm:constr type="w" for="ch" forName="compNode" refType="w"/>
          <dgm:constr type="h" for="ch" forName="sibTrans" refType="h" refFor="ch" refForName="compNode" fact="0.25"/>
          <dgm:constr type="primFontSz" for="des" forName="parTx" val="19"/>
          <dgm:constr type="primFontSz" for="des" forName="desTx" refType="primFontSz" refFor="des" refForName="parTx" op="lte" fact="0.75"/>
          <dgm:constr type="h" for="des" forName="compNode" op="equ"/>
          <dgm:constr type="h" for="des" forName="bgRect" op="equ"/>
          <dgm:constr type="h" for="des" forName="iconRect" op="equ"/>
          <dgm:constr type="w" for="des" forName="iconRect" op="equ"/>
          <dgm:constr type="h" for="des" forName="spaceRect" op="equ"/>
          <dgm:constr type="h" for="des" forName="parTx" op="equ"/>
          <dgm:constr type="h" for="des" forName="desTx" op="equ"/>
        </dgm:constrLst>
      </dgm:if>
      <dgm:else name="Name7">
        <dgm:constrLst>
          <dgm:constr type="h" for="ch" forName="compNode" refType="h" fact="0.3"/>
          <dgm:constr type="w" for="ch" forName="compNode" refType="w"/>
          <dgm:constr type="h" for="ch" forName="sibTrans" refType="h" refFor="ch" refForName="compNode" fact="0.25"/>
          <dgm:constr type="primFontSz" for="des" forName="parTx" val="16"/>
          <dgm:constr type="primFontSz" for="des" forName="desTx" refType="primFontSz" refFor="des" refForName="parTx" op="lte" fact="0.75"/>
          <dgm:constr type="h" for="des" forName="compNode" op="equ"/>
          <dgm:constr type="h" for="des" forName="bgRect" op="equ"/>
          <dgm:constr type="h" for="des" forName="iconRect" op="equ"/>
          <dgm:constr type="w" for="des" forName="iconRect" op="equ"/>
          <dgm:constr type="h" for="des" forName="spaceRect" op="equ"/>
          <dgm:constr type="h" for="des" forName="parTx" op="equ"/>
          <dgm:constr type="h" for="des" forName="desTx" op="equ"/>
        </dgm:constrLst>
      </dgm:else>
    </dgm:choose>
    <dgm:ruleLst>
      <dgm:rule type="h" for="ch" forName="compNode" val="0" fact="NaN" max="NaN"/>
    </dgm:ruleLst>
    <dgm:forEach name="Name8" axis="ch" ptType="node">
      <dgm:layoutNode name="compNode">
        <dgm:alg type="composite"/>
        <dgm:shape xmlns:r="http://schemas.openxmlformats.org/officeDocument/2006/relationships" r:blip="">
          <dgm:adjLst/>
        </dgm:shape>
        <dgm:presOf axis="self"/>
        <dgm:choose name="Name9">
          <dgm:if name="Name10" axis="ch" ptType="node" func="cnt" op="gte" val="1">
            <dgm:constrLst>
              <dgm:constr type="w" for="ch" forName="bgRect" refType="w"/>
              <dgm:constr type="h" for="ch" forName="bgRect" refType="h"/>
              <dgm:constr type="l" for="ch" forName="bgRect"/>
              <dgm:constr type="t" for="ch" forName="bgRect"/>
              <dgm:constr type="h" for="ch" forName="iconRect" refType="h" fact="0.55"/>
              <dgm:constr type="w" for="ch" forName="iconRect" refType="h" refFor="ch" refForName="iconRect"/>
              <dgm:constr type="l" for="ch" forName="iconRect" refType="h" refFor="ch" refForName="iconRect" fact="0.55"/>
              <dgm:constr type="ctrY" for="ch" forName="iconRect" refType="ctrY" refFor="ch" refForName="bgRect"/>
              <dgm:constr type="w" for="ch" forName="spaceRect" refType="l" refFor="ch" refForName="iconRect"/>
              <dgm:constr type="h" for="ch" forName="spaceRect" refType="h"/>
              <dgm:constr type="l" for="ch" forName="spaceRect" refType="r" refFor="ch" refForName="iconRect"/>
              <dgm:constr type="t" for="ch" forName="spaceRect"/>
              <dgm:constr type="w" for="ch" forName="parTx" refType="w" fact="0.45"/>
              <dgm:constr type="h" for="ch" forName="parTx" refType="h"/>
              <dgm:constr type="l" for="ch" forName="parTx" refType="r" refFor="ch" refForName="spaceRect"/>
              <dgm:constr type="t" for="ch" forName="parTx"/>
              <dgm:constr type="h" for="ch" forName="desTx" refType="h"/>
              <dgm:constr type="l" for="ch" forName="desTx" refType="r" refFor="ch" refForName="parTx"/>
              <dgm:constr type="t" for="ch" forName="desTx"/>
            </dgm:constrLst>
          </dgm:if>
          <dgm:else name="Name11">
            <dgm:constrLst>
              <dgm:constr type="w" for="ch" forName="bgRect" refType="w"/>
              <dgm:constr type="h" for="ch" forName="bgRect" refType="h"/>
              <dgm:constr type="l" for="ch" forName="bgRect"/>
              <dgm:constr type="t" for="ch" forName="bgRect"/>
              <dgm:constr type="h" for="ch" forName="iconRect" refType="h" fact="0.55"/>
              <dgm:constr type="w" for="ch" forName="iconRect" refType="h" refFor="ch" refForName="iconRect"/>
              <dgm:constr type="l" for="ch" forName="iconRect" refType="h" refFor="ch" refForName="iconRect" fact="0.55"/>
              <dgm:constr type="ctrY" for="ch" forName="iconRect" refType="ctrY" refFor="ch" refForName="bgRect"/>
              <dgm:constr type="w" for="ch" forName="spaceRect" refType="l" refFor="ch" refForName="iconRect"/>
              <dgm:constr type="h" for="ch" forName="spaceRect" refType="h"/>
              <dgm:constr type="l" for="ch" forName="spaceRect" refType="r" refFor="ch" refForName="iconRect"/>
              <dgm:constr type="t" for="ch" forName="spaceRect"/>
              <dgm:constr type="h" for="ch" forName="parTx" refType="h"/>
              <dgm:constr type="l" for="ch" forName="parTx" refType="r" refFor="ch" refForName="spaceRect"/>
              <dgm:constr type="t" for="ch" forName="parTx"/>
            </dgm:constrLst>
          </dgm:else>
        </dgm:choose>
        <dgm:ruleLst>
          <dgm:rule type="h" val="INF" fact="NaN" max="NaN"/>
        </dgm:ruleLst>
        <dgm:layoutNode name="bgRect" styleLbl="bgShp">
          <dgm:alg type="sp"/>
          <dgm:shape xmlns:r="http://schemas.openxmlformats.org/officeDocument/2006/relationships" type="roundRect" r:blip="">
            <dgm:adjLst>
              <dgm:adj idx="1" val="0.1"/>
            </dgm:adjLst>
          </dgm:shape>
          <dgm:presOf/>
          <dgm:constrLst/>
          <dgm:ruleLst/>
        </dgm:layoutNode>
        <dgm:layoutNode name="iconRect" styleLbl="node1">
          <dgm:alg type="sp"/>
          <dgm:shape xmlns:r="http://schemas.openxmlformats.org/officeDocument/2006/relationships" type="rect" r:blip="" blipPhldr="1">
            <dgm:adjLst/>
          </dgm:shape>
          <dgm:presOf/>
          <dgm:constrLst/>
          <dgm:ruleLst/>
        </dgm:layoutNode>
        <dgm:layoutNode name="spaceRect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  <dgm:layoutNode name="parTx" styleLbl="revTx">
          <dgm:varLst>
            <dgm:chMax val="0"/>
            <dgm:chPref val="0"/>
          </dgm:varLst>
          <dgm:alg type="tx">
            <dgm:param type="txAnchorVert" val="mid"/>
            <dgm:param type="parTxLTRAlign" val="l"/>
            <dgm:param type="shpTxLTRAlignCh" val="l"/>
            <dgm:param type="parTxRTLAlign" val="r"/>
            <dgm:param type="shpTxRTLAlignCh" val="r"/>
          </dgm:alg>
          <dgm:shape xmlns:r="http://schemas.openxmlformats.org/officeDocument/2006/relationships" type="rect" r:blip="">
            <dgm:adjLst/>
          </dgm:shape>
          <dgm:presOf axis="self" ptType="node"/>
          <dgm:constrLst>
            <dgm:constr type="lMarg" refType="h" fact="0.3"/>
            <dgm:constr type="rMarg" refType="h" fact="0.3"/>
            <dgm:constr type="tMarg" refType="h" fact="0.3"/>
            <dgm:constr type="bMarg" refType="h" fact="0.3"/>
          </dgm:constrLst>
          <dgm:ruleLst>
            <dgm:rule type="primFontSz" val="14" fact="NaN" max="NaN"/>
            <dgm:rule type="h" val="INF" fact="NaN" max="NaN"/>
          </dgm:ruleLst>
        </dgm:layoutNode>
        <dgm:choose name="Name12">
          <dgm:if name="Name13" axis="ch" ptType="node" func="cnt" op="gte" val="1">
            <dgm:layoutNode name="desTx" styleLbl="revTx">
              <dgm:varLst/>
              <dgm:alg type="tx">
                <dgm:param type="txAnchorVertCh" val="mid"/>
                <dgm:param type="parTxLTRAlign" val="l"/>
                <dgm:param type="shpTxLTRAlignCh" val="l"/>
                <dgm:param type="parTxRTLAlign" val="r"/>
                <dgm:param type="shpTxRTLAlignCh" val="r"/>
                <dgm:param type="stBulletLvl" val="0"/>
              </dgm:alg>
              <dgm:shape xmlns:r="http://schemas.openxmlformats.org/officeDocument/2006/relationships" type="rect" r:blip="">
                <dgm:adjLst/>
              </dgm:shape>
              <dgm:presOf axis="des" ptType="node"/>
              <dgm:constrLst>
                <dgm:constr type="primFontSz" val="18"/>
                <dgm:constr type="secFontSz" refType="primFontSz"/>
                <dgm:constr type="lMarg" refType="h" fact="0.3"/>
                <dgm:constr type="rMarg" refType="h" fact="0.3"/>
                <dgm:constr type="tMarg" refType="h" fact="0.3"/>
                <dgm:constr type="bMarg" refType="h" fact="0.3"/>
              </dgm:constrLst>
              <dgm:ruleLst>
                <dgm:rule type="primFontSz" val="11" fact="NaN" max="NaN"/>
              </dgm:ruleLst>
            </dgm:layoutNode>
          </dgm:if>
          <dgm:else name="Name14"/>
        </dgm:choose>
      </dgm:layoutNode>
      <dgm:forEach name="Name15" axis="followSib" ptType="sibTrans" cnt="1">
        <dgm:layoutNode name="sibTrans">
          <dgm:alg type="sp"/>
          <dgm:shape xmlns:r="http://schemas.openxmlformats.org/officeDocument/2006/relationships" r:blip="">
            <dgm:adjLst/>
          </dgm:shape>
          <dgm:presOf axis="self"/>
          <dgm:constrLst/>
          <dgm:ruleLst/>
        </dgm:layoutNode>
      </dgm:forEach>
    </dgm:forEach>
  </dgm:layoutNode>
  <dgm:extLst>
    <a:ext uri="{68A01E43-0DF5-4B5B-8FA6-DAF915123BFB}">
      <dgm1612:lstStyle xmlns:dgm1612="http://schemas.microsoft.com/office/drawing/2016/12/diagram">
        <a:lvl1pPr>
          <a:lnSpc>
            <a:spcPct val="100000"/>
          </a:lnSpc>
        </a:lvl1pPr>
        <a:lvl2pPr>
          <a:lnSpc>
            <a:spcPct val="100000"/>
          </a:lnSpc>
        </a:lvl2pPr>
      </dgm1612:lstStyle>
    </a:ext>
  </dgm:extLst>
</dgm:layoutDef>
</file>

<file path=ppt/diagrams/layout5.xml><?xml version="1.0" encoding="utf-8"?>
<dgm:layoutDef xmlns:dgm="http://schemas.openxmlformats.org/drawingml/2006/diagram" xmlns:a="http://schemas.openxmlformats.org/drawingml/2006/main" uniqueId="urn:microsoft.com/office/officeart/2005/8/layout/process4">
  <dgm:title val=""/>
  <dgm:desc val=""/>
  <dgm:catLst>
    <dgm:cat type="process" pri="16000"/>
    <dgm:cat type="list" pri="20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Name0">
    <dgm:varLst>
      <dgm:dir/>
      <dgm:animLvl val="lvl"/>
      <dgm:resizeHandles val="exact"/>
    </dgm:varLst>
    <dgm:alg type="lin">
      <dgm:param type="linDir" val="fromB"/>
    </dgm:alg>
    <dgm:shape xmlns:r="http://schemas.openxmlformats.org/officeDocument/2006/relationships" r:blip="">
      <dgm:adjLst/>
    </dgm:shape>
    <dgm:presOf/>
    <dgm:constrLst>
      <dgm:constr type="h" for="ch" forName="boxAndChildren" refType="h"/>
      <dgm:constr type="h" for="ch" forName="arrowAndChildren" refType="h" refFor="ch" refForName="boxAndChildren" op="equ" fact="1.538"/>
      <dgm:constr type="w" for="ch" forName="arrowAndChildren" refType="w"/>
      <dgm:constr type="w" for="ch" forName="boxAndChildren" refType="w"/>
      <dgm:constr type="h" for="ch" forName="sp" refType="h" fact="-0.015"/>
      <dgm:constr type="primFontSz" for="des" forName="parentTextBox" val="65"/>
      <dgm:constr type="primFontSz" for="des" forName="parentTextArrow" refType="primFontSz" refFor="des" refForName="parentTextBox" op="equ"/>
      <dgm:constr type="primFontSz" for="des" forName="childTextArrow" val="65"/>
      <dgm:constr type="primFontSz" for="des" forName="childTextBox" refType="primFontSz" refFor="des" refForName="childTextArrow" op="equ"/>
    </dgm:constrLst>
    <dgm:ruleLst/>
    <dgm:forEach name="Name1" axis="ch" ptType="node" st="-1" step="-1">
      <dgm:choose name="Name2">
        <dgm:if name="Name3" axis="self" ptType="node" func="revPos" op="equ" val="1">
          <dgm:layoutNode name="boxAndChildren">
            <dgm:alg type="composite"/>
            <dgm:shape xmlns:r="http://schemas.openxmlformats.org/officeDocument/2006/relationships" r:blip="">
              <dgm:adjLst/>
            </dgm:shape>
            <dgm:presOf/>
            <dgm:choose name="Name4">
              <dgm:if name="Name5" axis="ch" ptType="node" func="cnt" op="gte" val="1">
                <dgm:constrLst>
                  <dgm:constr type="w" for="ch" forName="parentTextBox" refType="w"/>
                  <dgm:constr type="h" for="ch" forName="parentTextBox" refType="h" fact="0.54"/>
                  <dgm:constr type="t" for="ch" forName="parentTextBox"/>
                  <dgm:constr type="w" for="ch" forName="entireBox" refType="w"/>
                  <dgm:constr type="h" for="ch" forName="entireBox" refType="h"/>
                  <dgm:constr type="w" for="ch" forName="descendantBox" refType="w"/>
                  <dgm:constr type="b" for="ch" forName="descendantBox" refType="h" fact="0.98"/>
                  <dgm:constr type="h" for="ch" forName="descendantBox" refType="h" fact="0.46"/>
                </dgm:constrLst>
              </dgm:if>
              <dgm:else name="Name6">
                <dgm:constrLst>
                  <dgm:constr type="w" for="ch" forName="parentTextBox" refType="w"/>
                  <dgm:constr type="h" for="ch" forName="parentTextBox" refType="h"/>
                </dgm:constrLst>
              </dgm:else>
            </dgm:choose>
            <dgm:ruleLst/>
            <dgm:layoutNode name="parentTextBox">
              <dgm:alg type="tx"/>
              <dgm:choose name="Name7">
                <dgm:if name="Name8" axis="ch" ptType="node" func="cnt" op="gte" val="1">
                  <dgm:shape xmlns:r="http://schemas.openxmlformats.org/officeDocument/2006/relationships" type="rect" r:blip="" zOrderOff="1" hideGeom="1">
                    <dgm:adjLst/>
                  </dgm:shape>
                </dgm:if>
                <dgm:else name="Name9">
                  <dgm:shape xmlns:r="http://schemas.openxmlformats.org/officeDocument/2006/relationships" type="rect" r:blip="">
                    <dgm:adjLst/>
                  </dgm:shape>
                </dgm:else>
              </dgm:choose>
              <dgm:presOf axis="self"/>
              <dgm:constrLst/>
              <dgm:ruleLst>
                <dgm:rule type="primFontSz" val="5" fact="NaN" max="NaN"/>
              </dgm:ruleLst>
            </dgm:layoutNode>
            <dgm:choose name="Name10">
              <dgm:if name="Name11" axis="ch" ptType="node" func="cnt" op="gte" val="1">
                <dgm:layoutNode name="entireBox">
                  <dgm:alg type="sp"/>
                  <dgm:shape xmlns:r="http://schemas.openxmlformats.org/officeDocument/2006/relationships" type="rect" r:blip="">
                    <dgm:adjLst/>
                  </dgm:shape>
                  <dgm:presOf axis="self"/>
                  <dgm:constrLst/>
                  <dgm:ruleLst/>
                </dgm:layoutNode>
                <dgm:layoutNode name="descendantBox" styleLbl="fgAccFollowNode1">
                  <dgm:choose name="Name12">
                    <dgm:if name="Name13" func="var" arg="dir" op="equ" val="norm">
                      <dgm:alg type="lin"/>
                    </dgm:if>
                    <dgm:else name="Name14">
                      <dgm:alg type="lin">
                        <dgm:param type="linDir" val="fromR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>
                    <dgm:constr type="w" for="ch" forName="childTextBox" refType="w"/>
                    <dgm:constr type="h" for="ch" forName="childTextBox" refType="h"/>
                  </dgm:constrLst>
                  <dgm:ruleLst/>
                  <dgm:forEach name="Name15" axis="ch" ptType="node">
                    <dgm:layoutNode name="childTextBox" styleLbl="fgAccFollowNode1">
                      <dgm:varLst>
                        <dgm:bulletEnabled val="1"/>
                      </dgm:varLst>
                      <dgm:alg type="tx"/>
                      <dgm:shape xmlns:r="http://schemas.openxmlformats.org/officeDocument/2006/relationships" type="rect" r:blip="">
                        <dgm:adjLst/>
                      </dgm:shape>
                      <dgm:presOf axis="desOrSelf" ptType="node"/>
                      <dgm:constrLst>
                        <dgm:constr type="tMarg" refType="primFontSz" fact="0.1"/>
                        <dgm:constr type="bMarg" refType="primFontSz" fact="0.1"/>
                      </dgm:constrLst>
                      <dgm:ruleLst>
                        <dgm:rule type="primFontSz" val="5" fact="NaN" max="NaN"/>
                      </dgm:ruleLst>
                    </dgm:layoutNode>
                  </dgm:forEach>
                </dgm:layoutNode>
              </dgm:if>
              <dgm:else name="Name16"/>
            </dgm:choose>
          </dgm:layoutNode>
        </dgm:if>
        <dgm:else name="Name17">
          <dgm:layoutNode name="arrowAndChildren">
            <dgm:alg type="composite"/>
            <dgm:shape xmlns:r="http://schemas.openxmlformats.org/officeDocument/2006/relationships" r:blip="">
              <dgm:adjLst/>
            </dgm:shape>
            <dgm:presOf/>
            <dgm:choose name="Name18">
              <dgm:if name="Name19" axis="ch" ptType="node" func="cnt" op="gte" val="1">
                <dgm:constrLst>
                  <dgm:constr type="w" for="ch" forName="parentTextArrow" refType="w"/>
                  <dgm:constr type="t" for="ch" forName="parentTextArrow"/>
                  <dgm:constr type="h" for="ch" forName="parentTextArrow" refType="h" fact="0.351"/>
                  <dgm:constr type="w" for="ch" forName="arrow" refType="w"/>
                  <dgm:constr type="h" for="ch" forName="arrow" refType="h"/>
                  <dgm:constr type="w" for="ch" forName="descendantArrow" refType="w"/>
                  <dgm:constr type="b" for="ch" forName="descendantArrow" refType="h" fact="0.65"/>
                  <dgm:constr type="h" for="ch" forName="descendantArrow" refType="h" fact="0.299"/>
                </dgm:constrLst>
              </dgm:if>
              <dgm:else name="Name20">
                <dgm:constrLst>
                  <dgm:constr type="w" for="ch" forName="parentTextArrow" refType="w"/>
                  <dgm:constr type="h" for="ch" forName="parentTextArrow" refType="h"/>
                </dgm:constrLst>
              </dgm:else>
            </dgm:choose>
            <dgm:ruleLst/>
            <dgm:layoutNode name="parentTextArrow">
              <dgm:alg type="tx"/>
              <dgm:choose name="Name21">
                <dgm:if name="Name22" axis="ch" ptType="node" func="cnt" op="gte" val="1">
                  <dgm:shape xmlns:r="http://schemas.openxmlformats.org/officeDocument/2006/relationships" type="rect" r:blip="" zOrderOff="1" hideGeom="1">
                    <dgm:adjLst/>
                  </dgm:shape>
                </dgm:if>
                <dgm:else name="Name23">
                  <dgm:shape xmlns:r="http://schemas.openxmlformats.org/officeDocument/2006/relationships" rot="180" type="upArrowCallout" r:blip="">
                    <dgm:adjLst/>
                  </dgm:shape>
                </dgm:else>
              </dgm:choose>
              <dgm:presOf axis="self"/>
              <dgm:constrLst/>
              <dgm:ruleLst>
                <dgm:rule type="primFontSz" val="5" fact="NaN" max="NaN"/>
              </dgm:ruleLst>
            </dgm:layoutNode>
            <dgm:choose name="Name24">
              <dgm:if name="Name25" axis="ch" ptType="node" func="cnt" op="gte" val="1">
                <dgm:layoutNode name="arrow">
                  <dgm:alg type="sp"/>
                  <dgm:shape xmlns:r="http://schemas.openxmlformats.org/officeDocument/2006/relationships" rot="180" type="upArrowCallout" r:blip="">
                    <dgm:adjLst/>
                  </dgm:shape>
                  <dgm:presOf axis="self"/>
                  <dgm:constrLst/>
                  <dgm:ruleLst/>
                </dgm:layoutNode>
                <dgm:layoutNode name="descendantArrow">
                  <dgm:choose name="Name26">
                    <dgm:if name="Name27" func="var" arg="dir" op="equ" val="norm">
                      <dgm:alg type="lin"/>
                    </dgm:if>
                    <dgm:else name="Name28">
                      <dgm:alg type="lin">
                        <dgm:param type="linDir" val="fromR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>
                    <dgm:constr type="w" for="ch" forName="childTextArrow" refType="w"/>
                    <dgm:constr type="h" for="ch" forName="childTextArrow" refType="h"/>
                  </dgm:constrLst>
                  <dgm:ruleLst/>
                  <dgm:forEach name="Name29" axis="ch" ptType="node">
                    <dgm:layoutNode name="childTextArrow" styleLbl="fgAccFollowNode1">
                      <dgm:varLst>
                        <dgm:bulletEnabled val="1"/>
                      </dgm:varLst>
                      <dgm:alg type="tx"/>
                      <dgm:shape xmlns:r="http://schemas.openxmlformats.org/officeDocument/2006/relationships" type="rect" r:blip="">
                        <dgm:adjLst/>
                      </dgm:shape>
                      <dgm:presOf axis="desOrSelf" ptType="node"/>
                      <dgm:constrLst>
                        <dgm:constr type="tMarg" refType="primFontSz" fact="0.1"/>
                        <dgm:constr type="bMarg" refType="primFontSz" fact="0.1"/>
                      </dgm:constrLst>
                      <dgm:ruleLst>
                        <dgm:rule type="primFontSz" val="5" fact="NaN" max="NaN"/>
                      </dgm:ruleLst>
                    </dgm:layoutNode>
                  </dgm:forEach>
                </dgm:layoutNode>
              </dgm:if>
              <dgm:else name="Name30"/>
            </dgm:choose>
          </dgm:layoutNode>
        </dgm:else>
      </dgm:choose>
      <dgm:forEach name="Name31" axis="precedSib" ptType="sibTrans" st="-1" cnt="1">
        <dgm:layoutNode name="sp">
          <dgm:alg type="sp"/>
          <dgm:shape xmlns:r="http://schemas.openxmlformats.org/officeDocument/2006/relationships" r:blip="">
            <dgm:adjLst/>
          </dgm:shape>
          <dgm:presOf axis="self"/>
          <dgm:constrLst/>
          <dgm:ruleLst/>
        </dgm:layoutNode>
      </dgm:forEach>
    </dgm:forEach>
  </dgm:layoutNode>
</dgm:layoutDef>
</file>

<file path=ppt/diagrams/layout6.xml><?xml version="1.0" encoding="utf-8"?>
<dgm:layoutDef xmlns:dgm="http://schemas.openxmlformats.org/drawingml/2006/diagram" xmlns:a="http://schemas.openxmlformats.org/drawingml/2006/main" uniqueId="urn:microsoft.com/office/officeart/2005/8/layout/process4">
  <dgm:title val=""/>
  <dgm:desc val=""/>
  <dgm:catLst>
    <dgm:cat type="process" pri="16000"/>
    <dgm:cat type="list" pri="20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Name0">
    <dgm:varLst>
      <dgm:dir/>
      <dgm:animLvl val="lvl"/>
      <dgm:resizeHandles val="exact"/>
    </dgm:varLst>
    <dgm:alg type="lin">
      <dgm:param type="linDir" val="fromB"/>
    </dgm:alg>
    <dgm:shape xmlns:r="http://schemas.openxmlformats.org/officeDocument/2006/relationships" r:blip="">
      <dgm:adjLst/>
    </dgm:shape>
    <dgm:presOf/>
    <dgm:constrLst>
      <dgm:constr type="h" for="ch" forName="boxAndChildren" refType="h"/>
      <dgm:constr type="h" for="ch" forName="arrowAndChildren" refType="h" refFor="ch" refForName="boxAndChildren" op="equ" fact="1.538"/>
      <dgm:constr type="w" for="ch" forName="arrowAndChildren" refType="w"/>
      <dgm:constr type="w" for="ch" forName="boxAndChildren" refType="w"/>
      <dgm:constr type="h" for="ch" forName="sp" refType="h" fact="-0.015"/>
      <dgm:constr type="primFontSz" for="des" forName="parentTextBox" val="65"/>
      <dgm:constr type="primFontSz" for="des" forName="parentTextArrow" refType="primFontSz" refFor="des" refForName="parentTextBox" op="equ"/>
      <dgm:constr type="primFontSz" for="des" forName="childTextArrow" val="65"/>
      <dgm:constr type="primFontSz" for="des" forName="childTextBox" refType="primFontSz" refFor="des" refForName="childTextArrow" op="equ"/>
    </dgm:constrLst>
    <dgm:ruleLst/>
    <dgm:forEach name="Name1" axis="ch" ptType="node" st="-1" step="-1">
      <dgm:choose name="Name2">
        <dgm:if name="Name3" axis="self" ptType="node" func="revPos" op="equ" val="1">
          <dgm:layoutNode name="boxAndChildren">
            <dgm:alg type="composite"/>
            <dgm:shape xmlns:r="http://schemas.openxmlformats.org/officeDocument/2006/relationships" r:blip="">
              <dgm:adjLst/>
            </dgm:shape>
            <dgm:presOf/>
            <dgm:choose name="Name4">
              <dgm:if name="Name5" axis="ch" ptType="node" func="cnt" op="gte" val="1">
                <dgm:constrLst>
                  <dgm:constr type="w" for="ch" forName="parentTextBox" refType="w"/>
                  <dgm:constr type="h" for="ch" forName="parentTextBox" refType="h" fact="0.54"/>
                  <dgm:constr type="t" for="ch" forName="parentTextBox"/>
                  <dgm:constr type="w" for="ch" forName="entireBox" refType="w"/>
                  <dgm:constr type="h" for="ch" forName="entireBox" refType="h"/>
                  <dgm:constr type="w" for="ch" forName="descendantBox" refType="w"/>
                  <dgm:constr type="b" for="ch" forName="descendantBox" refType="h" fact="0.98"/>
                  <dgm:constr type="h" for="ch" forName="descendantBox" refType="h" fact="0.46"/>
                </dgm:constrLst>
              </dgm:if>
              <dgm:else name="Name6">
                <dgm:constrLst>
                  <dgm:constr type="w" for="ch" forName="parentTextBox" refType="w"/>
                  <dgm:constr type="h" for="ch" forName="parentTextBox" refType="h"/>
                </dgm:constrLst>
              </dgm:else>
            </dgm:choose>
            <dgm:ruleLst/>
            <dgm:layoutNode name="parentTextBox">
              <dgm:alg type="tx"/>
              <dgm:choose name="Name7">
                <dgm:if name="Name8" axis="ch" ptType="node" func="cnt" op="gte" val="1">
                  <dgm:shape xmlns:r="http://schemas.openxmlformats.org/officeDocument/2006/relationships" type="rect" r:blip="" zOrderOff="1" hideGeom="1">
                    <dgm:adjLst/>
                  </dgm:shape>
                </dgm:if>
                <dgm:else name="Name9">
                  <dgm:shape xmlns:r="http://schemas.openxmlformats.org/officeDocument/2006/relationships" type="rect" r:blip="">
                    <dgm:adjLst/>
                  </dgm:shape>
                </dgm:else>
              </dgm:choose>
              <dgm:presOf axis="self"/>
              <dgm:constrLst/>
              <dgm:ruleLst>
                <dgm:rule type="primFontSz" val="5" fact="NaN" max="NaN"/>
              </dgm:ruleLst>
            </dgm:layoutNode>
            <dgm:choose name="Name10">
              <dgm:if name="Name11" axis="ch" ptType="node" func="cnt" op="gte" val="1">
                <dgm:layoutNode name="entireBox">
                  <dgm:alg type="sp"/>
                  <dgm:shape xmlns:r="http://schemas.openxmlformats.org/officeDocument/2006/relationships" type="rect" r:blip="">
                    <dgm:adjLst/>
                  </dgm:shape>
                  <dgm:presOf axis="self"/>
                  <dgm:constrLst/>
                  <dgm:ruleLst/>
                </dgm:layoutNode>
                <dgm:layoutNode name="descendantBox" styleLbl="fgAccFollowNode1">
                  <dgm:choose name="Name12">
                    <dgm:if name="Name13" func="var" arg="dir" op="equ" val="norm">
                      <dgm:alg type="lin"/>
                    </dgm:if>
                    <dgm:else name="Name14">
                      <dgm:alg type="lin">
                        <dgm:param type="linDir" val="fromR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>
                    <dgm:constr type="w" for="ch" forName="childTextBox" refType="w"/>
                    <dgm:constr type="h" for="ch" forName="childTextBox" refType="h"/>
                  </dgm:constrLst>
                  <dgm:ruleLst/>
                  <dgm:forEach name="Name15" axis="ch" ptType="node">
                    <dgm:layoutNode name="childTextBox" styleLbl="fgAccFollowNode1">
                      <dgm:varLst>
                        <dgm:bulletEnabled val="1"/>
                      </dgm:varLst>
                      <dgm:alg type="tx"/>
                      <dgm:shape xmlns:r="http://schemas.openxmlformats.org/officeDocument/2006/relationships" type="rect" r:blip="">
                        <dgm:adjLst/>
                      </dgm:shape>
                      <dgm:presOf axis="desOrSelf" ptType="node"/>
                      <dgm:constrLst>
                        <dgm:constr type="tMarg" refType="primFontSz" fact="0.1"/>
                        <dgm:constr type="bMarg" refType="primFontSz" fact="0.1"/>
                      </dgm:constrLst>
                      <dgm:ruleLst>
                        <dgm:rule type="primFontSz" val="5" fact="NaN" max="NaN"/>
                      </dgm:ruleLst>
                    </dgm:layoutNode>
                  </dgm:forEach>
                </dgm:layoutNode>
              </dgm:if>
              <dgm:else name="Name16"/>
            </dgm:choose>
          </dgm:layoutNode>
        </dgm:if>
        <dgm:else name="Name17">
          <dgm:layoutNode name="arrowAndChildren">
            <dgm:alg type="composite"/>
            <dgm:shape xmlns:r="http://schemas.openxmlformats.org/officeDocument/2006/relationships" r:blip="">
              <dgm:adjLst/>
            </dgm:shape>
            <dgm:presOf/>
            <dgm:choose name="Name18">
              <dgm:if name="Name19" axis="ch" ptType="node" func="cnt" op="gte" val="1">
                <dgm:constrLst>
                  <dgm:constr type="w" for="ch" forName="parentTextArrow" refType="w"/>
                  <dgm:constr type="t" for="ch" forName="parentTextArrow"/>
                  <dgm:constr type="h" for="ch" forName="parentTextArrow" refType="h" fact="0.351"/>
                  <dgm:constr type="w" for="ch" forName="arrow" refType="w"/>
                  <dgm:constr type="h" for="ch" forName="arrow" refType="h"/>
                  <dgm:constr type="w" for="ch" forName="descendantArrow" refType="w"/>
                  <dgm:constr type="b" for="ch" forName="descendantArrow" refType="h" fact="0.65"/>
                  <dgm:constr type="h" for="ch" forName="descendantArrow" refType="h" fact="0.299"/>
                </dgm:constrLst>
              </dgm:if>
              <dgm:else name="Name20">
                <dgm:constrLst>
                  <dgm:constr type="w" for="ch" forName="parentTextArrow" refType="w"/>
                  <dgm:constr type="h" for="ch" forName="parentTextArrow" refType="h"/>
                </dgm:constrLst>
              </dgm:else>
            </dgm:choose>
            <dgm:ruleLst/>
            <dgm:layoutNode name="parentTextArrow">
              <dgm:alg type="tx"/>
              <dgm:choose name="Name21">
                <dgm:if name="Name22" axis="ch" ptType="node" func="cnt" op="gte" val="1">
                  <dgm:shape xmlns:r="http://schemas.openxmlformats.org/officeDocument/2006/relationships" type="rect" r:blip="" zOrderOff="1" hideGeom="1">
                    <dgm:adjLst/>
                  </dgm:shape>
                </dgm:if>
                <dgm:else name="Name23">
                  <dgm:shape xmlns:r="http://schemas.openxmlformats.org/officeDocument/2006/relationships" rot="180" type="upArrowCallout" r:blip="">
                    <dgm:adjLst/>
                  </dgm:shape>
                </dgm:else>
              </dgm:choose>
              <dgm:presOf axis="self"/>
              <dgm:constrLst/>
              <dgm:ruleLst>
                <dgm:rule type="primFontSz" val="5" fact="NaN" max="NaN"/>
              </dgm:ruleLst>
            </dgm:layoutNode>
            <dgm:choose name="Name24">
              <dgm:if name="Name25" axis="ch" ptType="node" func="cnt" op="gte" val="1">
                <dgm:layoutNode name="arrow">
                  <dgm:alg type="sp"/>
                  <dgm:shape xmlns:r="http://schemas.openxmlformats.org/officeDocument/2006/relationships" rot="180" type="upArrowCallout" r:blip="">
                    <dgm:adjLst/>
                  </dgm:shape>
                  <dgm:presOf axis="self"/>
                  <dgm:constrLst/>
                  <dgm:ruleLst/>
                </dgm:layoutNode>
                <dgm:layoutNode name="descendantArrow">
                  <dgm:choose name="Name26">
                    <dgm:if name="Name27" func="var" arg="dir" op="equ" val="norm">
                      <dgm:alg type="lin"/>
                    </dgm:if>
                    <dgm:else name="Name28">
                      <dgm:alg type="lin">
                        <dgm:param type="linDir" val="fromR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>
                    <dgm:constr type="w" for="ch" forName="childTextArrow" refType="w"/>
                    <dgm:constr type="h" for="ch" forName="childTextArrow" refType="h"/>
                  </dgm:constrLst>
                  <dgm:ruleLst/>
                  <dgm:forEach name="Name29" axis="ch" ptType="node">
                    <dgm:layoutNode name="childTextArrow" styleLbl="fgAccFollowNode1">
                      <dgm:varLst>
                        <dgm:bulletEnabled val="1"/>
                      </dgm:varLst>
                      <dgm:alg type="tx"/>
                      <dgm:shape xmlns:r="http://schemas.openxmlformats.org/officeDocument/2006/relationships" type="rect" r:blip="">
                        <dgm:adjLst/>
                      </dgm:shape>
                      <dgm:presOf axis="desOrSelf" ptType="node"/>
                      <dgm:constrLst>
                        <dgm:constr type="tMarg" refType="primFontSz" fact="0.1"/>
                        <dgm:constr type="bMarg" refType="primFontSz" fact="0.1"/>
                      </dgm:constrLst>
                      <dgm:ruleLst>
                        <dgm:rule type="primFontSz" val="5" fact="NaN" max="NaN"/>
                      </dgm:ruleLst>
                    </dgm:layoutNode>
                  </dgm:forEach>
                </dgm:layoutNode>
              </dgm:if>
              <dgm:else name="Name30"/>
            </dgm:choose>
          </dgm:layoutNode>
        </dgm:else>
      </dgm:choose>
      <dgm:forEach name="Name31" axis="precedSib" ptType="sibTrans" st="-1" cnt="1">
        <dgm:layoutNode name="sp">
          <dgm:alg type="sp"/>
          <dgm:shape xmlns:r="http://schemas.openxmlformats.org/officeDocument/2006/relationships" r:blip="">
            <dgm:adjLst/>
          </dgm:shape>
          <dgm:presOf axis="self"/>
          <dgm:constrLst/>
          <dgm:ruleLst/>
        </dgm:layoutNode>
      </dgm:forEach>
    </dgm:forEach>
  </dgm:layoutNode>
</dgm:layoutDef>
</file>

<file path=ppt/diagrams/layout7.xml><?xml version="1.0" encoding="utf-8"?>
<dgm:layoutDef xmlns:dgm="http://schemas.openxmlformats.org/drawingml/2006/diagram" xmlns:a="http://schemas.openxmlformats.org/drawingml/2006/main" uniqueId="urn:microsoft.com/office/officeart/2005/8/layout/vList2">
  <dgm:title val=""/>
  <dgm:desc val=""/>
  <dgm:catLst>
    <dgm:cat type="list" pri="3000"/>
    <dgm:cat type="convert" pri="1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2">
          <dgm:prSet phldr="1"/>
        </dgm:pt>
        <dgm:pt modelId="21">
          <dgm:prSet phldr="1"/>
        </dgm:pt>
      </dgm:ptLst>
      <dgm:cxnLst>
        <dgm:cxn modelId="4" srcId="0" destId="1" srcOrd="0" destOrd="0"/>
        <dgm:cxn modelId="5" srcId="0" destId="2" srcOrd="1" destOrd="0"/>
        <dgm:cxn modelId="12" srcId="1" destId="11" srcOrd="0" destOrd="0"/>
        <dgm:cxn modelId="23" srcId="2" destId="21" srcOrd="0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linear">
    <dgm:varLst>
      <dgm:animLvl val="lvl"/>
      <dgm:resizeHandles val="exact"/>
    </dgm:varLst>
    <dgm:alg type="lin">
      <dgm:param type="linDir" val="fromT"/>
      <dgm:param type="vertAlign" val="mid"/>
    </dgm:alg>
    <dgm:shape xmlns:r="http://schemas.openxmlformats.org/officeDocument/2006/relationships" r:blip="">
      <dgm:adjLst/>
    </dgm:shape>
    <dgm:presOf/>
    <dgm:constrLst>
      <dgm:constr type="w" for="ch" forName="parentText" refType="w"/>
      <dgm:constr type="h" for="ch" forName="parentText" refType="primFontSz" refFor="ch" refForName="parentText" fact="0.52"/>
      <dgm:constr type="w" for="ch" forName="childText" refType="w"/>
      <dgm:constr type="h" for="ch" forName="childText" refType="primFontSz" refFor="ch" refForName="parentText" fact="0.46"/>
      <dgm:constr type="h" for="ch" forName="parentText" op="equ"/>
      <dgm:constr type="primFontSz" for="ch" forName="parentText" op="equ" val="65"/>
      <dgm:constr type="primFontSz" for="ch" forName="childText" refType="primFontSz" refFor="ch" refForName="parentText" op="equ"/>
      <dgm:constr type="h" for="ch" forName="spacer" refType="primFontSz" refFor="ch" refForName="parentText" fact="0.08"/>
    </dgm:constrLst>
    <dgm:ruleLst>
      <dgm:rule type="primFontSz" for="ch" forName="parentText" val="5" fact="NaN" max="NaN"/>
    </dgm:ruleLst>
    <dgm:forEach name="Name0" axis="ch" ptType="node">
      <dgm:layoutNode name="parentText" styleLbl="node1">
        <dgm:varLst>
          <dgm:chMax val="0"/>
          <dgm:bulletEnabled val="1"/>
        </dgm:varLst>
        <dgm:alg type="tx">
          <dgm:param type="parTxLTRAlign" val="l"/>
          <dgm:param type="parTxRTLAlign" val="r"/>
        </dgm:alg>
        <dgm:shape xmlns:r="http://schemas.openxmlformats.org/officeDocument/2006/relationships" type="roundRect" r:blip="">
          <dgm:adjLst/>
        </dgm:shape>
        <dgm:presOf axis="self"/>
        <dgm:constrLst>
          <dgm:constr type="tMarg" refType="primFontSz" fact="0.3"/>
          <dgm:constr type="bMarg" refType="primFontSz" fact="0.3"/>
          <dgm:constr type="lMarg" refType="primFontSz" fact="0.3"/>
          <dgm:constr type="rMarg" refType="primFontSz" fact="0.3"/>
        </dgm:constrLst>
        <dgm:ruleLst>
          <dgm:rule type="h" val="INF" fact="NaN" max="NaN"/>
        </dgm:ruleLst>
      </dgm:layoutNode>
      <dgm:choose name="Name1">
        <dgm:if name="Name2" axis="ch" ptType="node" func="cnt" op="gte" val="1">
          <dgm:layoutNode name="childText" styleLbl="revTx">
            <dgm:varLst>
              <dgm:bulletEnabled val="1"/>
            </dgm:varLst>
            <dgm:alg type="tx">
              <dgm:param type="stBulletLvl" val="1"/>
              <dgm:param type="lnSpAfChP" val="20"/>
            </dgm:alg>
            <dgm:shape xmlns:r="http://schemas.openxmlformats.org/officeDocument/2006/relationships" type="rect" r:blip="">
              <dgm:adjLst/>
            </dgm:shape>
            <dgm:presOf axis="des" ptType="node"/>
            <dgm:constrLst>
              <dgm:constr type="tMarg" refType="primFontSz" fact="0.1"/>
              <dgm:constr type="bMarg" refType="primFontSz" fact="0.1"/>
              <dgm:constr type="lMarg" refType="w" fact="0.09"/>
            </dgm:constrLst>
            <dgm:ruleLst>
              <dgm:rule type="h" val="INF" fact="NaN" max="NaN"/>
            </dgm:ruleLst>
          </dgm:layoutNode>
        </dgm:if>
        <dgm:else name="Name3">
          <dgm:choose name="Name4">
            <dgm:if name="Name5" axis="par ch" ptType="doc node" func="cnt" op="gte" val="2">
              <dgm:forEach name="Name6" axis="followSib" ptType="sibTrans" cnt="1">
                <dgm:layoutNode name="spacer">
                  <dgm:alg type="sp"/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</dgm:layoutNode>
              </dgm:forEach>
            </dgm:if>
            <dgm:else name="Name7"/>
          </dgm:choose>
        </dgm:else>
      </dgm:choose>
    </dgm:forEach>
  </dgm:layoutNode>
</dgm:layoutDef>
</file>

<file path=ppt/diagrams/layout8.xml><?xml version="1.0" encoding="utf-8"?>
<dgm:layoutDef xmlns:dgm="http://schemas.openxmlformats.org/drawingml/2006/diagram" xmlns:a="http://schemas.openxmlformats.org/drawingml/2006/main" uniqueId="urn:microsoft.com/office/officeart/2005/8/layout/vList2">
  <dgm:title val=""/>
  <dgm:desc val=""/>
  <dgm:catLst>
    <dgm:cat type="list" pri="3000"/>
    <dgm:cat type="convert" pri="1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2">
          <dgm:prSet phldr="1"/>
        </dgm:pt>
        <dgm:pt modelId="21">
          <dgm:prSet phldr="1"/>
        </dgm:pt>
      </dgm:ptLst>
      <dgm:cxnLst>
        <dgm:cxn modelId="4" srcId="0" destId="1" srcOrd="0" destOrd="0"/>
        <dgm:cxn modelId="5" srcId="0" destId="2" srcOrd="1" destOrd="0"/>
        <dgm:cxn modelId="12" srcId="1" destId="11" srcOrd="0" destOrd="0"/>
        <dgm:cxn modelId="23" srcId="2" destId="21" srcOrd="0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linear">
    <dgm:varLst>
      <dgm:animLvl val="lvl"/>
      <dgm:resizeHandles val="exact"/>
    </dgm:varLst>
    <dgm:alg type="lin">
      <dgm:param type="linDir" val="fromT"/>
      <dgm:param type="vertAlign" val="mid"/>
    </dgm:alg>
    <dgm:shape xmlns:r="http://schemas.openxmlformats.org/officeDocument/2006/relationships" r:blip="">
      <dgm:adjLst/>
    </dgm:shape>
    <dgm:presOf/>
    <dgm:constrLst>
      <dgm:constr type="w" for="ch" forName="parentText" refType="w"/>
      <dgm:constr type="h" for="ch" forName="parentText" refType="primFontSz" refFor="ch" refForName="parentText" fact="0.52"/>
      <dgm:constr type="w" for="ch" forName="childText" refType="w"/>
      <dgm:constr type="h" for="ch" forName="childText" refType="primFontSz" refFor="ch" refForName="parentText" fact="0.46"/>
      <dgm:constr type="h" for="ch" forName="parentText" op="equ"/>
      <dgm:constr type="primFontSz" for="ch" forName="parentText" op="equ" val="65"/>
      <dgm:constr type="primFontSz" for="ch" forName="childText" refType="primFontSz" refFor="ch" refForName="parentText" op="equ"/>
      <dgm:constr type="h" for="ch" forName="spacer" refType="primFontSz" refFor="ch" refForName="parentText" fact="0.08"/>
    </dgm:constrLst>
    <dgm:ruleLst>
      <dgm:rule type="primFontSz" for="ch" forName="parentText" val="5" fact="NaN" max="NaN"/>
    </dgm:ruleLst>
    <dgm:forEach name="Name0" axis="ch" ptType="node">
      <dgm:layoutNode name="parentText" styleLbl="node1">
        <dgm:varLst>
          <dgm:chMax val="0"/>
          <dgm:bulletEnabled val="1"/>
        </dgm:varLst>
        <dgm:alg type="tx">
          <dgm:param type="parTxLTRAlign" val="l"/>
          <dgm:param type="parTxRTLAlign" val="r"/>
        </dgm:alg>
        <dgm:shape xmlns:r="http://schemas.openxmlformats.org/officeDocument/2006/relationships" type="roundRect" r:blip="">
          <dgm:adjLst/>
        </dgm:shape>
        <dgm:presOf axis="self"/>
        <dgm:constrLst>
          <dgm:constr type="tMarg" refType="primFontSz" fact="0.3"/>
          <dgm:constr type="bMarg" refType="primFontSz" fact="0.3"/>
          <dgm:constr type="lMarg" refType="primFontSz" fact="0.3"/>
          <dgm:constr type="rMarg" refType="primFontSz" fact="0.3"/>
        </dgm:constrLst>
        <dgm:ruleLst>
          <dgm:rule type="h" val="INF" fact="NaN" max="NaN"/>
        </dgm:ruleLst>
      </dgm:layoutNode>
      <dgm:choose name="Name1">
        <dgm:if name="Name2" axis="ch" ptType="node" func="cnt" op="gte" val="1">
          <dgm:layoutNode name="childText" styleLbl="revTx">
            <dgm:varLst>
              <dgm:bulletEnabled val="1"/>
            </dgm:varLst>
            <dgm:alg type="tx">
              <dgm:param type="stBulletLvl" val="1"/>
              <dgm:param type="lnSpAfChP" val="20"/>
            </dgm:alg>
            <dgm:shape xmlns:r="http://schemas.openxmlformats.org/officeDocument/2006/relationships" type="rect" r:blip="">
              <dgm:adjLst/>
            </dgm:shape>
            <dgm:presOf axis="des" ptType="node"/>
            <dgm:constrLst>
              <dgm:constr type="tMarg" refType="primFontSz" fact="0.1"/>
              <dgm:constr type="bMarg" refType="primFontSz" fact="0.1"/>
              <dgm:constr type="lMarg" refType="w" fact="0.09"/>
            </dgm:constrLst>
            <dgm:ruleLst>
              <dgm:rule type="h" val="INF" fact="NaN" max="NaN"/>
            </dgm:ruleLst>
          </dgm:layoutNode>
        </dgm:if>
        <dgm:else name="Name3">
          <dgm:choose name="Name4">
            <dgm:if name="Name5" axis="par ch" ptType="doc node" func="cnt" op="gte" val="2">
              <dgm:forEach name="Name6" axis="followSib" ptType="sibTrans" cnt="1">
                <dgm:layoutNode name="spacer">
                  <dgm:alg type="sp"/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</dgm:layoutNode>
              </dgm:forEach>
            </dgm:if>
            <dgm:else name="Name7"/>
          </dgm:choose>
        </dgm:else>
      </dgm:choos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3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4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5.xml><?xml version="1.0" encoding="utf-8"?>
<dgm:styleDef xmlns:dgm="http://schemas.openxmlformats.org/drawingml/2006/diagram" xmlns:a="http://schemas.openxmlformats.org/drawingml/2006/main" uniqueId="urn:microsoft.com/office/officeart/2005/8/quickstyle/simple4">
  <dgm:title val=""/>
  <dgm:desc val=""/>
  <dgm:catLst>
    <dgm:cat type="simple" pri="104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6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7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8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8912506-C1B1-6A4C-932E-FF6CC5771AA9}" type="datetimeFigureOut">
              <a:rPr lang="en-US" smtClean="0"/>
              <a:t>5/19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B2D6CEF-E9B0-8548-98D4-B64F2444CE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00211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B2D6CEF-E9B0-8548-98D4-B64F2444CEB1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418365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ttps://</a:t>
            </a:r>
            <a:r>
              <a:rPr lang="en-US" dirty="0" err="1"/>
              <a:t>www.cancer.gov</a:t>
            </a:r>
            <a:r>
              <a:rPr lang="en-US" dirty="0"/>
              <a:t>/about-cancer/treatment/types/precision-medicin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7F9AF8-8680-5844-8593-1D9B1E21D6E1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1756558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ttps://</a:t>
            </a:r>
            <a:r>
              <a:rPr lang="en-US" dirty="0" err="1"/>
              <a:t>www.cancer.gov</a:t>
            </a:r>
            <a:r>
              <a:rPr lang="en-US" dirty="0"/>
              <a:t>/about-cancer/treatment/types/precision-medicin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7F9AF8-8680-5844-8593-1D9B1E21D6E1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100962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ttps://</a:t>
            </a:r>
            <a:r>
              <a:rPr lang="en-US" dirty="0" err="1"/>
              <a:t>pubmed.ncbi.nlm.nih.gov</a:t>
            </a:r>
            <a:r>
              <a:rPr lang="en-US" dirty="0"/>
              <a:t>/28410237/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7F9AF8-8680-5844-8593-1D9B1E21D6E1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6252159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ttps://</a:t>
            </a:r>
            <a:r>
              <a:rPr lang="en-US" dirty="0" err="1"/>
              <a:t>www.sciencedirect.com</a:t>
            </a:r>
            <a:r>
              <a:rPr lang="en-US" dirty="0"/>
              <a:t>/topics/medicine-and-dentistry/combination-therapy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7F9AF8-8680-5844-8593-1D9B1E21D6E1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0889457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https://</a:t>
            </a:r>
            <a:r>
              <a:rPr lang="en-US" dirty="0" err="1"/>
              <a:t>www.sciencedirect.com</a:t>
            </a:r>
            <a:r>
              <a:rPr lang="en-US" dirty="0"/>
              <a:t>/topics/medicine-and-dentistry/combination-therapy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7F9AF8-8680-5844-8593-1D9B1E21D6E1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388449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ttps://</a:t>
            </a:r>
            <a:r>
              <a:rPr lang="en-US" dirty="0" err="1"/>
              <a:t>www.cancer.gov</a:t>
            </a:r>
            <a:r>
              <a:rPr lang="en-US" dirty="0"/>
              <a:t>/about-cancer/treatment/types/immunotherapy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7F9AF8-8680-5844-8593-1D9B1E21D6E1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775339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ttps://</a:t>
            </a:r>
            <a:r>
              <a:rPr lang="en-US" dirty="0" err="1"/>
              <a:t>www.cancer.gov</a:t>
            </a:r>
            <a:r>
              <a:rPr lang="en-US" dirty="0"/>
              <a:t>/about-cancer/treatment/types/immunotherapy/side-effect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7F9AF8-8680-5844-8593-1D9B1E21D6E1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05773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ttps://</a:t>
            </a:r>
            <a:r>
              <a:rPr lang="en-US" dirty="0" err="1"/>
              <a:t>www.cancer.gov</a:t>
            </a:r>
            <a:r>
              <a:rPr lang="en-US" dirty="0"/>
              <a:t>/about-cancer/treatment/types/targeted-therapie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7F9AF8-8680-5844-8593-1D9B1E21D6E1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929610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ttps://</a:t>
            </a:r>
            <a:r>
              <a:rPr lang="en-US" dirty="0" err="1"/>
              <a:t>www.cancer.gov</a:t>
            </a:r>
            <a:r>
              <a:rPr lang="en-US" dirty="0"/>
              <a:t>/about-cancer/treatment/types/targeted-therapie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7F9AF8-8680-5844-8593-1D9B1E21D6E1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45323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ttps://</a:t>
            </a:r>
            <a:r>
              <a:rPr lang="en-US" dirty="0" err="1"/>
              <a:t>www.cancer.gov</a:t>
            </a:r>
            <a:r>
              <a:rPr lang="en-US" dirty="0"/>
              <a:t>/about-cancer/treatment/types/targeted-therapie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7F9AF8-8680-5844-8593-1D9B1E21D6E1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4466305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ttps://</a:t>
            </a:r>
            <a:r>
              <a:rPr lang="en-US" dirty="0" err="1"/>
              <a:t>www.cancer.gov</a:t>
            </a:r>
            <a:r>
              <a:rPr lang="en-US" dirty="0"/>
              <a:t>/about-cancer/treatment/types/hormone-therapy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7F9AF8-8680-5844-8593-1D9B1E21D6E1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2443242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ttps://</a:t>
            </a:r>
            <a:r>
              <a:rPr lang="en-US" dirty="0" err="1"/>
              <a:t>www.cancer.gov</a:t>
            </a:r>
            <a:r>
              <a:rPr lang="en-US" dirty="0"/>
              <a:t>/about-cancer/treatment/types/hormone-therapy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7F9AF8-8680-5844-8593-1D9B1E21D6E1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6653836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ttps://</a:t>
            </a:r>
            <a:r>
              <a:rPr lang="en-US" dirty="0" err="1"/>
              <a:t>www.cancer.gov</a:t>
            </a:r>
            <a:r>
              <a:rPr lang="en-US" dirty="0"/>
              <a:t>/about-cancer/treatment/types/hormone-therapy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7F9AF8-8680-5844-8593-1D9B1E21D6E1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15729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C4609C-3B0F-414F-A318-1710F3CB562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D82E014-8CC0-1A43-A974-17528DC50DC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BD9FB9-4393-6E44-A6CE-9EC83A1AF2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C47-83A7-4A4C-BC12-D9DEC215109B}" type="datetimeFigureOut">
              <a:rPr lang="en-US" smtClean="0"/>
              <a:t>5/1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4AD60B-37E8-2D40-B743-729D215CBC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BA5541-A17F-AE41-8426-104B479A9E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BB60E-A4BE-7C4B-B36F-2D418C460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95650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8C5C2A-0E83-C846-A7EC-6A68BD9DBF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AE6FD23-248C-C44A-A723-3D8218D74B2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F8E10C-B4D4-844E-88AD-50BACB3F26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C47-83A7-4A4C-BC12-D9DEC215109B}" type="datetimeFigureOut">
              <a:rPr lang="en-US" smtClean="0"/>
              <a:t>5/1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2E3DA7-AE42-1846-9000-F0AC6BC5C5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9DA9DA-D75D-F344-89DB-BABAA5F3B8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BB60E-A4BE-7C4B-B36F-2D418C460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3029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566E520-6483-5A4D-BE6B-3D654CD140B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EE6697B-9126-E247-8D2F-B8D886C4C9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081534-B918-C54C-A653-C5F142EC1F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C47-83A7-4A4C-BC12-D9DEC215109B}" type="datetimeFigureOut">
              <a:rPr lang="en-US" smtClean="0"/>
              <a:t>5/1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98FFEB-1E9A-7E4C-96A9-B9AAED1F26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35AA49-7BC8-8C45-8708-93FC152C89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BB60E-A4BE-7C4B-B36F-2D418C460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2202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E852DB-2C0F-1E42-AA63-94727BA453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00C6D3-38AC-0341-8EA2-BE5E6045283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C21DCD-6ECC-554D-AAED-1FA2DF48A3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C47-83A7-4A4C-BC12-D9DEC215109B}" type="datetimeFigureOut">
              <a:rPr lang="en-US" smtClean="0"/>
              <a:t>5/1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17848B-677A-9645-83C2-2160CC2B47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F9E34D-2E1D-3240-8287-EBC114E0DE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BB60E-A4BE-7C4B-B36F-2D418C460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15125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9FB14A-FF1C-E545-93A9-214F13B05B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C5055C2-ADA0-364E-93BC-40BF2FD9E6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DC9775-8430-CF45-99E7-BBC43E7EDF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C47-83A7-4A4C-BC12-D9DEC215109B}" type="datetimeFigureOut">
              <a:rPr lang="en-US" smtClean="0"/>
              <a:t>5/1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CA008C-49C8-0A47-9241-50A9B6E451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B285BC-13B1-814A-972E-ACE4C4C68B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BB60E-A4BE-7C4B-B36F-2D418C460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83581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056DCE-A640-164A-9A9E-8B83102E36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9DB168-6DB1-CD4D-BC76-6FE37744FA9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95A1882-708A-3841-BCF9-CF8CFB86AE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E1DA11E-621D-9948-846E-CC78EAA154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C47-83A7-4A4C-BC12-D9DEC215109B}" type="datetimeFigureOut">
              <a:rPr lang="en-US" smtClean="0"/>
              <a:t>5/1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14877D-2FF5-5741-8807-ABCE42F165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02CADB-4019-EF4F-8EEF-7251DDFB3E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BB60E-A4BE-7C4B-B36F-2D418C460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83282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B0C36E-42BC-B241-B899-3AC6A3F38F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E49590-B428-304A-A8E8-23180F63D0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E6076C-922C-7D44-82D5-AF16D2D7AC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5C38731-9D4C-3844-B26C-86F5645FDA3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FC1E070-042D-9C41-A599-6710668C8B1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218A60A-468D-B941-BEDC-A4A70EAB08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C47-83A7-4A4C-BC12-D9DEC215109B}" type="datetimeFigureOut">
              <a:rPr lang="en-US" smtClean="0"/>
              <a:t>5/19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2064E80-C456-BA46-BA41-0261E36AF5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479D005-7944-AF47-BCC3-C6B57862D3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BB60E-A4BE-7C4B-B36F-2D418C460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2971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6D6A1A-B864-994E-AC16-15D03102CB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1637F8E-DDB5-8146-836D-D24E435AB1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C47-83A7-4A4C-BC12-D9DEC215109B}" type="datetimeFigureOut">
              <a:rPr lang="en-US" smtClean="0"/>
              <a:t>5/19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4C4DC44-BE55-9E42-92DB-E17613E8E6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4CD79B9-AF7E-A748-A18C-20970A96C1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BB60E-A4BE-7C4B-B36F-2D418C460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1253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291BDF9-FE6F-7F4F-8DEB-CA4B492F1F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C47-83A7-4A4C-BC12-D9DEC215109B}" type="datetimeFigureOut">
              <a:rPr lang="en-US" smtClean="0"/>
              <a:t>5/19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2913517-184E-8E4D-A5E3-EFA6A9FA91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995660B-68EA-8446-A4D3-76238883D0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BB60E-A4BE-7C4B-B36F-2D418C460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446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2A3D09-BC43-2340-9FB9-2EDA0F91A7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7FE945-3BF8-0F4C-B666-E9BF02C2595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5E15A8E-862B-9B41-B2B8-8F5A0B565E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5CAFAEF-2A01-FB45-BB92-F18722D0D6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C47-83A7-4A4C-BC12-D9DEC215109B}" type="datetimeFigureOut">
              <a:rPr lang="en-US" smtClean="0"/>
              <a:t>5/1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40D9B1-FB01-2D4A-B633-C3047F1CD2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76ADEBD-BC38-FE46-BDAF-A1E82059C1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BB60E-A4BE-7C4B-B36F-2D418C460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69291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B960A0-33E6-214C-9F5D-32F48AE0AD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0A71142-0BFA-C74B-825E-DC44A31923D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D98AD81-0B49-6743-89EE-0BB0040039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1F4530-B573-DF44-B06C-D5A61BE0AE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C47-83A7-4A4C-BC12-D9DEC215109B}" type="datetimeFigureOut">
              <a:rPr lang="en-US" smtClean="0"/>
              <a:t>5/1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FC4A83E-C7A8-0341-84EC-F5979FC42B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97A28C-B6FC-E345-839B-8E8F3026C1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BB60E-A4BE-7C4B-B36F-2D418C460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05692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C624326-72CA-2844-8670-C3944D9ABF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82DF56-5A58-6445-B155-9B735C7150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32AE30-FFA8-0243-8622-04197E3E87C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F45C47-83A7-4A4C-BC12-D9DEC215109B}" type="datetimeFigureOut">
              <a:rPr lang="en-US" smtClean="0"/>
              <a:t>5/1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0D89C0-38A9-A849-91FD-E474E32FF0C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4337C5-4A64-4A46-B4DF-5610B030581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ABB60E-A4BE-7C4B-B36F-2D418C4602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22542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svg"/><Relationship Id="rId5" Type="http://schemas.openxmlformats.org/officeDocument/2006/relationships/image" Target="../media/image20.png"/><Relationship Id="rId4" Type="http://schemas.openxmlformats.org/officeDocument/2006/relationships/image" Target="../media/image19.sv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5.xml"/><Relationship Id="rId7" Type="http://schemas.microsoft.com/office/2007/relationships/diagramDrawing" Target="../diagrams/drawing5.xml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5.xml"/><Relationship Id="rId5" Type="http://schemas.openxmlformats.org/officeDocument/2006/relationships/diagramQuickStyle" Target="../diagrams/quickStyle5.xml"/><Relationship Id="rId4" Type="http://schemas.openxmlformats.org/officeDocument/2006/relationships/diagramLayout" Target="../diagrams/layout5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f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svg"/><Relationship Id="rId3" Type="http://schemas.openxmlformats.org/officeDocument/2006/relationships/image" Target="../media/image23.png"/><Relationship Id="rId7" Type="http://schemas.openxmlformats.org/officeDocument/2006/relationships/image" Target="../media/image27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svg"/><Relationship Id="rId5" Type="http://schemas.openxmlformats.org/officeDocument/2006/relationships/image" Target="../media/image25.png"/><Relationship Id="rId4" Type="http://schemas.openxmlformats.org/officeDocument/2006/relationships/image" Target="../media/image24.sv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6.xml"/><Relationship Id="rId2" Type="http://schemas.openxmlformats.org/officeDocument/2006/relationships/diagramData" Target="../diagrams/data6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6.xml"/><Relationship Id="rId5" Type="http://schemas.openxmlformats.org/officeDocument/2006/relationships/diagramColors" Target="../diagrams/colors6.xml"/><Relationship Id="rId4" Type="http://schemas.openxmlformats.org/officeDocument/2006/relationships/diagramQuickStyle" Target="../diagrams/quickStyle6.xml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svg"/><Relationship Id="rId3" Type="http://schemas.openxmlformats.org/officeDocument/2006/relationships/image" Target="../media/image29.png"/><Relationship Id="rId7" Type="http://schemas.openxmlformats.org/officeDocument/2006/relationships/image" Target="../media/image20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svg"/><Relationship Id="rId5" Type="http://schemas.openxmlformats.org/officeDocument/2006/relationships/image" Target="../media/image18.png"/><Relationship Id="rId4" Type="http://schemas.openxmlformats.org/officeDocument/2006/relationships/image" Target="../media/image30.sv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7.xml"/><Relationship Id="rId7" Type="http://schemas.microsoft.com/office/2007/relationships/diagramDrawing" Target="../diagrams/drawing7.xml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7.xml"/><Relationship Id="rId5" Type="http://schemas.openxmlformats.org/officeDocument/2006/relationships/diagramQuickStyle" Target="../diagrams/quickStyle7.xml"/><Relationship Id="rId4" Type="http://schemas.openxmlformats.org/officeDocument/2006/relationships/diagramLayout" Target="../diagrams/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8.xml"/><Relationship Id="rId7" Type="http://schemas.microsoft.com/office/2007/relationships/diagramDrawing" Target="../diagrams/drawing8.xml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8.xml"/><Relationship Id="rId5" Type="http://schemas.openxmlformats.org/officeDocument/2006/relationships/diagramQuickStyle" Target="../diagrams/quickStyle8.xml"/><Relationship Id="rId4" Type="http://schemas.openxmlformats.org/officeDocument/2006/relationships/diagramLayout" Target="../diagrams/layout8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1.xml"/><Relationship Id="rId7" Type="http://schemas.microsoft.com/office/2007/relationships/diagramDrawing" Target="../diagrams/drawing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1.xml"/><Relationship Id="rId5" Type="http://schemas.openxmlformats.org/officeDocument/2006/relationships/diagramQuickStyle" Target="../diagrams/quickStyle1.xml"/><Relationship Id="rId4" Type="http://schemas.openxmlformats.org/officeDocument/2006/relationships/diagramLayout" Target="../diagrams/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youtube.com/watch?time_continue=6&amp;v=jDdL2bMQXfE&amp;feature=emb_logo" TargetMode="Externa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svg"/><Relationship Id="rId4" Type="http://schemas.openxmlformats.org/officeDocument/2006/relationships/image" Target="../media/image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2.xml"/><Relationship Id="rId7" Type="http://schemas.microsoft.com/office/2007/relationships/diagramDrawing" Target="../diagrams/drawing2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2.xml"/><Relationship Id="rId5" Type="http://schemas.openxmlformats.org/officeDocument/2006/relationships/diagramQuickStyle" Target="../diagrams/quickStyle2.xml"/><Relationship Id="rId4" Type="http://schemas.openxmlformats.org/officeDocument/2006/relationships/diagramLayout" Target="../diagrams/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3.xml"/><Relationship Id="rId7" Type="http://schemas.microsoft.com/office/2007/relationships/diagramDrawing" Target="../diagrams/drawing3.xml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3.xml"/><Relationship Id="rId5" Type="http://schemas.openxmlformats.org/officeDocument/2006/relationships/diagramQuickStyle" Target="../diagrams/quickStyle3.xml"/><Relationship Id="rId4" Type="http://schemas.openxmlformats.org/officeDocument/2006/relationships/diagramLayout" Target="../diagrams/layout3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4.xml"/><Relationship Id="rId7" Type="http://schemas.microsoft.com/office/2007/relationships/diagramDrawing" Target="../diagrams/drawing4.xml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4.xml"/><Relationship Id="rId5" Type="http://schemas.openxmlformats.org/officeDocument/2006/relationships/diagramQuickStyle" Target="../diagrams/quickStyle4.xml"/><Relationship Id="rId4" Type="http://schemas.openxmlformats.org/officeDocument/2006/relationships/diagramLayout" Target="../diagrams/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:a16="http://schemas.microsoft.com/office/drawing/2014/main" id="{95B96B88-480A-054E-9504-392E766DCC1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5135328" y="2325880"/>
            <a:ext cx="6105828" cy="1560320"/>
          </a:xfrm>
        </p:spPr>
        <p:txBody>
          <a:bodyPr>
            <a:normAutofit fontScale="90000"/>
          </a:bodyPr>
          <a:lstStyle/>
          <a:p>
            <a:pPr algn="l"/>
            <a:r>
              <a:rPr lang="en-US" sz="5800" b="1" dirty="0">
                <a:solidFill>
                  <a:schemeClr val="accent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NCER IN THE COMMONWEALTH</a:t>
            </a:r>
          </a:p>
        </p:txBody>
      </p:sp>
      <p:sp>
        <p:nvSpPr>
          <p:cNvPr id="7" name="Subtitle 2">
            <a:extLst>
              <a:ext uri="{FF2B5EF4-FFF2-40B4-BE49-F238E27FC236}">
                <a16:creationId xmlns:a16="http://schemas.microsoft.com/office/drawing/2014/main" id="{9167255E-73B0-CD40-B0ED-FBC2E3E9DE2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5135328" y="4217598"/>
            <a:ext cx="6420679" cy="440822"/>
          </a:xfrm>
        </p:spPr>
        <p:txBody>
          <a:bodyPr>
            <a:noAutofit/>
          </a:bodyPr>
          <a:lstStyle/>
          <a:p>
            <a:pPr algn="l"/>
            <a:r>
              <a:rPr lang="en-US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sson 3, Part 2: </a:t>
            </a:r>
            <a:r>
              <a:rPr lang="en-US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ncer Treatment</a:t>
            </a: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7218D9FF-93B8-BB4C-ADD6-DC0081775557}"/>
              </a:ext>
            </a:extLst>
          </p:cNvPr>
          <p:cNvCxnSpPr/>
          <p:nvPr/>
        </p:nvCxnSpPr>
        <p:spPr>
          <a:xfrm>
            <a:off x="5204902" y="3985592"/>
            <a:ext cx="6105828" cy="0"/>
          </a:xfrm>
          <a:prstGeom prst="line">
            <a:avLst/>
          </a:prstGeom>
          <a:ln w="19050"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2" descr="A picture containing fruit, rambutan, pizza, cake&#10;&#10;Description automatically generated">
            <a:extLst>
              <a:ext uri="{FF2B5EF4-FFF2-40B4-BE49-F238E27FC236}">
                <a16:creationId xmlns:a16="http://schemas.microsoft.com/office/drawing/2014/main" id="{EB7D5B9A-7CBB-E34B-91CD-08D9C16A3A2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500018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9683994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249E85-37C5-2B43-B067-DA26E478A8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2898" y="457199"/>
            <a:ext cx="5228393" cy="1374883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rmone Therap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97C91E-E87B-D946-9A9A-3621E4EC739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22899" y="1982609"/>
            <a:ext cx="5228392" cy="4035805"/>
          </a:xfrm>
        </p:spPr>
        <p:txBody>
          <a:bodyPr>
            <a:normAutofit/>
          </a:bodyPr>
          <a:lstStyle/>
          <a:p>
            <a:pPr>
              <a:lnSpc>
                <a:spcPct val="110000"/>
              </a:lnSpc>
              <a:spcBef>
                <a:spcPts val="600"/>
              </a:spcBef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lows or stops the growth of cancer using certain types of hormones</a:t>
            </a:r>
          </a:p>
          <a:p>
            <a:pPr lvl="1">
              <a:lnSpc>
                <a:spcPct val="110000"/>
              </a:lnSpc>
              <a:spcBef>
                <a:spcPts val="600"/>
              </a:spcBef>
            </a:pP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Can be used to stop cancer growth or ease symptoms</a:t>
            </a:r>
          </a:p>
          <a:p>
            <a:pPr>
              <a:lnSpc>
                <a:spcPct val="110000"/>
              </a:lnSpc>
              <a:spcBef>
                <a:spcPts val="600"/>
              </a:spcBef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nly used to treat patients with prostate and breast cancer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DB66D242-3C42-EB47-B997-748118F62B6C}"/>
              </a:ext>
            </a:extLst>
          </p:cNvPr>
          <p:cNvSpPr/>
          <p:nvPr/>
        </p:nvSpPr>
        <p:spPr>
          <a:xfrm>
            <a:off x="6867968" y="-68367"/>
            <a:ext cx="5392396" cy="7101555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61F2675B-920E-2B4D-92E2-6F10E2DC967B}"/>
              </a:ext>
            </a:extLst>
          </p:cNvPr>
          <p:cNvGrpSpPr/>
          <p:nvPr/>
        </p:nvGrpSpPr>
        <p:grpSpPr>
          <a:xfrm>
            <a:off x="7096615" y="1265667"/>
            <a:ext cx="5031557" cy="5031557"/>
            <a:chOff x="695815" y="699900"/>
            <a:chExt cx="5031557" cy="5031557"/>
          </a:xfrm>
        </p:grpSpPr>
        <p:pic>
          <p:nvPicPr>
            <p:cNvPr id="7" name="Graphic 6" descr="Medicine">
              <a:extLst>
                <a:ext uri="{FF2B5EF4-FFF2-40B4-BE49-F238E27FC236}">
                  <a16:creationId xmlns:a16="http://schemas.microsoft.com/office/drawing/2014/main" id="{BEAF4A47-2237-994A-8F9E-E604FE42086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695815" y="699900"/>
              <a:ext cx="5031557" cy="5031557"/>
            </a:xfrm>
            <a:prstGeom prst="rect">
              <a:avLst/>
            </a:prstGeom>
          </p:spPr>
        </p:pic>
        <p:pic>
          <p:nvPicPr>
            <p:cNvPr id="8" name="Graphic 7" descr="Medicine">
              <a:extLst>
                <a:ext uri="{FF2B5EF4-FFF2-40B4-BE49-F238E27FC236}">
                  <a16:creationId xmlns:a16="http://schemas.microsoft.com/office/drawing/2014/main" id="{384A86E2-7F0D-2446-B484-D16884E78EB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screen">
              <a:extLst>
                <a:ext uri="{28A0092B-C50C-407E-A947-70E740481C1C}">
                  <a14:useLocalDpi xmlns:a14="http://schemas.microsoft.com/office/drawing/2010/main"/>
                </a:ex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rcRect l="41568" t="71889" r="17159" b="5352"/>
            <a:stretch/>
          </p:blipFill>
          <p:spPr>
            <a:xfrm>
              <a:off x="2785931" y="4315626"/>
              <a:ext cx="2076628" cy="1145137"/>
            </a:xfrm>
            <a:prstGeom prst="ellipse">
              <a:avLst/>
            </a:prstGeom>
          </p:spPr>
        </p:pic>
        <p:sp>
          <p:nvSpPr>
            <p:cNvPr id="9" name="Round Same Side Corner Rectangle 8">
              <a:extLst>
                <a:ext uri="{FF2B5EF4-FFF2-40B4-BE49-F238E27FC236}">
                  <a16:creationId xmlns:a16="http://schemas.microsoft.com/office/drawing/2014/main" id="{1A8E881D-C173-D945-843F-2CA2ADFD7027}"/>
                </a:ext>
              </a:extLst>
            </p:cNvPr>
            <p:cNvSpPr/>
            <p:nvPr/>
          </p:nvSpPr>
          <p:spPr>
            <a:xfrm rot="16200000">
              <a:off x="2744271" y="2340477"/>
              <a:ext cx="914400" cy="1754029"/>
            </a:xfrm>
            <a:prstGeom prst="round2SameRect">
              <a:avLst>
                <a:gd name="adj1" fmla="val 9190"/>
                <a:gd name="adj2" fmla="val 0"/>
              </a:avLst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4A6D9F36-E820-AB46-BE87-951F45842CB3}"/>
              </a:ext>
            </a:extLst>
          </p:cNvPr>
          <p:cNvSpPr txBox="1"/>
          <p:nvPr/>
        </p:nvSpPr>
        <p:spPr>
          <a:xfrm>
            <a:off x="6658495" y="-108065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5537451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F5899F-99D1-D348-B139-E1481E32B4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2145" y="940910"/>
            <a:ext cx="4471588" cy="4976179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8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duction vs. Behavior</a:t>
            </a:r>
          </a:p>
        </p:txBody>
      </p:sp>
      <p:graphicFrame>
        <p:nvGraphicFramePr>
          <p:cNvPr id="5" name="Content Placeholder 2">
            <a:extLst>
              <a:ext uri="{FF2B5EF4-FFF2-40B4-BE49-F238E27FC236}">
                <a16:creationId xmlns:a16="http://schemas.microsoft.com/office/drawing/2014/main" id="{FA04E0D9-9584-479A-A418-527B816DBFC3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571999285"/>
              </p:ext>
            </p:extLst>
          </p:nvPr>
        </p:nvGraphicFramePr>
        <p:xfrm>
          <a:off x="5247020" y="699997"/>
          <a:ext cx="6240669" cy="54864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347260555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3BDE6F-44A4-D843-83A5-368F176B79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31719" y="509675"/>
            <a:ext cx="10328562" cy="1202689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8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de Effects of Hormone Therapy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52B52CA7-48B0-7343-A090-18809760C843}"/>
              </a:ext>
            </a:extLst>
          </p:cNvPr>
          <p:cNvSpPr/>
          <p:nvPr/>
        </p:nvSpPr>
        <p:spPr>
          <a:xfrm>
            <a:off x="931719" y="1828800"/>
            <a:ext cx="3307772" cy="41425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Different side effects for different types of cancer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0832B553-D37C-2846-977E-B7E3EDA559F8}"/>
              </a:ext>
            </a:extLst>
          </p:cNvPr>
          <p:cNvSpPr/>
          <p:nvPr/>
        </p:nvSpPr>
        <p:spPr>
          <a:xfrm>
            <a:off x="4562989" y="1828800"/>
            <a:ext cx="3066021" cy="1496291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28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state cancer side effects: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E4D0DD9A-FF52-A746-A3BC-1E9498472941}"/>
              </a:ext>
            </a:extLst>
          </p:cNvPr>
          <p:cNvSpPr/>
          <p:nvPr/>
        </p:nvSpPr>
        <p:spPr>
          <a:xfrm>
            <a:off x="8194260" y="1828800"/>
            <a:ext cx="3066021" cy="1496291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28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reast cancer side effects: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CFC9EF82-AD52-A443-8DFC-39E8EA355C5A}"/>
              </a:ext>
            </a:extLst>
          </p:cNvPr>
          <p:cNvSpPr/>
          <p:nvPr/>
        </p:nvSpPr>
        <p:spPr>
          <a:xfrm>
            <a:off x="8194260" y="3502312"/>
            <a:ext cx="3066021" cy="2468997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endParaRPr lang="en-US" sz="28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ECB4C471-E537-2548-AD90-111AC3090517}"/>
              </a:ext>
            </a:extLst>
          </p:cNvPr>
          <p:cNvSpPr/>
          <p:nvPr/>
        </p:nvSpPr>
        <p:spPr>
          <a:xfrm>
            <a:off x="4581335" y="3502312"/>
            <a:ext cx="3066021" cy="2468997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endParaRPr lang="en-US" sz="28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611E42F4-7629-5D4E-ABA4-06222B0DC5A5}"/>
              </a:ext>
            </a:extLst>
          </p:cNvPr>
          <p:cNvSpPr/>
          <p:nvPr/>
        </p:nvSpPr>
        <p:spPr>
          <a:xfrm>
            <a:off x="4777381" y="3597537"/>
            <a:ext cx="2673927" cy="16312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Hot flashes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Weakened bones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Nausea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Enlarged/tender breasts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091585D9-A947-1E44-A13C-3C7E4C44A7E5}"/>
              </a:ext>
            </a:extLst>
          </p:cNvPr>
          <p:cNvSpPr/>
          <p:nvPr/>
        </p:nvSpPr>
        <p:spPr>
          <a:xfrm>
            <a:off x="8476721" y="3611652"/>
            <a:ext cx="2662333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Hot flash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Vaginal drynes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Changes in period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Mood changes</a:t>
            </a:r>
          </a:p>
        </p:txBody>
      </p:sp>
    </p:spTree>
    <p:extLst>
      <p:ext uri="{BB962C8B-B14F-4D97-AF65-F5344CB8AC3E}">
        <p14:creationId xmlns:p14="http://schemas.microsoft.com/office/powerpoint/2010/main" val="149424164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978FE3-14FB-6245-8A44-6CE422EB07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23900" y="429491"/>
            <a:ext cx="5370576" cy="946640"/>
          </a:xfrm>
        </p:spPr>
        <p:txBody>
          <a:bodyPr anchor="b">
            <a:normAutofit/>
          </a:bodyPr>
          <a:lstStyle/>
          <a:p>
            <a:r>
              <a:rPr lang="en-US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ecision Medicin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D3C146-5E6E-F94C-989C-614647AAAC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86694" y="1538378"/>
            <a:ext cx="5720141" cy="3095445"/>
          </a:xfrm>
        </p:spPr>
        <p:txBody>
          <a:bodyPr anchor="t">
            <a:noAutofit/>
          </a:bodyPr>
          <a:lstStyle/>
          <a:p>
            <a:pPr>
              <a:lnSpc>
                <a:spcPct val="100000"/>
              </a:lnSpc>
              <a:spcBef>
                <a:spcPts val="600"/>
              </a:spcBef>
            </a:pPr>
            <a:r>
              <a:rPr lang="en-US" sz="2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ctors select cancer treatment based on a genetic understanding of their tumor type.</a:t>
            </a:r>
          </a:p>
          <a:p>
            <a:pPr lvl="1">
              <a:lnSpc>
                <a:spcPct val="100000"/>
              </a:lnSpc>
              <a:spcBef>
                <a:spcPts val="600"/>
              </a:spcBef>
            </a:pPr>
            <a:r>
              <a: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ach tumor type causes a genetic change that allows it to spread and grow.</a:t>
            </a:r>
          </a:p>
          <a:p>
            <a:pPr lvl="1">
              <a:lnSpc>
                <a:spcPct val="100000"/>
              </a:lnSpc>
              <a:spcBef>
                <a:spcPts val="600"/>
              </a:spcBef>
            </a:pPr>
            <a:r>
              <a: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l patients with that tumor type will receive one type of treatment, while those with another type will receive a different treatment.</a:t>
            </a:r>
          </a:p>
          <a:p>
            <a:pPr>
              <a:lnSpc>
                <a:spcPct val="100000"/>
              </a:lnSpc>
              <a:spcBef>
                <a:spcPts val="600"/>
              </a:spcBef>
            </a:pPr>
            <a:r>
              <a:rPr lang="en-US" sz="2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nly works if the tumor has a genetic change that can be targeted by a drug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BD139D3-EDC9-934C-BFB7-E516F66577C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3644"/>
          <a:stretch/>
        </p:blipFill>
        <p:spPr>
          <a:xfrm>
            <a:off x="6334731" y="0"/>
            <a:ext cx="5857269" cy="68652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929930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FC2295-178B-124A-BE95-3835EFB11D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2899" y="540167"/>
            <a:ext cx="5853209" cy="1500687"/>
          </a:xfrm>
        </p:spPr>
        <p:txBody>
          <a:bodyPr anchor="b">
            <a:normAutofit/>
          </a:bodyPr>
          <a:lstStyle/>
          <a:p>
            <a:r>
              <a:rPr lang="en-US" sz="48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w to Determine A Genetic Chang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B5F4C5-43A0-EF4F-A9CC-CBF8A55049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22900" y="2880452"/>
            <a:ext cx="5977900" cy="3095445"/>
          </a:xfrm>
        </p:spPr>
        <p:txBody>
          <a:bodyPr anchor="t">
            <a:normAutofit/>
          </a:bodyPr>
          <a:lstStyle/>
          <a:p>
            <a:pPr>
              <a:lnSpc>
                <a:spcPct val="100000"/>
              </a:lnSpc>
              <a:spcBef>
                <a:spcPts val="600"/>
              </a:spcBef>
            </a:pPr>
            <a:r>
              <a:rPr lang="en-US" sz="3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 biopsy must be completed.</a:t>
            </a:r>
          </a:p>
          <a:p>
            <a:pPr lvl="1">
              <a:lnSpc>
                <a:spcPct val="100000"/>
              </a:lnSpc>
              <a:spcBef>
                <a:spcPts val="600"/>
              </a:spcBef>
            </a:pPr>
            <a:r>
              <a:rPr lang="en-US" sz="28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opsy: </a:t>
            </a:r>
            <a:r>
              <a:rPr lang="en-US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 procedure in which a doctor removes a sample of the cancer to be sent to the lab, where a DNA sequences looks for genetic changes.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A00DF458-A934-214C-956F-E570E977D75E}"/>
              </a:ext>
            </a:extLst>
          </p:cNvPr>
          <p:cNvSpPr/>
          <p:nvPr/>
        </p:nvSpPr>
        <p:spPr>
          <a:xfrm>
            <a:off x="6867968" y="-68367"/>
            <a:ext cx="5392396" cy="7101555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0A71CA97-0737-9544-971C-B7984E67FBC8}"/>
              </a:ext>
            </a:extLst>
          </p:cNvPr>
          <p:cNvGrpSpPr/>
          <p:nvPr/>
        </p:nvGrpSpPr>
        <p:grpSpPr>
          <a:xfrm>
            <a:off x="7356003" y="2040854"/>
            <a:ext cx="4145544" cy="4145544"/>
            <a:chOff x="7356003" y="2040854"/>
            <a:chExt cx="4145544" cy="4145544"/>
          </a:xfrm>
        </p:grpSpPr>
        <p:pic>
          <p:nvPicPr>
            <p:cNvPr id="7" name="Graphic 6" descr="Stethoscope">
              <a:extLst>
                <a:ext uri="{FF2B5EF4-FFF2-40B4-BE49-F238E27FC236}">
                  <a16:creationId xmlns:a16="http://schemas.microsoft.com/office/drawing/2014/main" id="{E566471F-20AA-400E-93B3-249B01FF40F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7356003" y="2040854"/>
              <a:ext cx="4145544" cy="4145544"/>
            </a:xfrm>
            <a:prstGeom prst="rect">
              <a:avLst/>
            </a:prstGeom>
          </p:spPr>
        </p:pic>
        <p:pic>
          <p:nvPicPr>
            <p:cNvPr id="5" name="Graphic 4" descr="Stethoscope">
              <a:extLst>
                <a:ext uri="{FF2B5EF4-FFF2-40B4-BE49-F238E27FC236}">
                  <a16:creationId xmlns:a16="http://schemas.microsoft.com/office/drawing/2014/main" id="{AC7A6459-08B5-104C-A26C-62FFA0F7D42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rcRect l="60509" b="50306"/>
            <a:stretch/>
          </p:blipFill>
          <p:spPr>
            <a:xfrm>
              <a:off x="9864436" y="2040854"/>
              <a:ext cx="1637111" cy="2060091"/>
            </a:xfrm>
            <a:prstGeom prst="rect">
              <a:avLst/>
            </a:prstGeom>
          </p:spPr>
        </p:pic>
        <p:pic>
          <p:nvPicPr>
            <p:cNvPr id="8" name="Graphic 7" descr="Stethoscope">
              <a:extLst>
                <a:ext uri="{FF2B5EF4-FFF2-40B4-BE49-F238E27FC236}">
                  <a16:creationId xmlns:a16="http://schemas.microsoft.com/office/drawing/2014/main" id="{055AEC6E-4DCC-704E-9D31-DC0C00D38B4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8"/>
                </a:ext>
              </a:extLst>
            </a:blip>
            <a:srcRect r="39156" b="62003"/>
            <a:stretch/>
          </p:blipFill>
          <p:spPr>
            <a:xfrm>
              <a:off x="7356003" y="2040854"/>
              <a:ext cx="2522288" cy="157518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32433542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ontent Placeholder 2">
            <a:extLst>
              <a:ext uri="{FF2B5EF4-FFF2-40B4-BE49-F238E27FC236}">
                <a16:creationId xmlns:a16="http://schemas.microsoft.com/office/drawing/2014/main" id="{0476AED5-4CA8-4748-9045-436C4D9F2590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042114298"/>
              </p:ext>
            </p:extLst>
          </p:nvPr>
        </p:nvGraphicFramePr>
        <p:xfrm>
          <a:off x="5208067" y="738322"/>
          <a:ext cx="6635260" cy="5381355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2" name="Title 1">
            <a:extLst>
              <a:ext uri="{FF2B5EF4-FFF2-40B4-BE49-F238E27FC236}">
                <a16:creationId xmlns:a16="http://schemas.microsoft.com/office/drawing/2014/main" id="{4D1B0471-4391-3B4B-A692-A6918AC43F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10052" y="1143498"/>
            <a:ext cx="4185360" cy="4976179"/>
          </a:xfrm>
        </p:spPr>
        <p:txBody>
          <a:bodyPr>
            <a:normAutofit/>
          </a:bodyPr>
          <a:lstStyle/>
          <a:p>
            <a:r>
              <a:rPr lang="en-US" sz="48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 all treatments work for each patient?</a:t>
            </a:r>
          </a:p>
        </p:txBody>
      </p:sp>
    </p:spTree>
    <p:extLst>
      <p:ext uri="{BB962C8B-B14F-4D97-AF65-F5344CB8AC3E}">
        <p14:creationId xmlns:p14="http://schemas.microsoft.com/office/powerpoint/2010/main" val="12628409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0F9071-DCD9-0B49-97E2-5F935D5201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57726" y="514295"/>
            <a:ext cx="5392396" cy="1370853"/>
          </a:xfrm>
        </p:spPr>
        <p:txBody>
          <a:bodyPr anchor="b">
            <a:normAutofit fontScale="90000"/>
          </a:bodyPr>
          <a:lstStyle/>
          <a:p>
            <a:r>
              <a:rPr lang="en-US" sz="48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bination Therap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32FAD8A-5D30-F642-BB74-6475300A1C4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64420" y="1995055"/>
            <a:ext cx="5867826" cy="4348650"/>
          </a:xfrm>
        </p:spPr>
        <p:txBody>
          <a:bodyPr>
            <a:noAutofit/>
          </a:bodyPr>
          <a:lstStyle/>
          <a:p>
            <a:pPr>
              <a:lnSpc>
                <a:spcPct val="100000"/>
              </a:lnSpc>
              <a:spcBef>
                <a:spcPts val="600"/>
              </a:spcBef>
            </a:pP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When a doctor combines two or more drug or treatment types. </a:t>
            </a:r>
          </a:p>
          <a:p>
            <a:pPr>
              <a:lnSpc>
                <a:spcPct val="100000"/>
              </a:lnSpc>
              <a:spcBef>
                <a:spcPts val="600"/>
              </a:spcBef>
            </a:pP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an mean that different types of cancer treatments are combined.</a:t>
            </a:r>
          </a:p>
          <a:p>
            <a:pPr lvl="1">
              <a:lnSpc>
                <a:spcPct val="100000"/>
              </a:lnSpc>
              <a:spcBef>
                <a:spcPts val="600"/>
              </a:spcBef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x: surgery and radiation or radiation and chemotherapy</a:t>
            </a:r>
          </a:p>
          <a:p>
            <a:pPr>
              <a:lnSpc>
                <a:spcPct val="100000"/>
              </a:lnSpc>
              <a:spcBef>
                <a:spcPts val="600"/>
              </a:spcBef>
            </a:pP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an also mean different drugs are combined in one type of cancer treatment.</a:t>
            </a:r>
          </a:p>
          <a:p>
            <a:pPr lvl="1">
              <a:lnSpc>
                <a:spcPct val="100000"/>
              </a:lnSpc>
              <a:spcBef>
                <a:spcPts val="600"/>
              </a:spcBef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x: three different types of drugs during chemotherapy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73EED912-7228-A448-B973-9A4F5FF1EE97}"/>
              </a:ext>
            </a:extLst>
          </p:cNvPr>
          <p:cNvSpPr/>
          <p:nvPr/>
        </p:nvSpPr>
        <p:spPr>
          <a:xfrm>
            <a:off x="6867968" y="-68367"/>
            <a:ext cx="5392396" cy="7101555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34ECC81C-BC3E-5446-8DC6-B1305495AAD6}"/>
              </a:ext>
            </a:extLst>
          </p:cNvPr>
          <p:cNvGrpSpPr/>
          <p:nvPr/>
        </p:nvGrpSpPr>
        <p:grpSpPr>
          <a:xfrm>
            <a:off x="9333030" y="139913"/>
            <a:ext cx="4232590" cy="6922352"/>
            <a:chOff x="6348996" y="110836"/>
            <a:chExt cx="4232590" cy="6922352"/>
          </a:xfrm>
        </p:grpSpPr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F329FCBF-4D6A-9F44-99A6-07235D192A12}"/>
                </a:ext>
              </a:extLst>
            </p:cNvPr>
            <p:cNvSpPr/>
            <p:nvPr/>
          </p:nvSpPr>
          <p:spPr>
            <a:xfrm>
              <a:off x="7512687" y="913962"/>
              <a:ext cx="1987103" cy="1657446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12" name="Graphic 11" descr="IV">
              <a:extLst>
                <a:ext uri="{FF2B5EF4-FFF2-40B4-BE49-F238E27FC236}">
                  <a16:creationId xmlns:a16="http://schemas.microsoft.com/office/drawing/2014/main" id="{10AE5622-8784-804A-A335-A63B3B35460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6348996" y="110836"/>
              <a:ext cx="4232590" cy="4232590"/>
            </a:xfrm>
            <a:prstGeom prst="rect">
              <a:avLst/>
            </a:prstGeom>
          </p:spPr>
        </p:pic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1D095E9B-D205-3641-A359-A6A1CFCA06B8}"/>
                </a:ext>
              </a:extLst>
            </p:cNvPr>
            <p:cNvSpPr/>
            <p:nvPr/>
          </p:nvSpPr>
          <p:spPr>
            <a:xfrm>
              <a:off x="8337258" y="3763466"/>
              <a:ext cx="252559" cy="3269722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77B8C285-7718-6A40-90CC-120978FD4122}"/>
              </a:ext>
            </a:extLst>
          </p:cNvPr>
          <p:cNvGrpSpPr/>
          <p:nvPr/>
        </p:nvGrpSpPr>
        <p:grpSpPr>
          <a:xfrm>
            <a:off x="7467600" y="2992582"/>
            <a:ext cx="3769669" cy="3868514"/>
            <a:chOff x="695815" y="699900"/>
            <a:chExt cx="5031557" cy="5031557"/>
          </a:xfrm>
        </p:grpSpPr>
        <p:pic>
          <p:nvPicPr>
            <p:cNvPr id="7" name="Graphic 6" descr="Medicine">
              <a:extLst>
                <a:ext uri="{FF2B5EF4-FFF2-40B4-BE49-F238E27FC236}">
                  <a16:creationId xmlns:a16="http://schemas.microsoft.com/office/drawing/2014/main" id="{17B87F69-9FCA-8C4E-A5CB-3842A788C8B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/>
                </a:ex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>
              <a:off x="695815" y="699900"/>
              <a:ext cx="5031557" cy="5031557"/>
            </a:xfrm>
            <a:prstGeom prst="rect">
              <a:avLst/>
            </a:prstGeom>
          </p:spPr>
        </p:pic>
        <p:pic>
          <p:nvPicPr>
            <p:cNvPr id="8" name="Graphic 7" descr="Medicine">
              <a:extLst>
                <a:ext uri="{FF2B5EF4-FFF2-40B4-BE49-F238E27FC236}">
                  <a16:creationId xmlns:a16="http://schemas.microsoft.com/office/drawing/2014/main" id="{17D11BDF-7DF4-D74D-AEA4-DD5FF5E4B9C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screen">
              <a:extLst>
                <a:ext uri="{28A0092B-C50C-407E-A947-70E740481C1C}">
                  <a14:useLocalDpi xmlns:a14="http://schemas.microsoft.com/office/drawing/2010/main"/>
                </a:ext>
                <a:ext uri="{96DAC541-7B7A-43D3-8B79-37D633B846F1}">
                  <asvg:svgBlip xmlns:asvg="http://schemas.microsoft.com/office/drawing/2016/SVG/main" r:embed="rId8"/>
                </a:ext>
              </a:extLst>
            </a:blip>
            <a:srcRect l="41568" t="71889" r="17159" b="5352"/>
            <a:stretch/>
          </p:blipFill>
          <p:spPr>
            <a:xfrm>
              <a:off x="2785931" y="4315626"/>
              <a:ext cx="2076628" cy="1145137"/>
            </a:xfrm>
            <a:prstGeom prst="ellipse">
              <a:avLst/>
            </a:prstGeom>
          </p:spPr>
        </p:pic>
        <p:sp>
          <p:nvSpPr>
            <p:cNvPr id="9" name="Round Same Side Corner Rectangle 8">
              <a:extLst>
                <a:ext uri="{FF2B5EF4-FFF2-40B4-BE49-F238E27FC236}">
                  <a16:creationId xmlns:a16="http://schemas.microsoft.com/office/drawing/2014/main" id="{F86F3338-2A4A-CD47-8353-E56571A009C0}"/>
                </a:ext>
              </a:extLst>
            </p:cNvPr>
            <p:cNvSpPr/>
            <p:nvPr/>
          </p:nvSpPr>
          <p:spPr>
            <a:xfrm rot="16200000">
              <a:off x="2744271" y="2340477"/>
              <a:ext cx="914400" cy="1754029"/>
            </a:xfrm>
            <a:prstGeom prst="round2SameRect">
              <a:avLst>
                <a:gd name="adj1" fmla="val 9190"/>
                <a:gd name="adj2" fmla="val 0"/>
              </a:avLst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5074920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0A8832-6318-5947-B8C6-53A20F8079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2144" y="940910"/>
            <a:ext cx="4953419" cy="4976179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8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vantages of Combination Therapy</a:t>
            </a:r>
          </a:p>
        </p:txBody>
      </p:sp>
      <p:graphicFrame>
        <p:nvGraphicFramePr>
          <p:cNvPr id="24" name="Content Placeholder 2">
            <a:extLst>
              <a:ext uri="{FF2B5EF4-FFF2-40B4-BE49-F238E27FC236}">
                <a16:creationId xmlns:a16="http://schemas.microsoft.com/office/drawing/2014/main" id="{5E2634AB-28C4-4508-94DF-C1280069D061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837694704"/>
              </p:ext>
            </p:extLst>
          </p:nvPr>
        </p:nvGraphicFramePr>
        <p:xfrm>
          <a:off x="5088112" y="713852"/>
          <a:ext cx="6681744" cy="5714658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400700250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48F402-5889-3A4D-A996-00342DFCA6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2144" y="940910"/>
            <a:ext cx="4662473" cy="4976179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8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sadvantages of Combination Therapy</a:t>
            </a:r>
          </a:p>
        </p:txBody>
      </p:sp>
      <p:graphicFrame>
        <p:nvGraphicFramePr>
          <p:cNvPr id="5" name="Content Placeholder 2">
            <a:extLst>
              <a:ext uri="{FF2B5EF4-FFF2-40B4-BE49-F238E27FC236}">
                <a16:creationId xmlns:a16="http://schemas.microsoft.com/office/drawing/2014/main" id="{975267A2-F61A-4563-81C7-0DA2D460E124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124836293"/>
              </p:ext>
            </p:extLst>
          </p:nvPr>
        </p:nvGraphicFramePr>
        <p:xfrm>
          <a:off x="5247020" y="699997"/>
          <a:ext cx="6240669" cy="54864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112986082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20E5A8-967D-CA40-8F60-CC55D0602D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68036" y="447455"/>
            <a:ext cx="7474172" cy="1325563"/>
          </a:xfrm>
        </p:spPr>
        <p:txBody>
          <a:bodyPr>
            <a:normAutofit/>
          </a:bodyPr>
          <a:lstStyle/>
          <a:p>
            <a:r>
              <a:rPr lang="en-US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mmar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F11A70-4022-4345-8A67-CD79BBBDD60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68036" y="2120588"/>
            <a:ext cx="11305309" cy="4109848"/>
          </a:xfrm>
        </p:spPr>
        <p:txBody>
          <a:bodyPr anchor="ctr">
            <a:noAutofit/>
          </a:bodyPr>
          <a:lstStyle/>
          <a:p>
            <a:pPr>
              <a:lnSpc>
                <a:spcPct val="110000"/>
              </a:lnSpc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here are 4 cancer treatments that </a:t>
            </a:r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are more modern: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mmunotherapy, stem targeted therapy, hormone therapy, precision medicine.</a:t>
            </a:r>
          </a:p>
          <a:p>
            <a:pPr>
              <a:lnSpc>
                <a:spcPct val="110000"/>
              </a:lnSpc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ach person is different, so not all treatments will work for every person.</a:t>
            </a:r>
          </a:p>
          <a:p>
            <a:pPr marL="685800" lvl="2">
              <a:lnSpc>
                <a:spcPct val="110000"/>
              </a:lnSpc>
              <a:spcBef>
                <a:spcPts val="1000"/>
              </a:spcBef>
            </a:pP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Sometimes, combination therapy is necessary.</a:t>
            </a:r>
          </a:p>
          <a:p>
            <a:pPr marL="685800" lvl="2">
              <a:lnSpc>
                <a:spcPct val="110000"/>
              </a:lnSpc>
              <a:spcBef>
                <a:spcPts val="1000"/>
              </a:spcBef>
            </a:pP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Combination therapy can save a patient’s life, but drug interactions may be unclear.</a:t>
            </a:r>
          </a:p>
        </p:txBody>
      </p:sp>
    </p:spTree>
    <p:extLst>
      <p:ext uri="{BB962C8B-B14F-4D97-AF65-F5344CB8AC3E}">
        <p14:creationId xmlns:p14="http://schemas.microsoft.com/office/powerpoint/2010/main" val="2726699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sitting, door, snow, standing&#10;&#10;Description automatically generated">
            <a:extLst>
              <a:ext uri="{FF2B5EF4-FFF2-40B4-BE49-F238E27FC236}">
                <a16:creationId xmlns:a16="http://schemas.microsoft.com/office/drawing/2014/main" id="{001A086B-3E83-D946-983D-337CCADB903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5400000">
            <a:off x="2683867" y="-2683868"/>
            <a:ext cx="6857999" cy="12225737"/>
          </a:xfrm>
          <a:prstGeom prst="rect">
            <a:avLst/>
          </a:prstGeom>
        </p:spPr>
      </p:pic>
      <p:sp>
        <p:nvSpPr>
          <p:cNvPr id="6" name="Title 1">
            <a:extLst>
              <a:ext uri="{FF2B5EF4-FFF2-40B4-BE49-F238E27FC236}">
                <a16:creationId xmlns:a16="http://schemas.microsoft.com/office/drawing/2014/main" id="{A714D208-9323-6840-A689-74EB10860B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544461" y="2617286"/>
            <a:ext cx="7103078" cy="2135867"/>
          </a:xfrm>
        </p:spPr>
        <p:txBody>
          <a:bodyPr anchor="b">
            <a:noAutofit/>
          </a:bodyPr>
          <a:lstStyle/>
          <a:p>
            <a:pPr algn="ctr"/>
            <a:r>
              <a:rPr lang="en-US" sz="100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VITY</a:t>
            </a:r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D13E15C7-181A-4F45-B98B-4AB6076D6C27}"/>
              </a:ext>
            </a:extLst>
          </p:cNvPr>
          <p:cNvSpPr/>
          <p:nvPr/>
        </p:nvSpPr>
        <p:spPr>
          <a:xfrm>
            <a:off x="4774019" y="2617286"/>
            <a:ext cx="466155" cy="466155"/>
          </a:xfrm>
          <a:prstGeom prst="ellipse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CB7800A7-5E48-B348-AAE0-7F88BDB88DFF}"/>
              </a:ext>
            </a:extLst>
          </p:cNvPr>
          <p:cNvSpPr/>
          <p:nvPr/>
        </p:nvSpPr>
        <p:spPr>
          <a:xfrm>
            <a:off x="5868318" y="2617286"/>
            <a:ext cx="466155" cy="466155"/>
          </a:xfrm>
          <a:prstGeom prst="ellipse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accent1"/>
              </a:solidFill>
            </a:endParaRPr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92B0E41C-5917-884A-92AA-14597EF33BEF}"/>
              </a:ext>
            </a:extLst>
          </p:cNvPr>
          <p:cNvSpPr/>
          <p:nvPr/>
        </p:nvSpPr>
        <p:spPr>
          <a:xfrm>
            <a:off x="6962617" y="2617285"/>
            <a:ext cx="466155" cy="466155"/>
          </a:xfrm>
          <a:prstGeom prst="ellipse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101927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6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7" dur="29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" dur="911" tmFilter="0,0; 0.14,0.36; 0.43,0.73; 0.71,0.91; 1.0,1.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-0.25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332" tmFilter="0.0,0.0; 0.25,0.07; 0.50,0.2; 0.75,0.467; 1.0,1.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3">
                                          <p:val>
                                            <p:fltVal val="0.5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0" dur="332" tmFilter="0, 0; 0.125,0.2665; 0.25,0.4; 0.375,0.465; 0.5,0.5;  0.625,0.535; 0.75,0.6; 0.875,0.7335; 1,1">
                                          <p:stCondLst>
                                            <p:cond delay="332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9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1" dur="166" tmFilter="0, 0; 0.125,0.2665; 0.25,0.4; 0.375,0.465; 0.5,0.5;  0.625,0.535; 0.75,0.6; 0.875,0.7335; 1,1">
                                          <p:stCondLst>
                                            <p:cond delay="662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27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2" dur="82" tmFilter="0, 0; 0.125,0.2665; 0.25,0.4; 0.375,0.465; 0.5,0.5;  0.625,0.535; 0.75,0.6; 0.875,0.7335; 1,1">
                                          <p:stCondLst>
                                            <p:cond delay="828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81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Scale>
                                      <p:cBhvr>
                                        <p:cTn id="13" dur="13">
                                          <p:stCondLst>
                                            <p:cond delay="325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60000"/>
                                    </p:animScale>
                                    <p:animScale>
                                      <p:cBhvr>
                                        <p:cTn id="14" dur="83" decel="50000">
                                          <p:stCondLst>
                                            <p:cond delay="338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15" dur="13">
                                          <p:stCondLst>
                                            <p:cond delay="656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80000"/>
                                    </p:animScale>
                                    <p:animScale>
                                      <p:cBhvr>
                                        <p:cTn id="16" dur="83" decel="50000">
                                          <p:stCondLst>
                                            <p:cond delay="669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17" dur="13">
                                          <p:stCondLst>
                                            <p:cond delay="821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90000"/>
                                    </p:animScale>
                                    <p:animScale>
                                      <p:cBhvr>
                                        <p:cTn id="18" dur="83" decel="50000">
                                          <p:stCondLst>
                                            <p:cond delay="834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19" dur="13">
                                          <p:stCondLst>
                                            <p:cond delay="904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95000"/>
                                    </p:animScale>
                                    <p:animScale>
                                      <p:cBhvr>
                                        <p:cTn id="20" dur="83" decel="50000">
                                          <p:stCondLst>
                                            <p:cond delay="917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100000"/>
                                    </p:animScale>
                                  </p:childTnLst>
                                </p:cTn>
                              </p:par>
                              <p:par>
                                <p:cTn id="21" presetID="26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23" dur="29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4" dur="911" tmFilter="0,0; 0.14,0.36; 0.43,0.73; 0.71,0.91; 1.0,1.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-0.25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5" dur="332" tmFilter="0.0,0.0; 0.25,0.07; 0.50,0.2; 0.75,0.467; 1.0,1.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3">
                                          <p:val>
                                            <p:fltVal val="0.5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6" dur="332" tmFilter="0, 0; 0.125,0.2665; 0.25,0.4; 0.375,0.465; 0.5,0.5;  0.625,0.535; 0.75,0.6; 0.875,0.7335; 1,1">
                                          <p:stCondLst>
                                            <p:cond delay="332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9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7" dur="166" tmFilter="0, 0; 0.125,0.2665; 0.25,0.4; 0.375,0.465; 0.5,0.5;  0.625,0.535; 0.75,0.6; 0.875,0.7335; 1,1">
                                          <p:stCondLst>
                                            <p:cond delay="662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27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8" dur="82" tmFilter="0, 0; 0.125,0.2665; 0.25,0.4; 0.375,0.465; 0.5,0.5;  0.625,0.535; 0.75,0.6; 0.875,0.7335; 1,1">
                                          <p:stCondLst>
                                            <p:cond delay="828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81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Scale>
                                      <p:cBhvr>
                                        <p:cTn id="29" dur="13">
                                          <p:stCondLst>
                                            <p:cond delay="325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60000"/>
                                    </p:animScale>
                                    <p:animScale>
                                      <p:cBhvr>
                                        <p:cTn id="30" dur="83" decel="50000">
                                          <p:stCondLst>
                                            <p:cond delay="338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31" dur="13">
                                          <p:stCondLst>
                                            <p:cond delay="656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80000"/>
                                    </p:animScale>
                                    <p:animScale>
                                      <p:cBhvr>
                                        <p:cTn id="32" dur="83" decel="50000">
                                          <p:stCondLst>
                                            <p:cond delay="669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33" dur="13">
                                          <p:stCondLst>
                                            <p:cond delay="821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90000"/>
                                    </p:animScale>
                                    <p:animScale>
                                      <p:cBhvr>
                                        <p:cTn id="34" dur="83" decel="50000">
                                          <p:stCondLst>
                                            <p:cond delay="834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35" dur="13">
                                          <p:stCondLst>
                                            <p:cond delay="904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95000"/>
                                    </p:animScale>
                                    <p:animScale>
                                      <p:cBhvr>
                                        <p:cTn id="36" dur="83" decel="50000">
                                          <p:stCondLst>
                                            <p:cond delay="917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100000"/>
                                    </p:animScale>
                                  </p:childTnLst>
                                </p:cTn>
                              </p:par>
                              <p:par>
                                <p:cTn id="37" presetID="26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39" dur="29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40" dur="911" tmFilter="0,0; 0.14,0.36; 0.43,0.73; 0.71,0.91; 1.0,1.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-0.25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1" dur="332" tmFilter="0.0,0.0; 0.25,0.07; 0.50,0.2; 0.75,0.467; 1.0,1.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3">
                                          <p:val>
                                            <p:fltVal val="0.5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2" dur="332" tmFilter="0, 0; 0.125,0.2665; 0.25,0.4; 0.375,0.465; 0.5,0.5;  0.625,0.535; 0.75,0.6; 0.875,0.7335; 1,1">
                                          <p:stCondLst>
                                            <p:cond delay="332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9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3" dur="166" tmFilter="0, 0; 0.125,0.2665; 0.25,0.4; 0.375,0.465; 0.5,0.5;  0.625,0.535; 0.75,0.6; 0.875,0.7335; 1,1">
                                          <p:stCondLst>
                                            <p:cond delay="662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27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4" dur="82" tmFilter="0, 0; 0.125,0.2665; 0.25,0.4; 0.375,0.465; 0.5,0.5;  0.625,0.535; 0.75,0.6; 0.875,0.7335; 1,1">
                                          <p:stCondLst>
                                            <p:cond delay="828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81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Scale>
                                      <p:cBhvr>
                                        <p:cTn id="45" dur="13">
                                          <p:stCondLst>
                                            <p:cond delay="325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60000"/>
                                    </p:animScale>
                                    <p:animScale>
                                      <p:cBhvr>
                                        <p:cTn id="46" dur="83" decel="50000">
                                          <p:stCondLst>
                                            <p:cond delay="338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47" dur="13">
                                          <p:stCondLst>
                                            <p:cond delay="656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80000"/>
                                    </p:animScale>
                                    <p:animScale>
                                      <p:cBhvr>
                                        <p:cTn id="48" dur="83" decel="50000">
                                          <p:stCondLst>
                                            <p:cond delay="669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49" dur="13">
                                          <p:stCondLst>
                                            <p:cond delay="821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90000"/>
                                    </p:animScale>
                                    <p:animScale>
                                      <p:cBhvr>
                                        <p:cTn id="50" dur="83" decel="50000">
                                          <p:stCondLst>
                                            <p:cond delay="834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51" dur="13">
                                          <p:stCondLst>
                                            <p:cond delay="904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95000"/>
                                    </p:animScale>
                                    <p:animScale>
                                      <p:cBhvr>
                                        <p:cTn id="52" dur="83" decel="50000">
                                          <p:stCondLst>
                                            <p:cond delay="917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100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" grpId="0" animBg="1"/>
      <p:bldP spid="8" grpId="0" animBg="1"/>
      <p:bldP spid="9" grpId="0" animBg="1"/>
    </p:bld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sitting, door, snow, standing&#10;&#10;Description automatically generated">
            <a:extLst>
              <a:ext uri="{FF2B5EF4-FFF2-40B4-BE49-F238E27FC236}">
                <a16:creationId xmlns:a16="http://schemas.microsoft.com/office/drawing/2014/main" id="{001A086B-3E83-D946-983D-337CCADB903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5400000">
            <a:off x="2683867" y="-2683868"/>
            <a:ext cx="6857999" cy="12225737"/>
          </a:xfrm>
          <a:prstGeom prst="rect">
            <a:avLst/>
          </a:prstGeom>
        </p:spPr>
      </p:pic>
      <p:sp>
        <p:nvSpPr>
          <p:cNvPr id="6" name="Title 1">
            <a:extLst>
              <a:ext uri="{FF2B5EF4-FFF2-40B4-BE49-F238E27FC236}">
                <a16:creationId xmlns:a16="http://schemas.microsoft.com/office/drawing/2014/main" id="{A714D208-9323-6840-A689-74EB10860B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544460" y="2617286"/>
            <a:ext cx="7777175" cy="2135867"/>
          </a:xfrm>
        </p:spPr>
        <p:txBody>
          <a:bodyPr anchor="b">
            <a:noAutofit/>
          </a:bodyPr>
          <a:lstStyle/>
          <a:p>
            <a:pPr algn="ctr"/>
            <a:r>
              <a:rPr lang="en-US" sz="100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QUESTIONS</a:t>
            </a:r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D13E15C7-181A-4F45-B98B-4AB6076D6C27}"/>
              </a:ext>
            </a:extLst>
          </p:cNvPr>
          <p:cNvSpPr/>
          <p:nvPr/>
        </p:nvSpPr>
        <p:spPr>
          <a:xfrm>
            <a:off x="4774019" y="2617286"/>
            <a:ext cx="466155" cy="466155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CB7800A7-5E48-B348-AAE0-7F88BDB88DFF}"/>
              </a:ext>
            </a:extLst>
          </p:cNvPr>
          <p:cNvSpPr/>
          <p:nvPr/>
        </p:nvSpPr>
        <p:spPr>
          <a:xfrm>
            <a:off x="5868318" y="2617286"/>
            <a:ext cx="466155" cy="466155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accent1"/>
              </a:solidFill>
            </a:endParaRPr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92B0E41C-5917-884A-92AA-14597EF33BEF}"/>
              </a:ext>
            </a:extLst>
          </p:cNvPr>
          <p:cNvSpPr/>
          <p:nvPr/>
        </p:nvSpPr>
        <p:spPr>
          <a:xfrm>
            <a:off x="6962617" y="2617285"/>
            <a:ext cx="466155" cy="466155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975524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6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7" dur="29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" dur="911" tmFilter="0,0; 0.14,0.36; 0.43,0.73; 0.71,0.91; 1.0,1.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-0.25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332" tmFilter="0.0,0.0; 0.25,0.07; 0.50,0.2; 0.75,0.467; 1.0,1.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3">
                                          <p:val>
                                            <p:fltVal val="0.5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0" dur="332" tmFilter="0, 0; 0.125,0.2665; 0.25,0.4; 0.375,0.465; 0.5,0.5;  0.625,0.535; 0.75,0.6; 0.875,0.7335; 1,1">
                                          <p:stCondLst>
                                            <p:cond delay="332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9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1" dur="166" tmFilter="0, 0; 0.125,0.2665; 0.25,0.4; 0.375,0.465; 0.5,0.5;  0.625,0.535; 0.75,0.6; 0.875,0.7335; 1,1">
                                          <p:stCondLst>
                                            <p:cond delay="662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27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2" dur="82" tmFilter="0, 0; 0.125,0.2665; 0.25,0.4; 0.375,0.465; 0.5,0.5;  0.625,0.535; 0.75,0.6; 0.875,0.7335; 1,1">
                                          <p:stCondLst>
                                            <p:cond delay="828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81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Scale>
                                      <p:cBhvr>
                                        <p:cTn id="13" dur="13">
                                          <p:stCondLst>
                                            <p:cond delay="325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60000"/>
                                    </p:animScale>
                                    <p:animScale>
                                      <p:cBhvr>
                                        <p:cTn id="14" dur="83" decel="50000">
                                          <p:stCondLst>
                                            <p:cond delay="338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15" dur="13">
                                          <p:stCondLst>
                                            <p:cond delay="656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80000"/>
                                    </p:animScale>
                                    <p:animScale>
                                      <p:cBhvr>
                                        <p:cTn id="16" dur="83" decel="50000">
                                          <p:stCondLst>
                                            <p:cond delay="669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17" dur="13">
                                          <p:stCondLst>
                                            <p:cond delay="821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90000"/>
                                    </p:animScale>
                                    <p:animScale>
                                      <p:cBhvr>
                                        <p:cTn id="18" dur="83" decel="50000">
                                          <p:stCondLst>
                                            <p:cond delay="834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19" dur="13">
                                          <p:stCondLst>
                                            <p:cond delay="904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95000"/>
                                    </p:animScale>
                                    <p:animScale>
                                      <p:cBhvr>
                                        <p:cTn id="20" dur="83" decel="50000">
                                          <p:stCondLst>
                                            <p:cond delay="917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</p:cBhvr>
                                      <p:to x="100000" y="100000"/>
                                    </p:animScale>
                                  </p:childTnLst>
                                </p:cTn>
                              </p:par>
                              <p:par>
                                <p:cTn id="21" presetID="26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23" dur="29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4" dur="911" tmFilter="0,0; 0.14,0.36; 0.43,0.73; 0.71,0.91; 1.0,1.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-0.25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5" dur="332" tmFilter="0.0,0.0; 0.25,0.07; 0.50,0.2; 0.75,0.467; 1.0,1.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3">
                                          <p:val>
                                            <p:fltVal val="0.5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6" dur="332" tmFilter="0, 0; 0.125,0.2665; 0.25,0.4; 0.375,0.465; 0.5,0.5;  0.625,0.535; 0.75,0.6; 0.875,0.7335; 1,1">
                                          <p:stCondLst>
                                            <p:cond delay="332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9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7" dur="166" tmFilter="0, 0; 0.125,0.2665; 0.25,0.4; 0.375,0.465; 0.5,0.5;  0.625,0.535; 0.75,0.6; 0.875,0.7335; 1,1">
                                          <p:stCondLst>
                                            <p:cond delay="662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27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8" dur="82" tmFilter="0, 0; 0.125,0.2665; 0.25,0.4; 0.375,0.465; 0.5,0.5;  0.625,0.535; 0.75,0.6; 0.875,0.7335; 1,1">
                                          <p:stCondLst>
                                            <p:cond delay="828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81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Scale>
                                      <p:cBhvr>
                                        <p:cTn id="29" dur="13">
                                          <p:stCondLst>
                                            <p:cond delay="325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60000"/>
                                    </p:animScale>
                                    <p:animScale>
                                      <p:cBhvr>
                                        <p:cTn id="30" dur="83" decel="50000">
                                          <p:stCondLst>
                                            <p:cond delay="338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31" dur="13">
                                          <p:stCondLst>
                                            <p:cond delay="656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80000"/>
                                    </p:animScale>
                                    <p:animScale>
                                      <p:cBhvr>
                                        <p:cTn id="32" dur="83" decel="50000">
                                          <p:stCondLst>
                                            <p:cond delay="669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33" dur="13">
                                          <p:stCondLst>
                                            <p:cond delay="821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90000"/>
                                    </p:animScale>
                                    <p:animScale>
                                      <p:cBhvr>
                                        <p:cTn id="34" dur="83" decel="50000">
                                          <p:stCondLst>
                                            <p:cond delay="834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35" dur="13">
                                          <p:stCondLst>
                                            <p:cond delay="904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95000"/>
                                    </p:animScale>
                                    <p:animScale>
                                      <p:cBhvr>
                                        <p:cTn id="36" dur="83" decel="50000">
                                          <p:stCondLst>
                                            <p:cond delay="917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</p:cBhvr>
                                      <p:to x="100000" y="100000"/>
                                    </p:animScale>
                                  </p:childTnLst>
                                </p:cTn>
                              </p:par>
                              <p:par>
                                <p:cTn id="37" presetID="26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39" dur="29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40" dur="911" tmFilter="0,0; 0.14,0.36; 0.43,0.73; 0.71,0.91; 1.0,1.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-0.25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1" dur="332" tmFilter="0.0,0.0; 0.25,0.07; 0.50,0.2; 0.75,0.467; 1.0,1.0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3">
                                          <p:val>
                                            <p:fltVal val="0.5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2" dur="332" tmFilter="0, 0; 0.125,0.2665; 0.25,0.4; 0.375,0.465; 0.5,0.5;  0.625,0.535; 0.75,0.6; 0.875,0.7335; 1,1">
                                          <p:stCondLst>
                                            <p:cond delay="332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9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3" dur="166" tmFilter="0, 0; 0.125,0.2665; 0.25,0.4; 0.375,0.465; 0.5,0.5;  0.625,0.535; 0.75,0.6; 0.875,0.7335; 1,1">
                                          <p:stCondLst>
                                            <p:cond delay="662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27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4" dur="82" tmFilter="0, 0; 0.125,0.2665; 0.25,0.4; 0.375,0.465; 0.5,0.5;  0.625,0.535; 0.75,0.6; 0.875,0.7335; 1,1">
                                          <p:stCondLst>
                                            <p:cond delay="828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 fmla="#ppt_y-sin(pi*$)/81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Scale>
                                      <p:cBhvr>
                                        <p:cTn id="45" dur="13">
                                          <p:stCondLst>
                                            <p:cond delay="325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60000"/>
                                    </p:animScale>
                                    <p:animScale>
                                      <p:cBhvr>
                                        <p:cTn id="46" dur="83" decel="50000">
                                          <p:stCondLst>
                                            <p:cond delay="338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47" dur="13">
                                          <p:stCondLst>
                                            <p:cond delay="656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80000"/>
                                    </p:animScale>
                                    <p:animScale>
                                      <p:cBhvr>
                                        <p:cTn id="48" dur="83" decel="50000">
                                          <p:stCondLst>
                                            <p:cond delay="669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49" dur="13">
                                          <p:stCondLst>
                                            <p:cond delay="821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90000"/>
                                    </p:animScale>
                                    <p:animScale>
                                      <p:cBhvr>
                                        <p:cTn id="50" dur="83" decel="50000">
                                          <p:stCondLst>
                                            <p:cond delay="834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100000"/>
                                    </p:animScale>
                                    <p:animScale>
                                      <p:cBhvr>
                                        <p:cTn id="51" dur="13">
                                          <p:stCondLst>
                                            <p:cond delay="904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95000"/>
                                    </p:animScale>
                                    <p:animScale>
                                      <p:cBhvr>
                                        <p:cTn id="52" dur="83" decel="50000">
                                          <p:stCondLst>
                                            <p:cond delay="917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</p:cBhvr>
                                      <p:to x="100000" y="100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" grpId="0" animBg="1"/>
      <p:bldP spid="8" grpId="0" animBg="1"/>
      <p:bldP spid="9" grpId="0" animBg="1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EACAAD-01BC-7D44-AFE9-329691FF58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ncer Treatments In Depth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DB9EFB-9CF2-064A-B24F-3159702A927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>
              <a:spcBef>
                <a:spcPts val="900"/>
              </a:spcBef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You will each be assigned into a group. There will be a total of 4 groups. </a:t>
            </a:r>
          </a:p>
          <a:p>
            <a:pPr>
              <a:spcBef>
                <a:spcPts val="900"/>
              </a:spcBef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Your group will be assigned one of the following cancer treatments. Research it in depth. </a:t>
            </a:r>
          </a:p>
          <a:p>
            <a:pPr lvl="1">
              <a:spcBef>
                <a:spcPts val="900"/>
              </a:spcBef>
              <a:buFont typeface="System Font Regular"/>
              <a:buChar char="–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You will then partner with another group and explain to them how this treatment works.</a:t>
            </a:r>
          </a:p>
          <a:p>
            <a:pPr lvl="1">
              <a:lnSpc>
                <a:spcPct val="100000"/>
              </a:lnSpc>
              <a:spcBef>
                <a:spcPts val="900"/>
              </a:spcBef>
              <a:buFont typeface="System Font Regular"/>
              <a:buChar char="–"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int: Consider how the treatment works, why it is useful, and what side effects it may cause.</a:t>
            </a:r>
          </a:p>
        </p:txBody>
      </p:sp>
    </p:spTree>
    <p:extLst>
      <p:ext uri="{BB962C8B-B14F-4D97-AF65-F5344CB8AC3E}">
        <p14:creationId xmlns:p14="http://schemas.microsoft.com/office/powerpoint/2010/main" val="28969428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286410-93FD-6E44-84C3-7353531095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2145" y="940910"/>
            <a:ext cx="4471588" cy="4976179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54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 Types of Modern Cancer Treatment</a:t>
            </a:r>
          </a:p>
        </p:txBody>
      </p:sp>
      <p:graphicFrame>
        <p:nvGraphicFramePr>
          <p:cNvPr id="24" name="Content Placeholder 2">
            <a:extLst>
              <a:ext uri="{FF2B5EF4-FFF2-40B4-BE49-F238E27FC236}">
                <a16:creationId xmlns:a16="http://schemas.microsoft.com/office/drawing/2014/main" id="{7BBCEEEC-4064-4C6E-BD93-B56A4C3763E8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827496525"/>
              </p:ext>
            </p:extLst>
          </p:nvPr>
        </p:nvGraphicFramePr>
        <p:xfrm>
          <a:off x="5247020" y="699997"/>
          <a:ext cx="6240669" cy="54864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19847285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89D367-E1BC-BA4F-8BBF-EDB24E459A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2897" y="382385"/>
            <a:ext cx="5011380" cy="865865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munotherap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28A236-4605-214B-B15C-D9DDCC959F1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48640" y="1554481"/>
            <a:ext cx="5547360" cy="5087388"/>
          </a:xfrm>
        </p:spPr>
        <p:txBody>
          <a:bodyPr>
            <a:normAutofit/>
          </a:bodyPr>
          <a:lstStyle/>
          <a:p>
            <a:pPr>
              <a:lnSpc>
                <a:spcPct val="100000"/>
              </a:lnSpc>
              <a:spcBef>
                <a:spcPts val="600"/>
              </a:spcBef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Not as widely used as surgery, chemotherapy, and radiation therapy.</a:t>
            </a:r>
          </a:p>
          <a:p>
            <a:pPr>
              <a:lnSpc>
                <a:spcPct val="100000"/>
              </a:lnSpc>
              <a:spcBef>
                <a:spcPts val="600"/>
              </a:spcBef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reatment that helps the immune system better fight cancer.</a:t>
            </a:r>
          </a:p>
          <a:p>
            <a:pPr lvl="1">
              <a:lnSpc>
                <a:spcPct val="100000"/>
              </a:lnSpc>
              <a:spcBef>
                <a:spcPts val="600"/>
              </a:spcBef>
            </a:pP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  <a:hlinkClick r:id="rId3"/>
              </a:rPr>
              <a:t>How does immunotherapy work?</a:t>
            </a:r>
            <a:endParaRPr 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00000"/>
              </a:lnSpc>
              <a:spcBef>
                <a:spcPts val="600"/>
              </a:spcBef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an be given through an IV, a pill, a topical ointment, or inserted directly into the bladder.</a:t>
            </a:r>
          </a:p>
          <a:p>
            <a:pPr marL="457200" lvl="1" indent="0">
              <a:lnSpc>
                <a:spcPct val="100000"/>
              </a:lnSpc>
              <a:spcBef>
                <a:spcPts val="600"/>
              </a:spcBef>
              <a:buNone/>
            </a:pPr>
            <a:endParaRPr 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1">
              <a:lnSpc>
                <a:spcPct val="100000"/>
              </a:lnSpc>
              <a:spcBef>
                <a:spcPts val="600"/>
              </a:spcBef>
            </a:pPr>
            <a:endParaRPr 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7E11111B-CB4C-1D4A-89C2-DFE31E1F58FA}"/>
              </a:ext>
            </a:extLst>
          </p:cNvPr>
          <p:cNvSpPr/>
          <p:nvPr/>
        </p:nvSpPr>
        <p:spPr>
          <a:xfrm>
            <a:off x="6799604" y="0"/>
            <a:ext cx="5392396" cy="68580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C663DDA8-DFC7-F641-B046-71CC05ED12C5}"/>
              </a:ext>
            </a:extLst>
          </p:cNvPr>
          <p:cNvGrpSpPr/>
          <p:nvPr/>
        </p:nvGrpSpPr>
        <p:grpSpPr>
          <a:xfrm>
            <a:off x="7495419" y="699900"/>
            <a:ext cx="5031557" cy="6476386"/>
            <a:chOff x="7495419" y="699900"/>
            <a:chExt cx="5031557" cy="6476386"/>
          </a:xfrm>
        </p:grpSpPr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62513E96-51AB-054C-BBEF-D4785ACA04D8}"/>
                </a:ext>
              </a:extLst>
            </p:cNvPr>
            <p:cNvSpPr/>
            <p:nvPr/>
          </p:nvSpPr>
          <p:spPr>
            <a:xfrm>
              <a:off x="8878775" y="1654629"/>
              <a:ext cx="2362200" cy="1970314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7" name="Graphic 6" descr="IV">
              <a:extLst>
                <a:ext uri="{FF2B5EF4-FFF2-40B4-BE49-F238E27FC236}">
                  <a16:creationId xmlns:a16="http://schemas.microsoft.com/office/drawing/2014/main" id="{7120547F-285B-6947-BB66-D1AFE2C2D11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/>
                </a:ex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7495419" y="699900"/>
              <a:ext cx="5031557" cy="5031557"/>
            </a:xfrm>
            <a:prstGeom prst="rect">
              <a:avLst/>
            </a:prstGeom>
          </p:spPr>
        </p:pic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175242A1-0B24-7544-BBFE-2DFA5E299FD7}"/>
                </a:ext>
              </a:extLst>
            </p:cNvPr>
            <p:cNvSpPr/>
            <p:nvPr/>
          </p:nvSpPr>
          <p:spPr>
            <a:xfrm>
              <a:off x="9858998" y="5042020"/>
              <a:ext cx="284307" cy="2134266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2895566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47688336-7EC8-104F-B2D9-5951728597EE}"/>
              </a:ext>
            </a:extLst>
          </p:cNvPr>
          <p:cNvSpPr/>
          <p:nvPr/>
        </p:nvSpPr>
        <p:spPr>
          <a:xfrm>
            <a:off x="7099069" y="0"/>
            <a:ext cx="5092931" cy="68580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4DA0E3C-230A-544A-A730-200E65AC49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12865" y="2012818"/>
            <a:ext cx="4946072" cy="2832363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8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munotherapy Side Effects </a:t>
            </a:r>
          </a:p>
        </p:txBody>
      </p:sp>
      <p:graphicFrame>
        <p:nvGraphicFramePr>
          <p:cNvPr id="5" name="Content Placeholder 2">
            <a:extLst>
              <a:ext uri="{FF2B5EF4-FFF2-40B4-BE49-F238E27FC236}">
                <a16:creationId xmlns:a16="http://schemas.microsoft.com/office/drawing/2014/main" id="{42621764-E5A7-4169-B377-28721E94F12E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081204577"/>
              </p:ext>
            </p:extLst>
          </p:nvPr>
        </p:nvGraphicFramePr>
        <p:xfrm>
          <a:off x="5443595" y="902656"/>
          <a:ext cx="6335540" cy="5381355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310792778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A80CB714-D2BE-7E43-BFB4-C5460F6F2BA4}"/>
              </a:ext>
            </a:extLst>
          </p:cNvPr>
          <p:cNvSpPr/>
          <p:nvPr/>
        </p:nvSpPr>
        <p:spPr>
          <a:xfrm>
            <a:off x="7099069" y="0"/>
            <a:ext cx="5092931" cy="68580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accent2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0F145963-D08F-3945-98C4-1307373D31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2900" y="407324"/>
            <a:ext cx="5370576" cy="1138767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rgeted Therap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157ACD-BAB8-6B43-9C08-4B63621C88B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22900" y="1757632"/>
            <a:ext cx="5370576" cy="4410412"/>
          </a:xfrm>
        </p:spPr>
        <p:txBody>
          <a:bodyPr anchor="t">
            <a:noAutofit/>
          </a:bodyPr>
          <a:lstStyle/>
          <a:p>
            <a:pPr>
              <a:lnSpc>
                <a:spcPct val="100000"/>
              </a:lnSpc>
              <a:spcBef>
                <a:spcPts val="600"/>
              </a:spcBef>
            </a:pPr>
            <a:r>
              <a:rPr lang="en-US" sz="2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rgets proteins to control how cancer cells grow, divide, and spread.</a:t>
            </a:r>
          </a:p>
          <a:p>
            <a:pPr>
              <a:lnSpc>
                <a:spcPct val="100000"/>
              </a:lnSpc>
              <a:spcBef>
                <a:spcPts val="600"/>
              </a:spcBef>
            </a:pPr>
            <a:r>
              <a:rPr lang="en-US" sz="2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eats cancer in various ways:</a:t>
            </a:r>
          </a:p>
          <a:p>
            <a:pPr lvl="1">
              <a:lnSpc>
                <a:spcPct val="100000"/>
              </a:lnSpc>
              <a:spcBef>
                <a:spcPts val="600"/>
              </a:spcBef>
            </a:pPr>
            <a:r>
              <a: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ps immune system destroy cancer cells</a:t>
            </a:r>
          </a:p>
          <a:p>
            <a:pPr lvl="1">
              <a:lnSpc>
                <a:spcPct val="100000"/>
              </a:lnSpc>
              <a:spcBef>
                <a:spcPts val="600"/>
              </a:spcBef>
            </a:pPr>
            <a:r>
              <a: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ops cancer cells from growing</a:t>
            </a:r>
          </a:p>
          <a:p>
            <a:pPr lvl="1">
              <a:lnSpc>
                <a:spcPct val="100000"/>
              </a:lnSpc>
              <a:spcBef>
                <a:spcPts val="600"/>
              </a:spcBef>
            </a:pPr>
            <a:r>
              <a: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liver substances to cancer cells that kill them</a:t>
            </a:r>
          </a:p>
          <a:p>
            <a:pPr lvl="1">
              <a:lnSpc>
                <a:spcPct val="100000"/>
              </a:lnSpc>
              <a:spcBef>
                <a:spcPts val="600"/>
              </a:spcBef>
            </a:pPr>
            <a:r>
              <a: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rves cancer of hormones it needs to grow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594BB46-7BBF-D349-8A86-6497DD86D76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456" r="6718" b="3834"/>
          <a:stretch/>
        </p:blipFill>
        <p:spPr>
          <a:xfrm>
            <a:off x="6226233" y="1188554"/>
            <a:ext cx="4746567" cy="4705171"/>
          </a:xfrm>
          <a:prstGeom prst="ellipse">
            <a:avLst/>
          </a:prstGeom>
        </p:spPr>
      </p:pic>
    </p:spTree>
    <p:extLst>
      <p:ext uri="{BB962C8B-B14F-4D97-AF65-F5344CB8AC3E}">
        <p14:creationId xmlns:p14="http://schemas.microsoft.com/office/powerpoint/2010/main" val="110921975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FDC0D8-5DB1-644F-8EF0-ACE3D3FA0D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0624" y="1012004"/>
            <a:ext cx="4862576" cy="4795408"/>
          </a:xfrm>
        </p:spPr>
        <p:txBody>
          <a:bodyPr>
            <a:normAutofit/>
          </a:bodyPr>
          <a:lstStyle/>
          <a:p>
            <a:r>
              <a:rPr lang="en-US" sz="48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all-molecule vs. Monoclonal</a:t>
            </a:r>
          </a:p>
        </p:txBody>
      </p:sp>
      <p:graphicFrame>
        <p:nvGraphicFramePr>
          <p:cNvPr id="5" name="Content Placeholder 2">
            <a:extLst>
              <a:ext uri="{FF2B5EF4-FFF2-40B4-BE49-F238E27FC236}">
                <a16:creationId xmlns:a16="http://schemas.microsoft.com/office/drawing/2014/main" id="{149D504A-AB60-400F-9E60-8A6D2BDF9C2B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376655437"/>
              </p:ext>
            </p:extLst>
          </p:nvPr>
        </p:nvGraphicFramePr>
        <p:xfrm>
          <a:off x="5561161" y="992387"/>
          <a:ext cx="5393367" cy="4873226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386076956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DD281858-8F70-AE49-91AF-EE7D08798608}"/>
              </a:ext>
            </a:extLst>
          </p:cNvPr>
          <p:cNvSpPr/>
          <p:nvPr/>
        </p:nvSpPr>
        <p:spPr>
          <a:xfrm>
            <a:off x="7099069" y="0"/>
            <a:ext cx="5092931" cy="68580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itle 1">
            <a:extLst>
              <a:ext uri="{FF2B5EF4-FFF2-40B4-BE49-F238E27FC236}">
                <a16:creationId xmlns:a16="http://schemas.microsoft.com/office/drawing/2014/main" id="{A4AE8A33-5615-0A42-863D-F8702779790D}"/>
              </a:ext>
            </a:extLst>
          </p:cNvPr>
          <p:cNvSpPr txBox="1">
            <a:spLocks/>
          </p:cNvSpPr>
          <p:nvPr/>
        </p:nvSpPr>
        <p:spPr>
          <a:xfrm>
            <a:off x="412865" y="2012818"/>
            <a:ext cx="4946072" cy="28323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48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rgeted Therapy </a:t>
            </a:r>
          </a:p>
          <a:p>
            <a:r>
              <a:rPr lang="en-US" sz="48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de Effects </a:t>
            </a:r>
          </a:p>
        </p:txBody>
      </p:sp>
      <p:graphicFrame>
        <p:nvGraphicFramePr>
          <p:cNvPr id="25" name="Content Placeholder 2">
            <a:extLst>
              <a:ext uri="{FF2B5EF4-FFF2-40B4-BE49-F238E27FC236}">
                <a16:creationId xmlns:a16="http://schemas.microsoft.com/office/drawing/2014/main" id="{BC4ADF78-F706-46D0-BD38-772CB390B3B2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53176633"/>
              </p:ext>
            </p:extLst>
          </p:nvPr>
        </p:nvGraphicFramePr>
        <p:xfrm>
          <a:off x="5247020" y="828675"/>
          <a:ext cx="6240669" cy="5088414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41774544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Custom 1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0033A0"/>
      </a:accent1>
      <a:accent2>
        <a:srgbClr val="58C9E7"/>
      </a:accent2>
      <a:accent3>
        <a:srgbClr val="A5A5A5"/>
      </a:accent3>
      <a:accent4>
        <a:srgbClr val="FCB524"/>
      </a:accent4>
      <a:accent5>
        <a:srgbClr val="EF3A4C"/>
      </a:accent5>
      <a:accent6>
        <a:srgbClr val="81BD41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1</TotalTime>
  <Words>1075</Words>
  <Application>Microsoft Office PowerPoint</Application>
  <PresentationFormat>Widescreen</PresentationFormat>
  <Paragraphs>137</Paragraphs>
  <Slides>20</Slides>
  <Notes>1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5" baseType="lpstr">
      <vt:lpstr>Arial</vt:lpstr>
      <vt:lpstr>Calibri</vt:lpstr>
      <vt:lpstr>Calibri Light</vt:lpstr>
      <vt:lpstr>System Font Regular</vt:lpstr>
      <vt:lpstr>Office Theme</vt:lpstr>
      <vt:lpstr>CANCER IN THE COMMONWEALTH</vt:lpstr>
      <vt:lpstr>ACTIVITY</vt:lpstr>
      <vt:lpstr>Cancer Treatments In Depth</vt:lpstr>
      <vt:lpstr>4 Types of Modern Cancer Treatment</vt:lpstr>
      <vt:lpstr>Immunotherapy</vt:lpstr>
      <vt:lpstr>Immunotherapy Side Effects </vt:lpstr>
      <vt:lpstr>Targeted Therapy</vt:lpstr>
      <vt:lpstr>Small-molecule vs. Monoclonal</vt:lpstr>
      <vt:lpstr>PowerPoint Presentation</vt:lpstr>
      <vt:lpstr>Hormone Therapy</vt:lpstr>
      <vt:lpstr>Production vs. Behavior</vt:lpstr>
      <vt:lpstr>Side Effects of Hormone Therapy</vt:lpstr>
      <vt:lpstr>Precision Medicine</vt:lpstr>
      <vt:lpstr>How to Determine A Genetic Change</vt:lpstr>
      <vt:lpstr>Do all treatments work for each patient?</vt:lpstr>
      <vt:lpstr>Combination Therapy</vt:lpstr>
      <vt:lpstr>Advantages of Combination Therapy</vt:lpstr>
      <vt:lpstr>Disadvantages of Combination Therapy</vt:lpstr>
      <vt:lpstr>Summary</vt:lpstr>
      <vt:lpstr>QUESTION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ANCER IN THE COMMONWEALTH</dc:title>
  <dc:creator>Wright, Elise</dc:creator>
  <cp:lastModifiedBy>Charlotte Seidman</cp:lastModifiedBy>
  <cp:revision>34</cp:revision>
  <dcterms:created xsi:type="dcterms:W3CDTF">2020-07-30T14:59:59Z</dcterms:created>
  <dcterms:modified xsi:type="dcterms:W3CDTF">2022-05-20T00:10:24Z</dcterms:modified>
</cp:coreProperties>
</file>